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915" autoAdjust="0"/>
  </p:normalViewPr>
  <p:slideViewPr>
    <p:cSldViewPr snapToGrid="0">
      <p:cViewPr varScale="1">
        <p:scale>
          <a:sx n="69" d="100"/>
          <a:sy n="69" d="100"/>
        </p:scale>
        <p:origin x="40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kolaj Juul Nitschke" userId="eb944128-ea9e-41a1-979a-ca9bb959a91e" providerId="ADAL" clId="{6AFE4E9F-5EB9-4CE6-9784-903788AE6242}"/>
    <pc:docChg chg="undo custSel addSld delSld modSld sldOrd">
      <pc:chgData name="Nikolaj Juul Nitschke" userId="eb944128-ea9e-41a1-979a-ca9bb959a91e" providerId="ADAL" clId="{6AFE4E9F-5EB9-4CE6-9784-903788AE6242}" dt="2025-04-25T08:00:26.944" v="239" actId="1076"/>
      <pc:docMkLst>
        <pc:docMk/>
      </pc:docMkLst>
      <pc:sldChg chg="addSp delSp modSp mod">
        <pc:chgData name="Nikolaj Juul Nitschke" userId="eb944128-ea9e-41a1-979a-ca9bb959a91e" providerId="ADAL" clId="{6AFE4E9F-5EB9-4CE6-9784-903788AE6242}" dt="2025-04-24T09:48:32.312" v="167" actId="1076"/>
        <pc:sldMkLst>
          <pc:docMk/>
          <pc:sldMk cId="1461944421" sldId="257"/>
        </pc:sldMkLst>
        <pc:spChg chg="add mod">
          <ac:chgData name="Nikolaj Juul Nitschke" userId="eb944128-ea9e-41a1-979a-ca9bb959a91e" providerId="ADAL" clId="{6AFE4E9F-5EB9-4CE6-9784-903788AE6242}" dt="2025-04-24T09:47:28.732" v="155"/>
          <ac:spMkLst>
            <pc:docMk/>
            <pc:sldMk cId="1461944421" sldId="257"/>
            <ac:spMk id="3" creationId="{7D7719C8-8034-9466-25F1-5FF7028E836B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" creationId="{6A83B686-B8C1-8F35-3D2C-D1D19188E5C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" creationId="{0B012258-B820-8501-8FB5-C0DA7292F03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" creationId="{045B9B58-909A-6C57-F023-026042EFDBE7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" creationId="{B3867D2E-EAE3-132F-8D11-1E915DA88031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0" creationId="{C1A9ED5B-7517-F1F7-1D3C-9339AB7F2B1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1" creationId="{27242BF4-0423-DB74-1B8C-7B3BA27AFBB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2" creationId="{ADE0DA45-F8BC-AF3E-5A79-69F7596F6466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3" creationId="{5965668B-8563-A9EB-84D6-E3DC614C3C7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4" creationId="{1EAF905D-2F45-1DB4-532D-60AD42FC46F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5" creationId="{6A3D37CD-29E6-0222-C737-6C88B109FD2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6" creationId="{A973A2A4-7B2E-038E-3EB1-E2B986756406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7" creationId="{C45B9147-0CC8-7A89-F0F6-6AA6FF0684C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8" creationId="{14448A13-844B-86B2-BC39-BEA94D72CB3F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19" creationId="{4A1ABCFE-4B0C-A360-2ACA-B5A87A62B86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0" creationId="{6CBF9F66-77E9-1A22-BEAF-5497B3A37DD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1" creationId="{A6C616B2-C66A-A28D-48BE-613CE144C71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2" creationId="{B471E1DF-8D89-0B7F-7C5B-258C441DC0D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3" creationId="{44458D6C-7A0F-A825-BB7F-0777A1FADDE6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4" creationId="{B7DDC77A-8DC1-3775-8ECF-8E20E4017EC5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5" creationId="{DEF008C5-2F89-4ABA-F1D1-664928CD290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" creationId="{562D09A8-7B60-3261-7F43-51B022DEB1C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" creationId="{9A5FA11B-CDFC-1003-22CE-C7CD0F2BB1A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8" creationId="{EBA82662-A335-AB51-D917-FE14561669A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30" creationId="{E6B70A80-B1E0-5382-2C53-7E10E48743AF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31" creationId="{57014AFE-8044-5C19-C924-134127A680F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4" creationId="{87B51F2E-E3C6-D492-4187-3113BCA12CE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5" creationId="{6151B3FB-4288-8DA8-AA9D-A63EAB6BBD81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6" creationId="{6BAF34AA-FE95-FB09-962F-172ABCB3239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7" creationId="{0AEBD1E9-7F7A-BF66-7424-D67C64ACED4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8" creationId="{E77A742F-57DE-0EF5-8DCD-460621F08A15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69" creationId="{89B42AB7-9CFB-84CC-484C-74D2ADC12544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1" creationId="{E91FD540-4B99-64B3-B21D-7FB9E4E8DE66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2" creationId="{C6404C7F-2443-61E4-55D4-11B1498DA8A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3" creationId="{A8E9C80A-6337-6FFD-27AF-17351DAFEAE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4" creationId="{7ABB5A88-94E0-DC87-8D51-64D53CFA323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5" creationId="{2D75DE63-ACA3-5AA3-8FE1-3FA0E4C6EC1C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6" creationId="{3B7875FA-2DEE-1120-2DC7-BBBAF94E9C1F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7" creationId="{311EC920-BB23-6659-70C2-F8812344861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8" creationId="{6171113B-42DA-D701-5F8F-E50C18B0B2B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79" creationId="{F928C57B-D810-B543-28B9-91C1FEEC6A0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0" creationId="{44210EAE-6B04-0650-101A-7895D1DA6F0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1" creationId="{34A47C25-E850-92B9-ADCB-6946444A781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2" creationId="{EB179B5B-FD73-1995-6B17-2923DC3C128C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3" creationId="{D6F0A324-CC30-9D97-9A5B-346052AA5F1B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4" creationId="{E5938432-842B-55AD-2B01-591C84919AD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5" creationId="{50EA8C36-FA79-A2E1-19A8-0A4C57281BB1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6" creationId="{9D5720F7-041E-6F9C-A310-DDA22F9DE52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7" creationId="{EEAF2E9C-B971-783B-034B-4984E22053F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8" creationId="{56985C8C-AF9D-750E-DA4F-7ADBC74A463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89" creationId="{CBB0CE18-375D-A64C-F23F-61E92A94545F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0" creationId="{AD0AEDBF-10D9-6DDE-8DD7-E3FC7E62D56F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1" creationId="{BFE31461-4CF6-B570-F6B1-2FC9BD1D0BF7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2" creationId="{9939522F-E617-2096-801F-F6C07E307C0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3" creationId="{FF58939C-2673-E31A-D23C-F43B5D02BAE8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94" creationId="{8BDC9CCC-7509-E33E-0383-7561478000F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56" creationId="{BE267F00-8598-1066-B2D2-5F87103140F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57" creationId="{69766E4A-786A-C91B-3B77-B3CCAC66B185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58" creationId="{25F0AB4C-1EC9-E258-53D6-408FBB1AB984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59" creationId="{2FD35E9E-7077-E7E5-ACA4-F85BE4394D1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0" creationId="{BB6C91FE-8902-1992-74D3-FAC34F046C42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1" creationId="{B33907F9-3D24-D69E-D307-34417A017A27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2" creationId="{8D44BD05-C664-3AB9-91B8-60604BE3C5D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3" creationId="{D750070E-F06E-EEAC-29E3-1CDC8C61BDB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4" creationId="{A8CF41E7-3538-0F55-30A1-417716F9B81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5" creationId="{6398E366-679F-9AEB-A507-DFCBBDC864C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6" creationId="{24C7C0B8-D41B-BBC9-C056-541B2FBCADF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7" creationId="{05C49628-AC8B-1F9D-DDAE-C8939A994695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8" creationId="{5E91E949-9515-662E-D9B6-7EF2D2E9C6B6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69" creationId="{206AD506-97EA-C17E-A9BE-D4766E0FE91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0" creationId="{2685ECA7-F690-24CA-5BB5-331DE4205D54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1" creationId="{CBA025AD-EEC7-7A1F-BA73-5828FB0F635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2" creationId="{A03A0A00-C8AE-DA7B-20C8-1836BDC119CC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3" creationId="{A3AD28EB-4CD4-5A74-E0F7-F00DD661A563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4" creationId="{8CD0B2B8-1B0C-081F-AEE6-2381C2E156B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5" creationId="{E6C74CF9-799F-BA4D-8024-903815E0376A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6" creationId="{7C0E0001-BF58-EA94-C2E5-AD93FB06CFFE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7" creationId="{378C47A3-CEA3-53FE-3C6A-D5E5DFEC046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8" creationId="{78AB3D03-E3A6-1BD3-7EF3-D52B07FD278B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79" creationId="{B04BF747-674B-A7A9-5428-AFAB4CE31889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80" creationId="{45C507A7-ECE1-92E6-F2EF-C6DA86459500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81" creationId="{792B55F1-B907-9470-3FFB-0FC52E5626CC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82" creationId="{8BC5479E-F3E5-C42E-6245-9DC5622B3C8D}"/>
          </ac:spMkLst>
        </pc:spChg>
        <pc:spChg chg="mod">
          <ac:chgData name="Nikolaj Juul Nitschke" userId="eb944128-ea9e-41a1-979a-ca9bb959a91e" providerId="ADAL" clId="{6AFE4E9F-5EB9-4CE6-9784-903788AE6242}" dt="2025-04-24T09:47:39.471" v="156"/>
          <ac:spMkLst>
            <pc:docMk/>
            <pc:sldMk cId="1461944421" sldId="257"/>
            <ac:spMk id="287" creationId="{46634A5F-92D7-DAB4-A1A1-B63A004EAAFB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0" creationId="{EAE0B4B9-1F4E-561C-536E-5C22B51B7C7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1" creationId="{00657079-6C91-31E3-9641-7C2CB6E2A65A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2" creationId="{639E5B56-D952-21B8-426E-B3E18B7B4B5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3" creationId="{9532771D-ED82-EEBA-B9DB-A0D821864DA2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4" creationId="{F262A2B7-C7CB-AD19-A384-1773B256654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5" creationId="{A3353B21-B60F-E2B9-A2B0-8598C0535C44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6" creationId="{DBEE50AF-8559-E4D6-6F5C-4871CC385BEA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7" creationId="{54B092B4-6F5A-D4A1-3091-6C2ED429D66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8" creationId="{06B6FEAE-47C0-86DE-78B7-286247C8300E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29" creationId="{E5B01B81-815E-97D7-A2E7-B7074C82963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0" creationId="{A5CB7FB9-B21B-5ED2-E740-BF6000C5DA44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1" creationId="{63EC53CF-622B-FD41-A2B8-AF6C7D18AB1A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2" creationId="{9A078490-CE08-E9B0-9A41-5026F76C7A6D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3" creationId="{E3D37690-19C3-3C74-0613-9B10F0D56FD0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4" creationId="{66C0464B-23C3-824C-EB4F-901C9DC1CFE2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5" creationId="{F029AF78-9814-88B7-B593-C7AFD3094ADA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6" creationId="{BD5FF3B9-E84A-AB5B-BDFC-569A47B8D29B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7" creationId="{F5E6434A-5AA5-D1BA-ABC3-92D57005140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8" creationId="{3DF3F537-545E-A542-27F9-4B7797DE8EB8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39" creationId="{ADAA2EC7-511D-2B0E-32BF-966E330C20BC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0" creationId="{3E6C8643-BE1B-B716-BCCC-E6A78B3DBCD3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1" creationId="{8C96A8B1-6505-1E20-EF8A-811CF25E6AA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2" creationId="{BAFCA25F-BDBF-7036-90B6-C116905933C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3" creationId="{0D58D510-018A-0B48-EF43-15D78586D3C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4" creationId="{93CC5FB1-0074-76B8-682B-553AB7B41C5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5" creationId="{C3D4692C-325D-7BF5-826D-FCEA137C16DC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46" creationId="{D223FD47-4D05-9DD6-A2EA-B0C49F46D6BC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86" creationId="{9D51B0AF-2B0B-8CF1-F57D-33A7C51EB73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87" creationId="{4E7B2CDA-F4A3-AF05-1E69-F600730E836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88" creationId="{0FD057AA-6C34-862A-5EE3-F14663F7E5D3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89" creationId="{A2339FA2-339B-D05E-0F74-6E204A8EDEB8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0" creationId="{578F3ED9-6790-15A2-60FF-C2A3C0BEE54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1" creationId="{CA9D9C5F-A412-4B5E-8A38-1728461ED8B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2" creationId="{15AF14C7-32D8-BC7D-7F9A-BA5FF6DCF45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3" creationId="{88281B79-AC3F-8590-753B-5F0C0E98831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4" creationId="{29659E1D-1D28-C5CC-17D5-B333AE7EB0C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5" creationId="{20A04B79-53DD-4DA3-82D5-D11578DD9B89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6" creationId="{80E811BC-6204-F992-2864-9C90BB9CB80B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7" creationId="{0F139325-8C21-A020-1A03-AD5540559B60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8" creationId="{28DD4F9B-AEC2-D4FE-F4B2-E3D1BDAD393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399" creationId="{F2C7A546-14B2-738D-72EF-BB1A5E49D6AE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0" creationId="{01AADE13-98CD-A125-0FC5-1B1AD1362812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1" creationId="{8AACA10F-4C32-94AD-0E13-C4E0C7FE0975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2" creationId="{4222E642-8B28-36A1-BE77-AC0141ACE0A9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3" creationId="{6DD86A80-A19C-7B09-A450-7C0520BB3E0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4" creationId="{E4DB4D86-5FE7-6133-7C9F-AA9C1EBBE1E6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5" creationId="{AECFCA49-5570-1A26-2CAF-29A5A8AC3CC6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406" creationId="{31A5F2AB-8F05-F025-73D9-8222135CF49A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2" creationId="{77BEA466-6866-7562-03B3-49644ACA52AC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3" creationId="{06597E15-4474-9046-01DC-62BAB7AF6CC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4" creationId="{E675D20F-0E4B-AE17-F422-28E5B3F03968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5" creationId="{67BBB808-66A4-8F1D-CF30-CF090C53626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6" creationId="{2F5994F5-F79A-7828-A96A-E68E6532C6E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7" creationId="{94D7A01B-424F-F585-40CA-818412A3E038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8" creationId="{7EC3E403-D565-6169-243F-23637A82EDF2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19" creationId="{58586F68-640D-24C4-EF4F-2B5CFCE22F3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0" creationId="{D225632E-639C-3F09-BB5F-1E70780265B7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1" creationId="{B5A891FC-8529-4CD0-96C3-CFE9ECA52C6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2" creationId="{D593175F-5E9D-DFD1-9207-B57CFB848923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3" creationId="{5C8A15AD-A527-6A91-41C1-EAD3F5EE8AB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4" creationId="{0C58335F-2E77-3B75-E37E-97D3F66AC13C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6" creationId="{CAAD2B75-17D0-170E-4FEB-DBFE3EC9037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7" creationId="{22D9887C-F6E5-16FF-6A0A-E66833393760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8" creationId="{2E78EFE5-C315-08ED-5A91-DA1725ECE45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29" creationId="{EC5B7FB5-CA89-E2DE-561F-9A95FFCEB8D2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0" creationId="{EB5B94C7-2115-F0B8-D199-11633E40FBBF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1" creationId="{10A0EDE9-DB53-F50E-66BE-B818F742648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2" creationId="{B1EAF885-1A25-0E99-ABBB-CBEF3527C4C3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3" creationId="{D7C93405-1ED2-EEAF-156E-118932F378BE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4" creationId="{F16AC943-F62D-DBF0-FAEB-EB678DFB6B0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5" creationId="{CB90E6C7-54F6-FA29-3896-B93982F28FA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6" creationId="{444946C9-3616-0EA1-E417-01E3E05CB9E6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7" creationId="{9B63983B-7A9D-C34F-8F10-9EC1D1817761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8" creationId="{8624A45F-B61F-427A-ABF6-9961FA7F053E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39" creationId="{71026570-C863-7B1C-6E56-A9F63E561649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40" creationId="{362934F1-D8B0-8D62-CB39-1C5AF5D3BD78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41" creationId="{431CF699-05E0-9B59-4FBD-71F997459AD6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42" creationId="{E44E6D9D-5401-59E6-497C-24531768C8BB}"/>
          </ac:spMkLst>
        </pc:spChg>
        <pc:spChg chg="mod">
          <ac:chgData name="Nikolaj Juul Nitschke" userId="eb944128-ea9e-41a1-979a-ca9bb959a91e" providerId="ADAL" clId="{6AFE4E9F-5EB9-4CE6-9784-903788AE6242}" dt="2025-04-24T09:48:21.951" v="161"/>
          <ac:spMkLst>
            <pc:docMk/>
            <pc:sldMk cId="1461944421" sldId="257"/>
            <ac:spMk id="543" creationId="{79D1BFA8-4CEA-6468-333D-74860B809B93}"/>
          </ac:spMkLst>
        </pc:spChg>
        <pc:grpChg chg="add mod">
          <ac:chgData name="Nikolaj Juul Nitschke" userId="eb944128-ea9e-41a1-979a-ca9bb959a91e" providerId="ADAL" clId="{6AFE4E9F-5EB9-4CE6-9784-903788AE6242}" dt="2025-04-24T09:47:44.384" v="160" actId="1076"/>
          <ac:grpSpMkLst>
            <pc:docMk/>
            <pc:sldMk cId="1461944421" sldId="257"/>
            <ac:grpSpMk id="4" creationId="{86465911-9F5C-8D9C-C45A-E0ADB4D3E396}"/>
          </ac:grpSpMkLst>
        </pc:grpChg>
        <pc:grpChg chg="add mod">
          <ac:chgData name="Nikolaj Juul Nitschke" userId="eb944128-ea9e-41a1-979a-ca9bb959a91e" providerId="ADAL" clId="{6AFE4E9F-5EB9-4CE6-9784-903788AE6242}" dt="2025-04-24T09:48:32.312" v="167" actId="1076"/>
          <ac:grpSpMkLst>
            <pc:docMk/>
            <pc:sldMk cId="1461944421" sldId="257"/>
            <ac:grpSpMk id="95" creationId="{EFB0F414-434A-27F5-9178-6782483828D4}"/>
          </ac:grpSpMkLst>
        </pc:grpChg>
        <pc:grpChg chg="mod">
          <ac:chgData name="Nikolaj Juul Nitschke" userId="eb944128-ea9e-41a1-979a-ca9bb959a91e" providerId="ADAL" clId="{6AFE4E9F-5EB9-4CE6-9784-903788AE6242}" dt="2025-04-24T09:48:25.695" v="164" actId="1076"/>
          <ac:grpSpMkLst>
            <pc:docMk/>
            <pc:sldMk cId="1461944421" sldId="257"/>
            <ac:grpSpMk id="347" creationId="{B91BD34B-DBCF-1A47-7A25-6829EA9B8A06}"/>
          </ac:grpSpMkLst>
        </pc:grpChg>
        <pc:picChg chg="del">
          <ac:chgData name="Nikolaj Juul Nitschke" userId="eb944128-ea9e-41a1-979a-ca9bb959a91e" providerId="ADAL" clId="{6AFE4E9F-5EB9-4CE6-9784-903788AE6242}" dt="2025-04-24T09:47:28.452" v="154" actId="478"/>
          <ac:picMkLst>
            <pc:docMk/>
            <pc:sldMk cId="1461944421" sldId="257"/>
            <ac:picMk id="525" creationId="{B075BDA6-C91C-7723-A8A6-203908DB2A47}"/>
          </ac:picMkLst>
        </pc:picChg>
      </pc:sldChg>
      <pc:sldChg chg="addSp delSp modSp mod">
        <pc:chgData name="Nikolaj Juul Nitschke" userId="eb944128-ea9e-41a1-979a-ca9bb959a91e" providerId="ADAL" clId="{6AFE4E9F-5EB9-4CE6-9784-903788AE6242}" dt="2025-04-10T11:19:36.457" v="153" actId="27614"/>
        <pc:sldMkLst>
          <pc:docMk/>
          <pc:sldMk cId="3546809507" sldId="263"/>
        </pc:sldMkLst>
        <pc:picChg chg="del">
          <ac:chgData name="Nikolaj Juul Nitschke" userId="eb944128-ea9e-41a1-979a-ca9bb959a91e" providerId="ADAL" clId="{6AFE4E9F-5EB9-4CE6-9784-903788AE6242}" dt="2025-04-10T11:19:17.045" v="151" actId="478"/>
          <ac:picMkLst>
            <pc:docMk/>
            <pc:sldMk cId="3546809507" sldId="263"/>
            <ac:picMk id="4" creationId="{689E685D-2779-CA38-1BBD-13A1A7BAF483}"/>
          </ac:picMkLst>
        </pc:picChg>
        <pc:picChg chg="add mod">
          <ac:chgData name="Nikolaj Juul Nitschke" userId="eb944128-ea9e-41a1-979a-ca9bb959a91e" providerId="ADAL" clId="{6AFE4E9F-5EB9-4CE6-9784-903788AE6242}" dt="2025-04-10T11:19:36.457" v="153" actId="27614"/>
          <ac:picMkLst>
            <pc:docMk/>
            <pc:sldMk cId="3546809507" sldId="263"/>
            <ac:picMk id="5" creationId="{8E1EE370-AD32-881A-D601-FD939C1AA331}"/>
          </ac:picMkLst>
        </pc:picChg>
      </pc:sldChg>
      <pc:sldChg chg="del">
        <pc:chgData name="Nikolaj Juul Nitschke" userId="eb944128-ea9e-41a1-979a-ca9bb959a91e" providerId="ADAL" clId="{6AFE4E9F-5EB9-4CE6-9784-903788AE6242}" dt="2025-03-28T08:47:43.134" v="150" actId="47"/>
        <pc:sldMkLst>
          <pc:docMk/>
          <pc:sldMk cId="3699891032" sldId="267"/>
        </pc:sldMkLst>
      </pc:sldChg>
      <pc:sldChg chg="addSp modSp new del mod">
        <pc:chgData name="Nikolaj Juul Nitschke" userId="eb944128-ea9e-41a1-979a-ca9bb959a91e" providerId="ADAL" clId="{6AFE4E9F-5EB9-4CE6-9784-903788AE6242}" dt="2025-03-28T08:37:22.192" v="22" actId="47"/>
        <pc:sldMkLst>
          <pc:docMk/>
          <pc:sldMk cId="1848100295" sldId="268"/>
        </pc:sldMkLst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" creationId="{8BFAC7FD-AB31-3443-D5F1-735D2A94175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" creationId="{64341C2B-472C-A7B2-A7F3-A2E10441EFE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" creationId="{472AB97F-F6E9-744B-C828-609B1849157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" creationId="{E8A37AD2-94CD-8F66-D20B-8140976199D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" creationId="{C5589A59-18DE-DAEC-5138-8E56702D916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" creationId="{78ABEA0E-0E58-22B2-AB3F-01D5282DF23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" creationId="{9B723D8C-2B09-E9D6-45FB-28399C2FAEA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" creationId="{A72A8303-3CE7-9A38-8D3D-765D122A9CD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2" creationId="{34E48A51-B715-3A5A-A484-795062A10A7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3" creationId="{2E11A516-F55B-50C1-F520-8E3FB20BD2D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4" creationId="{9DE4B0EE-2F61-FDDF-AF8A-C1897CD815F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5" creationId="{47D341BE-3FAF-4CE4-435E-8DC312CB8D67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6" creationId="{D0B8F5A4-E70A-F0AB-6FC3-B718109A07C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7" creationId="{7DC713C4-B9DB-4FB1-5164-29625DB0902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8" creationId="{EFDF1F2C-1462-425E-D75A-8F1C07C2C9A8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9" creationId="{A62B6F23-B895-7532-3382-935933FA215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0" creationId="{700AFF2E-4649-DE0C-E3DB-DEF6E55EF1B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1" creationId="{2EF51792-4636-8D72-5AB6-C2A203AF3A4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2" creationId="{C533E782-4106-2589-CC8B-E67F9F1493A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3" creationId="{C86407FE-16FF-5797-0426-DBF3D4646077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4" creationId="{2F212DA9-8022-0D99-F358-492976FEEF91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5" creationId="{3C8079B2-B89A-2E60-40F1-866EA5A0F605}"/>
          </ac:spMkLst>
        </pc:spChg>
        <pc:spChg chg="add mod">
          <ac:chgData name="Nikolaj Juul Nitschke" userId="eb944128-ea9e-41a1-979a-ca9bb959a91e" providerId="ADAL" clId="{6AFE4E9F-5EB9-4CE6-9784-903788AE6242}" dt="2025-03-28T08:36:23.565" v="21" actId="14100"/>
          <ac:spMkLst>
            <pc:docMk/>
            <pc:sldMk cId="1848100295" sldId="268"/>
            <ac:spMk id="26" creationId="{97B60217-5F31-F048-569E-09B65519E3D7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7" creationId="{E2D12713-9AC0-78EE-E9D9-CE3B6AD8BA54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8" creationId="{6AFB95A9-F38C-FF84-CD9B-899FC78F39B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29" creationId="{465F520C-FA7B-7BB3-7BEF-537BC3A4E86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0" creationId="{4309E7A6-DA30-38C5-AEF0-6CAA2D8194E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1" creationId="{A46C5E43-F5FD-2797-3911-2706D879D8BE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2" creationId="{B817311E-29F3-0A19-60F1-C429C4AEC12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3" creationId="{DA7D7D42-F6F9-33AC-B210-DFCC1E13E2B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4" creationId="{4C552850-48B7-4557-DAE9-B13731606AAE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5" creationId="{FF33AEDB-5B5C-1DEB-AD3A-3228F16073F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6" creationId="{92702B2D-53A1-118A-1A72-F1E5B0D62488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7" creationId="{C99656FE-3021-4692-780A-8D0FB105D87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8" creationId="{DA9EC243-246A-2E65-5578-707D6BCDCAD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39" creationId="{C9AE0B33-3006-B852-5781-AFDFFFD2B58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0" creationId="{C2019645-40D6-F0D4-D12A-19A8DE3EC7C8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1" creationId="{C2C1B182-73B8-1374-DECB-D0B03AFC4DF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2" creationId="{966A2789-0165-7870-18DC-A3DC916740C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3" creationId="{82109F8A-6128-B467-E992-41A425D09B5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4" creationId="{9D399110-C6A4-0CF9-2564-132F8C32F6B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5" creationId="{89523232-A65D-9014-D40E-5A7488B14DC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6" creationId="{B43DEEDD-D814-85FE-7FA1-8B19800C89A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7" creationId="{E8088A42-E694-38B3-F2B5-41FA761EFB7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8" creationId="{D1C5E34A-EF4D-CA78-FE24-7D67A7CF766B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49" creationId="{6FEF5114-89B4-60D7-4BF5-2CCE244BE93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0" creationId="{AEDC0CEE-F8DC-C770-6FD7-F164EB86F9D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1" creationId="{395A0BAB-212A-6F04-ABE6-761F9E88C7C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2" creationId="{F90C14A1-B7B5-0FF7-EAF0-4FC1F47B92C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3" creationId="{6746A63B-A1FC-D2E2-61EC-C0F0B8C0379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4" creationId="{0F2C38C2-743C-25EC-0AF6-10C71EBF50D1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5" creationId="{062034D1-5333-195A-4951-E3071BEBF0C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6" creationId="{7F4D3424-7DFE-74D0-1866-87842BC4550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7" creationId="{8B4729DB-E23F-1BBA-1B1E-5614243DBA8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8" creationId="{D18A4EFC-A318-C49F-1DED-6C75DBBE155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59" creationId="{C6C80CC7-F958-4135-0BA0-BE9C0B0B53F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0" creationId="{E3F53D14-3A1D-35E1-4DCE-B6EFDB6EEA7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1" creationId="{E8F1E4C1-1A92-D074-F5DF-18FAFA4E656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2" creationId="{20AF8725-3CFE-DD05-DE60-D8BDEC03D87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3" creationId="{796A9906-9872-A8A9-105A-01F9E3CA9ED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4" creationId="{4997998F-518E-6A72-76B8-8B2872380148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5" creationId="{4F023679-B282-1D89-E868-147CFDF2889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6" creationId="{53CAA384-541D-D0DE-07CE-1CFB86348DC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7" creationId="{A8730F1B-FA8C-2731-AF00-9121FF0B8E9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8" creationId="{EE889AB7-CC36-FF95-A8F4-557EFD0C4FB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69" creationId="{DA552F5A-1E00-D86C-3D23-1CB42FDAA824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0" creationId="{A9383ABE-B024-8910-74E7-2C651C697A27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1" creationId="{D89A20E1-7643-C872-16BA-1EF140ECE52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2" creationId="{658D0443-5E11-E4EB-11C3-9E76B446476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3" creationId="{0A0D31EC-09E6-3FC9-4972-03EB7CB4746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4" creationId="{7334C256-5676-B940-550D-6F73AEC0951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5" creationId="{54D1D7ED-0E65-BB41-E6A4-2698F1AC89D8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6" creationId="{08ECEEC2-A1F2-1539-C513-C7A8E4B685A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7" creationId="{FAD36ED2-0B8F-2805-4E35-1A83F17F90F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8" creationId="{0E0B1F5D-A1DD-BF4C-F775-89C647751C7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79" creationId="{DD901787-ABD7-C242-48BA-8E3C5EF8A2A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0" creationId="{64ECEF5A-6A24-A6C8-1F97-90B783092F56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1" creationId="{53AE1147-514B-6702-BD9E-102AB0955FC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2" creationId="{C3FDCDA0-E903-F733-72B1-973DF0A64C87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3" creationId="{426E1672-7EF0-586A-75DF-89392005430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4" creationId="{01150024-BA8F-32FB-77DF-A290525EDE1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5" creationId="{456373D9-26C9-72C8-6E33-1AF1A45B6CA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6" creationId="{82B768B2-E564-4654-8F52-57C7C110E7A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7" creationId="{FE85A968-6F39-F8F7-3D07-416A6ABC55C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8" creationId="{52E1773B-2DD6-8EAB-4472-AA7C585BA1FE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89" creationId="{CD727CBE-6B9A-726B-E528-06EB829D801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0" creationId="{091335B3-9341-3726-3D2D-4A60FDE5D70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1" creationId="{9BCC1422-4F5D-2697-4198-ABFBCDD805F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2" creationId="{CEE6215C-3719-4214-9232-532D9D52BB1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3" creationId="{4D1BDB77-DE61-0681-ADD3-1E49584F9A25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4" creationId="{D65C9379-3CE6-D704-E0C8-6BDB1DE081F4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5" creationId="{CDAE6D42-3EA5-BB66-F30D-A4CBA45B0F1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6" creationId="{9643E495-5DC0-E97B-9A98-8599F0A2C68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7" creationId="{0EF11CF9-56A4-80FB-F21B-96689DF23CB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8" creationId="{D36AE8D2-59AD-6544-EA2C-22992652916B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99" creationId="{03875E36-6CF6-6475-B7B8-95101797A53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0" creationId="{8DD9B0A4-DF65-D651-C2E5-B0478D37F4C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1" creationId="{46B89A46-22E4-ABAA-7FD5-682D2AE67D6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2" creationId="{26D80296-0F8A-B160-53A4-28C617363D8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3" creationId="{556506E5-D875-1982-C435-A8863367C4AC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4" creationId="{62C8445D-9F1E-695E-78A8-3CA90FB57453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5" creationId="{07D6AA25-0B11-D11C-7943-3B19F0C453BF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6" creationId="{E6BF0AF2-0586-9ABE-D39A-624A82D2B33B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7" creationId="{5C5C0048-2ED5-7EE9-3D29-5C8863117FFB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8" creationId="{428E6F05-3CAE-FFB5-700B-86ABD6E7895D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09" creationId="{7FA1B4D3-ED47-0686-2049-8DCED59D3F32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0" creationId="{6DFC06FC-4236-0686-6879-5FB9F196479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1" creationId="{6920FAAD-2D3A-1392-7268-CCEE97BABEA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2" creationId="{A7C3030B-9A8F-B417-3088-9200C4B0D461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3" creationId="{2FBD89F6-BCB9-6E1D-B59D-55B2CA8516C0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4" creationId="{C95D3B98-2B7C-33DD-0DAE-ABD5742AEF7A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5" creationId="{123D945A-CD69-BA43-3F7D-94598BB256C9}"/>
          </ac:spMkLst>
        </pc:spChg>
        <pc:spChg chg="add mod">
          <ac:chgData name="Nikolaj Juul Nitschke" userId="eb944128-ea9e-41a1-979a-ca9bb959a91e" providerId="ADAL" clId="{6AFE4E9F-5EB9-4CE6-9784-903788AE6242}" dt="2025-03-28T08:36:08.851" v="9" actId="164"/>
          <ac:spMkLst>
            <pc:docMk/>
            <pc:sldMk cId="1848100295" sldId="268"/>
            <ac:spMk id="116" creationId="{167BE0D2-B02C-7AB6-41F8-3E6645D9AF1D}"/>
          </ac:spMkLst>
        </pc:spChg>
        <pc:grpChg chg="add mod">
          <ac:chgData name="Nikolaj Juul Nitschke" userId="eb944128-ea9e-41a1-979a-ca9bb959a91e" providerId="ADAL" clId="{6AFE4E9F-5EB9-4CE6-9784-903788AE6242}" dt="2025-03-28T08:36:18.451" v="18" actId="14100"/>
          <ac:grpSpMkLst>
            <pc:docMk/>
            <pc:sldMk cId="1848100295" sldId="268"/>
            <ac:grpSpMk id="117" creationId="{0959BB71-435F-35BB-A78A-52E5DB9F164F}"/>
          </ac:grpSpMkLst>
        </pc:grpChg>
      </pc:sldChg>
      <pc:sldChg chg="addSp delSp modSp new mod ord">
        <pc:chgData name="Nikolaj Juul Nitschke" userId="eb944128-ea9e-41a1-979a-ca9bb959a91e" providerId="ADAL" clId="{6AFE4E9F-5EB9-4CE6-9784-903788AE6242}" dt="2025-03-28T08:47:36.859" v="149"/>
        <pc:sldMkLst>
          <pc:docMk/>
          <pc:sldMk cId="679851506" sldId="269"/>
        </pc:sldMkLst>
        <pc:spChg chg="del">
          <ac:chgData name="Nikolaj Juul Nitschke" userId="eb944128-ea9e-41a1-979a-ca9bb959a91e" providerId="ADAL" clId="{6AFE4E9F-5EB9-4CE6-9784-903788AE6242}" dt="2025-03-28T08:43:05.763" v="99" actId="478"/>
          <ac:spMkLst>
            <pc:docMk/>
            <pc:sldMk cId="679851506" sldId="269"/>
            <ac:spMk id="2" creationId="{41F58C76-9047-7881-3EEA-A08E99DBD9A4}"/>
          </ac:spMkLst>
        </pc:spChg>
        <pc:spChg chg="del">
          <ac:chgData name="Nikolaj Juul Nitschke" userId="eb944128-ea9e-41a1-979a-ca9bb959a91e" providerId="ADAL" clId="{6AFE4E9F-5EB9-4CE6-9784-903788AE6242}" dt="2025-03-28T08:43:08.260" v="100" actId="478"/>
          <ac:spMkLst>
            <pc:docMk/>
            <pc:sldMk cId="679851506" sldId="269"/>
            <ac:spMk id="3" creationId="{B29C4706-D4BF-578A-87ED-D426D8A83EA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" creationId="{E65A8937-5F01-BE07-9E19-6FF5070AB4F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" creationId="{55A08BF5-B490-9EFC-3DD3-81F93A47506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" creationId="{179EF35A-973B-46E1-8219-EB25563C3954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" creationId="{F5A8377E-DA4E-A0FE-0B4A-C2DC5080BF6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" creationId="{8EF37E75-5559-1EEA-9B78-813DBB2DDDB7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" creationId="{B939F8E2-87C0-3935-787F-F01CE975551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" creationId="{24CDD7F8-A882-B8D8-1316-A93D87F0ED3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" creationId="{9649DCC2-3C04-A215-83BF-C819882DB5B8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" creationId="{AF142AE2-6220-1B8C-3211-E5C16533E4EF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" creationId="{21B7B86C-7774-02C9-B8D8-87AF862C4481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" creationId="{A4168950-3419-9112-CB03-049AF21469C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" creationId="{94AC4C04-7CF1-090D-D017-DAB1927EA22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" creationId="{F60BD5A2-4E59-A2F1-D07F-8B814DE5F20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" creationId="{5C08B8E2-531C-3376-9A53-2BE0E47B7BE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" creationId="{7C5B744F-CAFE-89E8-4D1D-C0F8D129DBF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" creationId="{C3698835-1F31-C62E-4574-F7C5657BCF6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" creationId="{0848437D-9DB6-AEEB-53BD-79A10A036A0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" creationId="{F99CFE71-FFA0-25F4-8C7B-A1B3FD4FA2D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" creationId="{5913A586-C983-B9DC-6D08-A2326460554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3" creationId="{EFFC02CB-2B01-8124-E0A9-4EDEB1C082E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4" creationId="{2529FBDD-27F0-2EDD-1173-141779BAA21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5" creationId="{1BD04BEE-3A94-47DC-A563-E43C2453699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6" creationId="{DE8BDF88-6E5E-AF3B-9016-119BAFA990B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7" creationId="{6A18FD04-D3E6-C2A1-FB68-55A47EA498B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8" creationId="{3CC2C058-ADEB-DA34-2C77-390FE3AC69C2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" creationId="{17F384B3-9A6F-4290-07FD-ACA8DA1FC877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0" creationId="{C7D0FB6D-B325-CD29-911A-7657FBCCE2D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1" creationId="{66D532EA-7C1E-F842-3AB7-62F85D9AE25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" creationId="{D37BD3B2-A691-9CC2-AB2A-D2A692F680C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" creationId="{F73E133A-67D2-DFBD-329A-EF47CB63190F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" creationId="{85B12527-A990-1AF2-CE53-68BA0B6E442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" creationId="{2FBC0479-D375-4C68-7738-E65BF689BA0C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" creationId="{4874073A-1C99-59FE-2167-4F2E030ECD24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" creationId="{1A454102-9393-7365-5316-F1D5F8E9270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" creationId="{92983141-E78D-7FA3-3AC2-689B799B237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" creationId="{7A8A5DC8-2CA4-6125-F186-63331B5CD33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" creationId="{10ED6675-65A3-2319-D41B-984776308309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1" creationId="{868904E5-33B8-F768-5FD0-FBD3B0519B3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2" creationId="{7D4ABE74-011B-A3A7-5D2A-D5CF6E0ABE97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3" creationId="{0377D8AD-D925-14B0-C55E-5D833920293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4" creationId="{A70CC61C-E732-C207-E40B-251B73DB8A0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5" creationId="{6A7338C3-645E-EDF4-C82F-D0995DE26E2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6" creationId="{F0F77C28-6AFA-4D70-6FF3-4E2AE0FFDE8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7" creationId="{B4DDE4C8-8394-F810-26E5-C0B2B1676F5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8" creationId="{450C0BD7-7385-A6E8-53CE-A6571E67428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9" creationId="{85B3E9B5-D538-29BF-CD7C-22E6C7F0594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" creationId="{8CE9A9A7-7D79-5AF3-048F-2DA372AC2C3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" creationId="{E58F8A6D-FD4C-DBBF-8C92-13F1000340E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" creationId="{E8C47718-4BB3-74FC-6945-B0838C5B3E0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" creationId="{9E093EAD-14FE-D385-DCA3-1077402E8B3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" creationId="{5C6B43E7-13EB-9340-9D8C-2E2DAD3E0C5F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" creationId="{9C4F11E1-586B-6B93-845A-C62AAFA0C06E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" creationId="{393B6FCB-626E-1C35-D995-EBF4E3F1911B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" creationId="{F7080F3C-F9CD-C833-4362-B6237A091426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" creationId="{AF063CDB-BF0B-891A-E589-24D9D5E98C4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" creationId="{859C2A21-C1C9-4CF3-6149-6DE7C9D53BAC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0" creationId="{B83074FB-B361-64F6-559A-08BCDE0D8FD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1" creationId="{D70AEE48-9720-C172-FB87-079011B9EB3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2" creationId="{FCAC66AF-BC6E-6189-21E7-DD142D09B69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3" creationId="{3AFBC556-77EA-ABE6-9DD2-F13FDB656661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4" creationId="{DB39258E-F39A-A33E-538F-8BE2E783772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5" creationId="{9D9AE87F-C86D-A28A-E3FB-2104E349D2C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6" creationId="{2CACC4C3-114A-8191-3F60-5482D3E77BD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7" creationId="{872EBC6E-5827-A0A6-2644-258C662EF42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8" creationId="{A246DC9A-950F-6B61-858B-AFCC1657303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9" creationId="{FC9E4868-4C89-4740-7FCF-045887B54F9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0" creationId="{9FB6904B-8ECF-F747-04BE-29D2B462D00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1" creationId="{F358CDEF-D5C7-6711-8580-3351D0E8EE1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2" creationId="{5AB5A549-2490-0D20-39BD-16763BCF180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3" creationId="{3297D730-EF60-1E82-831A-AEA44475798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4" creationId="{9BC4F640-1C24-AF21-0E5F-249057402A5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5" creationId="{598DE686-163B-5CD4-656D-AC3EEF4031D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6" creationId="{6C9A2577-3E8B-9AF4-2238-91C7CDB217E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7" creationId="{D520288D-4E99-F119-6DC6-F2061FB607C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8" creationId="{3C970F7D-B2D2-17EA-F918-57EC9B211A7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79" creationId="{E0EDD7D3-B31B-71F6-F6BF-1922FEAD776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0" creationId="{C90EE00A-C495-6608-0341-EFF6D27F674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1" creationId="{4D89E1BC-BB35-5F0B-F0FE-9283D1F8E1D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2" creationId="{E871E8C2-B193-6967-A163-2354BC22FAE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3" creationId="{31BE8B61-730A-62E8-5F84-FFB58E0A081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4" creationId="{D15475B0-7438-DE25-C329-3129B09E9A2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5" creationId="{C71B19B0-57B0-C484-DB55-63B6D4AF9BB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6" creationId="{7108E21C-019C-DCAB-3AA4-384564709451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7" creationId="{F5DCE718-7301-3A2E-39E7-32283E60F39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8" creationId="{39409274-7E24-A9CE-6A14-0125E8AD28F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89" creationId="{5CE751F6-72D1-4F3E-CFD0-346CAF31837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0" creationId="{32C8E8EC-2FFD-C811-31AB-5763B9EB4C9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1" creationId="{701A641B-3B58-DF0A-F759-334A900B347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2" creationId="{C5AC047B-F3DC-827B-E369-A1C175C0DEE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3" creationId="{B72F2F06-0BC1-CEEF-673C-B4B7D2444AF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4" creationId="{BD7243C1-FA7E-7255-E153-ECEC6392229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5" creationId="{72024181-D4FA-BE33-4AA5-219AC53645C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6" creationId="{AA76988A-037B-83B2-C11A-D554B786EDB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7" creationId="{83AB39EC-F5E7-6445-8A57-8BF46F45A39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8" creationId="{D616B791-907D-F280-A22F-2541450ED42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99" creationId="{6B48E6A4-D284-7375-9429-26D7004DE12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0" creationId="{45F948FD-B3D2-511B-3545-8FF5265A03A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1" creationId="{B37089CE-F3B7-25B1-92E4-D6D304020A7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2" creationId="{CB131DBE-8ACC-C5C0-B602-1EFB32E3CA9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3" creationId="{31877795-A9B1-DE5B-59A4-B557DE659BE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4" creationId="{F23717E3-64D8-F009-E402-7F57AD181B8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5" creationId="{E4804F21-4428-DBA5-A7D2-CC14FC1F036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6" creationId="{BAD58CE4-74BA-6471-1D9A-9B4D2794B37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7" creationId="{7E0450CF-1B28-67C4-6CD7-540EA8A0546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8" creationId="{461CDC69-492B-FCA0-7C7C-95F0F2FBD4C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09" creationId="{23B536AD-386D-4E53-29B1-3AC6D5F53D0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0" creationId="{2EC2BD9B-40FC-D7D8-5340-B0429DEA341B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1" creationId="{AF71C2E3-F1EA-ED2C-AA2B-6C2FD184C352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2" creationId="{EB931D54-BA7C-9647-A25D-A2851D8654B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3" creationId="{F1D59466-4662-5FE0-6B88-AA38602C87AB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4" creationId="{BA1516E1-F311-65AA-46F1-AE61CD2A60C4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5" creationId="{77FF31E2-35D2-7CC4-F863-DD4CC157A98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6" creationId="{0541654D-D0E3-B5A7-64D5-34792A716F2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7" creationId="{02D2FD7F-05A9-6ACB-5F18-B7303BB5140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8" creationId="{DBF05FEE-9CFD-D731-4658-8DE2F3215B5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19" creationId="{39F4F72B-E7AD-C015-678A-C025F61D06B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0" creationId="{D183DFEF-5BFF-3F3B-F10A-EEE84CCA038B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1" creationId="{EDA60ECC-F0A8-4A27-57BE-7329AF04D96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2" creationId="{E3C24F39-2978-858E-F3D9-6B62CE4FA4A8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3" creationId="{BC5B9C03-A2B4-B981-E269-70557881627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4" creationId="{43B3950C-5B56-2F7A-75B7-F9ADB2E2BB93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5" creationId="{B01FE5C3-DD1D-39F8-56DB-BC0DCCF1594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6" creationId="{38C7BC2A-5327-E8E0-40B3-D1281FE222D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7" creationId="{73280919-290D-84D4-ADAC-67EEE225172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8" creationId="{2213190D-B5AB-182E-6312-1258C55522A9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29" creationId="{BC5084C6-A592-8CCC-6ADD-20A7C9747A4B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0" creationId="{2376D51E-CEB6-A915-2279-D78E614A91E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1" creationId="{95879DB1-485A-DE35-A1B2-A95EF2C8ECD2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2" creationId="{C7D529E8-3F23-3C82-3076-6EC14B9B826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3" creationId="{ABFCC33D-BE38-5301-317E-B54920D4A0D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4" creationId="{6B555BF6-0D97-7AEB-4B2B-0CACADB70D8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5" creationId="{F3D57667-5BAB-CD2C-9B0D-4FE1D9834B2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6" creationId="{3C5FE259-6AE4-EFB4-A6B1-0AA06E4C71C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7" creationId="{DCA8D56D-6B76-B6E9-4F74-A9304EA5A98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8" creationId="{345C0580-CB2F-54BA-3C80-41285324E09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39" creationId="{3C8B6378-A40C-CE28-B22D-011A644A896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0" creationId="{0D838CC1-A0E0-E160-5225-66CF30B0140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1" creationId="{1A2464A7-CB8B-B3C8-1ED2-DFEE024EE45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2" creationId="{ABB9CE00-1CFD-5DA2-FAB2-35662E6E3F7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3" creationId="{EE9EC47D-E0C9-3E2B-0FAC-B834AFC0250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4" creationId="{791EA7D7-5F31-E4F0-7885-81C3656B2B3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5" creationId="{80C13D45-412B-43E0-520F-493E416C4B4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6" creationId="{455328FC-A2D0-8CD4-8CBE-ADECC3A081E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7" creationId="{2EF44EA2-9B83-05BA-06C3-11476957830E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8" creationId="{1C21D757-9B17-FF17-5ABE-808287EF0BF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49" creationId="{965660F0-40D5-8760-848A-662A520D461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0" creationId="{5C39EE1E-D97B-FD7A-362C-BE77BDA85F6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1" creationId="{2712F97B-46B8-A983-5702-FA8F933E323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2" creationId="{D6986C84-6872-778F-F39A-D9F135B8BF0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3" creationId="{1510A660-7680-BAF8-4247-BAE9F43D2B3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4" creationId="{9986E56B-B93B-5ED7-E96F-24909750F2B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5" creationId="{C7047052-081C-2B39-C5B3-5C08477E0EC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6" creationId="{C8A00390-0650-BE88-FF7A-1BC9A72566D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7" creationId="{51C224C0-DFC1-BC84-E082-387F8658DA2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8" creationId="{BB37C27F-4A8C-92E0-48D3-593DD1A4C10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59" creationId="{987FB2BF-A14C-C36A-9D47-5007E292863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0" creationId="{6FA696A6-2EF0-D687-2111-2B56ECFD457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1" creationId="{CEFB0789-FAD6-4878-5689-9721112F669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2" creationId="{699C31BB-0805-942D-6161-0D8D70DBEB7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3" creationId="{1E8852E5-E088-81BE-DC0A-C9E2022ED4F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4" creationId="{82EF433B-37DD-9B19-3657-0233F0D38E1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5" creationId="{0CB1BFD6-876A-B1DF-7978-B12B8F76170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6" creationId="{BCC4B777-AA5F-78ED-414E-74F85587765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7" creationId="{75319980-DCD7-6CF8-D70F-74121B8A7FD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8" creationId="{9C586CFA-3013-9AE7-530B-2A614711B15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69" creationId="{F1AD40AC-4029-84F0-7300-B28392901E8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0" creationId="{99AED368-96EA-9EDD-8993-C60A7158737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1" creationId="{6CCB2BA7-5D4D-3F35-09D1-0FF0726BEEB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2" creationId="{FB1D7067-683B-7365-8BB1-4E0160A3346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3" creationId="{37AD7B5D-6398-D2DD-AB63-D91252EE768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4" creationId="{3DE2E082-11B5-8B41-62E6-29940D895AFF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5" creationId="{FA880A31-3DAF-CA9B-9405-FC98EC4B336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6" creationId="{5F560E9A-0B77-41BF-C4F2-EAC0E181685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7" creationId="{5B0B2DDB-DD38-DFB7-321A-559CE298751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8" creationId="{741CF1B6-6547-8E3E-5346-8F30E7F26B04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79" creationId="{7979AAB3-0469-3214-0C71-26CA8F43A4A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0" creationId="{FD2E7362-79A9-B47A-7656-3B671360DEA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1" creationId="{8D312B2B-29EC-BBEC-CC9C-963AD58A551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2" creationId="{78E4811B-ADD2-E750-92DE-FAF4894658D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3" creationId="{AEF7758F-1D50-4CAB-5FD4-53321DAE6AC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4" creationId="{70F0128C-3738-F39E-9378-B9F3AAF1905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5" creationId="{D6CDA378-F1BC-17FF-CC4D-92DBB939CD2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6" creationId="{C0488F09-EE07-9F27-BF28-4B0A236A473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7" creationId="{ABAE9084-AA47-1C21-98F5-11AFE4873861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8" creationId="{8937FEFE-4201-7E6D-A17F-7C078B90B36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89" creationId="{58AF5752-F275-DC0C-477B-B93C7FB3562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0" creationId="{D9BBED79-D2BE-38AC-A271-5D4B0FB2FF2B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1" creationId="{1E757509-D3B8-7BC2-5199-A325D1315DD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2" creationId="{D903B3E7-BD57-BDB5-4BB8-12C70018C28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3" creationId="{379A6AE9-8C98-05C9-1BAC-A2C3004C17F7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194" creationId="{7FFE0EC1-4D5A-4BF9-295B-30212789B5DE}"/>
          </ac:spMkLst>
        </pc:spChg>
        <pc:spChg chg="add mod">
          <ac:chgData name="Nikolaj Juul Nitschke" userId="eb944128-ea9e-41a1-979a-ca9bb959a91e" providerId="ADAL" clId="{6AFE4E9F-5EB9-4CE6-9784-903788AE6242}" dt="2025-03-28T08:46:20.570" v="134" actId="1076"/>
          <ac:spMkLst>
            <pc:docMk/>
            <pc:sldMk cId="679851506" sldId="269"/>
            <ac:spMk id="195" creationId="{A5EFF95E-EC24-35FF-547F-5534B43EF683}"/>
          </ac:spMkLst>
        </pc:spChg>
        <pc:spChg chg="add del mod">
          <ac:chgData name="Nikolaj Juul Nitschke" userId="eb944128-ea9e-41a1-979a-ca9bb959a91e" providerId="ADAL" clId="{6AFE4E9F-5EB9-4CE6-9784-903788AE6242}" dt="2025-03-28T08:46:23.610" v="135" actId="1076"/>
          <ac:spMkLst>
            <pc:docMk/>
            <pc:sldMk cId="679851506" sldId="269"/>
            <ac:spMk id="196" creationId="{EF6AC9EE-6856-3296-1DC5-7573FB88A83C}"/>
          </ac:spMkLst>
        </pc:spChg>
        <pc:spChg chg="add mod">
          <ac:chgData name="Nikolaj Juul Nitschke" userId="eb944128-ea9e-41a1-979a-ca9bb959a91e" providerId="ADAL" clId="{6AFE4E9F-5EB9-4CE6-9784-903788AE6242}" dt="2025-03-28T08:46:28.853" v="136" actId="1076"/>
          <ac:spMkLst>
            <pc:docMk/>
            <pc:sldMk cId="679851506" sldId="269"/>
            <ac:spMk id="197" creationId="{8ACE3A23-5000-83F5-86E5-F2C557E26CBD}"/>
          </ac:spMkLst>
        </pc:spChg>
        <pc:spChg chg="add mod">
          <ac:chgData name="Nikolaj Juul Nitschke" userId="eb944128-ea9e-41a1-979a-ca9bb959a91e" providerId="ADAL" clId="{6AFE4E9F-5EB9-4CE6-9784-903788AE6242}" dt="2025-03-28T08:46:33.060" v="137" actId="1076"/>
          <ac:spMkLst>
            <pc:docMk/>
            <pc:sldMk cId="679851506" sldId="269"/>
            <ac:spMk id="198" creationId="{C2077E5D-139C-2854-641E-10B253131AF5}"/>
          </ac:spMkLst>
        </pc:spChg>
        <pc:spChg chg="add mod">
          <ac:chgData name="Nikolaj Juul Nitschke" userId="eb944128-ea9e-41a1-979a-ca9bb959a91e" providerId="ADAL" clId="{6AFE4E9F-5EB9-4CE6-9784-903788AE6242}" dt="2025-03-28T08:46:35.317" v="138" actId="1076"/>
          <ac:spMkLst>
            <pc:docMk/>
            <pc:sldMk cId="679851506" sldId="269"/>
            <ac:spMk id="199" creationId="{1DA4F67B-3F17-C935-AB33-B98E7ED6872C}"/>
          </ac:spMkLst>
        </pc:spChg>
        <pc:spChg chg="add del mod">
          <ac:chgData name="Nikolaj Juul Nitschke" userId="eb944128-ea9e-41a1-979a-ca9bb959a91e" providerId="ADAL" clId="{6AFE4E9F-5EB9-4CE6-9784-903788AE6242}" dt="2025-03-28T08:46:20.570" v="134" actId="1076"/>
          <ac:spMkLst>
            <pc:docMk/>
            <pc:sldMk cId="679851506" sldId="269"/>
            <ac:spMk id="200" creationId="{1C444F55-888E-2921-544F-F8E05315E3FD}"/>
          </ac:spMkLst>
        </pc:spChg>
        <pc:spChg chg="add mod">
          <ac:chgData name="Nikolaj Juul Nitschke" userId="eb944128-ea9e-41a1-979a-ca9bb959a91e" providerId="ADAL" clId="{6AFE4E9F-5EB9-4CE6-9784-903788AE6242}" dt="2025-03-28T08:46:20.570" v="134" actId="1076"/>
          <ac:spMkLst>
            <pc:docMk/>
            <pc:sldMk cId="679851506" sldId="269"/>
            <ac:spMk id="201" creationId="{F75CA7AE-C9A5-495F-617C-80B4BB183BAC}"/>
          </ac:spMkLst>
        </pc:spChg>
        <pc:spChg chg="add mod">
          <ac:chgData name="Nikolaj Juul Nitschke" userId="eb944128-ea9e-41a1-979a-ca9bb959a91e" providerId="ADAL" clId="{6AFE4E9F-5EB9-4CE6-9784-903788AE6242}" dt="2025-03-28T08:46:20.570" v="134" actId="1076"/>
          <ac:spMkLst>
            <pc:docMk/>
            <pc:sldMk cId="679851506" sldId="269"/>
            <ac:spMk id="202" creationId="{D3E3BC61-C2D7-DE27-21D7-3630508FC9C1}"/>
          </ac:spMkLst>
        </pc:spChg>
        <pc:spChg chg="add mod">
          <ac:chgData name="Nikolaj Juul Nitschke" userId="eb944128-ea9e-41a1-979a-ca9bb959a91e" providerId="ADAL" clId="{6AFE4E9F-5EB9-4CE6-9784-903788AE6242}" dt="2025-03-28T08:46:20.570" v="134" actId="1076"/>
          <ac:spMkLst>
            <pc:docMk/>
            <pc:sldMk cId="679851506" sldId="269"/>
            <ac:spMk id="203" creationId="{B6685638-37ED-9F95-889A-24D65B9EC13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4" creationId="{19BAD7B6-AB5B-11E2-7E6A-85B2A0327824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5" creationId="{DD4BEAF0-1079-50E6-B5B9-72FAC09E60F1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6" creationId="{018B1D35-0C06-006A-2107-C61DA078200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7" creationId="{52FC3348-FA02-8C2C-DA90-57F74FE21D5D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8" creationId="{82D4FFD7-9C2F-5EAF-2128-F35A2CA5FCF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09" creationId="{7926DD15-2671-013A-FE9C-230EBBE3C4E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0" creationId="{2845B4C1-9696-8DE7-6C49-35407A4277C5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1" creationId="{AACED820-C789-BF56-3750-90706799C65C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2" creationId="{2F5E94C8-A401-80F2-E018-0087B2BC3AE6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3" creationId="{0BD591B1-ADD5-935E-EE4B-C2FB96872CC3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4" creationId="{305E84FA-1E63-EE35-C78B-1701D6990436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5" creationId="{92977A40-51CE-07E5-5E05-8C21831952EE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6" creationId="{3539CF09-55B7-B926-F90F-223D4AA632E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7" creationId="{1D3FDC0E-89D8-176A-01D2-5502E83C0092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8" creationId="{CBCD4B85-4D57-FE77-2893-71E2246E225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19" creationId="{85A17AC2-4226-E0DE-09DE-9BDA1DC7D92A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0" creationId="{1BF6BE4F-6B28-4F73-923C-556389D9DB26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1" creationId="{CC8155C0-FC75-B2B7-C344-879710259AB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2" creationId="{576391F2-1CBC-1D76-AFD7-9733B830AB49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3" creationId="{190CDC63-AFF7-A552-41C3-FB124C31C623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4" creationId="{421AA276-0AC2-231C-4133-028299FEAA1D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5" creationId="{513F6D92-4729-0594-DC56-DC02EF260921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6" creationId="{D75ACEE1-36ED-7A2B-67FF-0CFAEEA54B58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7" creationId="{6E55BFE5-D2B8-9AEA-C20D-8DC428B6E3F0}"/>
          </ac:spMkLst>
        </pc:spChg>
        <pc:spChg chg="add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28" creationId="{33A28EA8-FC6B-1BAD-08AA-27BE14CD9653}"/>
          </ac:spMkLst>
        </pc:spChg>
        <pc:spChg chg="add mod">
          <ac:chgData name="Nikolaj Juul Nitschke" userId="eb944128-ea9e-41a1-979a-ca9bb959a91e" providerId="ADAL" clId="{6AFE4E9F-5EB9-4CE6-9784-903788AE6242}" dt="2025-03-28T08:47:30.795" v="147" actId="1076"/>
          <ac:spMkLst>
            <pc:docMk/>
            <pc:sldMk cId="679851506" sldId="269"/>
            <ac:spMk id="229" creationId="{C7D8B09A-4696-E9E7-C699-05FA883271AD}"/>
          </ac:spMkLst>
        </pc:spChg>
        <pc:spChg chg="add del mod">
          <ac:chgData name="Nikolaj Juul Nitschke" userId="eb944128-ea9e-41a1-979a-ca9bb959a91e" providerId="ADAL" clId="{6AFE4E9F-5EB9-4CE6-9784-903788AE6242}" dt="2025-03-28T08:37:33.932" v="30" actId="478"/>
          <ac:spMkLst>
            <pc:docMk/>
            <pc:sldMk cId="679851506" sldId="269"/>
            <ac:spMk id="230" creationId="{314B6C3A-7F7B-9652-BA71-0A604722FE8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0" creationId="{C0FEA6D9-39AE-92C2-0473-8DFC04DD8FD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1" creationId="{12605B04-7B42-241C-DC7C-DE2307746C7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2" creationId="{41CA72DB-52C2-0D42-7C8D-6F31BDF8AF5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2" creationId="{EFE79D54-FB0C-036F-7911-C24B29CDD6FD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3" creationId="{2FDB3954-F316-C1BB-65E1-585CF6B7765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3" creationId="{B2401549-85AC-19EE-F451-BB338C3E79B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4" creationId="{3FBFC07A-155A-A4E6-74AC-7129AEC44CD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4" creationId="{4C0601CD-0D0E-41FD-3E5D-3F39D33C8802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5" creationId="{0AE9B746-9A87-873B-C43B-D9D61A2A9C5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5" creationId="{C6A49CB5-3AA2-0E13-D5D4-D05CCCC1F08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6" creationId="{535E9F3A-82D8-A34F-E733-B3FCBABEA37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6" creationId="{C7112291-6023-74FF-0863-3FC2CF270B1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7" creationId="{B9C24AC9-97BF-ED48-D127-C452A65CF52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7" creationId="{F824C55E-D39E-3A6D-F884-F541BC90302A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8" creationId="{1282C485-178D-EB11-E076-D0BA0ABA481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8" creationId="{EDB3AD1B-B87C-3DA0-3594-3076DF8AD0D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39" creationId="{5EDCDAC3-0BDC-2016-E39D-38F2BAE86B02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39" creationId="{D755B683-6B3D-54A1-3DC1-5EC29C35586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0" creationId="{65DADBF4-5CF5-4EA4-9DBA-5906C1C736C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0" creationId="{9451D361-2936-B447-0520-BD071C4662B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1" creationId="{43E060C7-10FC-8527-21C2-AAABF131FD47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1" creationId="{4DD19CB0-128E-E930-FBB3-C711D174373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2" creationId="{5506A9B9-F8D9-CCDC-964C-2BFE1411D6A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2" creationId="{FE1F0E7A-DFBA-34B0-62AE-C892D1BD982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3" creationId="{108B4E39-6902-BE41-DAFB-2D251FC4D9A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3" creationId="{1F9BF836-8D11-DA9D-CFC8-818126150BF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4" creationId="{6B032342-418B-FF06-2310-641BF74BDD06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4" creationId="{9398471B-0389-140C-010E-BCD462263B7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5" creationId="{4DA1FF3C-B23F-981C-2D22-90DCB4ADF4A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5" creationId="{B5106EE0-38AC-7039-A5E6-DEEDC4B1F6F8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6" creationId="{47EF2EC7-C6E1-870B-59BA-E7240AEDE46E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6" creationId="{E43C31C2-9B69-DF83-7D58-3B1D6C7E162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7" creationId="{147027B1-40B4-3B43-D886-CF3C1558C55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7" creationId="{74BA4F07-9645-7A55-E36D-49CD29B4606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8" creationId="{030549A6-5C1E-BB36-ADB9-A5602FF3E6CC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8" creationId="{77815462-11EA-C9F6-9886-9F024209AC5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49" creationId="{F33575D4-9021-4CB6-246B-02B8DC040DB7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49" creationId="{FC78596B-9436-FA80-F81E-627526AB8BA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0" creationId="{0AF16BD6-B39E-97CB-038B-470576D6E202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0" creationId="{F1DED5E9-F237-A3DD-04EB-59930BD50F2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1" creationId="{042D6937-AC99-E281-609C-D153B5DA9CD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1" creationId="{D8B2AD78-4FF7-F138-F0D9-65636C05AAD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2" creationId="{086AA43B-94EE-3998-B57B-377057B9479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2" creationId="{B04143D3-9159-31E3-8ED2-DA2D4181935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3" creationId="{528CFF5A-2C5C-D131-E75D-BC478859DA2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3" creationId="{ACC793F5-3ECA-5F54-6D3B-F4DBE45A9D7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4" creationId="{8CB7AEE6-CB49-F586-D3BB-C6A2C307D53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4" creationId="{DBF277A4-EFA0-AC32-4EEA-4186BE938AE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55" creationId="{15D34D2F-0F7E-FD7A-70BB-754BEF3E1E7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5" creationId="{BA3DF0F8-F515-60CB-BB29-4141D617924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6" creationId="{FB517E18-2A0D-4547-D897-21443EDA6F1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7" creationId="{48B090A7-E390-B12F-D9E2-6FBE1294428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8" creationId="{3BDF97B2-0256-A38F-9DA0-03FFC6BCE28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59" creationId="{FDE60268-C4E7-D4DD-32EA-132CD918E94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0" creationId="{F8DF6C52-B535-B906-A2C0-3F95E304402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1" creationId="{E0C44C12-1456-C9C1-8EA3-BB813786A9BC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2" creationId="{77B3FDBB-2A4D-B4F1-0226-D47AF682DD84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3" creationId="{63C81663-8F5C-C378-B73A-814955979DBE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4" creationId="{EE62A03A-04D7-83D9-F955-2BFD27FC9384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5" creationId="{14B5BF33-EEE7-EA99-821E-C62B421A0AB0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6" creationId="{51AFB389-40E3-6753-77B7-8BD3BCA4608D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7" creationId="{EA6D3FFE-F401-96E5-EDB4-233DC64978C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8" creationId="{2194AFDF-1193-E53B-5457-F0F105D43A5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69" creationId="{80E998B8-A7C7-CD17-6A99-6327DB8DB7D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0" creationId="{2D211721-43BE-7EC0-89E7-8DEDFCD67BFC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1" creationId="{08120A76-CB4F-B809-2A5D-B4B85E1403A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2" creationId="{F53396EB-71F5-7F95-8408-D8EB07A510DD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3" creationId="{772D6446-F3FE-49AD-1887-E2B6A6DBEEBB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4" creationId="{37C75747-2652-E7DC-5A02-C09180FB387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5" creationId="{6C3B8960-2DD8-A8AA-EB95-B4DE9FF7D52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6" creationId="{9BBA40B0-676A-53E2-2573-69F890E4BF5A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7" creationId="{EE4DA5E8-6DA5-1829-202C-8BFE004B3BB4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8" creationId="{F18EF63E-BBF0-611C-30AE-5DDE520F087E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79" creationId="{BE708569-98EB-C184-407D-CE6868B7BB0B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0" creationId="{08ACA3E3-359C-CA8D-D4F1-F9536F6FC9A3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1" creationId="{0F1482C2-F803-A1A0-6177-CA003E3BFF8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2" creationId="{7A7092B3-689F-270C-21B9-1A710E54A53E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3" creationId="{0094910B-3799-392E-47E0-77410865C56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4" creationId="{55298A58-995A-C475-3708-A8B526F78783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5" creationId="{E553E1B6-DE44-E0A3-A89D-506CD4AF9E0C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6" creationId="{1D3774C0-4A83-2214-D193-C494443FAD8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7" creationId="{0078D738-C01E-8401-B5B2-05059C0037A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88" creationId="{65D0F707-B7E5-B8E0-CA84-4DC5FCE6BCC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8" creationId="{91E5D753-16F1-5BCF-513D-1122752CAE7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89" creationId="{69D5A2C9-1F07-9486-22A3-991319DAFE08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89" creationId="{DEDBB6EF-4186-6147-04D2-553096A59EF0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0" creationId="{FC829DC8-984F-16B0-3E3B-E41BC193EED9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1" creationId="{452F7412-8942-0AD6-2AF8-446A3D3DD77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2" creationId="{8AA216BC-A9A2-4195-474B-B4227973C8F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3" creationId="{3AD2D06B-AD6C-1D94-7AB1-6DEC8A3BD025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4" creationId="{4106D294-66F4-85F5-2475-F014399CAAE1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5" creationId="{201FBA97-119F-6FAA-3883-B2669DA1C757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6" creationId="{BB036E99-C444-76B4-6CDB-72611EE6D982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7" creationId="{621E4FDE-FBCC-7259-29E8-039E5971E6B6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298" creationId="{EDE12553-818C-558A-A305-827F41FDC8B4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299" creationId="{3B728C80-5F14-13D0-7364-B2AE5745A5D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299" creationId="{C47883CE-8A25-17F2-43CB-BAD04777087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0" creationId="{9846F495-E951-D7FB-6A73-A021A518282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0" creationId="{B1C24F87-C68F-409D-4E26-ACEA352E750B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1" creationId="{0B8023AE-8201-B940-EC87-43E8C6B973B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1" creationId="{87514F58-6941-3DFD-B26E-0D29D27EACF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2" creationId="{0B6E7E0D-9A88-BBE3-826A-CA7F5DCA969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2" creationId="{6E3F18A8-85B8-219F-D06E-8C1ECF08060F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3" creationId="{D792179A-C5BA-DB9D-85B4-13A6686DD9B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3" creationId="{FBF08EF1-D4CB-9F58-25E9-9265FEB3A58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4" creationId="{72316F24-710B-CDB0-0443-86DCA3BD276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4" creationId="{9C5ED89B-7D13-6723-AC71-D9B4F5859503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5" creationId="{36F12067-1E76-7664-010F-C7E27B4A56FE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5" creationId="{94A98298-A064-BC42-D49E-F5E83893304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6" creationId="{63EC45EA-DEF3-238F-3874-072B0D8221C6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6" creationId="{EDE33B64-2139-E47C-9879-F191BF014B0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7" creationId="{7CA0316F-714B-D8AA-ACA7-5271DD031F35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7" creationId="{DAA8BAF1-AEF1-AEE3-B1A2-E2F0E668056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8" creationId="{348A8BF3-201D-8B38-4712-978268F4FF2B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8" creationId="{B6100CE8-F49C-E894-349E-0EBE99FF23E9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09" creationId="{2608BE4F-9E36-4BB3-591F-C57F375F314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09" creationId="{3774DB7A-729F-6102-5D8B-55BD7F4E459A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10" creationId="{5C4E22AA-24B5-9932-4538-D3F3B4B448A8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10" creationId="{B54F58A8-B308-AFF5-79EC-39F52801B99D}"/>
          </ac:spMkLst>
        </pc:spChg>
        <pc:spChg chg="add del mod">
          <ac:chgData name="Nikolaj Juul Nitschke" userId="eb944128-ea9e-41a1-979a-ca9bb959a91e" providerId="ADAL" clId="{6AFE4E9F-5EB9-4CE6-9784-903788AE6242}" dt="2025-03-28T08:35:58.715" v="6" actId="478"/>
          <ac:spMkLst>
            <pc:docMk/>
            <pc:sldMk cId="679851506" sldId="269"/>
            <ac:spMk id="311" creationId="{52D7B60E-1033-8D46-F277-12E93B2C4FB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311" creationId="{AAB8A391-861B-72C0-BE6A-96BD2185362B}"/>
          </ac:spMkLst>
        </pc:spChg>
        <pc:spChg chg="add del mod">
          <ac:chgData name="Nikolaj Juul Nitschke" userId="eb944128-ea9e-41a1-979a-ca9bb959a91e" providerId="ADAL" clId="{6AFE4E9F-5EB9-4CE6-9784-903788AE6242}" dt="2025-03-28T08:37:27.267" v="26" actId="478"/>
          <ac:spMkLst>
            <pc:docMk/>
            <pc:sldMk cId="679851506" sldId="269"/>
            <ac:spMk id="312" creationId="{E0FC2B82-FEB9-89C9-043C-91A93D3171EE}"/>
          </ac:spMkLst>
        </pc:spChg>
        <pc:spChg chg="add del mod">
          <ac:chgData name="Nikolaj Juul Nitschke" userId="eb944128-ea9e-41a1-979a-ca9bb959a91e" providerId="ADAL" clId="{6AFE4E9F-5EB9-4CE6-9784-903788AE6242}" dt="2025-03-28T08:37:28.891" v="27" actId="478"/>
          <ac:spMkLst>
            <pc:docMk/>
            <pc:sldMk cId="679851506" sldId="269"/>
            <ac:spMk id="313" creationId="{1913BE2A-8D5C-995C-FFB4-C225F5ED60EB}"/>
          </ac:spMkLst>
        </pc:spChg>
        <pc:spChg chg="add del mod">
          <ac:chgData name="Nikolaj Juul Nitschke" userId="eb944128-ea9e-41a1-979a-ca9bb959a91e" providerId="ADAL" clId="{6AFE4E9F-5EB9-4CE6-9784-903788AE6242}" dt="2025-03-28T08:37:24.753" v="23" actId="478"/>
          <ac:spMkLst>
            <pc:docMk/>
            <pc:sldMk cId="679851506" sldId="269"/>
            <ac:spMk id="314" creationId="{2BA2DA36-338E-C43F-9792-263257256D9A}"/>
          </ac:spMkLst>
        </pc:spChg>
        <pc:spChg chg="add del 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15" creationId="{830A4F1F-666D-EB15-605B-ED9BEAE69FF8}"/>
          </ac:spMkLst>
        </pc:spChg>
        <pc:spChg chg="mod">
          <ac:chgData name="Nikolaj Juul Nitschke" userId="eb944128-ea9e-41a1-979a-ca9bb959a91e" providerId="ADAL" clId="{6AFE4E9F-5EB9-4CE6-9784-903788AE6242}" dt="2025-03-28T08:47:24.901" v="146" actId="1076"/>
          <ac:spMkLst>
            <pc:docMk/>
            <pc:sldMk cId="679851506" sldId="269"/>
            <ac:spMk id="317" creationId="{E48C0916-8547-A2BF-EE2B-56F51FFCCE6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18" creationId="{DCCC3150-6D5B-E06C-9B32-0F66AEFE094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19" creationId="{6F14A5CA-99AF-D1BD-58AD-C7BA32D8FA6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0" creationId="{12F2C28E-F097-E454-CC5C-CD1B99949D2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1" creationId="{CFDF742C-57B0-65E3-A260-9685D830180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2" creationId="{54A4DA78-004C-A0BE-52AD-5054EBDD077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3" creationId="{2C9024EE-BCE7-4EF5-BFB7-CC35E00DD07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4" creationId="{CD7054C5-607A-91DE-89E3-FD4CC95C1ED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5" creationId="{C9C6652E-BA4B-4B73-3B26-104ACA9C9FD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6" creationId="{00DEF8AD-F08A-ECF6-814D-05E01B92545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7" creationId="{5C1EBBA9-A0DD-1855-6767-357A47CA32C5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8" creationId="{C1881B2C-E3E0-3B11-A6CB-B78D7C733A71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29" creationId="{E2FAACE0-1225-D943-B459-0972514D79B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0" creationId="{5E943906-5A94-529A-8778-9F16CD64277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1" creationId="{FF244E89-D3BC-B489-863F-F1FF7393240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2" creationId="{CA06BFCD-BD08-C7BD-0A35-03CF39206DF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3" creationId="{8D0F7D50-158B-4F6C-E34E-188381330A1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4" creationId="{D4ACDB7F-3FED-42EF-07CA-D5E93B8269E0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5" creationId="{D7F55912-FBDB-6CB2-9318-3E440F6F101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6" creationId="{8664585E-408C-3436-C1BD-B1F7B496723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7" creationId="{76005D59-16D8-C190-B8EA-12CF6F3E86FC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8" creationId="{D6916E2C-6CD1-655C-C1D7-2ADAD8482DB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39" creationId="{A63A81BA-BA63-B42F-CB1B-47452777B325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0" creationId="{5FA8EB85-DD3B-AF0F-AC6F-097189824C5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1" creationId="{34DCE575-ECEF-813A-A526-670CA195A85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2" creationId="{0C0449A8-53EC-3929-F061-196C44F0E2A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3" creationId="{2A0937A0-90B3-7CD4-2BE0-70FA58C5692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4" creationId="{63A9C58F-C092-6254-AE37-7BB2131F97F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5" creationId="{E4D488CB-66ED-3F06-ED6E-4560E6A4EBC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6" creationId="{9FBF67D8-1D33-3CBB-2FD7-AB07A7E569E0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7" creationId="{5A0F3CF3-21B1-FA2D-071E-A2AC3F0FA58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8" creationId="{A54CCE5B-B12B-0DB8-CD26-5F2806F8AC3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49" creationId="{79B42AAE-434F-3233-63E0-D3D47D915ED1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0" creationId="{6A0460EF-E8CD-70B0-7F92-E8FF8E39EE4C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1" creationId="{5776B888-4B72-1D2D-D668-DEEC303CC3F6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2" creationId="{05C0B21C-20ED-B7A5-A22F-2E37275B876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3" creationId="{2A0BD8BA-C12C-0BEC-EADF-6FB2EF37ACB0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4" creationId="{075AB74C-1374-F588-A1D1-433131C94BF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5" creationId="{01B86999-FD52-0094-90B9-AA59188A497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6" creationId="{FC7B199A-3568-55E8-8DE9-71EEBD8AA42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7" creationId="{7B49B159-0676-2097-3270-950F84A5C1B1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8" creationId="{2A26615B-0C16-D2EF-30C4-9D5D6B7D510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59" creationId="{A07E1A1B-CA2C-99F7-9894-F3F79B1651B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0" creationId="{BCED3749-83B0-9290-639B-8A1FB1C68BA5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1" creationId="{74969F6C-61BF-996B-239E-F1919E72F6B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2" creationId="{098A6F08-8046-C7B3-96E9-79A527D54C8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3" creationId="{86F964FC-D4C8-E3BA-1EAB-97564CDB8BC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4" creationId="{B511512C-E28C-0E9E-2D86-DC43E19C980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5" creationId="{157D3C09-97E2-DD63-0C62-FB335625E6B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6" creationId="{677272FF-E123-F6E3-8016-653C88B26415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7" creationId="{7C4F1D64-4E27-22D7-CAC0-B0059A20257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8" creationId="{3DF68102-0BC9-E86E-F309-449D028805E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69" creationId="{EA8FDA95-19CB-E05A-F53D-B7EC8F63161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0" creationId="{BA7CE937-0A35-EE85-C599-A6995E49BBA0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1" creationId="{520AFC57-F9E0-B9E2-475E-65EC8DD5F9F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2" creationId="{F94DD8A3-731D-4467-0D1C-7C4EE5F046F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3" creationId="{6D0BA50B-D672-789C-F78F-28604190AA9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4" creationId="{573F2E3B-BF04-4C55-A70E-F98184685B51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5" creationId="{8874A80C-4DFF-C4FE-0B5D-3D04E60CA31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6" creationId="{2B142AF1-41DE-58F4-55CF-3BD153A85D4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7" creationId="{73C57EF9-DA68-2111-9079-B2350BE1BD5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8" creationId="{E9FEB5A5-FA26-BDF8-6757-29DE92AC057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79" creationId="{2AF703DD-4F70-0C25-3921-65FE1B4E48F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0" creationId="{852F8749-1081-8668-AF95-7D69D7C6C51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1" creationId="{D2B09100-48EE-67B6-F990-8F7E8C54078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2" creationId="{5E190B60-BCFA-7A1B-8049-A79F69B7CFC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3" creationId="{17BBF23D-0A77-33B3-1936-9BFE6729901C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4" creationId="{D8F1DAFE-5E4B-9102-D114-CE24C40AFA7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5" creationId="{911A2077-D9A0-486C-DFC0-2C7E8D652280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6" creationId="{209DC29A-EC48-180A-F149-BA2A79B3365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7" creationId="{93D770D1-6FB0-B9D5-22B8-1E15ABEB36A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8" creationId="{1827A39B-21F2-665B-0A02-A2860280D673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89" creationId="{B34A4BB1-D141-AA33-A141-F5F370AAE89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0" creationId="{8C167A01-CD14-4ABA-61CA-B8D934BDD59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1" creationId="{8E038916-418B-884E-B506-0665B04FEF9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2" creationId="{AD51135A-D32A-8B61-7600-7E73E023DCC9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3" creationId="{046613D9-B29E-CA67-CC15-69CE0887074E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4" creationId="{89EE1FAA-A72E-F79F-1FFB-7186CB51597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5" creationId="{FAC41B03-7BC8-2114-E1ED-742C6890BB76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6" creationId="{EB53A908-2C1A-1289-427C-344237076E7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7" creationId="{F48B5271-1B32-B73D-671D-49362737CFDB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8" creationId="{804B36C3-1047-BA09-B9EC-3C93FCE80FD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399" creationId="{0D611E43-7E89-F1A5-388F-AFA90BDFA04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0" creationId="{47FFDFEA-08B3-BE33-AB38-DB581E5CC9C8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1" creationId="{17BD61C2-BF82-B7D3-0AA4-C5E7E0C1958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2" creationId="{E8A226B4-D753-62DE-B837-AA68CBF3CCA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3" creationId="{2C44ABE6-5EAB-3236-2D17-FF1F6A30C68D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4" creationId="{2137B7E9-A6CE-6DEA-92A8-44C096335BD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5" creationId="{2D0A25B9-184F-EED6-D65D-0F69ABF8E4FA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6" creationId="{B65C2656-C5E4-E07B-BFCC-C8F8C22946A2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7" creationId="{1040745E-71D8-474A-7D06-E3DF0999301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8" creationId="{1B1ED096-B23F-6BD8-12BC-1291B3AF0A57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09" creationId="{7EB57E73-C987-9476-71B3-C524915A6F14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10" creationId="{BDE270B4-943F-EC04-EB69-F4758255EF1F}"/>
          </ac:spMkLst>
        </pc:spChg>
        <pc:spChg chg="mod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411" creationId="{EF1D4CDA-0E23-1A71-6E89-C64041B9293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2" creationId="{86469030-51D4-D9F7-2F87-19D4223ED02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3" creationId="{CBF87FDC-2CC1-32A4-9E99-EA0DAEFBE50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4" creationId="{4B45F42B-1EC2-55E4-9688-E20C545ADEB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5" creationId="{B4D162ED-EF92-462C-957B-AC6D8A7BF3E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6" creationId="{3BF448D0-3479-10F6-8198-2B9472A9252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7" creationId="{6792798D-9328-1772-49D1-174C53EECC0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8" creationId="{E50AA3CF-6885-E1B0-AA68-4065D87E232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19" creationId="{C5C4A98F-975D-FB00-36E8-649264F8D0F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0" creationId="{EE6A5CC5-DD34-1349-F310-EAE014BB6A5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1" creationId="{1A59A4B9-97E3-4A89-9185-FA4F4EE956C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2" creationId="{3C54580F-B556-8F34-4C5F-033D6975304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3" creationId="{5582684A-9903-7444-B4CC-286CBB811AAE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4" creationId="{C7467AB2-8B46-F7F9-0C44-F23976EBB34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5" creationId="{52762564-BE63-0192-6697-CC72DFF305C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6" creationId="{413EE088-F542-40FF-C823-C5228874171E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7" creationId="{9C168475-3A1B-4CED-0261-0BA4C803A77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8" creationId="{EB2CBC45-0CC0-91EC-6565-8A3E7BE44B8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29" creationId="{F24FDBF4-155F-96B2-C42B-95D06D6FC68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0" creationId="{90C8E7AD-6CE4-1256-F533-F835AF816A6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1" creationId="{D4ED8720-DFE3-EE7E-6B18-C04FEF82149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2" creationId="{FDC508BC-27AE-3CBF-61CD-B62B7CB8074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3" creationId="{014BE8DB-7A37-0EC8-BE9D-4245706A217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4" creationId="{1AA598F6-F6A1-FA23-E88B-881EC8BE33E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5" creationId="{E8C56633-1A94-26B0-408E-7D541A685F9E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6" creationId="{CB946A42-053B-9704-1535-0EA3696B640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7" creationId="{FF1D2E92-AB7B-D10C-9F52-5517618543C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8" creationId="{96F8AB41-E4D3-196E-6629-1B2485C49D4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39" creationId="{A781FA93-A725-778C-23A7-F5CFE2C0B4B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0" creationId="{39A2B80A-4AAA-1D25-FC5D-8F387166230F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1" creationId="{399FACC2-16F5-FF9C-6AB3-8A8F7E544D3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2" creationId="{2CD2BD17-01B1-A936-CF8F-AFDD7A82B0B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3" creationId="{E6D39DE6-1364-C5C8-A136-C91AF8489A4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4" creationId="{9323670B-EC92-ACED-82DA-9BE3459AF15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5" creationId="{90215CE4-0C3B-FE48-6060-261F460A3C55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6" creationId="{7DC4BE0D-987F-12A7-605D-B2A536AECA8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7" creationId="{8EB001A4-FE1E-2B19-B03A-C425373EF74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8" creationId="{DE465DB7-0155-8D87-1F68-2D853A91234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49" creationId="{3470A28D-C459-5788-6304-FB94CD39741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0" creationId="{4B64B267-F3E8-B03F-2EAB-4ECE0F04FAE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1" creationId="{9C3E446E-A107-89C6-F53B-06F748DA0C6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2" creationId="{40A3AE05-E829-B9BA-DBED-31A011B24AD6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3" creationId="{D87BFF43-158B-E98E-FDCA-52221903B6D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4" creationId="{CB9B9EB7-315D-7D26-68F9-44EBD8C150B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5" creationId="{FAA8A579-49F9-F060-DF06-C215B2F1123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6" creationId="{765944B9-EEE2-4495-72B1-AAE8D7ECE84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7" creationId="{4FEDB518-28B3-DF4C-F26A-41AFEC9B0026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8" creationId="{C1A0F925-6CBF-F8DA-9CED-68364F6FD84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59" creationId="{D84F0243-D3F6-90F7-E0C1-BC1C2393088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0" creationId="{EDEB9DDB-A5DB-69BF-49BB-EC1BA3908C5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1" creationId="{B6F2CF03-CCE7-36BA-6B56-1FD788F3A57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2" creationId="{479BB6EF-952B-CF83-D6AE-C09BBBF2885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3" creationId="{26109EA7-5BD8-95B5-C6DE-6D96E013692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4" creationId="{3B434433-DC02-5AEC-9848-2211FF7991A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5" creationId="{E5DF878B-322F-2E8A-B19C-AA9DBAB28096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6" creationId="{A6081F63-2498-503A-C6F8-2EEA6A91AEA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7" creationId="{2A82267A-CD3A-1E68-E381-BE456B92024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8" creationId="{C844437C-7D82-D647-9634-724077E311B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69" creationId="{7D772621-FFED-CAE8-793C-9F2A3FAEE94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0" creationId="{72F64648-B4BE-9C18-E3AC-A6774D05277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1" creationId="{CA09B0C5-6FA8-E9F4-AA26-C2298E13842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2" creationId="{B6E98D69-21EE-D34D-C11C-AC43762584E9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3" creationId="{2F0CA510-30CA-3729-A62E-05A6357871A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4" creationId="{FF37E50E-D04A-468A-AD7F-C62F0E4C1F1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5" creationId="{F8F85E74-F0A4-DF01-FB69-812F6E43BB2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6" creationId="{52D34725-70DC-9C03-FA19-E4221B632C3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7" creationId="{4CA57F1F-30D7-5A83-73C0-AF055D4F658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8" creationId="{FB4A034C-DE71-2EBE-7414-AB435735672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79" creationId="{00DA3C51-4348-B91F-7887-EE438C5D44B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0" creationId="{88DF1B11-4D70-0288-30E4-500F39453208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1" creationId="{A68DCE95-2FA4-8FBF-4608-E73BE2BD3ABA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2" creationId="{D13EE3F0-1BE5-3AB1-40B2-293D91DD10D8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3" creationId="{6367BE9C-EEF2-680A-7065-3C0F61E5786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4" creationId="{0A7D63AB-1AED-7B1A-6D63-3E04E50EEE4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5" creationId="{84749BEB-3722-0331-4684-67A6304BBFC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6" creationId="{F43672F2-B438-056F-05A3-BADD318AFDF4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7" creationId="{4D150418-0046-17B6-77FF-9F26F0D5E6E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8" creationId="{B4631001-13A3-C582-10AA-444BBC3A79C0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89" creationId="{E8081B10-8B7A-8BF0-C4FC-3779956C467B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0" creationId="{2F45D0C2-6342-87E5-B7E6-9B1A0A17B4B1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1" creationId="{60568517-687A-4935-C7FD-961D7B6A8352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2" creationId="{A0BAF15F-59B9-360E-227A-A309626C7B4D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3" creationId="{ED8812F7-B01C-95F6-EF6F-9688E8C948EC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4" creationId="{C3FE2BFA-2E4E-7B02-3DAC-A6FA29D44AF3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5" creationId="{BC2E47F1-8ED6-D21A-DD7A-074E88C8C307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6" creationId="{CB2CDB90-E65F-7E11-48C2-85B6B04CC53F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7" creationId="{CA8DA3D4-1E42-6744-B6A6-15C6EB03B47F}"/>
          </ac:spMkLst>
        </pc:spChg>
        <pc:spChg chg="mod">
          <ac:chgData name="Nikolaj Juul Nitschke" userId="eb944128-ea9e-41a1-979a-ca9bb959a91e" providerId="ADAL" clId="{6AFE4E9F-5EB9-4CE6-9784-903788AE6242}" dt="2025-03-28T08:37:37.596" v="31"/>
          <ac:spMkLst>
            <pc:docMk/>
            <pc:sldMk cId="679851506" sldId="269"/>
            <ac:spMk id="498" creationId="{591857E9-275D-A351-C380-56FC7F150B6D}"/>
          </ac:spMkLst>
        </pc:spChg>
        <pc:spChg chg="del mod topLvl">
          <ac:chgData name="Nikolaj Juul Nitschke" userId="eb944128-ea9e-41a1-979a-ca9bb959a91e" providerId="ADAL" clId="{6AFE4E9F-5EB9-4CE6-9784-903788AE6242}" dt="2025-03-28T08:39:57.122" v="55" actId="478"/>
          <ac:spMkLst>
            <pc:docMk/>
            <pc:sldMk cId="679851506" sldId="269"/>
            <ac:spMk id="500" creationId="{DCFDD721-0774-5C7E-B959-6874D4C1C2D0}"/>
          </ac:spMkLst>
        </pc:spChg>
        <pc:spChg chg="del mod topLvl">
          <ac:chgData name="Nikolaj Juul Nitschke" userId="eb944128-ea9e-41a1-979a-ca9bb959a91e" providerId="ADAL" clId="{6AFE4E9F-5EB9-4CE6-9784-903788AE6242}" dt="2025-03-28T08:39:56.245" v="54" actId="478"/>
          <ac:spMkLst>
            <pc:docMk/>
            <pc:sldMk cId="679851506" sldId="269"/>
            <ac:spMk id="501" creationId="{5A55EC1F-3992-6215-BFAF-1CFC38F7D8D3}"/>
          </ac:spMkLst>
        </pc:spChg>
        <pc:spChg chg="del mod topLvl">
          <ac:chgData name="Nikolaj Juul Nitschke" userId="eb944128-ea9e-41a1-979a-ca9bb959a91e" providerId="ADAL" clId="{6AFE4E9F-5EB9-4CE6-9784-903788AE6242}" dt="2025-03-28T08:40:26.508" v="67" actId="478"/>
          <ac:spMkLst>
            <pc:docMk/>
            <pc:sldMk cId="679851506" sldId="269"/>
            <ac:spMk id="502" creationId="{EB48E482-C0C7-FDFC-8A02-B2FEEEC9E01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3" creationId="{F0065B32-2A81-E089-50B0-898BF90DB6C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4" creationId="{789C22CB-9EEF-9989-59B5-8CC26D07403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5" creationId="{190AC5AD-E430-B229-8852-8A86CF69233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6" creationId="{ED654470-754A-133B-69ED-D9CA1AA267C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7" creationId="{FDC2E173-40EA-59D6-FE8A-8A289270575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8" creationId="{A072C0D9-5A20-7F68-7043-6FC294EEDB5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09" creationId="{A53D4ADC-C3CD-71A8-1F37-09DF77A76E31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0" creationId="{91EEB66C-B4F0-DBAD-9AE9-C12462728BC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1" creationId="{8949D474-45C6-4FB4-4FEA-827DABBF4433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2" creationId="{A36E91BD-D7A1-EE77-7612-3FAC1DE286E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3" creationId="{B2029625-01E8-0B91-41FA-1A39D636839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4" creationId="{EA33B10E-4895-773A-1CFB-68A0D085946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5" creationId="{9FF7CF80-C69F-FF90-511A-7F92938C2454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6" creationId="{9AF4CACD-1C6A-C9E7-7B77-CE1ED878FAF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7" creationId="{073288AB-BD76-8BB4-7B90-51987E04EFFC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8" creationId="{4A727A81-5EE2-F4E5-B794-41DC1BD41BCC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19" creationId="{AAEEAB5B-9A78-FF2F-7502-B10C4B9F30B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0" creationId="{B0FC156F-9EB3-C4E4-69D4-633A5C03C43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1" creationId="{3500B47B-072B-3CC6-C597-669D21E638F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2" creationId="{5EDB7591-9330-8A4B-D29E-071B91B3793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3" creationId="{65365DB6-EA9D-1C35-24E9-2C2117146BF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4" creationId="{B7B40F60-BAB3-13F4-F99B-6474812C065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5" creationId="{3DEF6A2C-F0EC-CB74-A492-65665925935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6" creationId="{34EBC8D1-01E9-AC66-9486-B563FFBE2B81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7" creationId="{8E08AB0B-1ECC-4516-7A2B-82292E0E6A8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8" creationId="{99754D25-B139-544F-9610-036160FE3061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29" creationId="{BC446EA5-EE25-D8D5-F386-9A87083A4A7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0" creationId="{482C0D8C-8BAA-1125-C0D8-CC34FE2D720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1" creationId="{DF762744-277C-CC2E-FB10-8F9AD1F2F57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2" creationId="{B67FA545-2A63-314D-3D08-510E8A715FA1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3" creationId="{87E254D8-6661-F40A-541C-148DCFEF6A9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4" creationId="{94815E88-420E-48C1-E22F-61C3E1CADE7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5" creationId="{2EB551DD-4AAA-5E5B-4543-46AB2CB704E2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6" creationId="{E2C2A31F-9C46-E3AF-C03F-211D6593BBA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7" creationId="{5197434E-A3E9-82AD-E8CA-44DA66BF5B1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8" creationId="{2EEF8486-8442-BB68-61B6-8712ACBFFDD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39" creationId="{F6260D10-D6B3-2D91-8C1D-FCFB55E261B8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0" creationId="{8434D059-882C-DD6E-3B8F-A3BF47DECDB2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1" creationId="{1EE45EA0-CB9C-6474-7FA2-9EF6EBA5747C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2" creationId="{2B44A1AF-FE98-456D-0473-607C658D650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3" creationId="{7DC644F7-1611-24BB-30A7-1F1958A38A2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4" creationId="{3BCCB10B-7391-44C9-187D-85AD66D7167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5" creationId="{D13C32B2-19E9-28BB-58C0-42D9E78D1B5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6" creationId="{3CE180AD-319D-849A-F574-7BD74EC3B65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7" creationId="{339F5A86-7B8D-E950-6727-B734156BCE9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8" creationId="{394F4E14-A486-EC2F-B1FA-FEBA2C5F68B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49" creationId="{3CD3B24F-7AE0-6DA5-21B4-03A7E19E034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0" creationId="{765660C6-1A00-B57C-4180-B7DF5EF35A9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1" creationId="{E6734474-59BF-FC32-C0AE-BC5464E721C4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2" creationId="{473151C1-D428-75E3-63E4-4CEA5D4A355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3" creationId="{C4AEB656-07E0-52C4-BD30-E622E80CF97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4" creationId="{5CE2060E-2134-B41E-2498-B4AC7FB2D4E9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5" creationId="{D6CCD589-0581-BB13-910C-50861C7C237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6" creationId="{DAB75295-A8DD-3AC9-0DA7-5577B1CEDC9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7" creationId="{27F821A3-5433-4C9E-90CE-D01B4A9E113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8" creationId="{84D10F74-BAF4-96B2-86FA-3C071608C39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59" creationId="{7C048D6E-2011-22F2-E342-77466DBF39F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0" creationId="{9351A52A-2F63-DF0B-EE6B-9A359B873F23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1" creationId="{07E7EA49-4CBB-A1F9-8C37-44B3F585A8B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2" creationId="{4EF6E9A5-E8C5-86D4-879D-15CB449ACEF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3" creationId="{E83D6296-4865-1DB2-FDF8-6B4E3E3FDF5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4" creationId="{FB064503-C909-2613-59F7-BB13E9B7B434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5" creationId="{D4EDE4BD-67D5-F2D8-5C1B-ABBD5DAABE7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6" creationId="{AB7D4771-95C0-C066-02F3-BC308486DC0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7" creationId="{E8500368-1A0F-0A22-B1E6-350CEFAE9C1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8" creationId="{018D23D0-8BC7-4656-6C6E-C65AF5AD50F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69" creationId="{D668ADB5-8C68-5F28-6EFB-B033CA66CF4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0" creationId="{2C33C899-DE5E-D345-0E44-1E23854C477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1" creationId="{2883996A-903C-50F9-B4D2-1A567C390BDC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2" creationId="{6B6384EA-3E70-5E16-539E-B90838873091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3" creationId="{FEE7ABEE-497E-1CA5-E44D-3348C4D319A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4" creationId="{8EBB1D17-25FB-D2F6-7623-14A382A80443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5" creationId="{E77A5D7C-D083-ECC9-6275-1D5F8E0B6D9C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6" creationId="{F7108524-EC13-6E18-54A0-16C1864CA3E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7" creationId="{E4AE03AA-3863-41A7-1F01-4A06271B5942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8" creationId="{15F574FA-DBA1-3840-7708-C9E06EBEBEA9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79" creationId="{3D8AA0E4-6965-7595-9DFC-387DDD8D894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0" creationId="{663DF27B-0195-E424-5322-284DB920D964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1" creationId="{E500F5C7-6D83-D7AF-BEDA-10C6528CCD7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2" creationId="{2302DAD3-627C-13C6-6CF6-DED9C170C9AB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3" creationId="{F836C6EC-9E6B-D8A9-7C9A-0573B007EFF9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4" creationId="{751F7099-0FE6-8D9C-D441-59473D72248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5" creationId="{834E1D1C-9B65-7A53-CF4E-EE6D69E48B0D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6" creationId="{41C369CE-BFA2-A9D1-711B-46ED76AF877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7" creationId="{82DEFD2C-D88E-6DA7-58F3-6B789E51212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8" creationId="{18AF6A7E-3617-8636-1363-FD665D2E9E9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89" creationId="{34CDD948-D9B5-918C-0149-BEEDC13DA8F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0" creationId="{F38E1B97-1D72-0E24-F67D-088328E47AD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1" creationId="{38824191-3A03-9C09-4C38-816BF139723E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2" creationId="{2CD20068-EFF2-4088-9774-899AF4531D14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3" creationId="{31E3E31C-7A6A-75D9-53EC-5A46D1A1E7C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4" creationId="{A6DAA072-BCD5-6C33-8CFE-F3A4B3C9E366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5" creationId="{DF6D26DE-2C01-3450-6FD7-FE50B19757F7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6" creationId="{B5390734-4009-A346-31B1-C4D034D8FEAF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7" creationId="{133C463A-0AAE-7D22-D16A-D32067396E55}"/>
          </ac:spMkLst>
        </pc:spChg>
        <pc:spChg chg="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598" creationId="{03109AFA-5FF7-0EE2-B763-D6C87EBEC7A4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599" creationId="{C1F0C284-8AA3-366B-D071-50C071CF7243}"/>
          </ac:spMkLst>
        </pc:spChg>
        <pc:spChg chg="add del mod topLvl">
          <ac:chgData name="Nikolaj Juul Nitschke" userId="eb944128-ea9e-41a1-979a-ca9bb959a91e" providerId="ADAL" clId="{6AFE4E9F-5EB9-4CE6-9784-903788AE6242}" dt="2025-03-28T08:46:56.085" v="143" actId="1076"/>
          <ac:spMkLst>
            <pc:docMk/>
            <pc:sldMk cId="679851506" sldId="269"/>
            <ac:spMk id="600" creationId="{75584689-73EC-6297-91DD-A0B1BCDEED09}"/>
          </ac:spMkLst>
        </pc:spChg>
        <pc:spChg chg="add del mod topLvl">
          <ac:chgData name="Nikolaj Juul Nitschke" userId="eb944128-ea9e-41a1-979a-ca9bb959a91e" providerId="ADAL" clId="{6AFE4E9F-5EB9-4CE6-9784-903788AE6242}" dt="2025-03-28T08:46:53.572" v="142" actId="1076"/>
          <ac:spMkLst>
            <pc:docMk/>
            <pc:sldMk cId="679851506" sldId="269"/>
            <ac:spMk id="601" creationId="{0C67E5EE-A77D-8564-2DF4-25542CE5419F}"/>
          </ac:spMkLst>
        </pc:spChg>
        <pc:spChg chg="add del mod topLvl">
          <ac:chgData name="Nikolaj Juul Nitschke" userId="eb944128-ea9e-41a1-979a-ca9bb959a91e" providerId="ADAL" clId="{6AFE4E9F-5EB9-4CE6-9784-903788AE6242}" dt="2025-03-28T08:46:46.298" v="141" actId="1076"/>
          <ac:spMkLst>
            <pc:docMk/>
            <pc:sldMk cId="679851506" sldId="269"/>
            <ac:spMk id="602" creationId="{A458BE0C-B203-9003-9700-B710219AAC0E}"/>
          </ac:spMkLst>
        </pc:spChg>
        <pc:spChg chg="add del mod topLvl">
          <ac:chgData name="Nikolaj Juul Nitschke" userId="eb944128-ea9e-41a1-979a-ca9bb959a91e" providerId="ADAL" clId="{6AFE4E9F-5EB9-4CE6-9784-903788AE6242}" dt="2025-03-28T08:46:42.705" v="140" actId="1076"/>
          <ac:spMkLst>
            <pc:docMk/>
            <pc:sldMk cId="679851506" sldId="269"/>
            <ac:spMk id="603" creationId="{4A29BF4A-138C-6937-2027-FD449EB75188}"/>
          </ac:spMkLst>
        </pc:spChg>
        <pc:spChg chg="add del mod topLvl">
          <ac:chgData name="Nikolaj Juul Nitschke" userId="eb944128-ea9e-41a1-979a-ca9bb959a91e" providerId="ADAL" clId="{6AFE4E9F-5EB9-4CE6-9784-903788AE6242}" dt="2025-03-28T08:46:39.742" v="139" actId="1076"/>
          <ac:spMkLst>
            <pc:docMk/>
            <pc:sldMk cId="679851506" sldId="269"/>
            <ac:spMk id="604" creationId="{4B24765C-7FD6-D0D4-90A9-2E99EF6D1A31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05" creationId="{341398BF-F106-A0A8-6529-B53963A79E6B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06" creationId="{FF64D28B-4ABB-14B9-A56D-AAA79A7B06D8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07" creationId="{F6767206-98A3-D641-B81F-B865B731C284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08" creationId="{0587E367-8745-FEEF-A676-2AD4C1EBFCA7}"/>
          </ac:spMkLst>
        </pc:spChg>
        <pc:spChg chg="add del 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09" creationId="{55935963-3F4F-10A1-F728-A8A9B6CF42DF}"/>
          </ac:spMkLst>
        </pc:spChg>
        <pc:spChg chg="mod topLvl">
          <ac:chgData name="Nikolaj Juul Nitschke" userId="eb944128-ea9e-41a1-979a-ca9bb959a91e" providerId="ADAL" clId="{6AFE4E9F-5EB9-4CE6-9784-903788AE6242}" dt="2025-03-28T08:45:55.336" v="130" actId="1582"/>
          <ac:spMkLst>
            <pc:docMk/>
            <pc:sldMk cId="679851506" sldId="269"/>
            <ac:spMk id="610" creationId="{431E8EA3-32D7-DA17-BF72-590715BB68F2}"/>
          </ac:spMkLst>
        </pc:spChg>
        <pc:spChg chg="add del mod topLvl">
          <ac:chgData name="Nikolaj Juul Nitschke" userId="eb944128-ea9e-41a1-979a-ca9bb959a91e" providerId="ADAL" clId="{6AFE4E9F-5EB9-4CE6-9784-903788AE6242}" dt="2025-03-28T08:46:09.445" v="132" actId="1582"/>
          <ac:spMkLst>
            <pc:docMk/>
            <pc:sldMk cId="679851506" sldId="269"/>
            <ac:spMk id="611" creationId="{951C3809-43B6-8984-F22C-151229B43CC6}"/>
          </ac:spMkLst>
        </pc:spChg>
        <pc:spChg chg="add del mod topLvl">
          <ac:chgData name="Nikolaj Juul Nitschke" userId="eb944128-ea9e-41a1-979a-ca9bb959a91e" providerId="ADAL" clId="{6AFE4E9F-5EB9-4CE6-9784-903788AE6242}" dt="2025-03-28T08:46:09.445" v="132" actId="1582"/>
          <ac:spMkLst>
            <pc:docMk/>
            <pc:sldMk cId="679851506" sldId="269"/>
            <ac:spMk id="612" creationId="{1ACBB0A0-B50F-5961-EA0C-6487763FBDB8}"/>
          </ac:spMkLst>
        </pc:spChg>
        <pc:spChg chg="add del mod topLvl">
          <ac:chgData name="Nikolaj Juul Nitschke" userId="eb944128-ea9e-41a1-979a-ca9bb959a91e" providerId="ADAL" clId="{6AFE4E9F-5EB9-4CE6-9784-903788AE6242}" dt="2025-03-28T08:46:09.445" v="132" actId="1582"/>
          <ac:spMkLst>
            <pc:docMk/>
            <pc:sldMk cId="679851506" sldId="269"/>
            <ac:spMk id="613" creationId="{BC9222A1-9E75-697B-0CDF-93C51A452C51}"/>
          </ac:spMkLst>
        </pc:spChg>
        <pc:spChg chg="add del mod topLvl">
          <ac:chgData name="Nikolaj Juul Nitschke" userId="eb944128-ea9e-41a1-979a-ca9bb959a91e" providerId="ADAL" clId="{6AFE4E9F-5EB9-4CE6-9784-903788AE6242}" dt="2025-03-28T08:46:09.445" v="132" actId="1582"/>
          <ac:spMkLst>
            <pc:docMk/>
            <pc:sldMk cId="679851506" sldId="269"/>
            <ac:spMk id="614" creationId="{73544821-494F-8953-2DE2-B26F6B45D6E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15" creationId="{9C1E9445-80B1-69BD-CCA3-1567C58D30AA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16" creationId="{D0A115BF-D46B-E045-817C-C61EAA6D4B30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17" creationId="{5C333F15-0C9D-C9E7-162C-6485A77E1BF5}"/>
          </ac:spMkLst>
        </pc:spChg>
        <pc:spChg chg="add del mod topLvl">
          <ac:chgData name="Nikolaj Juul Nitschke" userId="eb944128-ea9e-41a1-979a-ca9bb959a91e" providerId="ADAL" clId="{6AFE4E9F-5EB9-4CE6-9784-903788AE6242}" dt="2025-03-28T08:45:24.792" v="129" actId="2711"/>
          <ac:spMkLst>
            <pc:docMk/>
            <pc:sldMk cId="679851506" sldId="269"/>
            <ac:spMk id="618" creationId="{71AC10A0-2D32-81B9-F49F-2AC706EDA8EC}"/>
          </ac:spMkLst>
        </pc:spChg>
        <pc:spChg chg="add del mod topLvl">
          <ac:chgData name="Nikolaj Juul Nitschke" userId="eb944128-ea9e-41a1-979a-ca9bb959a91e" providerId="ADAL" clId="{6AFE4E9F-5EB9-4CE6-9784-903788AE6242}" dt="2025-03-28T08:42:57.370" v="97" actId="478"/>
          <ac:spMkLst>
            <pc:docMk/>
            <pc:sldMk cId="679851506" sldId="269"/>
            <ac:spMk id="619" creationId="{9E40340E-9080-2D6F-916D-EB5B56125A71}"/>
          </ac:spMkLst>
        </pc:spChg>
        <pc:spChg chg="del mod topLvl">
          <ac:chgData name="Nikolaj Juul Nitschke" userId="eb944128-ea9e-41a1-979a-ca9bb959a91e" providerId="ADAL" clId="{6AFE4E9F-5EB9-4CE6-9784-903788AE6242}" dt="2025-03-28T08:39:54.018" v="52" actId="478"/>
          <ac:spMkLst>
            <pc:docMk/>
            <pc:sldMk cId="679851506" sldId="269"/>
            <ac:spMk id="620" creationId="{D9E5D24F-EF61-91F4-25C4-1149F099B1EE}"/>
          </ac:spMkLst>
        </pc:spChg>
        <pc:spChg chg="del mod topLvl">
          <ac:chgData name="Nikolaj Juul Nitschke" userId="eb944128-ea9e-41a1-979a-ca9bb959a91e" providerId="ADAL" clId="{6AFE4E9F-5EB9-4CE6-9784-903788AE6242}" dt="2025-03-28T08:39:53.049" v="51" actId="478"/>
          <ac:spMkLst>
            <pc:docMk/>
            <pc:sldMk cId="679851506" sldId="269"/>
            <ac:spMk id="621" creationId="{1FC6B889-4EFD-4A58-7E95-0748E3779493}"/>
          </ac:spMkLst>
        </pc:spChg>
        <pc:spChg chg="del mod topLvl">
          <ac:chgData name="Nikolaj Juul Nitschke" userId="eb944128-ea9e-41a1-979a-ca9bb959a91e" providerId="ADAL" clId="{6AFE4E9F-5EB9-4CE6-9784-903788AE6242}" dt="2025-03-28T08:40:05.200" v="60" actId="478"/>
          <ac:spMkLst>
            <pc:docMk/>
            <pc:sldMk cId="679851506" sldId="269"/>
            <ac:spMk id="622" creationId="{A6D9721A-ED3E-FA1B-B5A6-600EDB48BCA1}"/>
          </ac:spMkLst>
        </pc:spChg>
        <pc:spChg chg="del mod topLvl">
          <ac:chgData name="Nikolaj Juul Nitschke" userId="eb944128-ea9e-41a1-979a-ca9bb959a91e" providerId="ADAL" clId="{6AFE4E9F-5EB9-4CE6-9784-903788AE6242}" dt="2025-03-28T08:40:04.727" v="59" actId="478"/>
          <ac:spMkLst>
            <pc:docMk/>
            <pc:sldMk cId="679851506" sldId="269"/>
            <ac:spMk id="623" creationId="{6E61A526-1D4D-1922-44F8-3D352FA5381B}"/>
          </ac:spMkLst>
        </pc:spChg>
        <pc:spChg chg="del mod topLvl">
          <ac:chgData name="Nikolaj Juul Nitschke" userId="eb944128-ea9e-41a1-979a-ca9bb959a91e" providerId="ADAL" clId="{6AFE4E9F-5EB9-4CE6-9784-903788AE6242}" dt="2025-03-28T08:40:04.098" v="58" actId="478"/>
          <ac:spMkLst>
            <pc:docMk/>
            <pc:sldMk cId="679851506" sldId="269"/>
            <ac:spMk id="624" creationId="{A8077F9A-F2A8-5812-05E3-48E7E2736FE2}"/>
          </ac:spMkLst>
        </pc:spChg>
        <pc:spChg chg="del mod topLvl">
          <ac:chgData name="Nikolaj Juul Nitschke" userId="eb944128-ea9e-41a1-979a-ca9bb959a91e" providerId="ADAL" clId="{6AFE4E9F-5EB9-4CE6-9784-903788AE6242}" dt="2025-03-28T08:40:06.730" v="61" actId="478"/>
          <ac:spMkLst>
            <pc:docMk/>
            <pc:sldMk cId="679851506" sldId="269"/>
            <ac:spMk id="625" creationId="{2072678F-E335-4C55-A89A-A1B0DE59C6F5}"/>
          </ac:spMkLst>
        </pc:spChg>
        <pc:spChg chg="del mod topLvl">
          <ac:chgData name="Nikolaj Juul Nitschke" userId="eb944128-ea9e-41a1-979a-ca9bb959a91e" providerId="ADAL" clId="{6AFE4E9F-5EB9-4CE6-9784-903788AE6242}" dt="2025-03-28T08:40:08.012" v="62" actId="478"/>
          <ac:spMkLst>
            <pc:docMk/>
            <pc:sldMk cId="679851506" sldId="269"/>
            <ac:spMk id="626" creationId="{7B05FF1C-26C6-E850-364C-307627000E9C}"/>
          </ac:spMkLst>
        </pc:spChg>
        <pc:spChg chg="del mod topLvl">
          <ac:chgData name="Nikolaj Juul Nitschke" userId="eb944128-ea9e-41a1-979a-ca9bb959a91e" providerId="ADAL" clId="{6AFE4E9F-5EB9-4CE6-9784-903788AE6242}" dt="2025-03-28T08:40:03.265" v="57" actId="478"/>
          <ac:spMkLst>
            <pc:docMk/>
            <pc:sldMk cId="679851506" sldId="269"/>
            <ac:spMk id="627" creationId="{CCF5835F-647D-C8DA-56F6-B1E00603F009}"/>
          </ac:spMkLst>
        </pc:spChg>
        <pc:spChg chg="add del mod topLvl">
          <ac:chgData name="Nikolaj Juul Nitschke" userId="eb944128-ea9e-41a1-979a-ca9bb959a91e" providerId="ADAL" clId="{6AFE4E9F-5EB9-4CE6-9784-903788AE6242}" dt="2025-03-28T08:42:25.264" v="75" actId="478"/>
          <ac:spMkLst>
            <pc:docMk/>
            <pc:sldMk cId="679851506" sldId="269"/>
            <ac:spMk id="628" creationId="{A6551EE5-4E49-4525-3508-5E7D08EABF8A}"/>
          </ac:spMkLst>
        </pc:spChg>
        <pc:spChg chg="add mod">
          <ac:chgData name="Nikolaj Juul Nitschke" userId="eb944128-ea9e-41a1-979a-ca9bb959a91e" providerId="ADAL" clId="{6AFE4E9F-5EB9-4CE6-9784-903788AE6242}" dt="2025-03-28T08:43:19.400" v="102" actId="571"/>
          <ac:spMkLst>
            <pc:docMk/>
            <pc:sldMk cId="679851506" sldId="269"/>
            <ac:spMk id="629" creationId="{F5457604-8A90-6321-7ADB-BE1169AF155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0" creationId="{EC8ABE31-D68C-06F8-A4E6-9785C30B10C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1" creationId="{3BE3D01E-8E31-B0EB-2F23-D9BF7AFC1EF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2" creationId="{98443596-323D-77F1-4F2F-32E7098BFC9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3" creationId="{64C21AFF-3F34-8016-215C-69030615B8D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4" creationId="{8CF41450-FC85-D389-D585-061D6A2295F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5" creationId="{94A9B9C6-DD5E-104E-A630-1B4DD9723E2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6" creationId="{E59A9EBF-C127-3270-E834-94FB880DFFF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7" creationId="{DE39FF6D-84CE-FD53-36C6-4FD4062EB1A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8" creationId="{43202018-19AB-81AE-07AB-A83B7BD810D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39" creationId="{98464691-9D1C-F149-E77F-973ED988BC04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0" creationId="{1F4A7A2F-2151-BA8D-5692-C841BC33706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1" creationId="{644F975B-0CFB-1940-48EC-C6711CE0E0D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2" creationId="{9E45F1C6-2218-7F31-15AD-121853B3F6E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3" creationId="{060FDCCE-4859-CF8C-BBBA-88E3203074B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4" creationId="{306A8869-E96F-E1AE-941A-1C38F34B775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5" creationId="{0DDEFAE5-11C3-9794-116B-534B6832435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6" creationId="{80728686-E064-E012-D260-1089729A53C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7" creationId="{542EFE5D-15AF-31A9-291E-783DFA63411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8" creationId="{233AC908-31D9-6EF1-AF85-4E2C073EADF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49" creationId="{1341EA55-19C0-D746-144E-D444D104393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0" creationId="{F204F1D4-4525-BB92-14CF-40DCCF32757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1" creationId="{6D873FCB-6D08-8E59-F7E4-6731075A573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2" creationId="{BFDD52BA-0192-6B51-E309-F291DFAA4F3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3" creationId="{F760ECD4-66C3-8A20-6E46-5F2AE0ACD83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4" creationId="{CA91FDFE-11BD-1CFC-E290-20DF0782908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5" creationId="{DE58125B-10FE-BF0D-5E3C-D23B5780D25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6" creationId="{98224060-391E-9A0A-169E-3CF1CCC3D814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7" creationId="{B433A3FD-DA40-AB1E-B01D-3911E21C009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8" creationId="{54A5623B-B8DF-7A25-3FF7-C9AEEBCA39E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59" creationId="{7B0ABBDF-54EE-CD55-FFB1-CDA23217E91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0" creationId="{FABA46A2-8EE4-A903-4516-829345C4CE6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1" creationId="{53E32E15-2BD4-41AF-662E-92858FFC2D8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2" creationId="{695892D6-7F37-EB97-901F-0717AE656A5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3" creationId="{F9A85D08-7E44-C2F4-2773-4C6DCA3F746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4" creationId="{A3359CF2-76F0-CEDD-0CC4-63A6B861C7A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5" creationId="{99710CB9-668D-040E-0B1A-816A95CF362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6" creationId="{4E4E05F3-1203-0A22-86BD-74A7EE4B4B0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7" creationId="{58964CA0-6638-0D5A-2965-2B4B4368016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8" creationId="{E9313771-1639-DB25-3D5B-C9C0998AA5C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69" creationId="{719382E3-1FB2-CE77-3C67-3F9D7A3B8B5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0" creationId="{C863E148-1C61-09C5-B8EC-A29F9696394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1" creationId="{1557F4D6-08D7-24EE-BD4B-A7C5C503AE2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2" creationId="{F6A55F62-5A1C-5C61-2ED1-95B9CBAC6E9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3" creationId="{3A8604DE-7EB5-8274-AD31-1E1BD99EF81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4" creationId="{9DEC2AC1-023C-E29A-4E9B-04060EB4E61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5" creationId="{92992521-BA15-6E17-DEB4-4EB39DBB5FA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6" creationId="{6B1FE52F-65ED-4330-0479-47FF4A07974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7" creationId="{3A2550B8-F6D6-608E-F1D8-CB6BDA54BB24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8" creationId="{53388800-32DE-249B-5EEE-499CE2C756C4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79" creationId="{11692C0B-1312-075B-FB17-412F76582F6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0" creationId="{5076D31E-5F32-ED0A-63ED-2FF41819164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1" creationId="{5EC7A81A-A175-6747-14B1-C56D5DC276F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2" creationId="{5CC32169-B03A-10BF-EE98-38832949006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3" creationId="{CB7BB5DC-E032-AC5E-80BE-9B43595B5BA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4" creationId="{9B53D13D-060C-72F0-79B9-613AAF56EA1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5" creationId="{393A9E9E-A259-324A-DA44-3278D9ED9E3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6" creationId="{6EC6B9DE-0126-AD63-E440-19F97B0C4D1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7" creationId="{5C3804F2-B8C2-1603-3441-2C37A23A8CE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8" creationId="{D2A029C2-EDA8-AA75-937A-1863F45C4C3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89" creationId="{2F469A66-7999-C927-6B43-B485527ECA9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0" creationId="{7E4BB9AE-E907-E63C-F3F2-E7EC2557F6D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1" creationId="{EDE7D5DB-B246-3B2C-2B0C-CB0EE279813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2" creationId="{2467AA50-2FFF-30E6-4B5D-856198F1DCE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3" creationId="{06F521D9-C394-5F54-2C88-85088286DB0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4" creationId="{050964F1-29DF-26D8-5CC1-EC733967356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5" creationId="{DD58A377-2211-50C5-B658-CC48F883CAF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6" creationId="{28FA3CBE-69EB-102A-7253-F6F1D93851C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7" creationId="{2555D456-F132-E613-9CE9-D2F10804127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8" creationId="{90DF6A8D-A37E-69AC-1A76-D13C72A1471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699" creationId="{75AFF2C7-F3C8-06D8-C4D9-0C83058CA11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0" creationId="{22C71ED2-1505-3A8E-CA88-C81BBE459B4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1" creationId="{D4106768-2EEB-AF42-B694-43B68D30A1C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2" creationId="{031BF047-E060-B073-C29A-8CDE2EAE692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3" creationId="{E143409E-EC3B-C05E-522F-D5215236D08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4" creationId="{804D1B0B-BE3D-9335-EA4D-B4BF15D7360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5" creationId="{7EA0725B-24E2-B263-0577-AE4835B9B22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6" creationId="{0D9ADDEA-4FFB-BC82-7C90-201A30D0840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7" creationId="{C16A14F3-A5C6-EA8F-D81F-4D3CC77F923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8" creationId="{CAD75472-844E-1C7B-68C8-04E91F03623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09" creationId="{A251A806-F004-F559-9B48-6D96911CB10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0" creationId="{55E8BDBB-4BF2-B4C2-88E6-87F322F94EE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1" creationId="{69ABC851-02DE-7CB1-A564-9F9921C7CF7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2" creationId="{FB556B4D-AB4D-D225-3B04-E92BB2DD382C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3" creationId="{2AA91C5B-79C1-8D85-7393-73980617CF5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4" creationId="{7DD34F68-9417-DE35-05E5-0A2958FA7ED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5" creationId="{BFBD904E-8F82-D836-B4D8-D88B5D50718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6" creationId="{2DE6F3E0-D246-5C49-E46B-34DD074F4C4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7" creationId="{D6794CBF-27CA-79C7-8483-50FC2B23DCB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8" creationId="{F3CCAF68-786C-7AE2-0DC2-25A9EC12529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19" creationId="{30C65FE4-064E-01CB-6CE7-6A704C64250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0" creationId="{A3236912-984B-8B58-3081-DF2EC13E917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1" creationId="{07164EE2-28A4-F08F-C2CA-C9F5A8DE906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2" creationId="{C219F647-8ADD-5E57-4DEC-72CFC0B2B7A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3" creationId="{952E26DA-1648-1B9C-0A58-1F10B6E109D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4" creationId="{F8582226-D2EF-49A5-9E13-A2E21BA4BAA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5" creationId="{401D686F-C208-FE1C-C454-F8E7D165603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6" creationId="{A14FDF42-B9E6-2832-F306-9F1C77E0D63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7" creationId="{13195F02-CC83-E602-C875-44570233BF7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8" creationId="{2916AD13-821A-102D-2C07-63366229428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29" creationId="{DB700E12-D6FF-00E7-5CA8-DF97121BF06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0" creationId="{1F5D679E-308D-027D-B7BB-9DE5D3A4243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1" creationId="{AEB4A2AC-291A-A90C-346A-EFF052917D3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2" creationId="{D6443DBE-29D7-EC23-E896-91E59140A92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3" creationId="{BDB1B19D-2CEB-66F2-BCF2-F97857EE79D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4" creationId="{703F2D6F-8F55-FCCC-C1A9-490FD40C0B4D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5" creationId="{51C4CB46-5FBF-B934-B122-B2BE2D58453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6" creationId="{5CAABDC0-0C09-615C-0E3B-AC05B492C0A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7" creationId="{0F967B82-7F14-69D0-E003-1D98137FB7F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8" creationId="{AEFA6E5D-549B-12E5-8C57-AC732D36153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39" creationId="{BF96B363-4F6E-CAEA-F3D8-400E8D92FCD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0" creationId="{EB24B995-6E14-2952-F40B-61EE6D57B6F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1" creationId="{494CE95B-FB35-A6A5-07CA-052C8B1E1D75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2" creationId="{2EEAC586-3721-F799-9588-5D9AA1E5411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3" creationId="{74D1C5A6-D1B7-D82B-45F5-34E3D589675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4" creationId="{F93D12B0-3F29-5B2E-5358-0EE833CB489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5" creationId="{06712343-273D-9209-D478-2C42509A858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6" creationId="{91944CA1-04E4-BF7C-4BC9-CCCBFC48614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7" creationId="{98284A95-CB70-B22B-F473-B02FEFC9D96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8" creationId="{D90BF3B2-9640-6AC4-3333-73A26E87E14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49" creationId="{D612811D-BB92-AFEF-ADEF-507641D650A7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0" creationId="{8369F9FE-6DC3-3CDE-621D-44477C9AAE2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1" creationId="{10ADC555-CD09-7428-F022-500A68938A7F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2" creationId="{A3724AEE-343E-D1C8-4F7F-9B745FF37F93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3" creationId="{C623A712-D07A-EEB5-B2DA-5F04BC22DA2A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4" creationId="{D0B1E4B3-850F-8B7F-C90D-C3956DA4250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5" creationId="{45343E4D-D8E4-0313-3B6C-F68C463C83B2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6" creationId="{0B67F554-B545-FF1B-8AAE-D6B5DD0DC4B4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7" creationId="{BB141427-49E8-269B-F1B3-61A1C6F66AAE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8" creationId="{7D6F1B84-D2E0-89F9-27AF-0FCDFCD57446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59" creationId="{1A5DB249-133E-FEA8-F949-1B7386320170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0" creationId="{89C7ED60-E52D-6D14-AB3E-2DA59212A209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1" creationId="{C933AAB0-D985-10FC-A1EF-33871A1F54B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2" creationId="{37DC5E4A-6D3C-1054-2DDB-08C3D7833D7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3" creationId="{DC736328-A780-92D5-482D-6BB9DE9234FB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4" creationId="{E53170CE-3E7B-4790-8D1D-270D0D6C3451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5" creationId="{EBBA8421-C23D-344E-C652-9C4C387861E8}"/>
          </ac:spMkLst>
        </pc:spChg>
        <pc:spChg chg="add mod">
          <ac:chgData name="Nikolaj Juul Nitschke" userId="eb944128-ea9e-41a1-979a-ca9bb959a91e" providerId="ADAL" clId="{6AFE4E9F-5EB9-4CE6-9784-903788AE6242}" dt="2025-03-28T08:44:00.845" v="112" actId="571"/>
          <ac:spMkLst>
            <pc:docMk/>
            <pc:sldMk cId="679851506" sldId="269"/>
            <ac:spMk id="766" creationId="{A8801502-134C-F305-99CA-450802426D3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67" creationId="{2259FCD4-EA02-75C8-9CF4-9F6A92A13C81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68" creationId="{221D9CBC-8770-49E9-FB04-CEFD20F2C4C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69" creationId="{BC1F77D7-2F5D-13F6-D19D-4C1E3B6C38C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0" creationId="{CD6A3FC5-5E8E-35E8-ADF8-69EE709C5A6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1" creationId="{12537DD9-B622-20CF-44C3-E89F3B50B1D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2" creationId="{A4A22432-0524-1287-EA09-0E9AFAFB16D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3" creationId="{10500237-14EA-7807-579C-0733987D0DB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4" creationId="{092E1400-964A-1A31-CD36-8ADD650997E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5" creationId="{87BDFC79-4354-AA50-5629-DB517C4D9A5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6" creationId="{388AB7E0-C8DD-2A6D-D6CF-6FD57846626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7" creationId="{E475F9EB-452B-690C-EC9F-BACF3D377B9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8" creationId="{16E26BF1-5D7A-344B-5E9D-25C4F6431B4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79" creationId="{A82C19CB-0A7C-BA5A-9557-7F18F101A1E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0" creationId="{0C9757DF-7DE6-ADC6-E25A-33572AA482B3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1" creationId="{764DA9FB-9F99-6160-0A45-29EF596A13E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2" creationId="{414CD41C-A8D7-D422-BE5C-F128B99B786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3" creationId="{83952375-84BB-CBEB-45BB-3A812CAA53D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4" creationId="{CF190FDD-4EAB-E4E6-2479-341036DDFE2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5" creationId="{3C2447E8-4329-7F6C-FEF5-AD45CE2737A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6" creationId="{C14B7989-7D24-3A93-7C14-C3299C3C3BB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7" creationId="{BFE13CE3-6036-40AB-BC38-CA697DB9666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8" creationId="{88782C47-4CA0-8AAC-5D8B-AB61F47EC34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89" creationId="{0392E65F-9C36-0A9E-71AC-7D4D3F3B7001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0" creationId="{E95CA7DC-E324-4641-C336-8119248D340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1" creationId="{CD0F685F-175B-CF7D-8D68-335DCC20B453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2" creationId="{75FF11D4-C4F7-FDE7-B81E-8907DED5962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3" creationId="{0F402B1E-F8E5-BA45-FEA7-106DF94A89B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4" creationId="{A7CCCE68-B6FB-665C-5B38-D86654E7063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5" creationId="{17406948-B557-CAFF-2B36-1950CFB473C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6" creationId="{76EA9B68-DD08-7748-879F-6D9B544E672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7" creationId="{04C139DB-040B-96B8-2DA3-C0D0C244ECD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8" creationId="{C8055988-09A6-8422-B5B0-1DE9FF0B9E6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799" creationId="{8B913B26-9608-8534-7D31-9D785DA472B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0" creationId="{21FCDFD9-540E-BCCA-4688-ABCCB9F62A3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1" creationId="{F565B051-CD1F-8474-545B-A0CE519175B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2" creationId="{288CA571-381E-6A6A-88DF-599EBFCD569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3" creationId="{ABD73D9E-8744-11E4-2F84-6656F589313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4" creationId="{4245E345-5B24-4A27-AD56-3136F08CA311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5" creationId="{F504C007-BA64-4D9C-A2DA-892137206E6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6" creationId="{D106BF2C-5AB3-3601-7B24-0316B6EA021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7" creationId="{FB3CD650-1BD5-671A-C6AB-F394C0187F4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8" creationId="{4A325F9F-6A00-0A35-EC49-80C2B892598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09" creationId="{3439EA56-AECD-575E-1A7B-E8CF20A3B62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0" creationId="{3E9C9B5E-F454-04FE-3F36-C0ABA709676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1" creationId="{A28FB4C2-C4DF-1E94-E45E-9DB4DAD99BF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2" creationId="{07CEFCC1-0F30-0059-FFF4-AA9B4648162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3" creationId="{F74A17FA-B02B-779D-9D11-723AA0E0BE1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4" creationId="{710EB604-56CC-E659-724E-D7E171E1664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5" creationId="{E7CB1598-9E4C-26EF-7087-F9CD3C05422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6" creationId="{799556C9-4EFF-86BC-EA48-B2E46D91E2A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7" creationId="{0E1AA43E-F651-19E5-C957-B27EAFB4FAA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8" creationId="{DC19B8F1-6D81-E9BD-8611-EDF18ED805C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19" creationId="{F895C4A2-C878-5609-21D5-453D9356110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0" creationId="{21190E51-6ABD-1C49-1180-B30A57BA76C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1" creationId="{51478A93-1E01-21E7-1088-683D31FCD98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2" creationId="{4CE349ED-59E3-62BB-0FF1-C1ACA406092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3" creationId="{A3940569-800F-57B1-88C1-DAF2EECE3F1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4" creationId="{13B88A56-C792-C439-B24B-727DF29574A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5" creationId="{5DB04E2A-87D5-8F5F-318C-135CD1E0BB6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6" creationId="{51F51116-5088-153F-FBE0-87562B3C554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7" creationId="{1E3BD835-0C99-9F9E-92CF-37DCFDBB0AE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8" creationId="{0213C121-B2E6-75F9-3308-5753F357256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29" creationId="{FECF9D03-C8AB-F041-1327-412287B7B251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0" creationId="{DF38097C-0033-89D8-C918-B82A70DDAB2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1" creationId="{EEDDEFC3-D096-3900-E341-7E4CBB10496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2" creationId="{1A47EB09-AE29-13A9-C836-EEA19A9746B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3" creationId="{8303773B-8156-9566-0B21-B2284154442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4" creationId="{806C5DFC-29A6-90EA-42F0-FC7D7BD4B29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5" creationId="{B2FB675F-29DE-08E7-BBA9-A09AFE4A3B9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6" creationId="{164C2817-EAFB-20AF-73F0-A7142DCFBF1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7" creationId="{BFE08B4E-3198-336B-2512-91E7C8DBEC0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8" creationId="{81CE4F5C-8DD5-3E9E-0248-A6C00859A9E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39" creationId="{517E8EBF-A75F-D12B-A17D-F169415D1D5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0" creationId="{F96D9C00-7053-7F67-88B0-8BBD758584D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1" creationId="{F97C3593-99ED-B4BC-A64F-D468365906A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2" creationId="{D2309333-6349-53D6-A84A-FB9E5452841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3" creationId="{F5766F16-CF9A-C6EA-C2A1-30A6F57AB9B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4" creationId="{134E3365-64A5-792C-31A8-25AA24CA48A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5" creationId="{7B678BDB-B5A2-D9E9-354E-F79607C0B85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6" creationId="{F5DC5871-840A-06A7-9734-DC41D9E52F6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7" creationId="{F19F7FAD-424B-B6C0-509C-5BC286681E8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8" creationId="{1BBA4942-82A8-4D4C-921E-4AB52F979C1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49" creationId="{045D2A88-F03D-5B9C-886E-D858FC3AB6DB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0" creationId="{912324DE-3810-AFBF-86A7-E3E233ED430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1" creationId="{0AE397AD-B2EE-E7D2-80B1-94D1FCE50A3E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2" creationId="{92207AA6-B03A-6676-B90D-8687C10EB9E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3" creationId="{89949938-762C-960A-324D-8A96453B003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4" creationId="{0A47A225-DDE1-9AF0-E016-B1E59FCC590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5" creationId="{D1A200C1-7480-3778-1E06-92F971F04F3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6" creationId="{243C7421-D85C-8855-2EE2-792BCCC95C3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7" creationId="{89D45B12-876E-BAFA-9420-C52022ED627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8" creationId="{D3B51A9F-609E-C66F-1B7B-0F1BA8A88E3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59" creationId="{CFB1FFFC-036E-36AA-D01B-ACC4F2DC9086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0" creationId="{17D5DEDE-EB93-6A4F-084E-C6BC374D831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1" creationId="{E480CCA0-D7C7-4633-6BED-D3573DB684D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2" creationId="{5DB1C4B1-C55F-1D23-2BB8-50E3DD72FD0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3" creationId="{F7631A1F-6748-EDA3-B09A-3A3558D09DF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4" creationId="{027AAF79-747B-F56A-8DE8-F627766709F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5" creationId="{D9E9509E-BF46-E31F-5F02-E7EA6058A00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6" creationId="{140E924C-8C9F-6CF2-D721-8A2F848CE683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7" creationId="{4F75D342-E402-7468-0B5B-E153FB5B92DA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8" creationId="{3C52FA79-0C50-B895-7014-D36FD9461F39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69" creationId="{46C2C263-DC04-5DDB-DF8D-E58DAD2DADE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0" creationId="{50C81019-511A-EC12-A668-7F7807BB7DE4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1" creationId="{F2AA2C4C-6837-09E2-B917-627F0E8311B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2" creationId="{C032A38E-6045-F4F9-79D9-0F41138FEE06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3" creationId="{406C6E2E-818A-8B83-2FC8-9105D7A45D0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4" creationId="{C382CFDF-0917-5CFF-02F8-A9F09A886286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5" creationId="{4FD10977-65A9-F138-6A24-C9E211FDB227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6" creationId="{63C5F653-4AEA-4833-467C-EFA0B009985C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7" creationId="{D6EB8F48-A5F7-F732-471B-10F6F9B673F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8" creationId="{2183611E-763D-5BA0-A635-1FA07967C8D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79" creationId="{281D7F4B-F864-1A5E-9317-4DAE5F3DEDF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0" creationId="{913EB024-CB0C-224F-6A96-CAC4634B1145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1" creationId="{0CFD567E-DF2D-1284-709A-00E55F4D58F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2" creationId="{C675D110-5A9B-D787-04DE-4D760DA28D0F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3" creationId="{1E02A2A4-6723-D167-C391-6EB99CE06909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4" creationId="{FB56D27B-5170-F7A5-E902-BE5D4249403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5" creationId="{8B561786-B4EE-374A-1174-31019CD67630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6" creationId="{AD07C058-7573-F0D9-3C07-FD16DD191A68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7" creationId="{A6B971BF-F68F-1F97-7FE2-D777C2F22E89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8" creationId="{5CA14D10-EFDD-124B-C1E6-E4610E963C2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89" creationId="{D7F67051-AEAF-9D5A-B39B-B549B38322ED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90" creationId="{9008BAB8-29E2-7439-33EC-F8B8CBD6D482}"/>
          </ac:spMkLst>
        </pc:spChg>
        <pc:spChg chg="add mod">
          <ac:chgData name="Nikolaj Juul Nitschke" userId="eb944128-ea9e-41a1-979a-ca9bb959a91e" providerId="ADAL" clId="{6AFE4E9F-5EB9-4CE6-9784-903788AE6242}" dt="2025-03-28T08:44:08.625" v="114" actId="571"/>
          <ac:spMkLst>
            <pc:docMk/>
            <pc:sldMk cId="679851506" sldId="269"/>
            <ac:spMk id="891" creationId="{4D151B79-347B-05ED-9EFB-737A1EA348EC}"/>
          </ac:spMkLst>
        </pc:spChg>
        <pc:grpChg chg="add del mod">
          <ac:chgData name="Nikolaj Juul Nitschke" userId="eb944128-ea9e-41a1-979a-ca9bb959a91e" providerId="ADAL" clId="{6AFE4E9F-5EB9-4CE6-9784-903788AE6242}" dt="2025-03-28T08:37:48.379" v="34" actId="478"/>
          <ac:grpSpMkLst>
            <pc:docMk/>
            <pc:sldMk cId="679851506" sldId="269"/>
            <ac:grpSpMk id="231" creationId="{C72AED1D-C0F5-C0B3-8DE1-DA464477718E}"/>
          </ac:grpSpMkLst>
        </pc:grpChg>
        <pc:grpChg chg="add mod">
          <ac:chgData name="Nikolaj Juul Nitschke" userId="eb944128-ea9e-41a1-979a-ca9bb959a91e" providerId="ADAL" clId="{6AFE4E9F-5EB9-4CE6-9784-903788AE6242}" dt="2025-03-28T08:47:14.615" v="145" actId="1076"/>
          <ac:grpSpMkLst>
            <pc:docMk/>
            <pc:sldMk cId="679851506" sldId="269"/>
            <ac:grpSpMk id="316" creationId="{FE82F961-D97E-C427-3177-E05AAD0F07AF}"/>
          </ac:grpSpMkLst>
        </pc:grpChg>
        <pc:grpChg chg="add del mod">
          <ac:chgData name="Nikolaj Juul Nitschke" userId="eb944128-ea9e-41a1-979a-ca9bb959a91e" providerId="ADAL" clId="{6AFE4E9F-5EB9-4CE6-9784-903788AE6242}" dt="2025-03-28T08:39:49.393" v="49" actId="165"/>
          <ac:grpSpMkLst>
            <pc:docMk/>
            <pc:sldMk cId="679851506" sldId="269"/>
            <ac:grpSpMk id="499" creationId="{6D514C6D-82D8-5E24-B276-5E38BEA79245}"/>
          </ac:grpSpMkLst>
        </pc:grpChg>
      </pc:sldChg>
      <pc:sldChg chg="addSp delSp modSp add mod">
        <pc:chgData name="Nikolaj Juul Nitschke" userId="eb944128-ea9e-41a1-979a-ca9bb959a91e" providerId="ADAL" clId="{6AFE4E9F-5EB9-4CE6-9784-903788AE6242}" dt="2025-04-25T08:00:26.944" v="239" actId="1076"/>
        <pc:sldMkLst>
          <pc:docMk/>
          <pc:sldMk cId="3863922482" sldId="270"/>
        </pc:sldMkLst>
        <pc:spChg chg="add mod">
          <ac:chgData name="Nikolaj Juul Nitschke" userId="eb944128-ea9e-41a1-979a-ca9bb959a91e" providerId="ADAL" clId="{6AFE4E9F-5EB9-4CE6-9784-903788AE6242}" dt="2025-04-25T06:29:58.017" v="201" actId="20577"/>
          <ac:spMkLst>
            <pc:docMk/>
            <pc:sldMk cId="3863922482" sldId="270"/>
            <ac:spMk id="2" creationId="{58C52D4F-B2E9-FABC-1813-7D7922B6BCAE}"/>
          </ac:spMkLst>
        </pc:spChg>
        <pc:spChg chg="add mod">
          <ac:chgData name="Nikolaj Juul Nitschke" userId="eb944128-ea9e-41a1-979a-ca9bb959a91e" providerId="ADAL" clId="{6AFE4E9F-5EB9-4CE6-9784-903788AE6242}" dt="2025-04-25T08:00:26.944" v="239" actId="1076"/>
          <ac:spMkLst>
            <pc:docMk/>
            <pc:sldMk cId="3863922482" sldId="270"/>
            <ac:spMk id="3" creationId="{91DD5A39-636A-F4A4-D6C7-8151170BBDE9}"/>
          </ac:spMkLst>
        </pc:spChg>
        <pc:spChg chg="del mod">
          <ac:chgData name="Nikolaj Juul Nitschke" userId="eb944128-ea9e-41a1-979a-ca9bb959a91e" providerId="ADAL" clId="{6AFE4E9F-5EB9-4CE6-9784-903788AE6242}" dt="2025-04-25T07:59:55.662" v="211" actId="478"/>
          <ac:spMkLst>
            <pc:docMk/>
            <pc:sldMk cId="3863922482" sldId="270"/>
            <ac:spMk id="798" creationId="{514F0352-846D-18D5-D74E-47DA1CDA95FE}"/>
          </ac:spMkLst>
        </pc:spChg>
        <pc:spChg chg="mod">
          <ac:chgData name="Nikolaj Juul Nitschke" userId="eb944128-ea9e-41a1-979a-ca9bb959a91e" providerId="ADAL" clId="{6AFE4E9F-5EB9-4CE6-9784-903788AE6242}" dt="2025-04-25T06:36:01.607" v="204" actId="20577"/>
          <ac:spMkLst>
            <pc:docMk/>
            <pc:sldMk cId="3863922482" sldId="270"/>
            <ac:spMk id="807" creationId="{959C1E54-ADB7-20C8-598C-10FF58E09AD1}"/>
          </ac:spMkLst>
        </pc:spChg>
        <pc:spChg chg="mod">
          <ac:chgData name="Nikolaj Juul Nitschke" userId="eb944128-ea9e-41a1-979a-ca9bb959a91e" providerId="ADAL" clId="{6AFE4E9F-5EB9-4CE6-9784-903788AE6242}" dt="2025-04-25T06:36:08.020" v="210" actId="20577"/>
          <ac:spMkLst>
            <pc:docMk/>
            <pc:sldMk cId="3863922482" sldId="270"/>
            <ac:spMk id="900" creationId="{188940DE-AEA1-CB63-3E99-AFD87CEF5D10}"/>
          </ac:spMkLst>
        </pc:spChg>
        <pc:spChg chg="mod">
          <ac:chgData name="Nikolaj Juul Nitschke" userId="eb944128-ea9e-41a1-979a-ca9bb959a91e" providerId="ADAL" clId="{6AFE4E9F-5EB9-4CE6-9784-903788AE6242}" dt="2025-04-25T06:36:05.162" v="207" actId="20577"/>
          <ac:spMkLst>
            <pc:docMk/>
            <pc:sldMk cId="3863922482" sldId="270"/>
            <ac:spMk id="1017" creationId="{04B1743F-D8F3-91E9-2846-98AF5B949FB5}"/>
          </ac:spMkLst>
        </pc:spChg>
        <pc:grpChg chg="mod">
          <ac:chgData name="Nikolaj Juul Nitschke" userId="eb944128-ea9e-41a1-979a-ca9bb959a91e" providerId="ADAL" clId="{6AFE4E9F-5EB9-4CE6-9784-903788AE6242}" dt="2025-04-25T06:29:44.382" v="176" actId="14100"/>
          <ac:grpSpMkLst>
            <pc:docMk/>
            <pc:sldMk cId="3863922482" sldId="270"/>
            <ac:grpSpMk id="579" creationId="{25F09E52-2BE9-8794-298A-5378277CA9A1}"/>
          </ac:grpSpMkLst>
        </pc:grpChg>
        <pc:grpChg chg="mod">
          <ac:chgData name="Nikolaj Juul Nitschke" userId="eb944128-ea9e-41a1-979a-ca9bb959a91e" providerId="ADAL" clId="{6AFE4E9F-5EB9-4CE6-9784-903788AE6242}" dt="2025-04-25T06:29:51.821" v="180" actId="1076"/>
          <ac:grpSpMkLst>
            <pc:docMk/>
            <pc:sldMk cId="3863922482" sldId="270"/>
            <ac:grpSpMk id="809" creationId="{A1DB8D1A-F0B9-EB82-4055-D621C0DFF135}"/>
          </ac:grpSpMkLst>
        </pc:grpChg>
        <pc:grpChg chg="mod">
          <ac:chgData name="Nikolaj Juul Nitschke" userId="eb944128-ea9e-41a1-979a-ca9bb959a91e" providerId="ADAL" clId="{6AFE4E9F-5EB9-4CE6-9784-903788AE6242}" dt="2025-04-25T06:29:46.698" v="177" actId="14100"/>
          <ac:grpSpMkLst>
            <pc:docMk/>
            <pc:sldMk cId="3863922482" sldId="270"/>
            <ac:grpSpMk id="901" creationId="{B1E2D1CE-867B-463D-45D0-EA5DD66C4F17}"/>
          </ac:grpSpMkLst>
        </pc:grpChg>
      </pc:sldChg>
    </pc:docChg>
  </pc:docChgLst>
  <pc:docChgLst>
    <pc:chgData name="Nikolaj Juul Nitschke" userId="eb944128-ea9e-41a1-979a-ca9bb959a91e" providerId="ADAL" clId="{FB72BA7A-A123-4CF7-B149-D14E3747318B}"/>
    <pc:docChg chg="custSel modSld">
      <pc:chgData name="Nikolaj Juul Nitschke" userId="eb944128-ea9e-41a1-979a-ca9bb959a91e" providerId="ADAL" clId="{FB72BA7A-A123-4CF7-B149-D14E3747318B}" dt="2025-08-25T09:52:09.277" v="0" actId="478"/>
      <pc:docMkLst>
        <pc:docMk/>
      </pc:docMkLst>
      <pc:sldChg chg="delSp mod">
        <pc:chgData name="Nikolaj Juul Nitschke" userId="eb944128-ea9e-41a1-979a-ca9bb959a91e" providerId="ADAL" clId="{FB72BA7A-A123-4CF7-B149-D14E3747318B}" dt="2025-08-25T09:52:09.277" v="0" actId="478"/>
        <pc:sldMkLst>
          <pc:docMk/>
          <pc:sldMk cId="3863922482" sldId="270"/>
        </pc:sldMkLst>
        <pc:spChg chg="del">
          <ac:chgData name="Nikolaj Juul Nitschke" userId="eb944128-ea9e-41a1-979a-ca9bb959a91e" providerId="ADAL" clId="{FB72BA7A-A123-4CF7-B149-D14E3747318B}" dt="2025-08-25T09:52:09.277" v="0" actId="478"/>
          <ac:spMkLst>
            <pc:docMk/>
            <pc:sldMk cId="3863922482" sldId="270"/>
            <ac:spMk id="2" creationId="{58C52D4F-B2E9-FABC-1813-7D7922B6BCAE}"/>
          </ac:spMkLst>
        </pc:spChg>
      </pc:sldChg>
    </pc:docChg>
  </pc:docChgLst>
  <pc:docChgLst>
    <pc:chgData name="Nikolaj Juul Nitschke" userId="eb944128-ea9e-41a1-979a-ca9bb959a91e" providerId="ADAL" clId="{DB0AC6FA-188A-467D-A641-67A51E13D857}"/>
    <pc:docChg chg="undo custSel modSld">
      <pc:chgData name="Nikolaj Juul Nitschke" userId="eb944128-ea9e-41a1-979a-ca9bb959a91e" providerId="ADAL" clId="{DB0AC6FA-188A-467D-A641-67A51E13D857}" dt="2025-05-19T09:31:32.549" v="112" actId="20577"/>
      <pc:docMkLst>
        <pc:docMk/>
      </pc:docMkLst>
      <pc:sldChg chg="modSp mod">
        <pc:chgData name="Nikolaj Juul Nitschke" userId="eb944128-ea9e-41a1-979a-ca9bb959a91e" providerId="ADAL" clId="{DB0AC6FA-188A-467D-A641-67A51E13D857}" dt="2025-05-19T09:27:56.749" v="97" actId="1076"/>
        <pc:sldMkLst>
          <pc:docMk/>
          <pc:sldMk cId="1461944421" sldId="257"/>
        </pc:sldMkLst>
        <pc:spChg chg="mod">
          <ac:chgData name="Nikolaj Juul Nitschke" userId="eb944128-ea9e-41a1-979a-ca9bb959a91e" providerId="ADAL" clId="{DB0AC6FA-188A-467D-A641-67A51E13D857}" dt="2025-05-15T09:27:33.223" v="19" actId="255"/>
          <ac:spMkLst>
            <pc:docMk/>
            <pc:sldMk cId="1461944421" sldId="257"/>
            <ac:spMk id="2" creationId="{CF38BBAD-ADFC-B72C-5B2A-4C968F6AC845}"/>
          </ac:spMkLst>
        </pc:spChg>
        <pc:spChg chg="mod">
          <ac:chgData name="Nikolaj Juul Nitschke" userId="eb944128-ea9e-41a1-979a-ca9bb959a91e" providerId="ADAL" clId="{DB0AC6FA-188A-467D-A641-67A51E13D857}" dt="2025-05-19T09:27:51.236" v="92" actId="20577"/>
          <ac:spMkLst>
            <pc:docMk/>
            <pc:sldMk cId="1461944421" sldId="257"/>
            <ac:spMk id="378" creationId="{8FFA6A32-E337-21E5-4C87-EAD20EAEFFC2}"/>
          </ac:spMkLst>
        </pc:spChg>
        <pc:spChg chg="mod">
          <ac:chgData name="Nikolaj Juul Nitschke" userId="eb944128-ea9e-41a1-979a-ca9bb959a91e" providerId="ADAL" clId="{DB0AC6FA-188A-467D-A641-67A51E13D857}" dt="2025-05-19T09:27:54.746" v="95" actId="20577"/>
          <ac:spMkLst>
            <pc:docMk/>
            <pc:sldMk cId="1461944421" sldId="257"/>
            <ac:spMk id="384" creationId="{2B8914F6-3E72-E4FB-47D4-A1A59EDA5544}"/>
          </ac:spMkLst>
        </pc:spChg>
        <pc:spChg chg="mod">
          <ac:chgData name="Nikolaj Juul Nitschke" userId="eb944128-ea9e-41a1-979a-ca9bb959a91e" providerId="ADAL" clId="{DB0AC6FA-188A-467D-A641-67A51E13D857}" dt="2025-05-19T09:26:04.203" v="47" actId="20577"/>
          <ac:spMkLst>
            <pc:docMk/>
            <pc:sldMk cId="1461944421" sldId="257"/>
            <ac:spMk id="397" creationId="{0F139325-8C21-A020-1A03-AD5540559B60}"/>
          </ac:spMkLst>
        </pc:spChg>
        <pc:spChg chg="mod">
          <ac:chgData name="Nikolaj Juul Nitschke" userId="eb944128-ea9e-41a1-979a-ca9bb959a91e" providerId="ADAL" clId="{DB0AC6FA-188A-467D-A641-67A51E13D857}" dt="2025-05-19T09:27:13.014" v="76" actId="1076"/>
          <ac:spMkLst>
            <pc:docMk/>
            <pc:sldMk cId="1461944421" sldId="257"/>
            <ac:spMk id="404" creationId="{E4DB4D86-5FE7-6133-7C9F-AA9C1EBBE1E6}"/>
          </ac:spMkLst>
        </pc:spChg>
        <pc:spChg chg="mod">
          <ac:chgData name="Nikolaj Juul Nitschke" userId="eb944128-ea9e-41a1-979a-ca9bb959a91e" providerId="ADAL" clId="{DB0AC6FA-188A-467D-A641-67A51E13D857}" dt="2025-05-19T09:27:24.008" v="84" actId="1076"/>
          <ac:spMkLst>
            <pc:docMk/>
            <pc:sldMk cId="1461944421" sldId="257"/>
            <ac:spMk id="405" creationId="{AECFCA49-5570-1A26-2CAF-29A5A8AC3CC6}"/>
          </ac:spMkLst>
        </pc:spChg>
        <pc:spChg chg="mod">
          <ac:chgData name="Nikolaj Juul Nitschke" userId="eb944128-ea9e-41a1-979a-ca9bb959a91e" providerId="ADAL" clId="{DB0AC6FA-188A-467D-A641-67A51E13D857}" dt="2025-05-19T09:26:58.755" v="74" actId="1076"/>
          <ac:spMkLst>
            <pc:docMk/>
            <pc:sldMk cId="1461944421" sldId="257"/>
            <ac:spMk id="406" creationId="{31A5F2AB-8F05-F025-73D9-8222135CF49A}"/>
          </ac:spMkLst>
        </pc:spChg>
        <pc:picChg chg="mod">
          <ac:chgData name="Nikolaj Juul Nitschke" userId="eb944128-ea9e-41a1-979a-ca9bb959a91e" providerId="ADAL" clId="{DB0AC6FA-188A-467D-A641-67A51E13D857}" dt="2025-05-19T09:27:56.749" v="97" actId="1076"/>
          <ac:picMkLst>
            <pc:docMk/>
            <pc:sldMk cId="1461944421" sldId="257"/>
            <ac:picMk id="70" creationId="{B4C6D859-78FA-7E1F-5483-668A79816C59}"/>
          </ac:picMkLst>
        </pc:picChg>
      </pc:sldChg>
      <pc:sldChg chg="addSp delSp modSp mod">
        <pc:chgData name="Nikolaj Juul Nitschke" userId="eb944128-ea9e-41a1-979a-ca9bb959a91e" providerId="ADAL" clId="{DB0AC6FA-188A-467D-A641-67A51E13D857}" dt="2025-05-19T09:30:07.711" v="100" actId="27614"/>
        <pc:sldMkLst>
          <pc:docMk/>
          <pc:sldMk cId="3546809507" sldId="263"/>
        </pc:sldMkLst>
        <pc:spChg chg="mod">
          <ac:chgData name="Nikolaj Juul Nitschke" userId="eb944128-ea9e-41a1-979a-ca9bb959a91e" providerId="ADAL" clId="{DB0AC6FA-188A-467D-A641-67A51E13D857}" dt="2025-05-15T09:27:29.512" v="18" actId="255"/>
          <ac:spMkLst>
            <pc:docMk/>
            <pc:sldMk cId="3546809507" sldId="263"/>
            <ac:spMk id="2" creationId="{A48B5A82-6A72-A2A5-7ED5-FB856B58F289}"/>
          </ac:spMkLst>
        </pc:spChg>
        <pc:picChg chg="add del mod">
          <ac:chgData name="Nikolaj Juul Nitschke" userId="eb944128-ea9e-41a1-979a-ca9bb959a91e" providerId="ADAL" clId="{DB0AC6FA-188A-467D-A641-67A51E13D857}" dt="2025-05-19T09:29:57.394" v="98" actId="478"/>
          <ac:picMkLst>
            <pc:docMk/>
            <pc:sldMk cId="3546809507" sldId="263"/>
            <ac:picMk id="4" creationId="{05887C78-DBE9-4D8A-6ADD-F0F3D191E82C}"/>
          </ac:picMkLst>
        </pc:picChg>
        <pc:picChg chg="add mod">
          <ac:chgData name="Nikolaj Juul Nitschke" userId="eb944128-ea9e-41a1-979a-ca9bb959a91e" providerId="ADAL" clId="{DB0AC6FA-188A-467D-A641-67A51E13D857}" dt="2025-05-19T09:30:07.711" v="100" actId="27614"/>
          <ac:picMkLst>
            <pc:docMk/>
            <pc:sldMk cId="3546809507" sldId="263"/>
            <ac:picMk id="5" creationId="{432DA040-E3D7-8D51-08CB-50A455965BA3}"/>
          </ac:picMkLst>
        </pc:picChg>
        <pc:picChg chg="del">
          <ac:chgData name="Nikolaj Juul Nitschke" userId="eb944128-ea9e-41a1-979a-ca9bb959a91e" providerId="ADAL" clId="{DB0AC6FA-188A-467D-A641-67A51E13D857}" dt="2025-05-15T09:26:04.782" v="10" actId="478"/>
          <ac:picMkLst>
            <pc:docMk/>
            <pc:sldMk cId="3546809507" sldId="263"/>
            <ac:picMk id="5" creationId="{8E1EE370-AD32-881A-D601-FD939C1AA331}"/>
          </ac:picMkLst>
        </pc:picChg>
      </pc:sldChg>
      <pc:sldChg chg="modSp mod">
        <pc:chgData name="Nikolaj Juul Nitschke" userId="eb944128-ea9e-41a1-979a-ca9bb959a91e" providerId="ADAL" clId="{DB0AC6FA-188A-467D-A641-67A51E13D857}" dt="2025-05-15T09:27:36.688" v="20" actId="255"/>
        <pc:sldMkLst>
          <pc:docMk/>
          <pc:sldMk cId="674599831" sldId="265"/>
        </pc:sldMkLst>
        <pc:spChg chg="mod">
          <ac:chgData name="Nikolaj Juul Nitschke" userId="eb944128-ea9e-41a1-979a-ca9bb959a91e" providerId="ADAL" clId="{DB0AC6FA-188A-467D-A641-67A51E13D857}" dt="2025-05-15T09:27:36.688" v="20" actId="255"/>
          <ac:spMkLst>
            <pc:docMk/>
            <pc:sldMk cId="674599831" sldId="265"/>
            <ac:spMk id="18" creationId="{E24166C1-B2E6-6FEE-9859-31152815C425}"/>
          </ac:spMkLst>
        </pc:spChg>
      </pc:sldChg>
      <pc:sldChg chg="modSp mod">
        <pc:chgData name="Nikolaj Juul Nitschke" userId="eb944128-ea9e-41a1-979a-ca9bb959a91e" providerId="ADAL" clId="{DB0AC6FA-188A-467D-A641-67A51E13D857}" dt="2025-05-19T09:30:45.972" v="108" actId="20577"/>
        <pc:sldMkLst>
          <pc:docMk/>
          <pc:sldMk cId="679851506" sldId="269"/>
        </pc:sldMkLst>
        <pc:spChg chg="mod">
          <ac:chgData name="Nikolaj Juul Nitschke" userId="eb944128-ea9e-41a1-979a-ca9bb959a91e" providerId="ADAL" clId="{DB0AC6FA-188A-467D-A641-67A51E13D857}" dt="2025-05-19T09:30:45.972" v="108" actId="20577"/>
          <ac:spMkLst>
            <pc:docMk/>
            <pc:sldMk cId="679851506" sldId="269"/>
            <ac:spMk id="221" creationId="{CC8155C0-FC75-B2B7-C344-879710259AB3}"/>
          </ac:spMkLst>
        </pc:spChg>
      </pc:sldChg>
      <pc:sldChg chg="modSp mod">
        <pc:chgData name="Nikolaj Juul Nitschke" userId="eb944128-ea9e-41a1-979a-ca9bb959a91e" providerId="ADAL" clId="{DB0AC6FA-188A-467D-A641-67A51E13D857}" dt="2025-05-19T09:31:32.549" v="112" actId="20577"/>
        <pc:sldMkLst>
          <pc:docMk/>
          <pc:sldMk cId="3863922482" sldId="270"/>
        </pc:sldMkLst>
        <pc:spChg chg="mod">
          <ac:chgData name="Nikolaj Juul Nitschke" userId="eb944128-ea9e-41a1-979a-ca9bb959a91e" providerId="ADAL" clId="{DB0AC6FA-188A-467D-A641-67A51E13D857}" dt="2025-05-15T09:27:47.914" v="41" actId="20577"/>
          <ac:spMkLst>
            <pc:docMk/>
            <pc:sldMk cId="3863922482" sldId="270"/>
            <ac:spMk id="2" creationId="{58C52D4F-B2E9-FABC-1813-7D7922B6BCAE}"/>
          </ac:spMkLst>
        </pc:spChg>
        <pc:spChg chg="mod">
          <ac:chgData name="Nikolaj Juul Nitschke" userId="eb944128-ea9e-41a1-979a-ca9bb959a91e" providerId="ADAL" clId="{DB0AC6FA-188A-467D-A641-67A51E13D857}" dt="2025-05-19T09:30:54.860" v="110" actId="6549"/>
          <ac:spMkLst>
            <pc:docMk/>
            <pc:sldMk cId="3863922482" sldId="270"/>
            <ac:spMk id="3" creationId="{91DD5A39-636A-F4A4-D6C7-8151170BBDE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0" creationId="{32FBCCDA-EF35-72E9-B9F3-A173F550C9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1" creationId="{C56BF5D8-BF53-35E2-C9EA-C4416296C33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2" creationId="{45E6FFAC-7F36-A3D1-0EDE-B066BC26D6B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3" creationId="{1FE3230F-CEAD-1F60-BEF0-73B7D2A739F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4" creationId="{99E630F8-ADE2-067E-F6EE-F0272E75F0D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5" creationId="{D630C0A4-01E2-FD0F-0491-0400DEC9F43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6" creationId="{024822C1-9A88-3826-DCF4-4DEB0EFB15C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7" creationId="{5AB5FA75-276A-738A-8FFD-F816D5AB03B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8" creationId="{0B8C86FE-05B9-5FC5-EB21-6C4EA944ED9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89" creationId="{EC098392-ACE9-517A-D2CE-A2DEBA0F2C6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0" creationId="{C1A7F27E-E7B5-3280-514D-C74846B43DA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1" creationId="{ED526CAC-3AAB-6180-38C5-C7D1852F438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2" creationId="{7BA754FC-C7C1-2683-930E-A012B635C9B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3" creationId="{F16D2F41-4DEB-DBDE-E6A4-DB2B2C1BD9F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4" creationId="{7E41742E-80B4-7400-AB93-00EBCE2972F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5" creationId="{53CB9C50-B7ED-29A7-8CBE-F34CA2762BB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6" creationId="{BE4EE895-8B5C-AF39-ECAD-F5543F609A8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7" creationId="{EF4BFEC7-AE13-BCBE-C05D-A7B661922FC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8" creationId="{3440B9E3-CC46-8559-C070-A94FFCA2C25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599" creationId="{95C7BF98-0C07-AD24-D076-DA08AC172AD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0" creationId="{B23B4F06-2E1E-CDEA-21C1-6DD41DBEFE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1" creationId="{F855A74A-144B-2893-C615-5615160EB9F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2" creationId="{67CF3372-C42F-CF74-A95F-552D61D0CBD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3" creationId="{58CFC33F-E992-BA69-BD68-8C49B40B44C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4" creationId="{EF739C28-CE6E-8A2F-7C87-D01F54DBDC8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5" creationId="{842D88E3-8CCD-6796-FBD3-1BEDC15A865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6" creationId="{041D428D-2C74-417C-4F1A-9DA49A27A55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7" creationId="{F584E204-608E-FE51-948F-1A5F4628B39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8" creationId="{724D3C36-53E9-62F6-73A3-D214326A03C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09" creationId="{6FBA2097-5F5A-0E48-ADD1-91726577A5C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0" creationId="{379BDE0A-2DBC-303A-A210-1F3018455B0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1" creationId="{C66445A8-AEF5-790D-F3D2-69E5FCE906C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2" creationId="{216A8935-3922-E8F7-2766-5C396B1F3A8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3" creationId="{B34D650E-A0FE-B724-16FF-B9C733727BE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4" creationId="{396501B4-93E1-28CD-A71B-D36C138CADF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5" creationId="{8D4FD45A-0532-F5FC-0C1E-D89357362CA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6" creationId="{7C8A21D2-C8F6-593A-CC4F-896A06103E5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7" creationId="{BF8FEEC3-9242-BF93-BCFB-9E13A716C34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8" creationId="{66CCA242-B0DD-735A-AC96-6E8C55572E2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19" creationId="{0060D0D8-A4FE-DACD-4E03-C51B2C54D96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0" creationId="{84FD5092-0FC8-63A0-686A-D464E614C26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1" creationId="{7FF8F490-91CA-073C-405C-9024459F68F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2" creationId="{D1BD9481-F8E4-540B-E717-28F7648F53C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3" creationId="{36FC6FB8-6CFA-4BD8-4993-5FC6AF4DD0A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4" creationId="{CD97FEAE-E0D9-6E57-EDB7-1954EB351B5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5" creationId="{DDF6F92A-FB68-8459-072E-666EB7AC473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6" creationId="{468B2470-E179-D7DD-2A95-AED2EFE56DF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7" creationId="{28B7CB63-7EF9-7061-FCE8-A74E3473201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8" creationId="{9E9EA14B-828B-BA92-5889-2BBB337626D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29" creationId="{F10AB2DB-1E14-A4FF-DE6F-7DDAB24DA73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0" creationId="{602ED85E-E12F-40B7-7F42-B660D5D805A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1" creationId="{CA5C4000-42EB-1F28-C2B4-7FFE93D8C48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2" creationId="{56FBA886-E513-72F6-D335-2EB531AAE56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3" creationId="{5D3D2873-24E6-B100-B6FA-67C093351BD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4" creationId="{002E1C34-E4BB-07F4-0B84-2CFF98C59B3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5" creationId="{52608CCB-FB3C-D1AF-86A7-1A7874384D8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6" creationId="{F24DE777-BA13-3BE0-23E5-ABBD7C2364A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7" creationId="{25558826-7C2A-C815-9F93-12F06F1C0DE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8" creationId="{F6F4560F-653E-B248-9660-4B77C058C34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39" creationId="{EDEA6D56-C7B6-E030-E7B2-AFF55F6E598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0" creationId="{46FF0FF2-4AAD-9035-7B3A-5D9EB05B7CB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1" creationId="{1531E1D4-C147-2516-4C99-5BBE7217992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2" creationId="{F2AC7092-252C-A649-0B8B-DD66D0CAFCD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3" creationId="{13E19C14-E454-1800-C466-DA35BD3F6B9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4" creationId="{104E4EB3-82CB-3982-0CA9-E6D4A172D80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5" creationId="{BE189E0F-B532-EA3C-4099-AA6D1C5C832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6" creationId="{F0F4F634-26BF-C4A8-8EF3-5FC44CB0E50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7" creationId="{665B96C7-6ACB-0541-BC85-01087CB203F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8" creationId="{26F02AC5-B54C-B4F7-83D5-F240C621222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49" creationId="{07896913-41C7-48C3-12E2-B0E74BCCBBF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0" creationId="{80B06E50-1F09-39A3-BE95-3F94BB3FBDC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1" creationId="{2BF17141-BAC9-8FB5-3A30-0AF01EC232B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2" creationId="{6144625F-B130-3837-9CE9-7A860651335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3" creationId="{ABA74663-AA3E-A0E1-219D-89EF2339902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4" creationId="{CAF2FF4C-E444-BF3C-7D97-65CCE013701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5" creationId="{BCED7D9F-F1ED-8973-FE7E-1E2BBB6E886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6" creationId="{34F01342-03CA-7CD5-67B8-C2698D38A6E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7" creationId="{7F6E6E88-8C4D-FFD5-AFDC-7646B808B0A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8" creationId="{F086A7C0-0F3B-400D-259B-D264C1FBD66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59" creationId="{33C7140A-B632-F7F0-84E2-F4CEAD6A121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0" creationId="{F4DD763D-4F2F-E714-AC23-9C0498E3706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1" creationId="{7315B172-8391-A3AC-8E91-2DF81162C1D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2" creationId="{0BF4AFD7-6127-D537-ACF3-4E705A7EA78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3" creationId="{98D6FE94-A8A5-54B5-9424-7CA3EAB214D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4" creationId="{9EE65E8C-03E3-83F3-24FA-6FFFE85072C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5" creationId="{F9C3F5F8-FFCB-11F0-EB21-967E2D5CBFE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6" creationId="{40D1F51C-A2EC-8828-B6E3-5D9689D0E39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7" creationId="{07AED21E-80E6-8CA7-AA50-F9E9BBDB3BC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8" creationId="{8E700AB5-1E3F-4643-9200-766C871EFB5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69" creationId="{647FAD95-B44F-ADF2-DF9C-DD9F8E73248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0" creationId="{B678EEE9-4FE0-949A-0C5A-42368896FD6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1" creationId="{6EF585CA-6B18-8295-ECFD-8188C910880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2" creationId="{DA5F8820-758C-BAF8-F73B-065619849C1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3" creationId="{F80D2654-A24D-AC30-6F4C-89A22E1AE02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4" creationId="{FA37174E-7C6F-1457-CE6E-6D027A2080C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5" creationId="{11D1C9A1-D987-B0FE-FF8C-0610ED6739D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6" creationId="{47FE1CAF-F634-279D-89CF-CAF2D5EF985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7" creationId="{43C86B58-31F5-965F-99A9-014BFF3AA7E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8" creationId="{C1310E71-58C7-5522-A788-7121B97E66C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79" creationId="{986E1F4A-85DA-FEC3-6176-683F79991EB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0" creationId="{34B51903-B4B9-EE27-9041-7E6B11002B6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1" creationId="{AE9DBA1C-AC48-7585-B96A-F88D4602963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2" creationId="{AABCFAFC-E7AB-B0B9-5BC0-31389D64F17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3" creationId="{10BACC90-354E-A3FD-5722-5998420371F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4" creationId="{77F43953-8EE9-539A-BE8B-8CAA49DF29C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5" creationId="{542AB410-43A7-B4C9-6AEE-E24A54158AF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6" creationId="{6249A957-69D6-AABF-C0D9-D28892D2241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7" creationId="{28B33D96-BCE3-356F-6D9C-B74237024FA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8" creationId="{46606DEC-5A1B-49F1-36D2-AE9B2C60FE1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89" creationId="{7382578E-6DFC-4746-3ADC-7E965C7C15B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0" creationId="{9E545917-B89B-1E9B-DA8F-A7D1C3677F5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1" creationId="{A1032C19-2354-45C4-A919-9FC9D1EB22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2" creationId="{169AA310-F0C8-68E4-3E7F-0FE38FBAF2C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3" creationId="{F7A26972-E2C3-A916-906F-3A68143C1BB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4" creationId="{96F957BF-E9C7-E428-4162-F8D68B76496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5" creationId="{AD955D4C-D010-DEAA-95E8-3F913D23E11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6" creationId="{3F8DEC0A-9148-FE72-E058-AE188B3451B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7" creationId="{69BAEBAF-2BCE-3426-8CF7-6B4C534E1A8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8" creationId="{FE970AB9-67C2-9D9A-C0AB-50C9AC41C5E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699" creationId="{49A69334-CB7F-853A-B807-AC6030D88EE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0" creationId="{A8768DB0-CC06-5EE4-F047-E177C593D8A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1" creationId="{793AEC83-4413-4066-1FCF-4AA19191581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2" creationId="{F2188F30-7EE4-640B-D103-4D919132C8B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3" creationId="{F063AD8E-BD73-3255-C6B5-71CEDEABCCD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4" creationId="{4ABE1CAC-D6B3-5901-EF1F-98E8C406A4C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5" creationId="{D7A30445-D221-22B5-D0D2-29315E2426D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6" creationId="{26D81C18-73F6-25C4-A08E-7CBE0388F8D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7" creationId="{AA65E4A4-4030-6215-2C0F-782C60335B9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8" creationId="{B5EBB52C-1987-1B52-846D-BFF8CA2DAAE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09" creationId="{CA1CD15D-E032-670A-B475-AD3470F943E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0" creationId="{E99EAC52-175D-59B9-3375-53987DA0AE0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1" creationId="{8B64CE80-F8A0-CDAB-167B-F0F942F76F7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2" creationId="{B0D8C92A-198C-3605-4AE0-666B5E22172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3" creationId="{FC0B5966-4DC7-F503-7531-FAD4D5A0F8D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4" creationId="{B3F7AC1A-1494-5B07-206A-6433F3E6DFE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5" creationId="{5AA342D9-E7C6-1799-BFF2-2CAD93123F7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6" creationId="{86D32651-2707-5A45-9863-EF6875486E4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7" creationId="{CFAFD2EA-C00E-2B52-D4BE-6EF1EB5948A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8" creationId="{DD13B830-D452-B3D6-CC28-6401CFE7D6A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19" creationId="{97B90956-4CFC-8A93-B966-60571EEEF5D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0" creationId="{2D542B09-D46E-7EA0-F2B0-9B38DB18054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1" creationId="{C25FF511-19F4-F4FC-C6F1-A45950495FC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2" creationId="{3569F76A-7978-80AA-0900-2C418C7959A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3" creationId="{FCD70ED5-D6A6-5481-A5C9-E76EFB60B10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4" creationId="{D7DABBF9-6CCD-4640-25D1-C327DF1288F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5" creationId="{332721E1-0D34-4A71-B7E4-93315E3A17E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6" creationId="{DBF1E58C-8AF2-9ACD-E084-82223355E7E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7" creationId="{21419CE0-E794-891B-C78E-2D7FD2A4AEF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8" creationId="{0495E8D5-3578-BF85-D4E7-A06277197A1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29" creationId="{14507357-811F-94B9-6D3F-49B623C5FC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0" creationId="{DEABE43E-0128-895F-BF4A-15A965D0526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1" creationId="{8F0ED752-B82D-EDEE-540D-2E9E1B8AB31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2" creationId="{6C8D36AA-D2D3-CF48-48BE-F1C97DA2A23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3" creationId="{1B4CD7EE-11B2-13BC-0383-5FD1231B73B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4" creationId="{A2833B09-98AD-4533-578A-42902AEE68D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5" creationId="{63FF6698-2F0F-1F22-ABA9-E491A8F91C1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6" creationId="{9547B420-8CE5-3180-E2E7-22275C9FB82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7" creationId="{3B432DFE-DE1E-3686-49D8-8316E7F29E6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8" creationId="{2E77FA27-94E6-308C-0FBC-ADA1C3CF557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39" creationId="{41A90F02-057B-62F0-86CD-DC4887E1F74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0" creationId="{2A58F413-D129-8CE4-3A00-48BF8EC392A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1" creationId="{B725AC17-4503-9A2A-CE30-064040CE4B9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2" creationId="{2420DAD5-488A-D7FC-ACF9-885804F8A8E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3" creationId="{687B24C7-7997-5CD5-D3AF-DF32CF175D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4" creationId="{C3C737C3-1640-D4B5-B1B1-2917FBF6E45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5" creationId="{53163275-F15B-7DE4-924D-C5CD5F34A24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6" creationId="{5AF1DFDD-1C23-5FCC-FB40-0F113F6144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7" creationId="{F29BE31B-6F7F-359C-ABEE-2923AE8CAE8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8" creationId="{0B8B9937-6F3A-C19B-C003-4D75945D40D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49" creationId="{2077CE96-62A1-18B6-BC13-4CA74084CC8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0" creationId="{67F14A2C-3E93-B328-5259-1A9C5073BF2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1" creationId="{02F793B7-3CBA-D979-7E8D-695259B4600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2" creationId="{4D5A63E0-6107-4405-9F56-EAFCDFCD83D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3" creationId="{4E03C293-8664-3724-86C1-5BD58B0FD3F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4" creationId="{64AEDDC4-A64A-8E0E-FE66-85DF2913944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5" creationId="{AA293791-7A84-A460-0B34-022694B04A5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6" creationId="{47B12CEB-43EA-D438-03E5-22A59835E24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7" creationId="{5583F707-1405-5ECE-C259-A89636ADE91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8" creationId="{373B9EE8-7644-D290-3DE2-0386B4068FD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59" creationId="{29C956AB-4F15-474C-2C79-696E7D16289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0" creationId="{CD2A8748-3236-A324-7999-9BFD6DBB9F3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1" creationId="{203292CB-ABBA-8447-124E-033EA8CE1E2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2" creationId="{8DDCE060-331F-1FCE-8E85-3720ECC2580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3" creationId="{9E8156B7-D905-F51C-D5BF-C17500B8B6E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4" creationId="{9188CF57-1793-FF63-735A-A5A4ABE3945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5" creationId="{4A10BA87-4866-39D6-D678-F10DFC850F9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6" creationId="{287493A7-0D9E-A06B-4098-E06CA2A7EB5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7" creationId="{011281CF-A169-52BD-5CDF-C847DD5434B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8" creationId="{28BA5351-F69A-7331-B2D1-6D58021DF68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69" creationId="{C91FCF5A-2F3B-FF0E-2A0F-9F6DFC13DC9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0" creationId="{1A61BABF-4F6A-44B2-9600-2E82F533A8E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1" creationId="{295B7C1D-44C2-6AFB-813B-3E93F772942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2" creationId="{8CFDE4DF-3286-20CE-6C72-C566C684D03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3" creationId="{20C63497-4E9E-501C-1893-7F29FE20D60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4" creationId="{7CC40965-B935-2389-B4EC-0C4B2A0BC4D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5" creationId="{7EB06B40-DE73-1554-4A51-BE26408B551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6" creationId="{D6C5ED87-8FF5-63C6-2C00-1E0667572B7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7" creationId="{D59FE2B9-B9E0-1F5B-8E66-B5550E03ACE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8" creationId="{CF7F9A3C-1353-E2DD-DCCD-87A0E7B3488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79" creationId="{8C1065A1-92D1-FCC7-382A-75AC4F78C16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0" creationId="{DA5AD26C-334A-61CE-EC45-4CAC7F95F23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1" creationId="{CA2D96B0-F9FE-810D-9697-85352DA0858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2" creationId="{5E288AEF-4E02-CAAF-4424-87867FC9311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3" creationId="{CE841CA6-86B5-45FE-9A55-80AAA7E3E81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4" creationId="{A390A72C-0242-CB3D-EBF4-76F03C2A599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5" creationId="{3A76D7BB-641B-607F-B6DC-747C9312B69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6" creationId="{1FCC49A0-4FD2-9DF9-8FDE-2A708A29830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7" creationId="{1D861691-3E1D-3D43-8C66-E27D06A69D7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8" creationId="{D211FFAC-C898-0FBF-9228-5848CC830B5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89" creationId="{49453394-D767-8897-E1A6-810DC7C4C56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0" creationId="{D863CC00-AB69-33FA-9462-71D6E9F1218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1" creationId="{5DD51714-1456-DD1E-E0C2-48B9AD35AE1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2" creationId="{1F77B591-DA8A-84F7-006D-B4283AC4191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3" creationId="{CB599DBF-FE0E-DD15-1ACA-54A167C0F4D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4" creationId="{5819DB79-3215-D9DB-FC8D-4A055AE5FF1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5" creationId="{5ACBD314-0767-CAE7-096D-5182DE05A40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6" creationId="{DB922026-3C13-EAE4-8603-2F6BA1A8BD3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7" creationId="{6DF9B1D9-463B-C0FB-6AC1-E25623E1C8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799" creationId="{A67CDCD2-624C-FFFF-9F2B-55C5E36498D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0" creationId="{DCF03673-FC5A-861A-3B60-5B4CCE12236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1" creationId="{6C3164E6-A5E1-9821-B3EE-0DF2B19CF78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2" creationId="{DC5BB67A-0DF5-A9D9-2443-4AE649F6A07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3" creationId="{5C0141A0-DE11-B8E4-CD6E-3B474D7F23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4" creationId="{A5976641-A4B4-2863-309F-D4BD59F4E44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5" creationId="{F21772EE-F0F2-4D58-8772-A7A7C52C4B0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06" creationId="{BEBE402C-0E7A-AF91-F70D-249926CE9CE0}"/>
          </ac:spMkLst>
        </pc:spChg>
        <pc:spChg chg="mod">
          <ac:chgData name="Nikolaj Juul Nitschke" userId="eb944128-ea9e-41a1-979a-ca9bb959a91e" providerId="ADAL" clId="{DB0AC6FA-188A-467D-A641-67A51E13D857}" dt="2025-05-19T09:31:32.549" v="112" actId="20577"/>
          <ac:spMkLst>
            <pc:docMk/>
            <pc:sldMk cId="3863922482" sldId="270"/>
            <ac:spMk id="807" creationId="{959C1E54-ADB7-20C8-598C-10FF58E09AD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0" creationId="{512D33EA-F357-39C3-A86C-245D979BB39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1" creationId="{D7E7EE48-AD45-8AE9-6519-67E9C82E350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2" creationId="{B7A74D61-2E6B-F90E-915E-234CF215646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3" creationId="{2E40B172-E93F-10C2-1139-C2B6B386BE4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4" creationId="{7904156D-493A-4DAC-02CD-073D56FC975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5" creationId="{6EE1D428-7420-FAB7-C405-3F78C8FF17D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6" creationId="{B7AB858E-55AD-186F-E7E2-05D79AE5104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7" creationId="{ED067615-072E-2832-D77C-895984186A3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8" creationId="{EFD2CC4A-AEFD-081D-CEBB-D527029B019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19" creationId="{D450D963-CFBA-3F72-7B1C-2F93F972F1B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0" creationId="{6C598078-FFAB-B0E1-7A44-7ABF7C2D6F8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1" creationId="{309B9EC2-1ECA-0B51-E5FD-F2EC9C23D12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2" creationId="{DC36C988-E6F5-D494-76C8-8051C7762A9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3" creationId="{764C928B-F797-A78E-9DEA-1D9D33F5A6F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4" creationId="{7CBE9951-03C8-3284-4879-0754D8598B9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5" creationId="{53B92EC4-A918-09B8-2E23-2E15E0B985F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6" creationId="{DE6E957A-3134-F618-61F4-732F391624F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7" creationId="{782F52A7-C330-21DD-EED8-E911D9780C6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8" creationId="{FF9B78B8-979A-A75C-3745-27D91EEEDDB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29" creationId="{82EFF1DC-3ABE-9676-84D5-118E825E554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0" creationId="{E671ABFD-EFEE-2604-28AF-B471D81336E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1" creationId="{8699876C-B37B-BB78-A18A-C322BE239CD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2" creationId="{F4B9CA1E-8B28-6464-4FD8-41EC47E4777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3" creationId="{8D3861EB-38EA-2EB1-CC50-8565E2116CD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4" creationId="{9508362E-EC40-BB60-2ACD-5D868004242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5" creationId="{45288C88-D57E-EDCA-4F37-941D7E092F5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6" creationId="{476BC3AC-6DE2-BCAB-B277-5D00F7CA372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7" creationId="{D4943500-A058-5C65-1DE1-8097720281B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8" creationId="{B79E3640-D51F-C3FE-AA01-F8B13806109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39" creationId="{040421B1-BD81-77C0-1C3E-4E2C0ACED0C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0" creationId="{1F4216A2-566F-026F-6608-7259ADA7C1D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1" creationId="{BC0EA7F4-3EC9-AF6F-9903-DE6BE8DAE25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2" creationId="{49DD4389-3E75-7FAC-42DC-CA78F236F36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3" creationId="{68C2F4B1-9C65-4571-7FF4-D30128A9320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4" creationId="{54D92E06-320B-7B23-DDA6-84B4A5BF883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5" creationId="{80C8E487-6244-E38C-33D0-C2B2085F9B4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6" creationId="{772724CE-582D-63A6-3019-706A784D9AD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7" creationId="{81A60FBD-D3E3-66D8-61EB-5AE72B06769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8" creationId="{0B67A737-4A35-7B74-E327-709ED57E8D9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49" creationId="{26D693EA-3E3C-763A-AC26-B1D91FF6323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0" creationId="{FDFAF422-009C-A544-020F-94367F0D162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1" creationId="{8F68215B-7CD2-746C-B3F9-96D2AE5B980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2" creationId="{ABE31E36-A3D1-7D1E-88A4-A0E527DC058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3" creationId="{47563CD5-B369-B10C-5ECB-A677005019E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4" creationId="{055317CF-101D-681D-803D-F62ADFF0A33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5" creationId="{76790BD5-ECB0-DCEF-F867-89C0F58C316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6" creationId="{190544BD-724F-F6AB-8D8C-D1BF378F40F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7" creationId="{9F2389C9-D9D3-055D-685F-4B38155B275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8" creationId="{CFFC0A89-DB95-D456-EA93-8AFAC668DBE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59" creationId="{DD98484D-DE61-816B-959D-97687E34969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0" creationId="{6B8BB59A-722A-97BC-A173-4F0BFF1C54D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1" creationId="{9F288635-6E77-5BE2-B3F5-2383CDB2DF8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2" creationId="{C2DA94E7-8CE8-270B-B49A-FA847878C78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3" creationId="{53852767-DD42-BCE4-E4B1-DFB3F0962FF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4" creationId="{EC209412-B7D1-804E-D44D-123FC4661D9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5" creationId="{04E77B5C-FF9D-9E37-1FAE-47F52BF82F7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6" creationId="{D65F0C47-F501-7F6D-219F-4A5D48A2BF7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7" creationId="{CE0013AC-7FD8-975E-AF2D-B0028EB3130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8" creationId="{A3C243D3-CCAD-646B-B040-CF24B04DED2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69" creationId="{BEBAB621-B519-2221-7B3A-ABAFB509669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0" creationId="{BBFF8221-BFA7-8C83-4D19-00CF2DD630E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1" creationId="{136FEBAC-559A-AA29-117C-05B83FA10BE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2" creationId="{8D37244B-4AA0-2E0D-FC63-5C09544ED70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3" creationId="{88600A13-841B-D4DF-CD05-AB240A37BE0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4" creationId="{74300986-9F70-7AB5-9267-E41558F7336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5" creationId="{17A17937-07BB-6FEF-94F2-87C9222E334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7" creationId="{ECA8562D-B745-83B2-2A39-808FD9F31F1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79" creationId="{D0A525CE-B8EC-15DE-BC96-945E5B9FE2A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0" creationId="{276A44CF-A066-1A0E-07C8-0702BDED474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1" creationId="{4C91CF23-A95A-CD6A-2638-700F492C792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2" creationId="{9753C01E-4743-6F58-FCFA-DB8D83D73E3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3" creationId="{3CF5B428-0F73-6A0C-12CA-7BAE50FB904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4" creationId="{71211045-9318-8E95-8BBA-D5D2A921A60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5" creationId="{2832338B-8990-0383-69BB-9F976B76241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6" creationId="{79B0159C-5FCE-50D4-851D-6A12A56DA25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7" creationId="{78540002-CB31-394E-3CFA-FC1131E3B1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8" creationId="{22146EAD-0BD8-72C0-364E-5D7091D5BBE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89" creationId="{EB17BBC0-6782-952D-EAA9-BB3A4BA152A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0" creationId="{537C2FA8-4813-F771-3142-C85BC51C0A1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1" creationId="{EE71088F-6FEC-62D0-637E-2825382E7FF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2" creationId="{A834E494-BCDF-C296-1314-C59845D1F33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3" creationId="{1605AD0C-A99B-5757-6ECF-5460D50E17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4" creationId="{744159DF-EC37-4ECC-33F8-75ECF3BEC0F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5" creationId="{B81135CC-199B-F133-7746-7A929339030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6" creationId="{23DADE81-7D2B-8BF8-D246-7A5F9B4BD3E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7" creationId="{44BC1ED7-442E-20BA-6DDD-94DE0A56AAF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8" creationId="{C8B17B38-720C-8FE1-F786-D7BA8C595E9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899" creationId="{7712632E-FFBB-FFFF-B56B-C73671692724}"/>
          </ac:spMkLst>
        </pc:spChg>
        <pc:spChg chg="mod">
          <ac:chgData name="Nikolaj Juul Nitschke" userId="eb944128-ea9e-41a1-979a-ca9bb959a91e" providerId="ADAL" clId="{DB0AC6FA-188A-467D-A641-67A51E13D857}" dt="2025-05-15T09:27:14.284" v="17" actId="1076"/>
          <ac:spMkLst>
            <pc:docMk/>
            <pc:sldMk cId="3863922482" sldId="270"/>
            <ac:spMk id="900" creationId="{188940DE-AEA1-CB63-3E99-AFD87CEF5D1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2" creationId="{E12E5FAF-A967-3CAD-4A80-3EE6822FE72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3" creationId="{9BCA9959-F9AB-23A1-F3A7-218DDC9DE24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4" creationId="{ED4878EE-04E0-B503-AC3B-292851F790F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5" creationId="{F2F421FC-1C6E-35A6-3EDC-F96046F3796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6" creationId="{7EA70144-53D1-7243-FC81-32F1C872F85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7" creationId="{0959A694-FB49-84BD-7810-9BD22504813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8" creationId="{561CB5E3-77CF-23DB-5AA6-AF9735F9AA3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09" creationId="{58FE53DA-1E58-F49E-4FF6-C659E6B329A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0" creationId="{9751DB92-0776-CA10-E164-3F86D7661AD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1" creationId="{D484AB33-7B8A-C7F3-5BCE-912EDC3FD29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2" creationId="{82DD0A19-32D5-75C7-D0B5-65C26BFE3E7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3" creationId="{7FC29FA3-E87C-3308-8870-1DEC0ECFDF4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4" creationId="{035FAA26-4028-4912-9C9D-813EAEE17EF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5" creationId="{EAB7E48A-55AC-F442-AE31-AED13244F4F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6" creationId="{9652C6F8-6D15-46FF-697A-52BE056E804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7" creationId="{87DD4A3F-8365-EB4D-9AC0-175F3D467DD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8" creationId="{3C9EC897-7226-8634-1A0A-14A70219A02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19" creationId="{859F4B59-04B2-3016-4D30-F7CBDBE6AE8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0" creationId="{E20C9DD2-F57A-9A02-71C2-01F56DFDB0A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1" creationId="{5E780734-8493-9BBF-A3B4-19B42052D3F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2" creationId="{6690DE75-5752-E743-5A72-D758CCD9AF3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3" creationId="{46F5F5E7-DDEB-D054-8CF4-CBA7D7E0089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4" creationId="{7C155D5E-6B6C-F850-AE64-F20F7C22481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5" creationId="{8FB74AB2-57C5-919F-2210-952466826C5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6" creationId="{F0FB54FC-9130-94B9-5FFA-808E1A102AB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7" creationId="{F54556C8-EA80-EDCA-CC29-FC269D3A2F9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8" creationId="{BADEE4CE-5BA0-8D42-7649-1665BB05DA1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29" creationId="{BBE5C58E-8702-E8CB-7698-5A3B444DC2E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0" creationId="{57424FC6-92B5-01FE-0F71-3C51940D6DD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1" creationId="{5CFE7110-D58E-8466-4D72-AB8AF317F94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2" creationId="{FA39F8CB-EC9D-A0E3-D3CF-C291D62E15A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3" creationId="{25D823E4-C6FE-11E9-AA55-F07167A862B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4" creationId="{9ADA8E87-4B45-8DFF-F10C-293D7D34377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5" creationId="{0BAC7084-2587-8358-B485-42B4A5E1F3B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6" creationId="{F4FBD28D-B4B7-C87B-E4A2-5DF3ACE2CDE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7" creationId="{F2692AAC-B06B-8C5D-A166-05F39A63B93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8" creationId="{A9FF2167-2E61-82F5-7C21-A5A6A0D2987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39" creationId="{5234EF8D-6407-9CE4-DC86-9280162BE59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0" creationId="{700CE309-70C7-52FF-DF69-50FA0437BB1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1" creationId="{BAB598B8-5919-A641-82C8-83A3CE709A0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2" creationId="{38CC8D01-40D1-4F4B-5392-B6A753F1114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3" creationId="{4168268B-F817-0011-ACC9-76C7AA145FE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4" creationId="{ECDC311A-9FC0-5365-75C0-6F2E6A67DAF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5" creationId="{FA4E3654-0C50-94D0-5F8B-BE3A0BD81C40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6" creationId="{D53C19F1-3B5A-CF7D-179F-500A57496A2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7" creationId="{E0D5C372-1C65-2268-CD41-E5FC1DB1973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8" creationId="{7E90DDE8-D7A3-69DA-1A91-733F0EF89DE9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49" creationId="{24DA443B-7463-51AA-70B9-C5EDF87C2CE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0" creationId="{F3AE1445-FF18-722F-1BD2-B450FF82851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1" creationId="{8DA279B7-5F5A-772F-8948-6D8809DD4A7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2" creationId="{83A55A0F-46F5-E411-6E97-9837CD823AD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3" creationId="{F8C04900-998C-E1EF-DC2C-893277D8263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4" creationId="{63B54825-F3D7-5B4B-0FA1-2E2F113B947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5" creationId="{5556A2EC-3FF0-6132-74B2-B31EF9E8B6D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6" creationId="{7F0AE2CD-3FDB-5923-9452-926453AE925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7" creationId="{60265557-6ED0-7B3E-8977-481C11FA2EB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8" creationId="{28975DA9-3D39-1066-90F5-C2F00674795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59" creationId="{98F2520B-8A6F-C101-0268-B9E56AFD390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0" creationId="{7161B705-552A-7DB1-086D-23AA950BD98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1" creationId="{ECC6A0D8-2DCA-2F9C-A3E2-C23AFA3ACBF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2" creationId="{D3871A0A-BFAC-E313-9477-DD29B4D4CAE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3" creationId="{B051F84D-B2D4-0F2E-6D4E-E540ECA60BF8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4" creationId="{A1BD7EDE-4025-2381-F6A9-F3B37860C9D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5" creationId="{F711FFE1-3293-3CDB-69A5-ED6A2E6ADF7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6" creationId="{9320842A-7E4B-7B6F-1290-CB3EEF7E9A5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7" creationId="{AF8D9463-7BB8-DAF6-F5FB-4C17C62A4D5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8" creationId="{EF1C5ED4-D06E-2E11-A4D9-486997076FC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69" creationId="{26DFDC4F-8345-D1D3-7394-114845AAC97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0" creationId="{9E49B0B9-C62E-0194-B0C9-9A7EFFC9B46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1" creationId="{58CECD09-4439-C153-0459-B51F17C5727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2" creationId="{542FDE27-C2FC-88BD-7BA1-0413373A420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3" creationId="{615A9B1C-7FC0-D419-D028-6993E3AA850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4" creationId="{D432451B-424F-A03D-FC51-8A085F336A3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5" creationId="{5D129B80-D608-856D-C91E-4376D324B5F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6" creationId="{BA5109EC-5F75-FAE9-28B2-2A814F56B1A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7" creationId="{C7AD178A-0AC5-E974-2695-D0DB2AD9D75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8" creationId="{FB4363F0-FE03-EB79-8B76-C217B16B03D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79" creationId="{B4241D99-7A4B-9211-DB38-017C4575A58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0" creationId="{ACA3C31E-754F-6B5D-1147-F3CB86222AC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1" creationId="{7C7D1658-A087-0F85-F538-8E28DD0F092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2" creationId="{7D09C544-4AEE-4B7A-B1CD-1FA42F84F2C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3" creationId="{B8899A61-A76B-A5C0-DBCA-E9B07EAF827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4" creationId="{14C59FE1-AF69-34A8-CB6E-9D4F5525C04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5" creationId="{195B46E5-E1BE-61EF-6FCC-EF2BA62DD8E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6" creationId="{F40C4B69-F725-AA81-7AE2-FEBAFB59769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7" creationId="{43E1D1EB-982D-736D-B2B4-17CFE2DA910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8" creationId="{871584F2-CCB6-A409-CAD7-9E41B603ED1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89" creationId="{A1416F32-84C9-2D63-6E89-53E7EF05143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0" creationId="{0B428F84-14CE-E88E-140A-E26D7482A73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1" creationId="{58830785-53A9-4BA1-5A55-1623DD904A5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2" creationId="{45D39D28-6A99-98E2-C54E-7AFB84977FA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3" creationId="{76CB4348-94A1-5B38-6BA9-23BECA5E712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4" creationId="{E4F3C2A2-25FF-B594-1895-45D00EB0DD4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5" creationId="{AB56096A-1A65-BBCC-0B25-026912A0D0B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6" creationId="{EEED7E06-FF5D-7B49-34C4-1E04EE4D35F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7" creationId="{652466EB-1714-134D-CE71-F8BEEF636AC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8" creationId="{78054524-2B77-1D0F-85FF-0BD3B7E08652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999" creationId="{7B09B687-2A74-785E-AF3C-5CDE805F6F3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0" creationId="{C438191D-88F7-1D64-037D-480519AEF1F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1" creationId="{8D8C71CF-7CFC-4E71-AE0A-DA787F26A7A3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2" creationId="{870BD392-91E9-9136-AA76-162C906A7275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3" creationId="{891C3F5B-DA02-4D3E-D7D7-384827A6A5D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4" creationId="{32E5270F-05A8-1ED3-ABC7-DBD20E1F24BC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5" creationId="{21FFC091-DE1B-98CA-6BA3-64FA2DCFDCCB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6" creationId="{FFD30528-1065-2B1E-DBF8-EEEA630A0F5A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7" creationId="{5BC8AB96-1BBF-BAB2-8233-8EBA3B14C23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8" creationId="{F62D4FE7-A5CF-2643-C6C7-9B2AF5E21936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09" creationId="{D0E08357-AE5A-1C51-C0DB-FE8D7D635DB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0" creationId="{2200D68E-EC99-EF64-A5E8-6339537BCE71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1" creationId="{C59066AC-036C-F888-0BAD-37A74330FC8E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2" creationId="{F283F686-6499-BE38-86FC-681FBF72067F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3" creationId="{8E736964-CF98-F63C-BC31-E39FF5642B57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4" creationId="{DD1E245D-87F1-31AA-22EB-E863DEF85004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5" creationId="{C290A499-E4CE-A6E5-E5CD-BA301C0D375D}"/>
          </ac:spMkLst>
        </pc:spChg>
        <pc:spChg chg="mod">
          <ac:chgData name="Nikolaj Juul Nitschke" userId="eb944128-ea9e-41a1-979a-ca9bb959a91e" providerId="ADAL" clId="{DB0AC6FA-188A-467D-A641-67A51E13D857}" dt="2025-05-15T09:26:46.587" v="13" actId="2711"/>
          <ac:spMkLst>
            <pc:docMk/>
            <pc:sldMk cId="3863922482" sldId="270"/>
            <ac:spMk id="1016" creationId="{C8054B6F-883F-4A93-11DD-DA000E62C1D2}"/>
          </ac:spMkLst>
        </pc:spChg>
        <pc:spChg chg="mod">
          <ac:chgData name="Nikolaj Juul Nitschke" userId="eb944128-ea9e-41a1-979a-ca9bb959a91e" providerId="ADAL" clId="{DB0AC6FA-188A-467D-A641-67A51E13D857}" dt="2025-05-15T09:27:05.848" v="15" actId="1076"/>
          <ac:spMkLst>
            <pc:docMk/>
            <pc:sldMk cId="3863922482" sldId="270"/>
            <ac:spMk id="1017" creationId="{04B1743F-D8F3-91E9-2846-98AF5B949FB5}"/>
          </ac:spMkLst>
        </pc:spChg>
      </pc:sldChg>
    </pc:docChg>
  </pc:docChgLst>
  <pc:docChgLst>
    <pc:chgData name="Nikolaj Juul Nitschke" userId="eb944128-ea9e-41a1-979a-ca9bb959a91e" providerId="ADAL" clId="{D27D42F3-7890-4CCE-A4D0-717529310F7F}"/>
    <pc:docChg chg="delSld">
      <pc:chgData name="Nikolaj Juul Nitschke" userId="eb944128-ea9e-41a1-979a-ca9bb959a91e" providerId="ADAL" clId="{D27D42F3-7890-4CCE-A4D0-717529310F7F}" dt="2025-05-19T09:43:55.807" v="0" actId="47"/>
      <pc:docMkLst>
        <pc:docMk/>
      </pc:docMkLst>
      <pc:sldChg chg="del">
        <pc:chgData name="Nikolaj Juul Nitschke" userId="eb944128-ea9e-41a1-979a-ca9bb959a91e" providerId="ADAL" clId="{D27D42F3-7890-4CCE-A4D0-717529310F7F}" dt="2025-05-19T09:43:55.807" v="0" actId="47"/>
        <pc:sldMkLst>
          <pc:docMk/>
          <pc:sldMk cId="1461944421" sldId="257"/>
        </pc:sldMkLst>
      </pc:sldChg>
      <pc:sldChg chg="del">
        <pc:chgData name="Nikolaj Juul Nitschke" userId="eb944128-ea9e-41a1-979a-ca9bb959a91e" providerId="ADAL" clId="{D27D42F3-7890-4CCE-A4D0-717529310F7F}" dt="2025-05-19T09:43:55.807" v="0" actId="47"/>
        <pc:sldMkLst>
          <pc:docMk/>
          <pc:sldMk cId="3546809507" sldId="263"/>
        </pc:sldMkLst>
      </pc:sldChg>
      <pc:sldChg chg="del">
        <pc:chgData name="Nikolaj Juul Nitschke" userId="eb944128-ea9e-41a1-979a-ca9bb959a91e" providerId="ADAL" clId="{D27D42F3-7890-4CCE-A4D0-717529310F7F}" dt="2025-05-19T09:43:55.807" v="0" actId="47"/>
        <pc:sldMkLst>
          <pc:docMk/>
          <pc:sldMk cId="674599831" sldId="265"/>
        </pc:sldMkLst>
      </pc:sldChg>
      <pc:sldChg chg="del">
        <pc:chgData name="Nikolaj Juul Nitschke" userId="eb944128-ea9e-41a1-979a-ca9bb959a91e" providerId="ADAL" clId="{D27D42F3-7890-4CCE-A4D0-717529310F7F}" dt="2025-05-19T09:43:55.807" v="0" actId="47"/>
        <pc:sldMkLst>
          <pc:docMk/>
          <pc:sldMk cId="679851506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0E7CF6-ADC0-46D7-B257-29010AF96D1E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7F13C-4F37-402F-892C-472DB0701783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97379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F2D8A6-2B0D-D483-DD86-EACFB55D64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BB92740D-1D99-446D-EA6C-DAF604672D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341629D-0F7A-CBF0-C732-A2071DB51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3CC45E8-C8C3-075D-D6E3-3D6C7290B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54A22AE3-65D8-FBFB-D921-0B4CF4D74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24076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4283D09-95B7-C024-924D-484739E6DF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0CFFE4EA-7097-7297-E8E4-4AD887D273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C0165B0-6A08-9A9A-7649-CF60EA46F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52177E2-9DA0-7597-389E-B54581F3D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6A9F03FF-942E-AD8E-3F51-03B0A7BC5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91717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5B8B0E49-AAE6-DAE1-8219-10FC1DE2F3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F3AB69B7-6924-C7F0-75CA-821809A21F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AF752F35-5E5A-18BA-3C88-99499B58A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14427925-AEC8-F35F-1EA6-2C8466BA2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6C7B04D4-4DE3-4EF6-C1D3-BF41551A4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21934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5FAB19-57E4-5703-877E-0EE69C247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98EAE72E-6935-1D56-DAB6-5E6139EC2F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88CC012D-20F8-84FD-635E-E95AECE22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7490B226-5305-A83D-00A4-2FFEAEAF3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704C760-E9BD-CBF6-5365-A5874711A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5351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D70947-66F1-59F1-1201-512D0310BC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05C05375-F294-7F9B-4518-AF24CD5A87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91535816-8D38-C1FA-FC69-2763E9D02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20FE9051-6F3D-EBD7-E6AD-E7FC2BD02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4BDE90CA-070E-6A5A-A206-ECB08A6B7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25158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FA1AEB-2918-75E4-46B8-DE059B8B0C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B60E5E28-A1F6-2838-0811-55CF2265D2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1C8580C1-61E1-973E-35B3-51EA902E38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AAC3E0DC-D242-7F54-9348-27854445D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30B33E3A-90E6-4983-4846-E6FD16E61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8B9875D4-87E1-EFAB-CC1B-E07E2C943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9042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53A26F-AF87-91C3-B5A4-DCC3936537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AFDAE3D3-A5B1-C186-3D07-C6BC6728A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700F101C-7A27-4993-D229-95CEA8213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C59EF202-BF2A-A8C6-0853-6B553C68C3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5401EAF5-E1C9-F6B5-FEFE-16844CBC4A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E369CA36-03F8-6101-9BD6-7D764090E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59C5146B-4B4C-0647-5C7E-D30E207FD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17A7F776-00A0-A590-7ED4-308C1DB94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13181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12CD8D-F7E6-ACC8-BC4B-1A2951D0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4A9845FF-A6A3-E05C-C063-8941D04B8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B921F121-C121-5443-D458-D39A7FE37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CA318D13-879F-EB6D-0ECC-1FCDC486F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62800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CBFE2692-ECD3-8D2F-3EBC-D781DDBE3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9ABD5DD8-BD4D-FDBD-E673-6113A936B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D01D7B23-0F40-77ED-077C-7601AF989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82190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FE7000-605E-0E21-6F89-07B3E5EAA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270C21B6-4BA9-1AA2-0B76-EDA6F9AB33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AEE3F943-4C2E-1004-7DF0-DF8EFC1FBF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9C5569E1-CDE7-B8A2-1CCF-BD4CACBC9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4818243D-A976-8C8E-CC03-09936EC3A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86F99C9D-2B3E-6EF6-DA8C-164D76470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53525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B608FCF-D23B-1973-EE60-DB02680FF2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53C4DB40-40ED-F642-AFD2-5F028478E6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815AD6C9-C73D-EEC4-4CE9-6A39F42775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871EDF90-3BA0-C946-8EFC-48FF4EBB5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545558B7-97E5-5B8B-3D1A-A9ED4F7C8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1D063283-D70E-E2A5-C2B9-88F0281D8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02364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FC269E69-5F3C-C482-3B3F-CFCBDB46C6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7ABAC1D5-DA44-0B47-7E07-A646B8FA3C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D0E55E7B-D98E-FF17-33CA-A88E703D11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3A0C9-F97D-4290-8DE9-B41EB83FB17B}" type="datetimeFigureOut">
              <a:rPr lang="da-DK" smtClean="0"/>
              <a:t>25-08-2025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C157495A-6DBD-8D41-C18A-DD2920C13A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6F08B37-B96E-08E8-0891-89A54D1D12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DCB1B-F199-4FC4-91A6-885AC42C22AF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7379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9" name="Gruppe 578">
            <a:extLst>
              <a:ext uri="{FF2B5EF4-FFF2-40B4-BE49-F238E27FC236}">
                <a16:creationId xmlns:a16="http://schemas.microsoft.com/office/drawing/2014/main" id="{25F09E52-2BE9-8794-298A-5378277CA9A1}"/>
              </a:ext>
            </a:extLst>
          </p:cNvPr>
          <p:cNvGrpSpPr/>
          <p:nvPr/>
        </p:nvGrpSpPr>
        <p:grpSpPr>
          <a:xfrm>
            <a:off x="948794" y="144910"/>
            <a:ext cx="10855279" cy="3634346"/>
            <a:chOff x="546506" y="90866"/>
            <a:chExt cx="8316619" cy="6062693"/>
          </a:xfrm>
        </p:grpSpPr>
        <p:sp>
          <p:nvSpPr>
            <p:cNvPr id="580" name="rc5">
              <a:extLst>
                <a:ext uri="{FF2B5EF4-FFF2-40B4-BE49-F238E27FC236}">
                  <a16:creationId xmlns:a16="http://schemas.microsoft.com/office/drawing/2014/main" id="{32FBCCDA-EF35-72E9-B9F3-A173F550C9B2}"/>
                </a:ext>
              </a:extLst>
            </p:cNvPr>
            <p:cNvSpPr/>
            <p:nvPr/>
          </p:nvSpPr>
          <p:spPr>
            <a:xfrm>
              <a:off x="1141029" y="800363"/>
              <a:ext cx="5290116" cy="496420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1" name="rc6">
              <a:extLst>
                <a:ext uri="{FF2B5EF4-FFF2-40B4-BE49-F238E27FC236}">
                  <a16:creationId xmlns:a16="http://schemas.microsoft.com/office/drawing/2014/main" id="{C56BF5D8-BF53-35E2-C9EA-C4416296C337}"/>
                </a:ext>
              </a:extLst>
            </p:cNvPr>
            <p:cNvSpPr/>
            <p:nvPr/>
          </p:nvSpPr>
          <p:spPr>
            <a:xfrm>
              <a:off x="1237799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2" name="rc7">
              <a:extLst>
                <a:ext uri="{FF2B5EF4-FFF2-40B4-BE49-F238E27FC236}">
                  <a16:creationId xmlns:a16="http://schemas.microsoft.com/office/drawing/2014/main" id="{45E6FFAC-7F36-A3D1-0EDE-B066BC26D6BC}"/>
                </a:ext>
              </a:extLst>
            </p:cNvPr>
            <p:cNvSpPr/>
            <p:nvPr/>
          </p:nvSpPr>
          <p:spPr>
            <a:xfrm>
              <a:off x="1431340" y="2989668"/>
              <a:ext cx="193540" cy="2549254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3" name="rc8">
              <a:extLst>
                <a:ext uri="{FF2B5EF4-FFF2-40B4-BE49-F238E27FC236}">
                  <a16:creationId xmlns:a16="http://schemas.microsoft.com/office/drawing/2014/main" id="{1FE3230F-CEAD-1F60-BEF0-73B7D2A739F8}"/>
                </a:ext>
              </a:extLst>
            </p:cNvPr>
            <p:cNvSpPr/>
            <p:nvPr/>
          </p:nvSpPr>
          <p:spPr>
            <a:xfrm>
              <a:off x="1624881" y="2904979"/>
              <a:ext cx="193540" cy="2633942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4" name="rc9">
              <a:extLst>
                <a:ext uri="{FF2B5EF4-FFF2-40B4-BE49-F238E27FC236}">
                  <a16:creationId xmlns:a16="http://schemas.microsoft.com/office/drawing/2014/main" id="{99E630F8-ADE2-067E-F6EE-F0272E75F0D4}"/>
                </a:ext>
              </a:extLst>
            </p:cNvPr>
            <p:cNvSpPr/>
            <p:nvPr/>
          </p:nvSpPr>
          <p:spPr>
            <a:xfrm>
              <a:off x="1882935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5" name="rc10">
              <a:extLst>
                <a:ext uri="{FF2B5EF4-FFF2-40B4-BE49-F238E27FC236}">
                  <a16:creationId xmlns:a16="http://schemas.microsoft.com/office/drawing/2014/main" id="{D630C0A4-01E2-FD0F-0491-0400DEC9F432}"/>
                </a:ext>
              </a:extLst>
            </p:cNvPr>
            <p:cNvSpPr/>
            <p:nvPr/>
          </p:nvSpPr>
          <p:spPr>
            <a:xfrm>
              <a:off x="2076476" y="5212905"/>
              <a:ext cx="193540" cy="326017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6" name="rc11">
              <a:extLst>
                <a:ext uri="{FF2B5EF4-FFF2-40B4-BE49-F238E27FC236}">
                  <a16:creationId xmlns:a16="http://schemas.microsoft.com/office/drawing/2014/main" id="{024822C1-9A88-3826-DCF4-4DEB0EFB15C9}"/>
                </a:ext>
              </a:extLst>
            </p:cNvPr>
            <p:cNvSpPr/>
            <p:nvPr/>
          </p:nvSpPr>
          <p:spPr>
            <a:xfrm>
              <a:off x="2270017" y="5279802"/>
              <a:ext cx="193540" cy="259120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7" name="rc12">
              <a:extLst>
                <a:ext uri="{FF2B5EF4-FFF2-40B4-BE49-F238E27FC236}">
                  <a16:creationId xmlns:a16="http://schemas.microsoft.com/office/drawing/2014/main" id="{5AB5FA75-276A-738A-8FFD-F816D5AB03B5}"/>
                </a:ext>
              </a:extLst>
            </p:cNvPr>
            <p:cNvSpPr/>
            <p:nvPr/>
          </p:nvSpPr>
          <p:spPr>
            <a:xfrm>
              <a:off x="2528071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8" name="rc13">
              <a:extLst>
                <a:ext uri="{FF2B5EF4-FFF2-40B4-BE49-F238E27FC236}">
                  <a16:creationId xmlns:a16="http://schemas.microsoft.com/office/drawing/2014/main" id="{0B8C86FE-05B9-5FC5-EB21-6C4EA944ED9E}"/>
                </a:ext>
              </a:extLst>
            </p:cNvPr>
            <p:cNvSpPr/>
            <p:nvPr/>
          </p:nvSpPr>
          <p:spPr>
            <a:xfrm>
              <a:off x="2721612" y="5391117"/>
              <a:ext cx="193540" cy="147805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89" name="rc14">
              <a:extLst>
                <a:ext uri="{FF2B5EF4-FFF2-40B4-BE49-F238E27FC236}">
                  <a16:creationId xmlns:a16="http://schemas.microsoft.com/office/drawing/2014/main" id="{EC098392-ACE9-517A-D2CE-A2DEBA0F2C6A}"/>
                </a:ext>
              </a:extLst>
            </p:cNvPr>
            <p:cNvSpPr/>
            <p:nvPr/>
          </p:nvSpPr>
          <p:spPr>
            <a:xfrm>
              <a:off x="2915153" y="5446636"/>
              <a:ext cx="193540" cy="9228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0" name="rc15">
              <a:extLst>
                <a:ext uri="{FF2B5EF4-FFF2-40B4-BE49-F238E27FC236}">
                  <a16:creationId xmlns:a16="http://schemas.microsoft.com/office/drawing/2014/main" id="{C1A7F27E-E7B5-3280-514D-C74846B43DAF}"/>
                </a:ext>
              </a:extLst>
            </p:cNvPr>
            <p:cNvSpPr/>
            <p:nvPr/>
          </p:nvSpPr>
          <p:spPr>
            <a:xfrm>
              <a:off x="3173208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1" name="rc16">
              <a:extLst>
                <a:ext uri="{FF2B5EF4-FFF2-40B4-BE49-F238E27FC236}">
                  <a16:creationId xmlns:a16="http://schemas.microsoft.com/office/drawing/2014/main" id="{ED526CAC-3AAB-6180-38C5-C7D1852F4381}"/>
                </a:ext>
              </a:extLst>
            </p:cNvPr>
            <p:cNvSpPr/>
            <p:nvPr/>
          </p:nvSpPr>
          <p:spPr>
            <a:xfrm>
              <a:off x="3366748" y="4478439"/>
              <a:ext cx="193540" cy="1060482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2" name="rc17">
              <a:extLst>
                <a:ext uri="{FF2B5EF4-FFF2-40B4-BE49-F238E27FC236}">
                  <a16:creationId xmlns:a16="http://schemas.microsoft.com/office/drawing/2014/main" id="{7BA754FC-C7C1-2683-930E-A012B635C9B1}"/>
                </a:ext>
              </a:extLst>
            </p:cNvPr>
            <p:cNvSpPr/>
            <p:nvPr/>
          </p:nvSpPr>
          <p:spPr>
            <a:xfrm>
              <a:off x="3560289" y="4476026"/>
              <a:ext cx="193540" cy="106289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3" name="rc18">
              <a:extLst>
                <a:ext uri="{FF2B5EF4-FFF2-40B4-BE49-F238E27FC236}">
                  <a16:creationId xmlns:a16="http://schemas.microsoft.com/office/drawing/2014/main" id="{F16D2F41-4DEB-DBDE-E6A4-DB2B2C1BD9F5}"/>
                </a:ext>
              </a:extLst>
            </p:cNvPr>
            <p:cNvSpPr/>
            <p:nvPr/>
          </p:nvSpPr>
          <p:spPr>
            <a:xfrm>
              <a:off x="3818344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4" name="rc19">
              <a:extLst>
                <a:ext uri="{FF2B5EF4-FFF2-40B4-BE49-F238E27FC236}">
                  <a16:creationId xmlns:a16="http://schemas.microsoft.com/office/drawing/2014/main" id="{7E41742E-80B4-7400-AB93-00EBCE2972F2}"/>
                </a:ext>
              </a:extLst>
            </p:cNvPr>
            <p:cNvSpPr/>
            <p:nvPr/>
          </p:nvSpPr>
          <p:spPr>
            <a:xfrm>
              <a:off x="4011884" y="4570060"/>
              <a:ext cx="193540" cy="968862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5" name="rc20">
              <a:extLst>
                <a:ext uri="{FF2B5EF4-FFF2-40B4-BE49-F238E27FC236}">
                  <a16:creationId xmlns:a16="http://schemas.microsoft.com/office/drawing/2014/main" id="{53CB9C50-B7ED-29A7-8CBE-F34CA2762BB8}"/>
                </a:ext>
              </a:extLst>
            </p:cNvPr>
            <p:cNvSpPr/>
            <p:nvPr/>
          </p:nvSpPr>
          <p:spPr>
            <a:xfrm>
              <a:off x="4205425" y="4462509"/>
              <a:ext cx="193540" cy="1076413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6" name="rc21">
              <a:extLst>
                <a:ext uri="{FF2B5EF4-FFF2-40B4-BE49-F238E27FC236}">
                  <a16:creationId xmlns:a16="http://schemas.microsoft.com/office/drawing/2014/main" id="{BE4EE895-8B5C-AF39-ECAD-F5543F609A8B}"/>
                </a:ext>
              </a:extLst>
            </p:cNvPr>
            <p:cNvSpPr/>
            <p:nvPr/>
          </p:nvSpPr>
          <p:spPr>
            <a:xfrm>
              <a:off x="4463480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7" name="rc22">
              <a:extLst>
                <a:ext uri="{FF2B5EF4-FFF2-40B4-BE49-F238E27FC236}">
                  <a16:creationId xmlns:a16="http://schemas.microsoft.com/office/drawing/2014/main" id="{EF4BFEC7-AE13-BCBE-C05D-A7B661922FC8}"/>
                </a:ext>
              </a:extLst>
            </p:cNvPr>
            <p:cNvSpPr/>
            <p:nvPr/>
          </p:nvSpPr>
          <p:spPr>
            <a:xfrm>
              <a:off x="4657021" y="4774285"/>
              <a:ext cx="193540" cy="764637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8" name="rc23">
              <a:extLst>
                <a:ext uri="{FF2B5EF4-FFF2-40B4-BE49-F238E27FC236}">
                  <a16:creationId xmlns:a16="http://schemas.microsoft.com/office/drawing/2014/main" id="{3440B9E3-CC46-8559-C070-A94FFCA2C258}"/>
                </a:ext>
              </a:extLst>
            </p:cNvPr>
            <p:cNvSpPr/>
            <p:nvPr/>
          </p:nvSpPr>
          <p:spPr>
            <a:xfrm>
              <a:off x="4850561" y="4753155"/>
              <a:ext cx="193540" cy="78576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599" name="rc24">
              <a:extLst>
                <a:ext uri="{FF2B5EF4-FFF2-40B4-BE49-F238E27FC236}">
                  <a16:creationId xmlns:a16="http://schemas.microsoft.com/office/drawing/2014/main" id="{95C7BF98-0C07-AD24-D076-DA08AC172AD6}"/>
                </a:ext>
              </a:extLst>
            </p:cNvPr>
            <p:cNvSpPr/>
            <p:nvPr/>
          </p:nvSpPr>
          <p:spPr>
            <a:xfrm>
              <a:off x="5108616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0" name="rc25">
              <a:extLst>
                <a:ext uri="{FF2B5EF4-FFF2-40B4-BE49-F238E27FC236}">
                  <a16:creationId xmlns:a16="http://schemas.microsoft.com/office/drawing/2014/main" id="{B23B4F06-2E1E-CDEA-21C1-6DD41DBEFE31}"/>
                </a:ext>
              </a:extLst>
            </p:cNvPr>
            <p:cNvSpPr/>
            <p:nvPr/>
          </p:nvSpPr>
          <p:spPr>
            <a:xfrm>
              <a:off x="5302157" y="5517542"/>
              <a:ext cx="193540" cy="21380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1" name="rc26">
              <a:extLst>
                <a:ext uri="{FF2B5EF4-FFF2-40B4-BE49-F238E27FC236}">
                  <a16:creationId xmlns:a16="http://schemas.microsoft.com/office/drawing/2014/main" id="{F855A74A-144B-2893-C615-5615160EB9F0}"/>
                </a:ext>
              </a:extLst>
            </p:cNvPr>
            <p:cNvSpPr/>
            <p:nvPr/>
          </p:nvSpPr>
          <p:spPr>
            <a:xfrm>
              <a:off x="5495698" y="5522845"/>
              <a:ext cx="193540" cy="16077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2" name="rc27">
              <a:extLst>
                <a:ext uri="{FF2B5EF4-FFF2-40B4-BE49-F238E27FC236}">
                  <a16:creationId xmlns:a16="http://schemas.microsoft.com/office/drawing/2014/main" id="{67CF3372-C42F-CF74-A95F-552D61D0CBD9}"/>
                </a:ext>
              </a:extLst>
            </p:cNvPr>
            <p:cNvSpPr/>
            <p:nvPr/>
          </p:nvSpPr>
          <p:spPr>
            <a:xfrm>
              <a:off x="5753752" y="2960114"/>
              <a:ext cx="193540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3" name="rc28">
              <a:extLst>
                <a:ext uri="{FF2B5EF4-FFF2-40B4-BE49-F238E27FC236}">
                  <a16:creationId xmlns:a16="http://schemas.microsoft.com/office/drawing/2014/main" id="{58CFC33F-E992-BA69-BD68-8C49B40B44C4}"/>
                </a:ext>
              </a:extLst>
            </p:cNvPr>
            <p:cNvSpPr/>
            <p:nvPr/>
          </p:nvSpPr>
          <p:spPr>
            <a:xfrm>
              <a:off x="5947293" y="4658911"/>
              <a:ext cx="193540" cy="880011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4" name="rc29">
              <a:extLst>
                <a:ext uri="{FF2B5EF4-FFF2-40B4-BE49-F238E27FC236}">
                  <a16:creationId xmlns:a16="http://schemas.microsoft.com/office/drawing/2014/main" id="{EF739C28-CE6E-8A2F-7C87-D01F54DBDC81}"/>
                </a:ext>
              </a:extLst>
            </p:cNvPr>
            <p:cNvSpPr/>
            <p:nvPr/>
          </p:nvSpPr>
          <p:spPr>
            <a:xfrm>
              <a:off x="6140834" y="4649325"/>
              <a:ext cx="193540" cy="889597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5" name="pg30">
              <a:extLst>
                <a:ext uri="{FF2B5EF4-FFF2-40B4-BE49-F238E27FC236}">
                  <a16:creationId xmlns:a16="http://schemas.microsoft.com/office/drawing/2014/main" id="{842D88E3-8CCD-6796-FBD3-1BEDC15A865F}"/>
                </a:ext>
              </a:extLst>
            </p:cNvPr>
            <p:cNvSpPr/>
            <p:nvPr/>
          </p:nvSpPr>
          <p:spPr>
            <a:xfrm>
              <a:off x="2973547" y="544767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6" name="pg31">
              <a:extLst>
                <a:ext uri="{FF2B5EF4-FFF2-40B4-BE49-F238E27FC236}">
                  <a16:creationId xmlns:a16="http://schemas.microsoft.com/office/drawing/2014/main" id="{041D428D-2C74-417C-4F1A-9DA49A27A550}"/>
                </a:ext>
              </a:extLst>
            </p:cNvPr>
            <p:cNvSpPr/>
            <p:nvPr/>
          </p:nvSpPr>
          <p:spPr>
            <a:xfrm>
              <a:off x="2973547" y="541480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7" name="pg32">
              <a:extLst>
                <a:ext uri="{FF2B5EF4-FFF2-40B4-BE49-F238E27FC236}">
                  <a16:creationId xmlns:a16="http://schemas.microsoft.com/office/drawing/2014/main" id="{F584E204-608E-FE51-948F-1A5F4628B39C}"/>
                </a:ext>
              </a:extLst>
            </p:cNvPr>
            <p:cNvSpPr/>
            <p:nvPr/>
          </p:nvSpPr>
          <p:spPr>
            <a:xfrm>
              <a:off x="2973547" y="536229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8" name="pg33">
              <a:extLst>
                <a:ext uri="{FF2B5EF4-FFF2-40B4-BE49-F238E27FC236}">
                  <a16:creationId xmlns:a16="http://schemas.microsoft.com/office/drawing/2014/main" id="{724D3C36-53E9-62F6-73A3-D214326A03C1}"/>
                </a:ext>
              </a:extLst>
            </p:cNvPr>
            <p:cNvSpPr/>
            <p:nvPr/>
          </p:nvSpPr>
          <p:spPr>
            <a:xfrm>
              <a:off x="2780006" y="538114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09" name="pg34">
              <a:extLst>
                <a:ext uri="{FF2B5EF4-FFF2-40B4-BE49-F238E27FC236}">
                  <a16:creationId xmlns:a16="http://schemas.microsoft.com/office/drawing/2014/main" id="{6FBA2097-5F5A-0E48-ADD1-91726577A5CC}"/>
                </a:ext>
              </a:extLst>
            </p:cNvPr>
            <p:cNvSpPr/>
            <p:nvPr/>
          </p:nvSpPr>
          <p:spPr>
            <a:xfrm>
              <a:off x="2586465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0" name="pg35">
              <a:extLst>
                <a:ext uri="{FF2B5EF4-FFF2-40B4-BE49-F238E27FC236}">
                  <a16:creationId xmlns:a16="http://schemas.microsoft.com/office/drawing/2014/main" id="{379BDE0A-2DBC-303A-A210-1F3018455B02}"/>
                </a:ext>
              </a:extLst>
            </p:cNvPr>
            <p:cNvSpPr/>
            <p:nvPr/>
          </p:nvSpPr>
          <p:spPr>
            <a:xfrm>
              <a:off x="2780006" y="532433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1" name="pg36">
              <a:extLst>
                <a:ext uri="{FF2B5EF4-FFF2-40B4-BE49-F238E27FC236}">
                  <a16:creationId xmlns:a16="http://schemas.microsoft.com/office/drawing/2014/main" id="{C66445A8-AEF5-790D-F3D2-69E5FCE906C1}"/>
                </a:ext>
              </a:extLst>
            </p:cNvPr>
            <p:cNvSpPr/>
            <p:nvPr/>
          </p:nvSpPr>
          <p:spPr>
            <a:xfrm>
              <a:off x="2586465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2" name="pg37">
              <a:extLst>
                <a:ext uri="{FF2B5EF4-FFF2-40B4-BE49-F238E27FC236}">
                  <a16:creationId xmlns:a16="http://schemas.microsoft.com/office/drawing/2014/main" id="{216A8935-3922-E8F7-2766-5C396B1F3A8C}"/>
                </a:ext>
              </a:extLst>
            </p:cNvPr>
            <p:cNvSpPr/>
            <p:nvPr/>
          </p:nvSpPr>
          <p:spPr>
            <a:xfrm>
              <a:off x="2328411" y="522411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3" name="pg38">
              <a:extLst>
                <a:ext uri="{FF2B5EF4-FFF2-40B4-BE49-F238E27FC236}">
                  <a16:creationId xmlns:a16="http://schemas.microsoft.com/office/drawing/2014/main" id="{B34D650E-A0FE-B724-16FF-B9C733727BEF}"/>
                </a:ext>
              </a:extLst>
            </p:cNvPr>
            <p:cNvSpPr/>
            <p:nvPr/>
          </p:nvSpPr>
          <p:spPr>
            <a:xfrm>
              <a:off x="2328411" y="51886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4" name="pg39">
              <a:extLst>
                <a:ext uri="{FF2B5EF4-FFF2-40B4-BE49-F238E27FC236}">
                  <a16:creationId xmlns:a16="http://schemas.microsoft.com/office/drawing/2014/main" id="{396501B4-93E1-28CD-A71B-D36C138CADFF}"/>
                </a:ext>
              </a:extLst>
            </p:cNvPr>
            <p:cNvSpPr/>
            <p:nvPr/>
          </p:nvSpPr>
          <p:spPr>
            <a:xfrm>
              <a:off x="2328411" y="531151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5" name="pg40">
              <a:extLst>
                <a:ext uri="{FF2B5EF4-FFF2-40B4-BE49-F238E27FC236}">
                  <a16:creationId xmlns:a16="http://schemas.microsoft.com/office/drawing/2014/main" id="{8D4FD45A-0532-F5FC-0C1E-D89357362CA5}"/>
                </a:ext>
              </a:extLst>
            </p:cNvPr>
            <p:cNvSpPr/>
            <p:nvPr/>
          </p:nvSpPr>
          <p:spPr>
            <a:xfrm>
              <a:off x="2134870" y="513377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6" name="pg41">
              <a:extLst>
                <a:ext uri="{FF2B5EF4-FFF2-40B4-BE49-F238E27FC236}">
                  <a16:creationId xmlns:a16="http://schemas.microsoft.com/office/drawing/2014/main" id="{7C8A21D2-C8F6-593A-CC4F-896A06103E55}"/>
                </a:ext>
              </a:extLst>
            </p:cNvPr>
            <p:cNvSpPr/>
            <p:nvPr/>
          </p:nvSpPr>
          <p:spPr>
            <a:xfrm>
              <a:off x="1941329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7" name="pg42">
              <a:extLst>
                <a:ext uri="{FF2B5EF4-FFF2-40B4-BE49-F238E27FC236}">
                  <a16:creationId xmlns:a16="http://schemas.microsoft.com/office/drawing/2014/main" id="{BF8FEEC3-9242-BF93-BCFB-9E13A716C344}"/>
                </a:ext>
              </a:extLst>
            </p:cNvPr>
            <p:cNvSpPr/>
            <p:nvPr/>
          </p:nvSpPr>
          <p:spPr>
            <a:xfrm>
              <a:off x="2134870" y="517403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8" name="pg43">
              <a:extLst>
                <a:ext uri="{FF2B5EF4-FFF2-40B4-BE49-F238E27FC236}">
                  <a16:creationId xmlns:a16="http://schemas.microsoft.com/office/drawing/2014/main" id="{66CCA242-B0DD-735A-AC96-6E8C55572E29}"/>
                </a:ext>
              </a:extLst>
            </p:cNvPr>
            <p:cNvSpPr/>
            <p:nvPr/>
          </p:nvSpPr>
          <p:spPr>
            <a:xfrm>
              <a:off x="1941329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19" name="pg44">
              <a:extLst>
                <a:ext uri="{FF2B5EF4-FFF2-40B4-BE49-F238E27FC236}">
                  <a16:creationId xmlns:a16="http://schemas.microsoft.com/office/drawing/2014/main" id="{0060D0D8-A4FE-DACD-4E03-C51B2C54D96E}"/>
                </a:ext>
              </a:extLst>
            </p:cNvPr>
            <p:cNvSpPr/>
            <p:nvPr/>
          </p:nvSpPr>
          <p:spPr>
            <a:xfrm>
              <a:off x="2134870" y="521577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0" name="pg45">
              <a:extLst>
                <a:ext uri="{FF2B5EF4-FFF2-40B4-BE49-F238E27FC236}">
                  <a16:creationId xmlns:a16="http://schemas.microsoft.com/office/drawing/2014/main" id="{84FD5092-0FC8-63A0-686A-D464E614C26C}"/>
                </a:ext>
              </a:extLst>
            </p:cNvPr>
            <p:cNvSpPr/>
            <p:nvPr/>
          </p:nvSpPr>
          <p:spPr>
            <a:xfrm>
              <a:off x="1941329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1" name="pg46">
              <a:extLst>
                <a:ext uri="{FF2B5EF4-FFF2-40B4-BE49-F238E27FC236}">
                  <a16:creationId xmlns:a16="http://schemas.microsoft.com/office/drawing/2014/main" id="{7FF8F490-91CA-073C-405C-9024459F68F1}"/>
                </a:ext>
              </a:extLst>
            </p:cNvPr>
            <p:cNvSpPr/>
            <p:nvPr/>
          </p:nvSpPr>
          <p:spPr>
            <a:xfrm>
              <a:off x="4070278" y="447149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2" name="pg47">
              <a:extLst>
                <a:ext uri="{FF2B5EF4-FFF2-40B4-BE49-F238E27FC236}">
                  <a16:creationId xmlns:a16="http://schemas.microsoft.com/office/drawing/2014/main" id="{D1BD9481-F8E4-540B-E717-28F7648F53C3}"/>
                </a:ext>
              </a:extLst>
            </p:cNvPr>
            <p:cNvSpPr/>
            <p:nvPr/>
          </p:nvSpPr>
          <p:spPr>
            <a:xfrm>
              <a:off x="4263819" y="442533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3" name="pg48">
              <a:extLst>
                <a:ext uri="{FF2B5EF4-FFF2-40B4-BE49-F238E27FC236}">
                  <a16:creationId xmlns:a16="http://schemas.microsoft.com/office/drawing/2014/main" id="{36FC6FB8-6CFA-4BD8-4993-5FC6AF4DD0AA}"/>
                </a:ext>
              </a:extLst>
            </p:cNvPr>
            <p:cNvSpPr/>
            <p:nvPr/>
          </p:nvSpPr>
          <p:spPr>
            <a:xfrm>
              <a:off x="4263819" y="420343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4" name="pg49">
              <a:extLst>
                <a:ext uri="{FF2B5EF4-FFF2-40B4-BE49-F238E27FC236}">
                  <a16:creationId xmlns:a16="http://schemas.microsoft.com/office/drawing/2014/main" id="{CD97FEAE-E0D9-6E57-EDB7-1954EB351B57}"/>
                </a:ext>
              </a:extLst>
            </p:cNvPr>
            <p:cNvSpPr/>
            <p:nvPr/>
          </p:nvSpPr>
          <p:spPr>
            <a:xfrm>
              <a:off x="4263819" y="464363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5" name="pg50">
              <a:extLst>
                <a:ext uri="{FF2B5EF4-FFF2-40B4-BE49-F238E27FC236}">
                  <a16:creationId xmlns:a16="http://schemas.microsoft.com/office/drawing/2014/main" id="{DDF6F92A-FB68-8459-072E-666EB7AC4735}"/>
                </a:ext>
              </a:extLst>
            </p:cNvPr>
            <p:cNvSpPr/>
            <p:nvPr/>
          </p:nvSpPr>
          <p:spPr>
            <a:xfrm>
              <a:off x="3876737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6" name="pg51">
              <a:extLst>
                <a:ext uri="{FF2B5EF4-FFF2-40B4-BE49-F238E27FC236}">
                  <a16:creationId xmlns:a16="http://schemas.microsoft.com/office/drawing/2014/main" id="{468B2470-E179-D7DD-2A95-AED2EFE56DF1}"/>
                </a:ext>
              </a:extLst>
            </p:cNvPr>
            <p:cNvSpPr/>
            <p:nvPr/>
          </p:nvSpPr>
          <p:spPr>
            <a:xfrm>
              <a:off x="4070278" y="435335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7" name="pg52">
              <a:extLst>
                <a:ext uri="{FF2B5EF4-FFF2-40B4-BE49-F238E27FC236}">
                  <a16:creationId xmlns:a16="http://schemas.microsoft.com/office/drawing/2014/main" id="{28B7CB63-7EF9-7061-FCE8-A74E3473201D}"/>
                </a:ext>
              </a:extLst>
            </p:cNvPr>
            <p:cNvSpPr/>
            <p:nvPr/>
          </p:nvSpPr>
          <p:spPr>
            <a:xfrm>
              <a:off x="3876737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8" name="pg53">
              <a:extLst>
                <a:ext uri="{FF2B5EF4-FFF2-40B4-BE49-F238E27FC236}">
                  <a16:creationId xmlns:a16="http://schemas.microsoft.com/office/drawing/2014/main" id="{9E9EA14B-828B-BA92-5889-2BBB337626D9}"/>
                </a:ext>
              </a:extLst>
            </p:cNvPr>
            <p:cNvSpPr/>
            <p:nvPr/>
          </p:nvSpPr>
          <p:spPr>
            <a:xfrm>
              <a:off x="4070278" y="477020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29" name="pg54">
              <a:extLst>
                <a:ext uri="{FF2B5EF4-FFF2-40B4-BE49-F238E27FC236}">
                  <a16:creationId xmlns:a16="http://schemas.microsoft.com/office/drawing/2014/main" id="{F10AB2DB-1E14-A4FF-DE6F-7DDAB24DA734}"/>
                </a:ext>
              </a:extLst>
            </p:cNvPr>
            <p:cNvSpPr/>
            <p:nvPr/>
          </p:nvSpPr>
          <p:spPr>
            <a:xfrm>
              <a:off x="3876737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0" name="pg55">
              <a:extLst>
                <a:ext uri="{FF2B5EF4-FFF2-40B4-BE49-F238E27FC236}">
                  <a16:creationId xmlns:a16="http://schemas.microsoft.com/office/drawing/2014/main" id="{602ED85E-E12F-40B7-7F42-B660D5D805A4}"/>
                </a:ext>
              </a:extLst>
            </p:cNvPr>
            <p:cNvSpPr/>
            <p:nvPr/>
          </p:nvSpPr>
          <p:spPr>
            <a:xfrm>
              <a:off x="3618683" y="424420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1" name="pg56">
              <a:extLst>
                <a:ext uri="{FF2B5EF4-FFF2-40B4-BE49-F238E27FC236}">
                  <a16:creationId xmlns:a16="http://schemas.microsoft.com/office/drawing/2014/main" id="{CA5C4000-42EB-1F28-C2B4-7FFE93D8C481}"/>
                </a:ext>
              </a:extLst>
            </p:cNvPr>
            <p:cNvSpPr/>
            <p:nvPr/>
          </p:nvSpPr>
          <p:spPr>
            <a:xfrm>
              <a:off x="3618683" y="462464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2" name="pg57">
              <a:extLst>
                <a:ext uri="{FF2B5EF4-FFF2-40B4-BE49-F238E27FC236}">
                  <a16:creationId xmlns:a16="http://schemas.microsoft.com/office/drawing/2014/main" id="{56FBA886-E513-72F6-D335-2EB531AAE56E}"/>
                </a:ext>
              </a:extLst>
            </p:cNvPr>
            <p:cNvSpPr/>
            <p:nvPr/>
          </p:nvSpPr>
          <p:spPr>
            <a:xfrm>
              <a:off x="3425142" y="458669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3" name="pg58">
              <a:extLst>
                <a:ext uri="{FF2B5EF4-FFF2-40B4-BE49-F238E27FC236}">
                  <a16:creationId xmlns:a16="http://schemas.microsoft.com/office/drawing/2014/main" id="{5D3D2873-24E6-B100-B6FA-67C093351BDB}"/>
                </a:ext>
              </a:extLst>
            </p:cNvPr>
            <p:cNvSpPr/>
            <p:nvPr/>
          </p:nvSpPr>
          <p:spPr>
            <a:xfrm>
              <a:off x="3618683" y="444410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4" name="pg59">
              <a:extLst>
                <a:ext uri="{FF2B5EF4-FFF2-40B4-BE49-F238E27FC236}">
                  <a16:creationId xmlns:a16="http://schemas.microsoft.com/office/drawing/2014/main" id="{002E1C34-E4BB-07F4-0B84-2CFF98C59B3A}"/>
                </a:ext>
              </a:extLst>
            </p:cNvPr>
            <p:cNvSpPr/>
            <p:nvPr/>
          </p:nvSpPr>
          <p:spPr>
            <a:xfrm>
              <a:off x="3425142" y="452922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5" name="pg60">
              <a:extLst>
                <a:ext uri="{FF2B5EF4-FFF2-40B4-BE49-F238E27FC236}">
                  <a16:creationId xmlns:a16="http://schemas.microsoft.com/office/drawing/2014/main" id="{52608CCB-FB3C-D1AF-86A7-1A7874384D8E}"/>
                </a:ext>
              </a:extLst>
            </p:cNvPr>
            <p:cNvSpPr/>
            <p:nvPr/>
          </p:nvSpPr>
          <p:spPr>
            <a:xfrm>
              <a:off x="3231601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6" name="pg61">
              <a:extLst>
                <a:ext uri="{FF2B5EF4-FFF2-40B4-BE49-F238E27FC236}">
                  <a16:creationId xmlns:a16="http://schemas.microsoft.com/office/drawing/2014/main" id="{F24DE777-BA13-3BE0-23E5-ABBD7C2364A1}"/>
                </a:ext>
              </a:extLst>
            </p:cNvPr>
            <p:cNvSpPr/>
            <p:nvPr/>
          </p:nvSpPr>
          <p:spPr>
            <a:xfrm>
              <a:off x="3425142" y="420426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7" name="pg62">
              <a:extLst>
                <a:ext uri="{FF2B5EF4-FFF2-40B4-BE49-F238E27FC236}">
                  <a16:creationId xmlns:a16="http://schemas.microsoft.com/office/drawing/2014/main" id="{25558826-7C2A-C815-9F93-12F06F1C0DE6}"/>
                </a:ext>
              </a:extLst>
            </p:cNvPr>
            <p:cNvSpPr/>
            <p:nvPr/>
          </p:nvSpPr>
          <p:spPr>
            <a:xfrm>
              <a:off x="3231601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8" name="pg63">
              <a:extLst>
                <a:ext uri="{FF2B5EF4-FFF2-40B4-BE49-F238E27FC236}">
                  <a16:creationId xmlns:a16="http://schemas.microsoft.com/office/drawing/2014/main" id="{F6F4560F-653E-B248-9660-4B77C058C34E}"/>
                </a:ext>
              </a:extLst>
            </p:cNvPr>
            <p:cNvSpPr/>
            <p:nvPr/>
          </p:nvSpPr>
          <p:spPr>
            <a:xfrm>
              <a:off x="3231601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39" name="pg64">
              <a:extLst>
                <a:ext uri="{FF2B5EF4-FFF2-40B4-BE49-F238E27FC236}">
                  <a16:creationId xmlns:a16="http://schemas.microsoft.com/office/drawing/2014/main" id="{EDEA6D56-C7B6-E030-E7B2-AFF55F6E598B}"/>
                </a:ext>
              </a:extLst>
            </p:cNvPr>
            <p:cNvSpPr/>
            <p:nvPr/>
          </p:nvSpPr>
          <p:spPr>
            <a:xfrm>
              <a:off x="1683275" y="2157241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0" name="pg65">
              <a:extLst>
                <a:ext uri="{FF2B5EF4-FFF2-40B4-BE49-F238E27FC236}">
                  <a16:creationId xmlns:a16="http://schemas.microsoft.com/office/drawing/2014/main" id="{46FF0FF2-4AAD-9035-7B3A-5D9EB05B7CBE}"/>
                </a:ext>
              </a:extLst>
            </p:cNvPr>
            <p:cNvSpPr/>
            <p:nvPr/>
          </p:nvSpPr>
          <p:spPr>
            <a:xfrm>
              <a:off x="1683275" y="341363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1" name="pg66">
              <a:extLst>
                <a:ext uri="{FF2B5EF4-FFF2-40B4-BE49-F238E27FC236}">
                  <a16:creationId xmlns:a16="http://schemas.microsoft.com/office/drawing/2014/main" id="{1531E1D4-C147-2516-4C99-5BBE7217992F}"/>
                </a:ext>
              </a:extLst>
            </p:cNvPr>
            <p:cNvSpPr/>
            <p:nvPr/>
          </p:nvSpPr>
          <p:spPr>
            <a:xfrm>
              <a:off x="1683275" y="302893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2" name="pg67">
              <a:extLst>
                <a:ext uri="{FF2B5EF4-FFF2-40B4-BE49-F238E27FC236}">
                  <a16:creationId xmlns:a16="http://schemas.microsoft.com/office/drawing/2014/main" id="{F2AC7092-252C-A649-0B8B-DD66D0CAFCDF}"/>
                </a:ext>
              </a:extLst>
            </p:cNvPr>
            <p:cNvSpPr/>
            <p:nvPr/>
          </p:nvSpPr>
          <p:spPr>
            <a:xfrm>
              <a:off x="1489734" y="243043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3" name="pg68">
              <a:extLst>
                <a:ext uri="{FF2B5EF4-FFF2-40B4-BE49-F238E27FC236}">
                  <a16:creationId xmlns:a16="http://schemas.microsoft.com/office/drawing/2014/main" id="{13E19C14-E454-1800-C466-DA35BD3F6B95}"/>
                </a:ext>
              </a:extLst>
            </p:cNvPr>
            <p:cNvSpPr/>
            <p:nvPr/>
          </p:nvSpPr>
          <p:spPr>
            <a:xfrm>
              <a:off x="1296193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4" name="pg69">
              <a:extLst>
                <a:ext uri="{FF2B5EF4-FFF2-40B4-BE49-F238E27FC236}">
                  <a16:creationId xmlns:a16="http://schemas.microsoft.com/office/drawing/2014/main" id="{104E4EB3-82CB-3982-0CA9-E6D4A172D805}"/>
                </a:ext>
              </a:extLst>
            </p:cNvPr>
            <p:cNvSpPr/>
            <p:nvPr/>
          </p:nvSpPr>
          <p:spPr>
            <a:xfrm>
              <a:off x="1489734" y="3333151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5" name="pg70">
              <a:extLst>
                <a:ext uri="{FF2B5EF4-FFF2-40B4-BE49-F238E27FC236}">
                  <a16:creationId xmlns:a16="http://schemas.microsoft.com/office/drawing/2014/main" id="{BE189E0F-B532-EA3C-4099-AA6D1C5C8326}"/>
                </a:ext>
              </a:extLst>
            </p:cNvPr>
            <p:cNvSpPr/>
            <p:nvPr/>
          </p:nvSpPr>
          <p:spPr>
            <a:xfrm>
              <a:off x="1296193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6" name="pg71">
              <a:extLst>
                <a:ext uri="{FF2B5EF4-FFF2-40B4-BE49-F238E27FC236}">
                  <a16:creationId xmlns:a16="http://schemas.microsoft.com/office/drawing/2014/main" id="{F0F4F634-26BF-C4A8-8EF3-5FC44CB0E502}"/>
                </a:ext>
              </a:extLst>
            </p:cNvPr>
            <p:cNvSpPr/>
            <p:nvPr/>
          </p:nvSpPr>
          <p:spPr>
            <a:xfrm>
              <a:off x="1489734" y="309028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7" name="pg72">
              <a:extLst>
                <a:ext uri="{FF2B5EF4-FFF2-40B4-BE49-F238E27FC236}">
                  <a16:creationId xmlns:a16="http://schemas.microsoft.com/office/drawing/2014/main" id="{665B96C7-6ACB-0541-BC85-01087CB203FF}"/>
                </a:ext>
              </a:extLst>
            </p:cNvPr>
            <p:cNvSpPr/>
            <p:nvPr/>
          </p:nvSpPr>
          <p:spPr>
            <a:xfrm>
              <a:off x="1296193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8" name="pg73">
              <a:extLst>
                <a:ext uri="{FF2B5EF4-FFF2-40B4-BE49-F238E27FC236}">
                  <a16:creationId xmlns:a16="http://schemas.microsoft.com/office/drawing/2014/main" id="{26F02AC5-B54C-B4F7-83D5-F240C6212226}"/>
                </a:ext>
              </a:extLst>
            </p:cNvPr>
            <p:cNvSpPr/>
            <p:nvPr/>
          </p:nvSpPr>
          <p:spPr>
            <a:xfrm>
              <a:off x="6005687" y="447970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49" name="pg74">
              <a:extLst>
                <a:ext uri="{FF2B5EF4-FFF2-40B4-BE49-F238E27FC236}">
                  <a16:creationId xmlns:a16="http://schemas.microsoft.com/office/drawing/2014/main" id="{07896913-41C7-48C3-12E2-B0E74BCCBBF6}"/>
                </a:ext>
              </a:extLst>
            </p:cNvPr>
            <p:cNvSpPr/>
            <p:nvPr/>
          </p:nvSpPr>
          <p:spPr>
            <a:xfrm>
              <a:off x="5812146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0" name="pg75">
              <a:extLst>
                <a:ext uri="{FF2B5EF4-FFF2-40B4-BE49-F238E27FC236}">
                  <a16:creationId xmlns:a16="http://schemas.microsoft.com/office/drawing/2014/main" id="{80B06E50-1F09-39A3-BE95-3F94BB3FBDCC}"/>
                </a:ext>
              </a:extLst>
            </p:cNvPr>
            <p:cNvSpPr/>
            <p:nvPr/>
          </p:nvSpPr>
          <p:spPr>
            <a:xfrm>
              <a:off x="6199228" y="4582551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1" name="pg76">
              <a:extLst>
                <a:ext uri="{FF2B5EF4-FFF2-40B4-BE49-F238E27FC236}">
                  <a16:creationId xmlns:a16="http://schemas.microsoft.com/office/drawing/2014/main" id="{2BF17141-BAC9-8FB5-3A30-0AF01EC232BD}"/>
                </a:ext>
              </a:extLst>
            </p:cNvPr>
            <p:cNvSpPr/>
            <p:nvPr/>
          </p:nvSpPr>
          <p:spPr>
            <a:xfrm>
              <a:off x="6005687" y="480537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2" name="pg77">
              <a:extLst>
                <a:ext uri="{FF2B5EF4-FFF2-40B4-BE49-F238E27FC236}">
                  <a16:creationId xmlns:a16="http://schemas.microsoft.com/office/drawing/2014/main" id="{6144625F-B130-3837-9CE9-7A8606513353}"/>
                </a:ext>
              </a:extLst>
            </p:cNvPr>
            <p:cNvSpPr/>
            <p:nvPr/>
          </p:nvSpPr>
          <p:spPr>
            <a:xfrm>
              <a:off x="5812146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3" name="pg78">
              <a:extLst>
                <a:ext uri="{FF2B5EF4-FFF2-40B4-BE49-F238E27FC236}">
                  <a16:creationId xmlns:a16="http://schemas.microsoft.com/office/drawing/2014/main" id="{ABA74663-AA3E-A0E1-219D-89EF23399021}"/>
                </a:ext>
              </a:extLst>
            </p:cNvPr>
            <p:cNvSpPr/>
            <p:nvPr/>
          </p:nvSpPr>
          <p:spPr>
            <a:xfrm>
              <a:off x="6199228" y="453378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4" name="pg79">
              <a:extLst>
                <a:ext uri="{FF2B5EF4-FFF2-40B4-BE49-F238E27FC236}">
                  <a16:creationId xmlns:a16="http://schemas.microsoft.com/office/drawing/2014/main" id="{CAF2FF4C-E444-BF3C-7D97-65CCE0137012}"/>
                </a:ext>
              </a:extLst>
            </p:cNvPr>
            <p:cNvSpPr/>
            <p:nvPr/>
          </p:nvSpPr>
          <p:spPr>
            <a:xfrm>
              <a:off x="6005687" y="457652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5" name="pg80">
              <a:extLst>
                <a:ext uri="{FF2B5EF4-FFF2-40B4-BE49-F238E27FC236}">
                  <a16:creationId xmlns:a16="http://schemas.microsoft.com/office/drawing/2014/main" id="{BCED7D9F-F1ED-8973-FE7E-1E2BBB6E8869}"/>
                </a:ext>
              </a:extLst>
            </p:cNvPr>
            <p:cNvSpPr/>
            <p:nvPr/>
          </p:nvSpPr>
          <p:spPr>
            <a:xfrm>
              <a:off x="5812146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6" name="pg81">
              <a:extLst>
                <a:ext uri="{FF2B5EF4-FFF2-40B4-BE49-F238E27FC236}">
                  <a16:creationId xmlns:a16="http://schemas.microsoft.com/office/drawing/2014/main" id="{34F01342-03CA-7CD5-67B8-C2698D38A6E9}"/>
                </a:ext>
              </a:extLst>
            </p:cNvPr>
            <p:cNvSpPr/>
            <p:nvPr/>
          </p:nvSpPr>
          <p:spPr>
            <a:xfrm>
              <a:off x="6199228" y="471651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7" name="pg82">
              <a:extLst>
                <a:ext uri="{FF2B5EF4-FFF2-40B4-BE49-F238E27FC236}">
                  <a16:creationId xmlns:a16="http://schemas.microsoft.com/office/drawing/2014/main" id="{7F6E6E88-8C4D-FFD5-AFDC-7646B808B0AD}"/>
                </a:ext>
              </a:extLst>
            </p:cNvPr>
            <p:cNvSpPr/>
            <p:nvPr/>
          </p:nvSpPr>
          <p:spPr>
            <a:xfrm>
              <a:off x="5554091" y="548660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8" name="pg83">
              <a:extLst>
                <a:ext uri="{FF2B5EF4-FFF2-40B4-BE49-F238E27FC236}">
                  <a16:creationId xmlns:a16="http://schemas.microsoft.com/office/drawing/2014/main" id="{F086A7C0-0F3B-400D-259B-D264C1FBD66A}"/>
                </a:ext>
              </a:extLst>
            </p:cNvPr>
            <p:cNvSpPr/>
            <p:nvPr/>
          </p:nvSpPr>
          <p:spPr>
            <a:xfrm>
              <a:off x="5554091" y="547792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59" name="pg84">
              <a:extLst>
                <a:ext uri="{FF2B5EF4-FFF2-40B4-BE49-F238E27FC236}">
                  <a16:creationId xmlns:a16="http://schemas.microsoft.com/office/drawing/2014/main" id="{33C7140A-B632-F7F0-84E2-F4CEAD6A1219}"/>
                </a:ext>
              </a:extLst>
            </p:cNvPr>
            <p:cNvSpPr/>
            <p:nvPr/>
          </p:nvSpPr>
          <p:spPr>
            <a:xfrm>
              <a:off x="5554091" y="548887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0" name="pg85">
              <a:extLst>
                <a:ext uri="{FF2B5EF4-FFF2-40B4-BE49-F238E27FC236}">
                  <a16:creationId xmlns:a16="http://schemas.microsoft.com/office/drawing/2014/main" id="{F4DD763D-4F2F-E714-AC23-9C0498E37068}"/>
                </a:ext>
              </a:extLst>
            </p:cNvPr>
            <p:cNvSpPr/>
            <p:nvPr/>
          </p:nvSpPr>
          <p:spPr>
            <a:xfrm>
              <a:off x="5360551" y="548326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1" name="pg86">
              <a:extLst>
                <a:ext uri="{FF2B5EF4-FFF2-40B4-BE49-F238E27FC236}">
                  <a16:creationId xmlns:a16="http://schemas.microsoft.com/office/drawing/2014/main" id="{7315B172-8391-A3AC-8E91-2DF81162C1DC}"/>
                </a:ext>
              </a:extLst>
            </p:cNvPr>
            <p:cNvSpPr/>
            <p:nvPr/>
          </p:nvSpPr>
          <p:spPr>
            <a:xfrm>
              <a:off x="5167010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2" name="pg87">
              <a:extLst>
                <a:ext uri="{FF2B5EF4-FFF2-40B4-BE49-F238E27FC236}">
                  <a16:creationId xmlns:a16="http://schemas.microsoft.com/office/drawing/2014/main" id="{0BF4AFD7-6127-D537-ACF3-4E705A7EA780}"/>
                </a:ext>
              </a:extLst>
            </p:cNvPr>
            <p:cNvSpPr/>
            <p:nvPr/>
          </p:nvSpPr>
          <p:spPr>
            <a:xfrm>
              <a:off x="5360551" y="546854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3" name="pg88">
              <a:extLst>
                <a:ext uri="{FF2B5EF4-FFF2-40B4-BE49-F238E27FC236}">
                  <a16:creationId xmlns:a16="http://schemas.microsoft.com/office/drawing/2014/main" id="{98D6FE94-A8A5-54B5-9424-7CA3EAB214DD}"/>
                </a:ext>
              </a:extLst>
            </p:cNvPr>
            <p:cNvSpPr/>
            <p:nvPr/>
          </p:nvSpPr>
          <p:spPr>
            <a:xfrm>
              <a:off x="5167010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4" name="pg89">
              <a:extLst>
                <a:ext uri="{FF2B5EF4-FFF2-40B4-BE49-F238E27FC236}">
                  <a16:creationId xmlns:a16="http://schemas.microsoft.com/office/drawing/2014/main" id="{9EE65E8C-03E3-83F3-24FA-6FFFE85072C0}"/>
                </a:ext>
              </a:extLst>
            </p:cNvPr>
            <p:cNvSpPr/>
            <p:nvPr/>
          </p:nvSpPr>
          <p:spPr>
            <a:xfrm>
              <a:off x="5360551" y="548568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5" name="pg90">
              <a:extLst>
                <a:ext uri="{FF2B5EF4-FFF2-40B4-BE49-F238E27FC236}">
                  <a16:creationId xmlns:a16="http://schemas.microsoft.com/office/drawing/2014/main" id="{F9C3F5F8-FFCB-11F0-EB21-967E2D5CBFE8}"/>
                </a:ext>
              </a:extLst>
            </p:cNvPr>
            <p:cNvSpPr/>
            <p:nvPr/>
          </p:nvSpPr>
          <p:spPr>
            <a:xfrm>
              <a:off x="5167010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6" name="pg91">
              <a:extLst>
                <a:ext uri="{FF2B5EF4-FFF2-40B4-BE49-F238E27FC236}">
                  <a16:creationId xmlns:a16="http://schemas.microsoft.com/office/drawing/2014/main" id="{40D1F51C-A2EC-8828-B6E3-5D9689D0E395}"/>
                </a:ext>
              </a:extLst>
            </p:cNvPr>
            <p:cNvSpPr/>
            <p:nvPr/>
          </p:nvSpPr>
          <p:spPr>
            <a:xfrm>
              <a:off x="4908955" y="496183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7" name="pg92">
              <a:extLst>
                <a:ext uri="{FF2B5EF4-FFF2-40B4-BE49-F238E27FC236}">
                  <a16:creationId xmlns:a16="http://schemas.microsoft.com/office/drawing/2014/main" id="{07AED21E-80E6-8CA7-AA50-F9E9BBDB3BCB}"/>
                </a:ext>
              </a:extLst>
            </p:cNvPr>
            <p:cNvSpPr/>
            <p:nvPr/>
          </p:nvSpPr>
          <p:spPr>
            <a:xfrm>
              <a:off x="4908955" y="472981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8" name="pg93">
              <a:extLst>
                <a:ext uri="{FF2B5EF4-FFF2-40B4-BE49-F238E27FC236}">
                  <a16:creationId xmlns:a16="http://schemas.microsoft.com/office/drawing/2014/main" id="{8E700AB5-1E3F-4643-9200-766C871EFB50}"/>
                </a:ext>
              </a:extLst>
            </p:cNvPr>
            <p:cNvSpPr/>
            <p:nvPr/>
          </p:nvSpPr>
          <p:spPr>
            <a:xfrm>
              <a:off x="4908955" y="445268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69" name="pg94">
              <a:extLst>
                <a:ext uri="{FF2B5EF4-FFF2-40B4-BE49-F238E27FC236}">
                  <a16:creationId xmlns:a16="http://schemas.microsoft.com/office/drawing/2014/main" id="{647FAD95-B44F-ADF2-DF9C-DD9F8E73248F}"/>
                </a:ext>
              </a:extLst>
            </p:cNvPr>
            <p:cNvSpPr/>
            <p:nvPr/>
          </p:nvSpPr>
          <p:spPr>
            <a:xfrm>
              <a:off x="4521874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0" name="pg95">
              <a:extLst>
                <a:ext uri="{FF2B5EF4-FFF2-40B4-BE49-F238E27FC236}">
                  <a16:creationId xmlns:a16="http://schemas.microsoft.com/office/drawing/2014/main" id="{B678EEE9-4FE0-949A-0C5A-42368896FD6C}"/>
                </a:ext>
              </a:extLst>
            </p:cNvPr>
            <p:cNvSpPr/>
            <p:nvPr/>
          </p:nvSpPr>
          <p:spPr>
            <a:xfrm>
              <a:off x="4715414" y="470851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1" name="pg96">
              <a:extLst>
                <a:ext uri="{FF2B5EF4-FFF2-40B4-BE49-F238E27FC236}">
                  <a16:creationId xmlns:a16="http://schemas.microsoft.com/office/drawing/2014/main" id="{6EF585CA-6B18-8295-ECFD-8188C910880C}"/>
                </a:ext>
              </a:extLst>
            </p:cNvPr>
            <p:cNvSpPr/>
            <p:nvPr/>
          </p:nvSpPr>
          <p:spPr>
            <a:xfrm>
              <a:off x="4521874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2" name="pg97">
              <a:extLst>
                <a:ext uri="{FF2B5EF4-FFF2-40B4-BE49-F238E27FC236}">
                  <a16:creationId xmlns:a16="http://schemas.microsoft.com/office/drawing/2014/main" id="{DA5F8820-758C-BAF8-F73B-065619849C19}"/>
                </a:ext>
              </a:extLst>
            </p:cNvPr>
            <p:cNvSpPr/>
            <p:nvPr/>
          </p:nvSpPr>
          <p:spPr>
            <a:xfrm>
              <a:off x="4715414" y="451572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3" name="pg98">
              <a:extLst>
                <a:ext uri="{FF2B5EF4-FFF2-40B4-BE49-F238E27FC236}">
                  <a16:creationId xmlns:a16="http://schemas.microsoft.com/office/drawing/2014/main" id="{F80D2654-A24D-AC30-6F4C-89A22E1AE021}"/>
                </a:ext>
              </a:extLst>
            </p:cNvPr>
            <p:cNvSpPr/>
            <p:nvPr/>
          </p:nvSpPr>
          <p:spPr>
            <a:xfrm>
              <a:off x="4521874" y="292173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4" name="pg99">
              <a:extLst>
                <a:ext uri="{FF2B5EF4-FFF2-40B4-BE49-F238E27FC236}">
                  <a16:creationId xmlns:a16="http://schemas.microsoft.com/office/drawing/2014/main" id="{FA37174E-7C6F-1457-CE6E-6D027A2080CC}"/>
                </a:ext>
              </a:extLst>
            </p:cNvPr>
            <p:cNvSpPr/>
            <p:nvPr/>
          </p:nvSpPr>
          <p:spPr>
            <a:xfrm>
              <a:off x="4715414" y="498348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5" name="pl100">
              <a:extLst>
                <a:ext uri="{FF2B5EF4-FFF2-40B4-BE49-F238E27FC236}">
                  <a16:creationId xmlns:a16="http://schemas.microsoft.com/office/drawing/2014/main" id="{11D1C9A1-D987-B0FE-FF8C-0610ED6739D3}"/>
                </a:ext>
              </a:extLst>
            </p:cNvPr>
            <p:cNvSpPr/>
            <p:nvPr/>
          </p:nvSpPr>
          <p:spPr>
            <a:xfrm>
              <a:off x="1302313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6" name="pl101">
              <a:extLst>
                <a:ext uri="{FF2B5EF4-FFF2-40B4-BE49-F238E27FC236}">
                  <a16:creationId xmlns:a16="http://schemas.microsoft.com/office/drawing/2014/main" id="{47FE1CAF-F634-279D-89CF-CAF2D5EF985E}"/>
                </a:ext>
              </a:extLst>
            </p:cNvPr>
            <p:cNvSpPr/>
            <p:nvPr/>
          </p:nvSpPr>
          <p:spPr>
            <a:xfrm>
              <a:off x="1334570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7" name="pl102">
              <a:extLst>
                <a:ext uri="{FF2B5EF4-FFF2-40B4-BE49-F238E27FC236}">
                  <a16:creationId xmlns:a16="http://schemas.microsoft.com/office/drawing/2014/main" id="{43C86B58-31F5-965F-99A9-014BFF3AA7E4}"/>
                </a:ext>
              </a:extLst>
            </p:cNvPr>
            <p:cNvSpPr/>
            <p:nvPr/>
          </p:nvSpPr>
          <p:spPr>
            <a:xfrm>
              <a:off x="1302313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8" name="pl103">
              <a:extLst>
                <a:ext uri="{FF2B5EF4-FFF2-40B4-BE49-F238E27FC236}">
                  <a16:creationId xmlns:a16="http://schemas.microsoft.com/office/drawing/2014/main" id="{C1310E71-58C7-5522-A788-7121B97E66CF}"/>
                </a:ext>
              </a:extLst>
            </p:cNvPr>
            <p:cNvSpPr/>
            <p:nvPr/>
          </p:nvSpPr>
          <p:spPr>
            <a:xfrm>
              <a:off x="1495854" y="252253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79" name="pl104">
              <a:extLst>
                <a:ext uri="{FF2B5EF4-FFF2-40B4-BE49-F238E27FC236}">
                  <a16:creationId xmlns:a16="http://schemas.microsoft.com/office/drawing/2014/main" id="{986E1F4A-85DA-FEC3-6176-683F79991EB3}"/>
                </a:ext>
              </a:extLst>
            </p:cNvPr>
            <p:cNvSpPr/>
            <p:nvPr/>
          </p:nvSpPr>
          <p:spPr>
            <a:xfrm>
              <a:off x="1528110" y="2522533"/>
              <a:ext cx="0" cy="934268"/>
            </a:xfrm>
            <a:custGeom>
              <a:avLst/>
              <a:gdLst/>
              <a:ahLst/>
              <a:cxnLst/>
              <a:rect l="0" t="0" r="0" b="0"/>
              <a:pathLst>
                <a:path h="934268">
                  <a:moveTo>
                    <a:pt x="0" y="0"/>
                  </a:moveTo>
                  <a:lnTo>
                    <a:pt x="0" y="93426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0" name="pl105">
              <a:extLst>
                <a:ext uri="{FF2B5EF4-FFF2-40B4-BE49-F238E27FC236}">
                  <a16:creationId xmlns:a16="http://schemas.microsoft.com/office/drawing/2014/main" id="{34B51903-B4B9-EE27-9041-7E6B11002B6E}"/>
                </a:ext>
              </a:extLst>
            </p:cNvPr>
            <p:cNvSpPr/>
            <p:nvPr/>
          </p:nvSpPr>
          <p:spPr>
            <a:xfrm>
              <a:off x="1495854" y="3456802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1" name="pl106">
              <a:extLst>
                <a:ext uri="{FF2B5EF4-FFF2-40B4-BE49-F238E27FC236}">
                  <a16:creationId xmlns:a16="http://schemas.microsoft.com/office/drawing/2014/main" id="{AE9DBA1C-AC48-7585-B96A-F88D46029636}"/>
                </a:ext>
              </a:extLst>
            </p:cNvPr>
            <p:cNvSpPr/>
            <p:nvPr/>
          </p:nvSpPr>
          <p:spPr>
            <a:xfrm>
              <a:off x="1689394" y="226124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2" name="pl107">
              <a:extLst>
                <a:ext uri="{FF2B5EF4-FFF2-40B4-BE49-F238E27FC236}">
                  <a16:creationId xmlns:a16="http://schemas.microsoft.com/office/drawing/2014/main" id="{AABCFAFC-E7AB-B0B9-5BC0-31389D64F175}"/>
                </a:ext>
              </a:extLst>
            </p:cNvPr>
            <p:cNvSpPr/>
            <p:nvPr/>
          </p:nvSpPr>
          <p:spPr>
            <a:xfrm>
              <a:off x="1721651" y="2261244"/>
              <a:ext cx="0" cy="1287471"/>
            </a:xfrm>
            <a:custGeom>
              <a:avLst/>
              <a:gdLst/>
              <a:ahLst/>
              <a:cxnLst/>
              <a:rect l="0" t="0" r="0" b="0"/>
              <a:pathLst>
                <a:path h="1287471">
                  <a:moveTo>
                    <a:pt x="0" y="0"/>
                  </a:moveTo>
                  <a:lnTo>
                    <a:pt x="0" y="128747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3" name="pl108">
              <a:extLst>
                <a:ext uri="{FF2B5EF4-FFF2-40B4-BE49-F238E27FC236}">
                  <a16:creationId xmlns:a16="http://schemas.microsoft.com/office/drawing/2014/main" id="{10BACC90-354E-A3FD-5722-5998420371F9}"/>
                </a:ext>
              </a:extLst>
            </p:cNvPr>
            <p:cNvSpPr/>
            <p:nvPr/>
          </p:nvSpPr>
          <p:spPr>
            <a:xfrm>
              <a:off x="1689394" y="354871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4" name="pl109">
              <a:extLst>
                <a:ext uri="{FF2B5EF4-FFF2-40B4-BE49-F238E27FC236}">
                  <a16:creationId xmlns:a16="http://schemas.microsoft.com/office/drawing/2014/main" id="{77F43953-8EE9-539A-BE8B-8CAA49DF29CE}"/>
                </a:ext>
              </a:extLst>
            </p:cNvPr>
            <p:cNvSpPr/>
            <p:nvPr/>
          </p:nvSpPr>
          <p:spPr>
            <a:xfrm>
              <a:off x="1947449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5" name="pl110">
              <a:extLst>
                <a:ext uri="{FF2B5EF4-FFF2-40B4-BE49-F238E27FC236}">
                  <a16:creationId xmlns:a16="http://schemas.microsoft.com/office/drawing/2014/main" id="{542AB410-43A7-B4C9-6AEE-E24A54158AFF}"/>
                </a:ext>
              </a:extLst>
            </p:cNvPr>
            <p:cNvSpPr/>
            <p:nvPr/>
          </p:nvSpPr>
          <p:spPr>
            <a:xfrm>
              <a:off x="1979706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6" name="pl111">
              <a:extLst>
                <a:ext uri="{FF2B5EF4-FFF2-40B4-BE49-F238E27FC236}">
                  <a16:creationId xmlns:a16="http://schemas.microsoft.com/office/drawing/2014/main" id="{6249A957-69D6-AABF-C0D9-D28892D2241D}"/>
                </a:ext>
              </a:extLst>
            </p:cNvPr>
            <p:cNvSpPr/>
            <p:nvPr/>
          </p:nvSpPr>
          <p:spPr>
            <a:xfrm>
              <a:off x="1947449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7" name="pl112">
              <a:extLst>
                <a:ext uri="{FF2B5EF4-FFF2-40B4-BE49-F238E27FC236}">
                  <a16:creationId xmlns:a16="http://schemas.microsoft.com/office/drawing/2014/main" id="{28B33D96-BCE3-356F-6D9C-B74237024FA6}"/>
                </a:ext>
              </a:extLst>
            </p:cNvPr>
            <p:cNvSpPr/>
            <p:nvPr/>
          </p:nvSpPr>
          <p:spPr>
            <a:xfrm>
              <a:off x="2140990" y="5171901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8" name="pl113">
              <a:extLst>
                <a:ext uri="{FF2B5EF4-FFF2-40B4-BE49-F238E27FC236}">
                  <a16:creationId xmlns:a16="http://schemas.microsoft.com/office/drawing/2014/main" id="{46606DEC-5A1B-49F1-36D2-AE9B2C60FE1C}"/>
                </a:ext>
              </a:extLst>
            </p:cNvPr>
            <p:cNvSpPr/>
            <p:nvPr/>
          </p:nvSpPr>
          <p:spPr>
            <a:xfrm>
              <a:off x="2173247" y="5171901"/>
              <a:ext cx="0" cy="82008"/>
            </a:xfrm>
            <a:custGeom>
              <a:avLst/>
              <a:gdLst/>
              <a:ahLst/>
              <a:cxnLst/>
              <a:rect l="0" t="0" r="0" b="0"/>
              <a:pathLst>
                <a:path h="82008">
                  <a:moveTo>
                    <a:pt x="0" y="0"/>
                  </a:moveTo>
                  <a:lnTo>
                    <a:pt x="0" y="8200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89" name="pl114">
              <a:extLst>
                <a:ext uri="{FF2B5EF4-FFF2-40B4-BE49-F238E27FC236}">
                  <a16:creationId xmlns:a16="http://schemas.microsoft.com/office/drawing/2014/main" id="{7382578E-6DFC-4746-3ADC-7E965C7C15B0}"/>
                </a:ext>
              </a:extLst>
            </p:cNvPr>
            <p:cNvSpPr/>
            <p:nvPr/>
          </p:nvSpPr>
          <p:spPr>
            <a:xfrm>
              <a:off x="2140990" y="5253909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0" name="pl115">
              <a:extLst>
                <a:ext uri="{FF2B5EF4-FFF2-40B4-BE49-F238E27FC236}">
                  <a16:creationId xmlns:a16="http://schemas.microsoft.com/office/drawing/2014/main" id="{9E545917-B89B-1E9B-DA8F-A7D1C3677F5C}"/>
                </a:ext>
              </a:extLst>
            </p:cNvPr>
            <p:cNvSpPr/>
            <p:nvPr/>
          </p:nvSpPr>
          <p:spPr>
            <a:xfrm>
              <a:off x="2334531" y="521656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1" name="pl116">
              <a:extLst>
                <a:ext uri="{FF2B5EF4-FFF2-40B4-BE49-F238E27FC236}">
                  <a16:creationId xmlns:a16="http://schemas.microsoft.com/office/drawing/2014/main" id="{A1032C19-2354-45C4-A919-9FC9D1EB22B2}"/>
                </a:ext>
              </a:extLst>
            </p:cNvPr>
            <p:cNvSpPr/>
            <p:nvPr/>
          </p:nvSpPr>
          <p:spPr>
            <a:xfrm>
              <a:off x="2366787" y="5216563"/>
              <a:ext cx="0" cy="126476"/>
            </a:xfrm>
            <a:custGeom>
              <a:avLst/>
              <a:gdLst/>
              <a:ahLst/>
              <a:cxnLst/>
              <a:rect l="0" t="0" r="0" b="0"/>
              <a:pathLst>
                <a:path h="126476">
                  <a:moveTo>
                    <a:pt x="0" y="0"/>
                  </a:moveTo>
                  <a:lnTo>
                    <a:pt x="0" y="12647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2" name="pl117">
              <a:extLst>
                <a:ext uri="{FF2B5EF4-FFF2-40B4-BE49-F238E27FC236}">
                  <a16:creationId xmlns:a16="http://schemas.microsoft.com/office/drawing/2014/main" id="{169AA310-F0C8-68E4-3E7F-0FE38FBAF2CE}"/>
                </a:ext>
              </a:extLst>
            </p:cNvPr>
            <p:cNvSpPr/>
            <p:nvPr/>
          </p:nvSpPr>
          <p:spPr>
            <a:xfrm>
              <a:off x="2334531" y="5343040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3" name="pl118">
              <a:extLst>
                <a:ext uri="{FF2B5EF4-FFF2-40B4-BE49-F238E27FC236}">
                  <a16:creationId xmlns:a16="http://schemas.microsoft.com/office/drawing/2014/main" id="{F7A26972-E2C3-A916-906F-3A68143C1BB8}"/>
                </a:ext>
              </a:extLst>
            </p:cNvPr>
            <p:cNvSpPr/>
            <p:nvPr/>
          </p:nvSpPr>
          <p:spPr>
            <a:xfrm>
              <a:off x="2592585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4" name="pl119">
              <a:extLst>
                <a:ext uri="{FF2B5EF4-FFF2-40B4-BE49-F238E27FC236}">
                  <a16:creationId xmlns:a16="http://schemas.microsoft.com/office/drawing/2014/main" id="{96F957BF-E9C7-E428-4162-F8D68B764964}"/>
                </a:ext>
              </a:extLst>
            </p:cNvPr>
            <p:cNvSpPr/>
            <p:nvPr/>
          </p:nvSpPr>
          <p:spPr>
            <a:xfrm>
              <a:off x="2624842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5" name="pl120">
              <a:extLst>
                <a:ext uri="{FF2B5EF4-FFF2-40B4-BE49-F238E27FC236}">
                  <a16:creationId xmlns:a16="http://schemas.microsoft.com/office/drawing/2014/main" id="{AD955D4C-D010-DEAA-95E8-3F913D23E11E}"/>
                </a:ext>
              </a:extLst>
            </p:cNvPr>
            <p:cNvSpPr/>
            <p:nvPr/>
          </p:nvSpPr>
          <p:spPr>
            <a:xfrm>
              <a:off x="2592585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6" name="pl121">
              <a:extLst>
                <a:ext uri="{FF2B5EF4-FFF2-40B4-BE49-F238E27FC236}">
                  <a16:creationId xmlns:a16="http://schemas.microsoft.com/office/drawing/2014/main" id="{3F8DEC0A-9148-FE72-E058-AE188B3451B8}"/>
                </a:ext>
              </a:extLst>
            </p:cNvPr>
            <p:cNvSpPr/>
            <p:nvPr/>
          </p:nvSpPr>
          <p:spPr>
            <a:xfrm>
              <a:off x="2786126" y="5350948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7" name="pl122">
              <a:extLst>
                <a:ext uri="{FF2B5EF4-FFF2-40B4-BE49-F238E27FC236}">
                  <a16:creationId xmlns:a16="http://schemas.microsoft.com/office/drawing/2014/main" id="{69BAEBAF-2BCE-3426-8CF7-6B4C534E1A8E}"/>
                </a:ext>
              </a:extLst>
            </p:cNvPr>
            <p:cNvSpPr/>
            <p:nvPr/>
          </p:nvSpPr>
          <p:spPr>
            <a:xfrm>
              <a:off x="2818383" y="5350948"/>
              <a:ext cx="0" cy="80337"/>
            </a:xfrm>
            <a:custGeom>
              <a:avLst/>
              <a:gdLst/>
              <a:ahLst/>
              <a:cxnLst/>
              <a:rect l="0" t="0" r="0" b="0"/>
              <a:pathLst>
                <a:path h="80337">
                  <a:moveTo>
                    <a:pt x="0" y="0"/>
                  </a:moveTo>
                  <a:lnTo>
                    <a:pt x="0" y="8033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8" name="pl123">
              <a:extLst>
                <a:ext uri="{FF2B5EF4-FFF2-40B4-BE49-F238E27FC236}">
                  <a16:creationId xmlns:a16="http://schemas.microsoft.com/office/drawing/2014/main" id="{FE970AB9-67C2-9D9A-C0AB-50C9AC41C5E0}"/>
                </a:ext>
              </a:extLst>
            </p:cNvPr>
            <p:cNvSpPr/>
            <p:nvPr/>
          </p:nvSpPr>
          <p:spPr>
            <a:xfrm>
              <a:off x="2786126" y="5431286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699" name="pl124">
              <a:extLst>
                <a:ext uri="{FF2B5EF4-FFF2-40B4-BE49-F238E27FC236}">
                  <a16:creationId xmlns:a16="http://schemas.microsoft.com/office/drawing/2014/main" id="{49A69334-CB7F-853A-B807-AC6030D88EE8}"/>
                </a:ext>
              </a:extLst>
            </p:cNvPr>
            <p:cNvSpPr/>
            <p:nvPr/>
          </p:nvSpPr>
          <p:spPr>
            <a:xfrm>
              <a:off x="2979667" y="5403569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0" name="pl125">
              <a:extLst>
                <a:ext uri="{FF2B5EF4-FFF2-40B4-BE49-F238E27FC236}">
                  <a16:creationId xmlns:a16="http://schemas.microsoft.com/office/drawing/2014/main" id="{A8768DB0-CC06-5EE4-F047-E177C593D8A0}"/>
                </a:ext>
              </a:extLst>
            </p:cNvPr>
            <p:cNvSpPr/>
            <p:nvPr/>
          </p:nvSpPr>
          <p:spPr>
            <a:xfrm>
              <a:off x="3011923" y="5403569"/>
              <a:ext cx="0" cy="86134"/>
            </a:xfrm>
            <a:custGeom>
              <a:avLst/>
              <a:gdLst/>
              <a:ahLst/>
              <a:cxnLst/>
              <a:rect l="0" t="0" r="0" b="0"/>
              <a:pathLst>
                <a:path h="86134">
                  <a:moveTo>
                    <a:pt x="0" y="0"/>
                  </a:moveTo>
                  <a:lnTo>
                    <a:pt x="0" y="861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1" name="pl126">
              <a:extLst>
                <a:ext uri="{FF2B5EF4-FFF2-40B4-BE49-F238E27FC236}">
                  <a16:creationId xmlns:a16="http://schemas.microsoft.com/office/drawing/2014/main" id="{793AEC83-4413-4066-1FCF-4AA191915817}"/>
                </a:ext>
              </a:extLst>
            </p:cNvPr>
            <p:cNvSpPr/>
            <p:nvPr/>
          </p:nvSpPr>
          <p:spPr>
            <a:xfrm>
              <a:off x="2979667" y="548970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2" name="pl127">
              <a:extLst>
                <a:ext uri="{FF2B5EF4-FFF2-40B4-BE49-F238E27FC236}">
                  <a16:creationId xmlns:a16="http://schemas.microsoft.com/office/drawing/2014/main" id="{F2188F30-7EE4-640B-D103-4D919132C8B6}"/>
                </a:ext>
              </a:extLst>
            </p:cNvPr>
            <p:cNvSpPr/>
            <p:nvPr/>
          </p:nvSpPr>
          <p:spPr>
            <a:xfrm>
              <a:off x="3237721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3" name="pl128">
              <a:extLst>
                <a:ext uri="{FF2B5EF4-FFF2-40B4-BE49-F238E27FC236}">
                  <a16:creationId xmlns:a16="http://schemas.microsoft.com/office/drawing/2014/main" id="{F063AD8E-BD73-3255-C6B5-71CEDEABCCD0}"/>
                </a:ext>
              </a:extLst>
            </p:cNvPr>
            <p:cNvSpPr/>
            <p:nvPr/>
          </p:nvSpPr>
          <p:spPr>
            <a:xfrm>
              <a:off x="3269978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4" name="pl129">
              <a:extLst>
                <a:ext uri="{FF2B5EF4-FFF2-40B4-BE49-F238E27FC236}">
                  <a16:creationId xmlns:a16="http://schemas.microsoft.com/office/drawing/2014/main" id="{4ABE1CAC-D6B3-5901-EF1F-98E8C406A4C7}"/>
                </a:ext>
              </a:extLst>
            </p:cNvPr>
            <p:cNvSpPr/>
            <p:nvPr/>
          </p:nvSpPr>
          <p:spPr>
            <a:xfrm>
              <a:off x="3237721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5" name="pl130">
              <a:extLst>
                <a:ext uri="{FF2B5EF4-FFF2-40B4-BE49-F238E27FC236}">
                  <a16:creationId xmlns:a16="http://schemas.microsoft.com/office/drawing/2014/main" id="{D7A30445-D221-22B5-D0D2-29315E2426D3}"/>
                </a:ext>
              </a:extLst>
            </p:cNvPr>
            <p:cNvSpPr/>
            <p:nvPr/>
          </p:nvSpPr>
          <p:spPr>
            <a:xfrm>
              <a:off x="3431262" y="427222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6" name="pl131">
              <a:extLst>
                <a:ext uri="{FF2B5EF4-FFF2-40B4-BE49-F238E27FC236}">
                  <a16:creationId xmlns:a16="http://schemas.microsoft.com/office/drawing/2014/main" id="{26D81C18-73F6-25C4-A08E-7CBE0388F8D9}"/>
                </a:ext>
              </a:extLst>
            </p:cNvPr>
            <p:cNvSpPr/>
            <p:nvPr/>
          </p:nvSpPr>
          <p:spPr>
            <a:xfrm>
              <a:off x="3463519" y="4272223"/>
              <a:ext cx="0" cy="412432"/>
            </a:xfrm>
            <a:custGeom>
              <a:avLst/>
              <a:gdLst/>
              <a:ahLst/>
              <a:cxnLst/>
              <a:rect l="0" t="0" r="0" b="0"/>
              <a:pathLst>
                <a:path h="412432">
                  <a:moveTo>
                    <a:pt x="0" y="0"/>
                  </a:moveTo>
                  <a:lnTo>
                    <a:pt x="0" y="41243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7" name="pl132">
              <a:extLst>
                <a:ext uri="{FF2B5EF4-FFF2-40B4-BE49-F238E27FC236}">
                  <a16:creationId xmlns:a16="http://schemas.microsoft.com/office/drawing/2014/main" id="{AA65E4A4-4030-6215-2C0F-782C60335B92}"/>
                </a:ext>
              </a:extLst>
            </p:cNvPr>
            <p:cNvSpPr/>
            <p:nvPr/>
          </p:nvSpPr>
          <p:spPr>
            <a:xfrm>
              <a:off x="3431262" y="468465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8" name="pl133">
              <a:extLst>
                <a:ext uri="{FF2B5EF4-FFF2-40B4-BE49-F238E27FC236}">
                  <a16:creationId xmlns:a16="http://schemas.microsoft.com/office/drawing/2014/main" id="{B5EBB52C-1987-1B52-846D-BFF8CA2DAAE0}"/>
                </a:ext>
              </a:extLst>
            </p:cNvPr>
            <p:cNvSpPr/>
            <p:nvPr/>
          </p:nvSpPr>
          <p:spPr>
            <a:xfrm>
              <a:off x="3624803" y="4285727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09" name="pl134">
              <a:extLst>
                <a:ext uri="{FF2B5EF4-FFF2-40B4-BE49-F238E27FC236}">
                  <a16:creationId xmlns:a16="http://schemas.microsoft.com/office/drawing/2014/main" id="{CA1CD15D-E032-670A-B475-AD3470F943E2}"/>
                </a:ext>
              </a:extLst>
            </p:cNvPr>
            <p:cNvSpPr/>
            <p:nvPr/>
          </p:nvSpPr>
          <p:spPr>
            <a:xfrm>
              <a:off x="3657060" y="4285727"/>
              <a:ext cx="0" cy="380597"/>
            </a:xfrm>
            <a:custGeom>
              <a:avLst/>
              <a:gdLst/>
              <a:ahLst/>
              <a:cxnLst/>
              <a:rect l="0" t="0" r="0" b="0"/>
              <a:pathLst>
                <a:path h="380597">
                  <a:moveTo>
                    <a:pt x="0" y="0"/>
                  </a:moveTo>
                  <a:lnTo>
                    <a:pt x="0" y="38059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0" name="pl135">
              <a:extLst>
                <a:ext uri="{FF2B5EF4-FFF2-40B4-BE49-F238E27FC236}">
                  <a16:creationId xmlns:a16="http://schemas.microsoft.com/office/drawing/2014/main" id="{E99EAC52-175D-59B9-3375-53987DA0AE03}"/>
                </a:ext>
              </a:extLst>
            </p:cNvPr>
            <p:cNvSpPr/>
            <p:nvPr/>
          </p:nvSpPr>
          <p:spPr>
            <a:xfrm>
              <a:off x="3624803" y="466632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1" name="pl136">
              <a:extLst>
                <a:ext uri="{FF2B5EF4-FFF2-40B4-BE49-F238E27FC236}">
                  <a16:creationId xmlns:a16="http://schemas.microsoft.com/office/drawing/2014/main" id="{8B64CE80-F8A0-CDAB-167B-F0F942F76F7A}"/>
                </a:ext>
              </a:extLst>
            </p:cNvPr>
            <p:cNvSpPr/>
            <p:nvPr/>
          </p:nvSpPr>
          <p:spPr>
            <a:xfrm>
              <a:off x="3882857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2" name="pl137">
              <a:extLst>
                <a:ext uri="{FF2B5EF4-FFF2-40B4-BE49-F238E27FC236}">
                  <a16:creationId xmlns:a16="http://schemas.microsoft.com/office/drawing/2014/main" id="{B0D8C92A-198C-3605-4AE0-666B5E22172F}"/>
                </a:ext>
              </a:extLst>
            </p:cNvPr>
            <p:cNvSpPr/>
            <p:nvPr/>
          </p:nvSpPr>
          <p:spPr>
            <a:xfrm>
              <a:off x="3915114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3" name="pl138">
              <a:extLst>
                <a:ext uri="{FF2B5EF4-FFF2-40B4-BE49-F238E27FC236}">
                  <a16:creationId xmlns:a16="http://schemas.microsoft.com/office/drawing/2014/main" id="{FC0B5966-4DC7-F503-7531-FAD4D5A0F8D0}"/>
                </a:ext>
              </a:extLst>
            </p:cNvPr>
            <p:cNvSpPr/>
            <p:nvPr/>
          </p:nvSpPr>
          <p:spPr>
            <a:xfrm>
              <a:off x="3882857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4" name="pl139">
              <a:extLst>
                <a:ext uri="{FF2B5EF4-FFF2-40B4-BE49-F238E27FC236}">
                  <a16:creationId xmlns:a16="http://schemas.microsoft.com/office/drawing/2014/main" id="{B3F7AC1A-1494-5B07-206A-6433F3E6DFE5}"/>
                </a:ext>
              </a:extLst>
            </p:cNvPr>
            <p:cNvSpPr/>
            <p:nvPr/>
          </p:nvSpPr>
          <p:spPr>
            <a:xfrm>
              <a:off x="4076398" y="4355217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5" name="pl140">
              <a:extLst>
                <a:ext uri="{FF2B5EF4-FFF2-40B4-BE49-F238E27FC236}">
                  <a16:creationId xmlns:a16="http://schemas.microsoft.com/office/drawing/2014/main" id="{5AA342D9-E7C6-1799-BFF2-2CAD93123F7B}"/>
                </a:ext>
              </a:extLst>
            </p:cNvPr>
            <p:cNvSpPr/>
            <p:nvPr/>
          </p:nvSpPr>
          <p:spPr>
            <a:xfrm>
              <a:off x="4108655" y="4355217"/>
              <a:ext cx="0" cy="429685"/>
            </a:xfrm>
            <a:custGeom>
              <a:avLst/>
              <a:gdLst/>
              <a:ahLst/>
              <a:cxnLst/>
              <a:rect l="0" t="0" r="0" b="0"/>
              <a:pathLst>
                <a:path h="429685">
                  <a:moveTo>
                    <a:pt x="0" y="0"/>
                  </a:moveTo>
                  <a:lnTo>
                    <a:pt x="0" y="42968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6" name="pl141">
              <a:extLst>
                <a:ext uri="{FF2B5EF4-FFF2-40B4-BE49-F238E27FC236}">
                  <a16:creationId xmlns:a16="http://schemas.microsoft.com/office/drawing/2014/main" id="{86D32651-2707-5A45-9863-EF6875486E43}"/>
                </a:ext>
              </a:extLst>
            </p:cNvPr>
            <p:cNvSpPr/>
            <p:nvPr/>
          </p:nvSpPr>
          <p:spPr>
            <a:xfrm>
              <a:off x="4076398" y="478490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7" name="pl142">
              <a:extLst>
                <a:ext uri="{FF2B5EF4-FFF2-40B4-BE49-F238E27FC236}">
                  <a16:creationId xmlns:a16="http://schemas.microsoft.com/office/drawing/2014/main" id="{CFAFD2EA-C00E-2B52-D4BE-6EF1EB5948AC}"/>
                </a:ext>
              </a:extLst>
            </p:cNvPr>
            <p:cNvSpPr/>
            <p:nvPr/>
          </p:nvSpPr>
          <p:spPr>
            <a:xfrm>
              <a:off x="4269939" y="424240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8" name="pl143">
              <a:extLst>
                <a:ext uri="{FF2B5EF4-FFF2-40B4-BE49-F238E27FC236}">
                  <a16:creationId xmlns:a16="http://schemas.microsoft.com/office/drawing/2014/main" id="{DD13B830-D452-B3D6-CC28-6401CFE7D6A1}"/>
                </a:ext>
              </a:extLst>
            </p:cNvPr>
            <p:cNvSpPr/>
            <p:nvPr/>
          </p:nvSpPr>
          <p:spPr>
            <a:xfrm>
              <a:off x="4302196" y="4242405"/>
              <a:ext cx="0" cy="440208"/>
            </a:xfrm>
            <a:custGeom>
              <a:avLst/>
              <a:gdLst/>
              <a:ahLst/>
              <a:cxnLst/>
              <a:rect l="0" t="0" r="0" b="0"/>
              <a:pathLst>
                <a:path h="440208">
                  <a:moveTo>
                    <a:pt x="0" y="0"/>
                  </a:moveTo>
                  <a:lnTo>
                    <a:pt x="0" y="44020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19" name="pl144">
              <a:extLst>
                <a:ext uri="{FF2B5EF4-FFF2-40B4-BE49-F238E27FC236}">
                  <a16:creationId xmlns:a16="http://schemas.microsoft.com/office/drawing/2014/main" id="{97B90956-4CFC-8A93-B966-60571EEEF5D9}"/>
                </a:ext>
              </a:extLst>
            </p:cNvPr>
            <p:cNvSpPr/>
            <p:nvPr/>
          </p:nvSpPr>
          <p:spPr>
            <a:xfrm>
              <a:off x="4269939" y="4682613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0" name="pl145">
              <a:extLst>
                <a:ext uri="{FF2B5EF4-FFF2-40B4-BE49-F238E27FC236}">
                  <a16:creationId xmlns:a16="http://schemas.microsoft.com/office/drawing/2014/main" id="{2D542B09-D46E-7EA0-F2B0-9B38DB180544}"/>
                </a:ext>
              </a:extLst>
            </p:cNvPr>
            <p:cNvSpPr/>
            <p:nvPr/>
          </p:nvSpPr>
          <p:spPr>
            <a:xfrm>
              <a:off x="4527993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1" name="pl146">
              <a:extLst>
                <a:ext uri="{FF2B5EF4-FFF2-40B4-BE49-F238E27FC236}">
                  <a16:creationId xmlns:a16="http://schemas.microsoft.com/office/drawing/2014/main" id="{C25FF511-19F4-F4FC-C6F1-A45950495FC0}"/>
                </a:ext>
              </a:extLst>
            </p:cNvPr>
            <p:cNvSpPr/>
            <p:nvPr/>
          </p:nvSpPr>
          <p:spPr>
            <a:xfrm>
              <a:off x="4560250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2" name="pl147">
              <a:extLst>
                <a:ext uri="{FF2B5EF4-FFF2-40B4-BE49-F238E27FC236}">
                  <a16:creationId xmlns:a16="http://schemas.microsoft.com/office/drawing/2014/main" id="{3569F76A-7978-80AA-0900-2C418C7959A1}"/>
                </a:ext>
              </a:extLst>
            </p:cNvPr>
            <p:cNvSpPr/>
            <p:nvPr/>
          </p:nvSpPr>
          <p:spPr>
            <a:xfrm>
              <a:off x="4527993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3" name="pl148">
              <a:extLst>
                <a:ext uri="{FF2B5EF4-FFF2-40B4-BE49-F238E27FC236}">
                  <a16:creationId xmlns:a16="http://schemas.microsoft.com/office/drawing/2014/main" id="{FCD70ED5-D6A6-5481-A5C9-E76EFB60B10F}"/>
                </a:ext>
              </a:extLst>
            </p:cNvPr>
            <p:cNvSpPr/>
            <p:nvPr/>
          </p:nvSpPr>
          <p:spPr>
            <a:xfrm>
              <a:off x="4721534" y="4539206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4" name="pl149">
              <a:extLst>
                <a:ext uri="{FF2B5EF4-FFF2-40B4-BE49-F238E27FC236}">
                  <a16:creationId xmlns:a16="http://schemas.microsoft.com/office/drawing/2014/main" id="{D7DABBF9-6CCD-4640-25D1-C327DF1288F0}"/>
                </a:ext>
              </a:extLst>
            </p:cNvPr>
            <p:cNvSpPr/>
            <p:nvPr/>
          </p:nvSpPr>
          <p:spPr>
            <a:xfrm>
              <a:off x="4753791" y="4539206"/>
              <a:ext cx="0" cy="470157"/>
            </a:xfrm>
            <a:custGeom>
              <a:avLst/>
              <a:gdLst/>
              <a:ahLst/>
              <a:cxnLst/>
              <a:rect l="0" t="0" r="0" b="0"/>
              <a:pathLst>
                <a:path h="470157">
                  <a:moveTo>
                    <a:pt x="0" y="0"/>
                  </a:moveTo>
                  <a:lnTo>
                    <a:pt x="0" y="47015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5" name="pl150">
              <a:extLst>
                <a:ext uri="{FF2B5EF4-FFF2-40B4-BE49-F238E27FC236}">
                  <a16:creationId xmlns:a16="http://schemas.microsoft.com/office/drawing/2014/main" id="{332721E1-0D34-4A71-B7E4-93315E3A17E2}"/>
                </a:ext>
              </a:extLst>
            </p:cNvPr>
            <p:cNvSpPr/>
            <p:nvPr/>
          </p:nvSpPr>
          <p:spPr>
            <a:xfrm>
              <a:off x="4721534" y="500936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6" name="pl151">
              <a:extLst>
                <a:ext uri="{FF2B5EF4-FFF2-40B4-BE49-F238E27FC236}">
                  <a16:creationId xmlns:a16="http://schemas.microsoft.com/office/drawing/2014/main" id="{DBF1E58C-8AF2-9ACD-E084-82223355E7E1}"/>
                </a:ext>
              </a:extLst>
            </p:cNvPr>
            <p:cNvSpPr/>
            <p:nvPr/>
          </p:nvSpPr>
          <p:spPr>
            <a:xfrm>
              <a:off x="4915075" y="4498250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7" name="pl152">
              <a:extLst>
                <a:ext uri="{FF2B5EF4-FFF2-40B4-BE49-F238E27FC236}">
                  <a16:creationId xmlns:a16="http://schemas.microsoft.com/office/drawing/2014/main" id="{21419CE0-E794-891B-C78E-2D7FD2A4AEFD}"/>
                </a:ext>
              </a:extLst>
            </p:cNvPr>
            <p:cNvSpPr/>
            <p:nvPr/>
          </p:nvSpPr>
          <p:spPr>
            <a:xfrm>
              <a:off x="4947332" y="4498250"/>
              <a:ext cx="0" cy="509811"/>
            </a:xfrm>
            <a:custGeom>
              <a:avLst/>
              <a:gdLst/>
              <a:ahLst/>
              <a:cxnLst/>
              <a:rect l="0" t="0" r="0" b="0"/>
              <a:pathLst>
                <a:path h="509811">
                  <a:moveTo>
                    <a:pt x="0" y="0"/>
                  </a:moveTo>
                  <a:lnTo>
                    <a:pt x="0" y="50981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8" name="pl153">
              <a:extLst>
                <a:ext uri="{FF2B5EF4-FFF2-40B4-BE49-F238E27FC236}">
                  <a16:creationId xmlns:a16="http://schemas.microsoft.com/office/drawing/2014/main" id="{0495E8D5-3578-BF85-D4E7-A06277197A1B}"/>
                </a:ext>
              </a:extLst>
            </p:cNvPr>
            <p:cNvSpPr/>
            <p:nvPr/>
          </p:nvSpPr>
          <p:spPr>
            <a:xfrm>
              <a:off x="4915075" y="5008061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29" name="pl154">
              <a:extLst>
                <a:ext uri="{FF2B5EF4-FFF2-40B4-BE49-F238E27FC236}">
                  <a16:creationId xmlns:a16="http://schemas.microsoft.com/office/drawing/2014/main" id="{14507357-811F-94B9-6D3F-49B623C5FCB2}"/>
                </a:ext>
              </a:extLst>
            </p:cNvPr>
            <p:cNvSpPr/>
            <p:nvPr/>
          </p:nvSpPr>
          <p:spPr>
            <a:xfrm>
              <a:off x="5173129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0" name="pl155">
              <a:extLst>
                <a:ext uri="{FF2B5EF4-FFF2-40B4-BE49-F238E27FC236}">
                  <a16:creationId xmlns:a16="http://schemas.microsoft.com/office/drawing/2014/main" id="{DEABE43E-0128-895F-BF4A-15A965D05267}"/>
                </a:ext>
              </a:extLst>
            </p:cNvPr>
            <p:cNvSpPr/>
            <p:nvPr/>
          </p:nvSpPr>
          <p:spPr>
            <a:xfrm>
              <a:off x="5205386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1" name="pl156">
              <a:extLst>
                <a:ext uri="{FF2B5EF4-FFF2-40B4-BE49-F238E27FC236}">
                  <a16:creationId xmlns:a16="http://schemas.microsoft.com/office/drawing/2014/main" id="{8F0ED752-B82D-EDEE-540D-2E9E1B8AB31F}"/>
                </a:ext>
              </a:extLst>
            </p:cNvPr>
            <p:cNvSpPr/>
            <p:nvPr/>
          </p:nvSpPr>
          <p:spPr>
            <a:xfrm>
              <a:off x="5173129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2" name="pl157">
              <a:extLst>
                <a:ext uri="{FF2B5EF4-FFF2-40B4-BE49-F238E27FC236}">
                  <a16:creationId xmlns:a16="http://schemas.microsoft.com/office/drawing/2014/main" id="{6C8D36AA-D2D3-CF48-48BE-F1C97DA2A23B}"/>
                </a:ext>
              </a:extLst>
            </p:cNvPr>
            <p:cNvSpPr/>
            <p:nvPr/>
          </p:nvSpPr>
          <p:spPr>
            <a:xfrm>
              <a:off x="5366670" y="550826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3" name="pl158">
              <a:extLst>
                <a:ext uri="{FF2B5EF4-FFF2-40B4-BE49-F238E27FC236}">
                  <a16:creationId xmlns:a16="http://schemas.microsoft.com/office/drawing/2014/main" id="{1B4CD7EE-11B2-13BC-0383-5FD1231B73B0}"/>
                </a:ext>
              </a:extLst>
            </p:cNvPr>
            <p:cNvSpPr/>
            <p:nvPr/>
          </p:nvSpPr>
          <p:spPr>
            <a:xfrm>
              <a:off x="5398927" y="5508265"/>
              <a:ext cx="0" cy="18554"/>
            </a:xfrm>
            <a:custGeom>
              <a:avLst/>
              <a:gdLst/>
              <a:ahLst/>
              <a:cxnLst/>
              <a:rect l="0" t="0" r="0" b="0"/>
              <a:pathLst>
                <a:path h="18554">
                  <a:moveTo>
                    <a:pt x="0" y="0"/>
                  </a:moveTo>
                  <a:lnTo>
                    <a:pt x="0" y="1855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4" name="pl159">
              <a:extLst>
                <a:ext uri="{FF2B5EF4-FFF2-40B4-BE49-F238E27FC236}">
                  <a16:creationId xmlns:a16="http://schemas.microsoft.com/office/drawing/2014/main" id="{A2833B09-98AD-4533-578A-42902AEE68DA}"/>
                </a:ext>
              </a:extLst>
            </p:cNvPr>
            <p:cNvSpPr/>
            <p:nvPr/>
          </p:nvSpPr>
          <p:spPr>
            <a:xfrm>
              <a:off x="5366670" y="5526819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5" name="pl160">
              <a:extLst>
                <a:ext uri="{FF2B5EF4-FFF2-40B4-BE49-F238E27FC236}">
                  <a16:creationId xmlns:a16="http://schemas.microsoft.com/office/drawing/2014/main" id="{63FF6698-2F0F-1F22-ABA9-E491A8F91C16}"/>
                </a:ext>
              </a:extLst>
            </p:cNvPr>
            <p:cNvSpPr/>
            <p:nvPr/>
          </p:nvSpPr>
          <p:spPr>
            <a:xfrm>
              <a:off x="5560211" y="5517069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6" name="pl161">
              <a:extLst>
                <a:ext uri="{FF2B5EF4-FFF2-40B4-BE49-F238E27FC236}">
                  <a16:creationId xmlns:a16="http://schemas.microsoft.com/office/drawing/2014/main" id="{9547B420-8CE5-3180-E2E7-22275C9FB822}"/>
                </a:ext>
              </a:extLst>
            </p:cNvPr>
            <p:cNvSpPr/>
            <p:nvPr/>
          </p:nvSpPr>
          <p:spPr>
            <a:xfrm>
              <a:off x="5592468" y="5517069"/>
              <a:ext cx="0" cy="11552"/>
            </a:xfrm>
            <a:custGeom>
              <a:avLst/>
              <a:gdLst/>
              <a:ahLst/>
              <a:cxnLst/>
              <a:rect l="0" t="0" r="0" b="0"/>
              <a:pathLst>
                <a:path h="11552">
                  <a:moveTo>
                    <a:pt x="0" y="0"/>
                  </a:moveTo>
                  <a:lnTo>
                    <a:pt x="0" y="1155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7" name="pl162">
              <a:extLst>
                <a:ext uri="{FF2B5EF4-FFF2-40B4-BE49-F238E27FC236}">
                  <a16:creationId xmlns:a16="http://schemas.microsoft.com/office/drawing/2014/main" id="{3B432DFE-DE1E-3686-49D8-8316E7F29E6F}"/>
                </a:ext>
              </a:extLst>
            </p:cNvPr>
            <p:cNvSpPr/>
            <p:nvPr/>
          </p:nvSpPr>
          <p:spPr>
            <a:xfrm>
              <a:off x="5560211" y="5528621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8" name="pl163">
              <a:extLst>
                <a:ext uri="{FF2B5EF4-FFF2-40B4-BE49-F238E27FC236}">
                  <a16:creationId xmlns:a16="http://schemas.microsoft.com/office/drawing/2014/main" id="{2E77FA27-94E6-308C-0FBC-ADA1C3CF5576}"/>
                </a:ext>
              </a:extLst>
            </p:cNvPr>
            <p:cNvSpPr/>
            <p:nvPr/>
          </p:nvSpPr>
          <p:spPr>
            <a:xfrm>
              <a:off x="5818266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39" name="pl164">
              <a:extLst>
                <a:ext uri="{FF2B5EF4-FFF2-40B4-BE49-F238E27FC236}">
                  <a16:creationId xmlns:a16="http://schemas.microsoft.com/office/drawing/2014/main" id="{41A90F02-057B-62F0-86CD-DC4887E1F74E}"/>
                </a:ext>
              </a:extLst>
            </p:cNvPr>
            <p:cNvSpPr/>
            <p:nvPr/>
          </p:nvSpPr>
          <p:spPr>
            <a:xfrm>
              <a:off x="5850522" y="2960114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0" name="pl165">
              <a:extLst>
                <a:ext uri="{FF2B5EF4-FFF2-40B4-BE49-F238E27FC236}">
                  <a16:creationId xmlns:a16="http://schemas.microsoft.com/office/drawing/2014/main" id="{2A58F413-D129-8CE4-3A00-48BF8EC392A3}"/>
                </a:ext>
              </a:extLst>
            </p:cNvPr>
            <p:cNvSpPr/>
            <p:nvPr/>
          </p:nvSpPr>
          <p:spPr>
            <a:xfrm>
              <a:off x="5818266" y="2960114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1" name="pl166">
              <a:extLst>
                <a:ext uri="{FF2B5EF4-FFF2-40B4-BE49-F238E27FC236}">
                  <a16:creationId xmlns:a16="http://schemas.microsoft.com/office/drawing/2014/main" id="{B725AC17-4503-9A2A-CE30-064040CE4B9C}"/>
                </a:ext>
              </a:extLst>
            </p:cNvPr>
            <p:cNvSpPr/>
            <p:nvPr/>
          </p:nvSpPr>
          <p:spPr>
            <a:xfrm>
              <a:off x="6011806" y="4491676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2" name="pl167">
              <a:extLst>
                <a:ext uri="{FF2B5EF4-FFF2-40B4-BE49-F238E27FC236}">
                  <a16:creationId xmlns:a16="http://schemas.microsoft.com/office/drawing/2014/main" id="{2420DAD5-488A-D7FC-ACF9-885804F8A8E4}"/>
                </a:ext>
              </a:extLst>
            </p:cNvPr>
            <p:cNvSpPr/>
            <p:nvPr/>
          </p:nvSpPr>
          <p:spPr>
            <a:xfrm>
              <a:off x="6044063" y="4491676"/>
              <a:ext cx="0" cy="334469"/>
            </a:xfrm>
            <a:custGeom>
              <a:avLst/>
              <a:gdLst/>
              <a:ahLst/>
              <a:cxnLst/>
              <a:rect l="0" t="0" r="0" b="0"/>
              <a:pathLst>
                <a:path h="334469">
                  <a:moveTo>
                    <a:pt x="0" y="0"/>
                  </a:moveTo>
                  <a:lnTo>
                    <a:pt x="0" y="33446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3" name="pl168">
              <a:extLst>
                <a:ext uri="{FF2B5EF4-FFF2-40B4-BE49-F238E27FC236}">
                  <a16:creationId xmlns:a16="http://schemas.microsoft.com/office/drawing/2014/main" id="{687B24C7-7997-5CD5-D3AF-DF32CF175D31}"/>
                </a:ext>
              </a:extLst>
            </p:cNvPr>
            <p:cNvSpPr/>
            <p:nvPr/>
          </p:nvSpPr>
          <p:spPr>
            <a:xfrm>
              <a:off x="6011806" y="4826145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4" name="pl169">
              <a:extLst>
                <a:ext uri="{FF2B5EF4-FFF2-40B4-BE49-F238E27FC236}">
                  <a16:creationId xmlns:a16="http://schemas.microsoft.com/office/drawing/2014/main" id="{C3C737C3-1640-D4B5-B1B1-2917FBF6E45E}"/>
                </a:ext>
              </a:extLst>
            </p:cNvPr>
            <p:cNvSpPr/>
            <p:nvPr/>
          </p:nvSpPr>
          <p:spPr>
            <a:xfrm>
              <a:off x="6205347" y="4554710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5" name="pl170">
              <a:extLst>
                <a:ext uri="{FF2B5EF4-FFF2-40B4-BE49-F238E27FC236}">
                  <a16:creationId xmlns:a16="http://schemas.microsoft.com/office/drawing/2014/main" id="{53163275-F15B-7DE4-924D-C5CD5F34A243}"/>
                </a:ext>
              </a:extLst>
            </p:cNvPr>
            <p:cNvSpPr/>
            <p:nvPr/>
          </p:nvSpPr>
          <p:spPr>
            <a:xfrm>
              <a:off x="6237604" y="4554710"/>
              <a:ext cx="0" cy="189229"/>
            </a:xfrm>
            <a:custGeom>
              <a:avLst/>
              <a:gdLst/>
              <a:ahLst/>
              <a:cxnLst/>
              <a:rect l="0" t="0" r="0" b="0"/>
              <a:pathLst>
                <a:path h="189229">
                  <a:moveTo>
                    <a:pt x="0" y="0"/>
                  </a:moveTo>
                  <a:lnTo>
                    <a:pt x="0" y="18922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6" name="pl171">
              <a:extLst>
                <a:ext uri="{FF2B5EF4-FFF2-40B4-BE49-F238E27FC236}">
                  <a16:creationId xmlns:a16="http://schemas.microsoft.com/office/drawing/2014/main" id="{5AF1DFDD-1C23-5FCC-FB40-0F113F6144B2}"/>
                </a:ext>
              </a:extLst>
            </p:cNvPr>
            <p:cNvSpPr/>
            <p:nvPr/>
          </p:nvSpPr>
          <p:spPr>
            <a:xfrm>
              <a:off x="6205347" y="4743940"/>
              <a:ext cx="64513" cy="0"/>
            </a:xfrm>
            <a:custGeom>
              <a:avLst/>
              <a:gdLst/>
              <a:ahLst/>
              <a:cxnLst/>
              <a:rect l="0" t="0" r="0" b="0"/>
              <a:pathLst>
                <a:path w="64513">
                  <a:moveTo>
                    <a:pt x="0" y="0"/>
                  </a:moveTo>
                  <a:lnTo>
                    <a:pt x="6451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47" name="tx172">
              <a:extLst>
                <a:ext uri="{FF2B5EF4-FFF2-40B4-BE49-F238E27FC236}">
                  <a16:creationId xmlns:a16="http://schemas.microsoft.com/office/drawing/2014/main" id="{F29BE31B-6F7F-359C-ABEE-2923AE8CAE88}"/>
                </a:ext>
              </a:extLst>
            </p:cNvPr>
            <p:cNvSpPr/>
            <p:nvPr/>
          </p:nvSpPr>
          <p:spPr>
            <a:xfrm>
              <a:off x="2793284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48" name="tx173">
              <a:extLst>
                <a:ext uri="{FF2B5EF4-FFF2-40B4-BE49-F238E27FC236}">
                  <a16:creationId xmlns:a16="http://schemas.microsoft.com/office/drawing/2014/main" id="{0B8B9937-6F3A-C19B-C003-4D75945D40DC}"/>
                </a:ext>
              </a:extLst>
            </p:cNvPr>
            <p:cNvSpPr/>
            <p:nvPr/>
          </p:nvSpPr>
          <p:spPr>
            <a:xfrm>
              <a:off x="2677760" y="2334565"/>
              <a:ext cx="281246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*</a:t>
              </a:r>
            </a:p>
          </p:txBody>
        </p:sp>
        <p:sp>
          <p:nvSpPr>
            <p:cNvPr id="749" name="tx174">
              <a:extLst>
                <a:ext uri="{FF2B5EF4-FFF2-40B4-BE49-F238E27FC236}">
                  <a16:creationId xmlns:a16="http://schemas.microsoft.com/office/drawing/2014/main" id="{2077CE96-62A1-18B6-BC13-4CA74084CC87}"/>
                </a:ext>
              </a:extLst>
            </p:cNvPr>
            <p:cNvSpPr/>
            <p:nvPr/>
          </p:nvSpPr>
          <p:spPr>
            <a:xfrm>
              <a:off x="2748071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50" name="tx175">
              <a:extLst>
                <a:ext uri="{FF2B5EF4-FFF2-40B4-BE49-F238E27FC236}">
                  <a16:creationId xmlns:a16="http://schemas.microsoft.com/office/drawing/2014/main" id="{67F14A2C-3E93-B328-5259-1A9C5073BF2B}"/>
                </a:ext>
              </a:extLst>
            </p:cNvPr>
            <p:cNvSpPr/>
            <p:nvPr/>
          </p:nvSpPr>
          <p:spPr>
            <a:xfrm>
              <a:off x="2148148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51" name="tx176">
              <a:extLst>
                <a:ext uri="{FF2B5EF4-FFF2-40B4-BE49-F238E27FC236}">
                  <a16:creationId xmlns:a16="http://schemas.microsoft.com/office/drawing/2014/main" id="{02F793B7-3CBA-D979-7E8D-695259B4600E}"/>
                </a:ext>
              </a:extLst>
            </p:cNvPr>
            <p:cNvSpPr/>
            <p:nvPr/>
          </p:nvSpPr>
          <p:spPr>
            <a:xfrm>
              <a:off x="2067779" y="2334565"/>
              <a:ext cx="210934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</a:t>
              </a:r>
            </a:p>
          </p:txBody>
        </p:sp>
        <p:sp>
          <p:nvSpPr>
            <p:cNvPr id="752" name="tx177">
              <a:extLst>
                <a:ext uri="{FF2B5EF4-FFF2-40B4-BE49-F238E27FC236}">
                  <a16:creationId xmlns:a16="http://schemas.microsoft.com/office/drawing/2014/main" id="{4D5A63E0-6107-4405-9F56-EAFCDFCD83DE}"/>
                </a:ext>
              </a:extLst>
            </p:cNvPr>
            <p:cNvSpPr/>
            <p:nvPr/>
          </p:nvSpPr>
          <p:spPr>
            <a:xfrm>
              <a:off x="2067779" y="2334565"/>
              <a:ext cx="210934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</a:t>
              </a:r>
            </a:p>
          </p:txBody>
        </p:sp>
        <p:sp>
          <p:nvSpPr>
            <p:cNvPr id="753" name="tx178">
              <a:extLst>
                <a:ext uri="{FF2B5EF4-FFF2-40B4-BE49-F238E27FC236}">
                  <a16:creationId xmlns:a16="http://schemas.microsoft.com/office/drawing/2014/main" id="{4E03C293-8664-3724-86C1-5BD58B0FD3FB}"/>
                </a:ext>
              </a:extLst>
            </p:cNvPr>
            <p:cNvSpPr/>
            <p:nvPr/>
          </p:nvSpPr>
          <p:spPr>
            <a:xfrm>
              <a:off x="4083556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54" name="tx179">
              <a:extLst>
                <a:ext uri="{FF2B5EF4-FFF2-40B4-BE49-F238E27FC236}">
                  <a16:creationId xmlns:a16="http://schemas.microsoft.com/office/drawing/2014/main" id="{64AEDDC4-A64A-8E0E-FE66-85DF2913944E}"/>
                </a:ext>
              </a:extLst>
            </p:cNvPr>
            <p:cNvSpPr/>
            <p:nvPr/>
          </p:nvSpPr>
          <p:spPr>
            <a:xfrm>
              <a:off x="4038343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55" name="tx180">
              <a:extLst>
                <a:ext uri="{FF2B5EF4-FFF2-40B4-BE49-F238E27FC236}">
                  <a16:creationId xmlns:a16="http://schemas.microsoft.com/office/drawing/2014/main" id="{AA293791-7A84-A460-0B34-022694B04A57}"/>
                </a:ext>
              </a:extLst>
            </p:cNvPr>
            <p:cNvSpPr/>
            <p:nvPr/>
          </p:nvSpPr>
          <p:spPr>
            <a:xfrm>
              <a:off x="4038343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56" name="tx181">
              <a:extLst>
                <a:ext uri="{FF2B5EF4-FFF2-40B4-BE49-F238E27FC236}">
                  <a16:creationId xmlns:a16="http://schemas.microsoft.com/office/drawing/2014/main" id="{47B12CEB-43EA-D438-03E5-22A59835E244}"/>
                </a:ext>
              </a:extLst>
            </p:cNvPr>
            <p:cNvSpPr/>
            <p:nvPr/>
          </p:nvSpPr>
          <p:spPr>
            <a:xfrm>
              <a:off x="3438420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57" name="tx182">
              <a:extLst>
                <a:ext uri="{FF2B5EF4-FFF2-40B4-BE49-F238E27FC236}">
                  <a16:creationId xmlns:a16="http://schemas.microsoft.com/office/drawing/2014/main" id="{5583F707-1405-5ECE-C259-A89636ADE91C}"/>
                </a:ext>
              </a:extLst>
            </p:cNvPr>
            <p:cNvSpPr/>
            <p:nvPr/>
          </p:nvSpPr>
          <p:spPr>
            <a:xfrm>
              <a:off x="3393207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58" name="tx183">
              <a:extLst>
                <a:ext uri="{FF2B5EF4-FFF2-40B4-BE49-F238E27FC236}">
                  <a16:creationId xmlns:a16="http://schemas.microsoft.com/office/drawing/2014/main" id="{373B9EE8-7644-D290-3DE2-0386B4068FD6}"/>
                </a:ext>
              </a:extLst>
            </p:cNvPr>
            <p:cNvSpPr/>
            <p:nvPr/>
          </p:nvSpPr>
          <p:spPr>
            <a:xfrm>
              <a:off x="3393207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59" name="tx184">
              <a:extLst>
                <a:ext uri="{FF2B5EF4-FFF2-40B4-BE49-F238E27FC236}">
                  <a16:creationId xmlns:a16="http://schemas.microsoft.com/office/drawing/2014/main" id="{29C956AB-4F15-474C-2C79-696E7D162895}"/>
                </a:ext>
              </a:extLst>
            </p:cNvPr>
            <p:cNvSpPr/>
            <p:nvPr/>
          </p:nvSpPr>
          <p:spPr>
            <a:xfrm>
              <a:off x="1503012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0" name="tx185">
              <a:extLst>
                <a:ext uri="{FF2B5EF4-FFF2-40B4-BE49-F238E27FC236}">
                  <a16:creationId xmlns:a16="http://schemas.microsoft.com/office/drawing/2014/main" id="{CD2A8748-3236-A324-7999-9BFD6DBB9F3D}"/>
                </a:ext>
              </a:extLst>
            </p:cNvPr>
            <p:cNvSpPr/>
            <p:nvPr/>
          </p:nvSpPr>
          <p:spPr>
            <a:xfrm>
              <a:off x="1503012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1" name="tx186">
              <a:extLst>
                <a:ext uri="{FF2B5EF4-FFF2-40B4-BE49-F238E27FC236}">
                  <a16:creationId xmlns:a16="http://schemas.microsoft.com/office/drawing/2014/main" id="{203292CB-ABBA-8447-124E-033EA8CE1E2C}"/>
                </a:ext>
              </a:extLst>
            </p:cNvPr>
            <p:cNvSpPr/>
            <p:nvPr/>
          </p:nvSpPr>
          <p:spPr>
            <a:xfrm>
              <a:off x="1503012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2" name="tx187">
              <a:extLst>
                <a:ext uri="{FF2B5EF4-FFF2-40B4-BE49-F238E27FC236}">
                  <a16:creationId xmlns:a16="http://schemas.microsoft.com/office/drawing/2014/main" id="{8DDCE060-331F-1FCE-8E85-3720ECC25803}"/>
                </a:ext>
              </a:extLst>
            </p:cNvPr>
            <p:cNvSpPr/>
            <p:nvPr/>
          </p:nvSpPr>
          <p:spPr>
            <a:xfrm>
              <a:off x="6018965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3" name="tx188">
              <a:extLst>
                <a:ext uri="{FF2B5EF4-FFF2-40B4-BE49-F238E27FC236}">
                  <a16:creationId xmlns:a16="http://schemas.microsoft.com/office/drawing/2014/main" id="{9E8156B7-D905-F51C-D5BF-C17500B8B6EB}"/>
                </a:ext>
              </a:extLst>
            </p:cNvPr>
            <p:cNvSpPr/>
            <p:nvPr/>
          </p:nvSpPr>
          <p:spPr>
            <a:xfrm>
              <a:off x="5973752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64" name="tx189">
              <a:extLst>
                <a:ext uri="{FF2B5EF4-FFF2-40B4-BE49-F238E27FC236}">
                  <a16:creationId xmlns:a16="http://schemas.microsoft.com/office/drawing/2014/main" id="{9188CF57-1793-FF63-735A-A5A4ABE39458}"/>
                </a:ext>
              </a:extLst>
            </p:cNvPr>
            <p:cNvSpPr/>
            <p:nvPr/>
          </p:nvSpPr>
          <p:spPr>
            <a:xfrm>
              <a:off x="5973752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65" name="tx190">
              <a:extLst>
                <a:ext uri="{FF2B5EF4-FFF2-40B4-BE49-F238E27FC236}">
                  <a16:creationId xmlns:a16="http://schemas.microsoft.com/office/drawing/2014/main" id="{4A10BA87-4866-39D6-D678-F10DFC850F98}"/>
                </a:ext>
              </a:extLst>
            </p:cNvPr>
            <p:cNvSpPr/>
            <p:nvPr/>
          </p:nvSpPr>
          <p:spPr>
            <a:xfrm>
              <a:off x="5373828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6" name="tx191">
              <a:extLst>
                <a:ext uri="{FF2B5EF4-FFF2-40B4-BE49-F238E27FC236}">
                  <a16:creationId xmlns:a16="http://schemas.microsoft.com/office/drawing/2014/main" id="{287493A7-0D9E-A06B-4098-E06CA2A7EB54}"/>
                </a:ext>
              </a:extLst>
            </p:cNvPr>
            <p:cNvSpPr/>
            <p:nvPr/>
          </p:nvSpPr>
          <p:spPr>
            <a:xfrm>
              <a:off x="5258304" y="2334565"/>
              <a:ext cx="281246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*</a:t>
              </a:r>
            </a:p>
          </p:txBody>
        </p:sp>
        <p:sp>
          <p:nvSpPr>
            <p:cNvPr id="767" name="tx192">
              <a:extLst>
                <a:ext uri="{FF2B5EF4-FFF2-40B4-BE49-F238E27FC236}">
                  <a16:creationId xmlns:a16="http://schemas.microsoft.com/office/drawing/2014/main" id="{011281CF-A169-52BD-5CDF-C847DD5434B6}"/>
                </a:ext>
              </a:extLst>
            </p:cNvPr>
            <p:cNvSpPr/>
            <p:nvPr/>
          </p:nvSpPr>
          <p:spPr>
            <a:xfrm>
              <a:off x="5258304" y="2334565"/>
              <a:ext cx="281246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*</a:t>
              </a:r>
            </a:p>
          </p:txBody>
        </p:sp>
        <p:sp>
          <p:nvSpPr>
            <p:cNvPr id="768" name="tx193">
              <a:extLst>
                <a:ext uri="{FF2B5EF4-FFF2-40B4-BE49-F238E27FC236}">
                  <a16:creationId xmlns:a16="http://schemas.microsoft.com/office/drawing/2014/main" id="{28BA5351-F69A-7331-B2D1-6D58021DF681}"/>
                </a:ext>
              </a:extLst>
            </p:cNvPr>
            <p:cNvSpPr/>
            <p:nvPr/>
          </p:nvSpPr>
          <p:spPr>
            <a:xfrm>
              <a:off x="4728692" y="23896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769" name="tx194">
              <a:extLst>
                <a:ext uri="{FF2B5EF4-FFF2-40B4-BE49-F238E27FC236}">
                  <a16:creationId xmlns:a16="http://schemas.microsoft.com/office/drawing/2014/main" id="{C91FCF5A-2F3B-FF0E-2A0F-9F6DFC13DC9A}"/>
                </a:ext>
              </a:extLst>
            </p:cNvPr>
            <p:cNvSpPr/>
            <p:nvPr/>
          </p:nvSpPr>
          <p:spPr>
            <a:xfrm>
              <a:off x="4683479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70" name="tx195">
              <a:extLst>
                <a:ext uri="{FF2B5EF4-FFF2-40B4-BE49-F238E27FC236}">
                  <a16:creationId xmlns:a16="http://schemas.microsoft.com/office/drawing/2014/main" id="{1A61BABF-4F6A-44B2-9600-2E82F533A8E2}"/>
                </a:ext>
              </a:extLst>
            </p:cNvPr>
            <p:cNvSpPr/>
            <p:nvPr/>
          </p:nvSpPr>
          <p:spPr>
            <a:xfrm>
              <a:off x="4683479" y="23345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771" name="pl196">
              <a:extLst>
                <a:ext uri="{FF2B5EF4-FFF2-40B4-BE49-F238E27FC236}">
                  <a16:creationId xmlns:a16="http://schemas.microsoft.com/office/drawing/2014/main" id="{295B7C1D-44C2-6AFB-813B-3E93F772942A}"/>
                </a:ext>
              </a:extLst>
            </p:cNvPr>
            <p:cNvSpPr/>
            <p:nvPr/>
          </p:nvSpPr>
          <p:spPr>
            <a:xfrm>
              <a:off x="1141029" y="2960114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  <a:lnTo>
                    <a:pt x="5290116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72" name="pl197">
              <a:extLst>
                <a:ext uri="{FF2B5EF4-FFF2-40B4-BE49-F238E27FC236}">
                  <a16:creationId xmlns:a16="http://schemas.microsoft.com/office/drawing/2014/main" id="{8CFDE4DF-3286-20CE-6C72-C566C684D03D}"/>
                </a:ext>
              </a:extLst>
            </p:cNvPr>
            <p:cNvSpPr/>
            <p:nvPr/>
          </p:nvSpPr>
          <p:spPr>
            <a:xfrm>
              <a:off x="1141029" y="800363"/>
              <a:ext cx="0" cy="4964205"/>
            </a:xfrm>
            <a:custGeom>
              <a:avLst/>
              <a:gdLst/>
              <a:ahLst/>
              <a:cxnLst/>
              <a:rect l="0" t="0" r="0" b="0"/>
              <a:pathLst>
                <a:path h="4964205">
                  <a:moveTo>
                    <a:pt x="0" y="4964205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73" name="tx198">
              <a:extLst>
                <a:ext uri="{FF2B5EF4-FFF2-40B4-BE49-F238E27FC236}">
                  <a16:creationId xmlns:a16="http://schemas.microsoft.com/office/drawing/2014/main" id="{20C63497-4E9E-501C-1893-7F29FE20D602}"/>
                </a:ext>
              </a:extLst>
            </p:cNvPr>
            <p:cNvSpPr/>
            <p:nvPr/>
          </p:nvSpPr>
          <p:spPr>
            <a:xfrm>
              <a:off x="546506" y="5425218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0</a:t>
              </a:r>
            </a:p>
          </p:txBody>
        </p:sp>
        <p:sp>
          <p:nvSpPr>
            <p:cNvPr id="774" name="tx199">
              <a:extLst>
                <a:ext uri="{FF2B5EF4-FFF2-40B4-BE49-F238E27FC236}">
                  <a16:creationId xmlns:a16="http://schemas.microsoft.com/office/drawing/2014/main" id="{7CC40965-B935-2389-B4EC-0C4B2A0BC4DB}"/>
                </a:ext>
              </a:extLst>
            </p:cNvPr>
            <p:cNvSpPr/>
            <p:nvPr/>
          </p:nvSpPr>
          <p:spPr>
            <a:xfrm>
              <a:off x="546506" y="4135814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5</a:t>
              </a:r>
            </a:p>
          </p:txBody>
        </p:sp>
        <p:sp>
          <p:nvSpPr>
            <p:cNvPr id="775" name="tx200">
              <a:extLst>
                <a:ext uri="{FF2B5EF4-FFF2-40B4-BE49-F238E27FC236}">
                  <a16:creationId xmlns:a16="http://schemas.microsoft.com/office/drawing/2014/main" id="{7EB06B40-DE73-1554-4A51-BE26408B551F}"/>
                </a:ext>
              </a:extLst>
            </p:cNvPr>
            <p:cNvSpPr/>
            <p:nvPr/>
          </p:nvSpPr>
          <p:spPr>
            <a:xfrm>
              <a:off x="546506" y="2846410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0</a:t>
              </a:r>
            </a:p>
          </p:txBody>
        </p:sp>
        <p:sp>
          <p:nvSpPr>
            <p:cNvPr id="776" name="tx201">
              <a:extLst>
                <a:ext uri="{FF2B5EF4-FFF2-40B4-BE49-F238E27FC236}">
                  <a16:creationId xmlns:a16="http://schemas.microsoft.com/office/drawing/2014/main" id="{D6C5ED87-8FF5-63C6-2C00-1E0667572B7F}"/>
                </a:ext>
              </a:extLst>
            </p:cNvPr>
            <p:cNvSpPr/>
            <p:nvPr/>
          </p:nvSpPr>
          <p:spPr>
            <a:xfrm>
              <a:off x="546506" y="1557006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5</a:t>
              </a:r>
            </a:p>
          </p:txBody>
        </p:sp>
        <p:sp>
          <p:nvSpPr>
            <p:cNvPr id="777" name="pl202">
              <a:extLst>
                <a:ext uri="{FF2B5EF4-FFF2-40B4-BE49-F238E27FC236}">
                  <a16:creationId xmlns:a16="http://schemas.microsoft.com/office/drawing/2014/main" id="{D59FE2B9-B9E0-1F5B-8E66-B5550E03ACE9}"/>
                </a:ext>
              </a:extLst>
            </p:cNvPr>
            <p:cNvSpPr/>
            <p:nvPr/>
          </p:nvSpPr>
          <p:spPr>
            <a:xfrm>
              <a:off x="1046135" y="5538922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78" name="pl203">
              <a:extLst>
                <a:ext uri="{FF2B5EF4-FFF2-40B4-BE49-F238E27FC236}">
                  <a16:creationId xmlns:a16="http://schemas.microsoft.com/office/drawing/2014/main" id="{CF7F9A3C-1353-E2DD-DCCD-87A0E7B34885}"/>
                </a:ext>
              </a:extLst>
            </p:cNvPr>
            <p:cNvSpPr/>
            <p:nvPr/>
          </p:nvSpPr>
          <p:spPr>
            <a:xfrm>
              <a:off x="1046135" y="4249518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79" name="pl204">
              <a:extLst>
                <a:ext uri="{FF2B5EF4-FFF2-40B4-BE49-F238E27FC236}">
                  <a16:creationId xmlns:a16="http://schemas.microsoft.com/office/drawing/2014/main" id="{8C1065A1-92D1-FCC7-382A-75AC4F78C16A}"/>
                </a:ext>
              </a:extLst>
            </p:cNvPr>
            <p:cNvSpPr/>
            <p:nvPr/>
          </p:nvSpPr>
          <p:spPr>
            <a:xfrm>
              <a:off x="1046135" y="2960114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80" name="pl205">
              <a:extLst>
                <a:ext uri="{FF2B5EF4-FFF2-40B4-BE49-F238E27FC236}">
                  <a16:creationId xmlns:a16="http://schemas.microsoft.com/office/drawing/2014/main" id="{DA5AD26C-334A-61CE-EC45-4CAC7F95F23D}"/>
                </a:ext>
              </a:extLst>
            </p:cNvPr>
            <p:cNvSpPr/>
            <p:nvPr/>
          </p:nvSpPr>
          <p:spPr>
            <a:xfrm>
              <a:off x="1046135" y="1670710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781" name="pl206">
              <a:extLst>
                <a:ext uri="{FF2B5EF4-FFF2-40B4-BE49-F238E27FC236}">
                  <a16:creationId xmlns:a16="http://schemas.microsoft.com/office/drawing/2014/main" id="{CA2D96B0-F9FE-810D-9697-85352DA08583}"/>
                </a:ext>
              </a:extLst>
            </p:cNvPr>
            <p:cNvSpPr/>
            <p:nvPr/>
          </p:nvSpPr>
          <p:spPr>
            <a:xfrm>
              <a:off x="1141029" y="5764568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2" name="pl207">
              <a:extLst>
                <a:ext uri="{FF2B5EF4-FFF2-40B4-BE49-F238E27FC236}">
                  <a16:creationId xmlns:a16="http://schemas.microsoft.com/office/drawing/2014/main" id="{5E288AEF-4E02-CAAF-4424-87867FC93116}"/>
                </a:ext>
              </a:extLst>
            </p:cNvPr>
            <p:cNvSpPr/>
            <p:nvPr/>
          </p:nvSpPr>
          <p:spPr>
            <a:xfrm>
              <a:off x="1528110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3" name="pl208">
              <a:extLst>
                <a:ext uri="{FF2B5EF4-FFF2-40B4-BE49-F238E27FC236}">
                  <a16:creationId xmlns:a16="http://schemas.microsoft.com/office/drawing/2014/main" id="{CE841CA6-86B5-45FE-9A55-80AAA7E3E810}"/>
                </a:ext>
              </a:extLst>
            </p:cNvPr>
            <p:cNvSpPr/>
            <p:nvPr/>
          </p:nvSpPr>
          <p:spPr>
            <a:xfrm>
              <a:off x="2173247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4" name="pl209">
              <a:extLst>
                <a:ext uri="{FF2B5EF4-FFF2-40B4-BE49-F238E27FC236}">
                  <a16:creationId xmlns:a16="http://schemas.microsoft.com/office/drawing/2014/main" id="{A390A72C-0242-CB3D-EBF4-76F03C2A599A}"/>
                </a:ext>
              </a:extLst>
            </p:cNvPr>
            <p:cNvSpPr/>
            <p:nvPr/>
          </p:nvSpPr>
          <p:spPr>
            <a:xfrm>
              <a:off x="2818383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5" name="pl210">
              <a:extLst>
                <a:ext uri="{FF2B5EF4-FFF2-40B4-BE49-F238E27FC236}">
                  <a16:creationId xmlns:a16="http://schemas.microsoft.com/office/drawing/2014/main" id="{3A76D7BB-641B-607F-B6DC-747C9312B69D}"/>
                </a:ext>
              </a:extLst>
            </p:cNvPr>
            <p:cNvSpPr/>
            <p:nvPr/>
          </p:nvSpPr>
          <p:spPr>
            <a:xfrm>
              <a:off x="3463519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6" name="pl211">
              <a:extLst>
                <a:ext uri="{FF2B5EF4-FFF2-40B4-BE49-F238E27FC236}">
                  <a16:creationId xmlns:a16="http://schemas.microsoft.com/office/drawing/2014/main" id="{1FCC49A0-4FD2-9DF9-8FDE-2A708A298304}"/>
                </a:ext>
              </a:extLst>
            </p:cNvPr>
            <p:cNvSpPr/>
            <p:nvPr/>
          </p:nvSpPr>
          <p:spPr>
            <a:xfrm>
              <a:off x="4108655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7" name="pl212">
              <a:extLst>
                <a:ext uri="{FF2B5EF4-FFF2-40B4-BE49-F238E27FC236}">
                  <a16:creationId xmlns:a16="http://schemas.microsoft.com/office/drawing/2014/main" id="{1D861691-3E1D-3D43-8C66-E27D06A69D72}"/>
                </a:ext>
              </a:extLst>
            </p:cNvPr>
            <p:cNvSpPr/>
            <p:nvPr/>
          </p:nvSpPr>
          <p:spPr>
            <a:xfrm>
              <a:off x="4753791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8" name="pl213">
              <a:extLst>
                <a:ext uri="{FF2B5EF4-FFF2-40B4-BE49-F238E27FC236}">
                  <a16:creationId xmlns:a16="http://schemas.microsoft.com/office/drawing/2014/main" id="{D211FFAC-C898-0FBF-9228-5848CC830B5F}"/>
                </a:ext>
              </a:extLst>
            </p:cNvPr>
            <p:cNvSpPr/>
            <p:nvPr/>
          </p:nvSpPr>
          <p:spPr>
            <a:xfrm>
              <a:off x="5398927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89" name="pl214">
              <a:extLst>
                <a:ext uri="{FF2B5EF4-FFF2-40B4-BE49-F238E27FC236}">
                  <a16:creationId xmlns:a16="http://schemas.microsoft.com/office/drawing/2014/main" id="{49453394-D767-8897-E1A6-810DC7C4C56A}"/>
                </a:ext>
              </a:extLst>
            </p:cNvPr>
            <p:cNvSpPr/>
            <p:nvPr/>
          </p:nvSpPr>
          <p:spPr>
            <a:xfrm>
              <a:off x="6044063" y="5764568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100">
                <a:latin typeface="SF Pro Semibold"/>
              </a:endParaRPr>
            </a:p>
          </p:txBody>
        </p:sp>
        <p:sp>
          <p:nvSpPr>
            <p:cNvPr id="790" name="tx215">
              <a:extLst>
                <a:ext uri="{FF2B5EF4-FFF2-40B4-BE49-F238E27FC236}">
                  <a16:creationId xmlns:a16="http://schemas.microsoft.com/office/drawing/2014/main" id="{D863CC00-AB69-33FA-9462-71D6E9F12184}"/>
                </a:ext>
              </a:extLst>
            </p:cNvPr>
            <p:cNvSpPr/>
            <p:nvPr/>
          </p:nvSpPr>
          <p:spPr>
            <a:xfrm>
              <a:off x="1274061" y="5934484"/>
              <a:ext cx="508099" cy="21907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 dirty="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M1I</a:t>
              </a:r>
            </a:p>
          </p:txBody>
        </p:sp>
        <p:sp>
          <p:nvSpPr>
            <p:cNvPr id="791" name="tx216">
              <a:extLst>
                <a:ext uri="{FF2B5EF4-FFF2-40B4-BE49-F238E27FC236}">
                  <a16:creationId xmlns:a16="http://schemas.microsoft.com/office/drawing/2014/main" id="{5DD51714-1456-DD1E-E0C2-48B9AD35AE19}"/>
                </a:ext>
              </a:extLst>
            </p:cNvPr>
            <p:cNvSpPr/>
            <p:nvPr/>
          </p:nvSpPr>
          <p:spPr>
            <a:xfrm>
              <a:off x="1690374" y="5927936"/>
              <a:ext cx="965745" cy="2256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 dirty="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D140fs</a:t>
              </a:r>
            </a:p>
          </p:txBody>
        </p:sp>
        <p:sp>
          <p:nvSpPr>
            <p:cNvPr id="792" name="tx217">
              <a:extLst>
                <a:ext uri="{FF2B5EF4-FFF2-40B4-BE49-F238E27FC236}">
                  <a16:creationId xmlns:a16="http://schemas.microsoft.com/office/drawing/2014/main" id="{1F77B591-DA8A-84F7-006D-B4283AC41913}"/>
                </a:ext>
              </a:extLst>
            </p:cNvPr>
            <p:cNvSpPr/>
            <p:nvPr/>
          </p:nvSpPr>
          <p:spPr>
            <a:xfrm>
              <a:off x="2343919" y="5927936"/>
              <a:ext cx="948928" cy="2256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A500fs</a:t>
              </a:r>
            </a:p>
          </p:txBody>
        </p:sp>
        <p:sp>
          <p:nvSpPr>
            <p:cNvPr id="793" name="tx218">
              <a:extLst>
                <a:ext uri="{FF2B5EF4-FFF2-40B4-BE49-F238E27FC236}">
                  <a16:creationId xmlns:a16="http://schemas.microsoft.com/office/drawing/2014/main" id="{CB599DBF-FE0E-DD15-1ACA-54A167C0F4D0}"/>
                </a:ext>
              </a:extLst>
            </p:cNvPr>
            <p:cNvSpPr/>
            <p:nvPr/>
          </p:nvSpPr>
          <p:spPr>
            <a:xfrm>
              <a:off x="2929747" y="5930615"/>
              <a:ext cx="1067544" cy="22294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K381ter</a:t>
              </a:r>
            </a:p>
          </p:txBody>
        </p:sp>
        <p:sp>
          <p:nvSpPr>
            <p:cNvPr id="794" name="tx219">
              <a:extLst>
                <a:ext uri="{FF2B5EF4-FFF2-40B4-BE49-F238E27FC236}">
                  <a16:creationId xmlns:a16="http://schemas.microsoft.com/office/drawing/2014/main" id="{5819DB79-3215-D9DB-FC8D-4A055AE5FF1A}"/>
                </a:ext>
              </a:extLst>
            </p:cNvPr>
            <p:cNvSpPr/>
            <p:nvPr/>
          </p:nvSpPr>
          <p:spPr>
            <a:xfrm>
              <a:off x="3625782" y="5927787"/>
              <a:ext cx="965745" cy="2257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G173R</a:t>
              </a:r>
            </a:p>
          </p:txBody>
        </p:sp>
        <p:sp>
          <p:nvSpPr>
            <p:cNvPr id="795" name="tx220">
              <a:extLst>
                <a:ext uri="{FF2B5EF4-FFF2-40B4-BE49-F238E27FC236}">
                  <a16:creationId xmlns:a16="http://schemas.microsoft.com/office/drawing/2014/main" id="{5ACBD314-0767-CAE7-096D-5182DE05A40E}"/>
                </a:ext>
              </a:extLst>
            </p:cNvPr>
            <p:cNvSpPr/>
            <p:nvPr/>
          </p:nvSpPr>
          <p:spPr>
            <a:xfrm>
              <a:off x="4287810" y="5927936"/>
              <a:ext cx="931961" cy="2256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Y259C</a:t>
              </a:r>
            </a:p>
          </p:txBody>
        </p:sp>
        <p:sp>
          <p:nvSpPr>
            <p:cNvPr id="796" name="tx221">
              <a:extLst>
                <a:ext uri="{FF2B5EF4-FFF2-40B4-BE49-F238E27FC236}">
                  <a16:creationId xmlns:a16="http://schemas.microsoft.com/office/drawing/2014/main" id="{DB922026-3C13-EAE4-8603-2F6BA1A8BD3E}"/>
                </a:ext>
              </a:extLst>
            </p:cNvPr>
            <p:cNvSpPr/>
            <p:nvPr/>
          </p:nvSpPr>
          <p:spPr>
            <a:xfrm>
              <a:off x="4839631" y="5927787"/>
              <a:ext cx="1118592" cy="2257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S363del</a:t>
              </a:r>
            </a:p>
          </p:txBody>
        </p:sp>
        <p:sp>
          <p:nvSpPr>
            <p:cNvPr id="797" name="tx222">
              <a:extLst>
                <a:ext uri="{FF2B5EF4-FFF2-40B4-BE49-F238E27FC236}">
                  <a16:creationId xmlns:a16="http://schemas.microsoft.com/office/drawing/2014/main" id="{6DF9B1D9-463B-C0FB-6AC1-E25623E1C831}"/>
                </a:ext>
              </a:extLst>
            </p:cNvPr>
            <p:cNvSpPr/>
            <p:nvPr/>
          </p:nvSpPr>
          <p:spPr>
            <a:xfrm>
              <a:off x="5569674" y="5930764"/>
              <a:ext cx="948779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400" dirty="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R525H</a:t>
              </a:r>
            </a:p>
          </p:txBody>
        </p:sp>
        <p:sp>
          <p:nvSpPr>
            <p:cNvPr id="799" name="rc224">
              <a:extLst>
                <a:ext uri="{FF2B5EF4-FFF2-40B4-BE49-F238E27FC236}">
                  <a16:creationId xmlns:a16="http://schemas.microsoft.com/office/drawing/2014/main" id="{A67CDCD2-624C-FFFF-9F2B-55C5E36498D7}"/>
                </a:ext>
              </a:extLst>
            </p:cNvPr>
            <p:cNvSpPr/>
            <p:nvPr/>
          </p:nvSpPr>
          <p:spPr>
            <a:xfrm>
              <a:off x="6810721" y="2397838"/>
              <a:ext cx="2052404" cy="176925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800" name="tx225">
              <a:extLst>
                <a:ext uri="{FF2B5EF4-FFF2-40B4-BE49-F238E27FC236}">
                  <a16:creationId xmlns:a16="http://schemas.microsoft.com/office/drawing/2014/main" id="{DCF03673-FC5A-861A-3B60-5B4CCE122367}"/>
                </a:ext>
              </a:extLst>
            </p:cNvPr>
            <p:cNvSpPr/>
            <p:nvPr/>
          </p:nvSpPr>
          <p:spPr>
            <a:xfrm>
              <a:off x="6838880" y="2504307"/>
              <a:ext cx="1672828" cy="34844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3000"/>
                </a:lnSpc>
              </a:pPr>
              <a:r>
                <a:rPr sz="30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Timepoint</a:t>
              </a:r>
            </a:p>
          </p:txBody>
        </p:sp>
        <p:sp>
          <p:nvSpPr>
            <p:cNvPr id="801" name="rc226">
              <a:extLst>
                <a:ext uri="{FF2B5EF4-FFF2-40B4-BE49-F238E27FC236}">
                  <a16:creationId xmlns:a16="http://schemas.microsoft.com/office/drawing/2014/main" id="{6C3164E6-A5E1-9821-B3EE-0DF2B19CF789}"/>
                </a:ext>
              </a:extLst>
            </p:cNvPr>
            <p:cNvSpPr/>
            <p:nvPr/>
          </p:nvSpPr>
          <p:spPr>
            <a:xfrm>
              <a:off x="6984611" y="3138878"/>
              <a:ext cx="201455" cy="264326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802" name="rc227">
              <a:extLst>
                <a:ext uri="{FF2B5EF4-FFF2-40B4-BE49-F238E27FC236}">
                  <a16:creationId xmlns:a16="http://schemas.microsoft.com/office/drawing/2014/main" id="{DC5BB67A-0DF5-A9D9-2443-4AE649F6A076}"/>
                </a:ext>
              </a:extLst>
            </p:cNvPr>
            <p:cNvSpPr/>
            <p:nvPr/>
          </p:nvSpPr>
          <p:spPr>
            <a:xfrm>
              <a:off x="6984611" y="3706357"/>
              <a:ext cx="201455" cy="264326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803" name="rc228">
              <a:extLst>
                <a:ext uri="{FF2B5EF4-FFF2-40B4-BE49-F238E27FC236}">
                  <a16:creationId xmlns:a16="http://schemas.microsoft.com/office/drawing/2014/main" id="{5C0141A0-DE11-B8E4-CD6E-3B474D7F2331}"/>
                </a:ext>
              </a:extLst>
            </p:cNvPr>
            <p:cNvSpPr/>
            <p:nvPr/>
          </p:nvSpPr>
          <p:spPr>
            <a:xfrm>
              <a:off x="6984611" y="4285727"/>
              <a:ext cx="201455" cy="26432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804" name="tx229">
              <a:extLst>
                <a:ext uri="{FF2B5EF4-FFF2-40B4-BE49-F238E27FC236}">
                  <a16:creationId xmlns:a16="http://schemas.microsoft.com/office/drawing/2014/main" id="{A5976641-A4B4-2863-309F-D4BD59F4E44D}"/>
                </a:ext>
              </a:extLst>
            </p:cNvPr>
            <p:cNvSpPr/>
            <p:nvPr/>
          </p:nvSpPr>
          <p:spPr>
            <a:xfrm>
              <a:off x="7409754" y="3161503"/>
              <a:ext cx="169515" cy="21907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24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2</a:t>
              </a:r>
            </a:p>
          </p:txBody>
        </p:sp>
        <p:sp>
          <p:nvSpPr>
            <p:cNvPr id="805" name="tx230">
              <a:extLst>
                <a:ext uri="{FF2B5EF4-FFF2-40B4-BE49-F238E27FC236}">
                  <a16:creationId xmlns:a16="http://schemas.microsoft.com/office/drawing/2014/main" id="{F21772EE-F0F2-4D58-8772-A7A7C52C4B08}"/>
                </a:ext>
              </a:extLst>
            </p:cNvPr>
            <p:cNvSpPr/>
            <p:nvPr/>
          </p:nvSpPr>
          <p:spPr>
            <a:xfrm>
              <a:off x="7349153" y="3783161"/>
              <a:ext cx="339030" cy="21907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14</a:t>
              </a:r>
            </a:p>
          </p:txBody>
        </p:sp>
        <p:sp>
          <p:nvSpPr>
            <p:cNvPr id="806" name="tx231">
              <a:extLst>
                <a:ext uri="{FF2B5EF4-FFF2-40B4-BE49-F238E27FC236}">
                  <a16:creationId xmlns:a16="http://schemas.microsoft.com/office/drawing/2014/main" id="{BEBE402C-0E7A-AF91-F70D-249926CE9CE0}"/>
                </a:ext>
              </a:extLst>
            </p:cNvPr>
            <p:cNvSpPr/>
            <p:nvPr/>
          </p:nvSpPr>
          <p:spPr>
            <a:xfrm>
              <a:off x="7374489" y="4367689"/>
              <a:ext cx="339030" cy="22294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30</a:t>
              </a:r>
            </a:p>
          </p:txBody>
        </p:sp>
        <p:sp>
          <p:nvSpPr>
            <p:cNvPr id="807" name="tx232">
              <a:extLst>
                <a:ext uri="{FF2B5EF4-FFF2-40B4-BE49-F238E27FC236}">
                  <a16:creationId xmlns:a16="http://schemas.microsoft.com/office/drawing/2014/main" id="{959C1E54-ADB7-20C8-598C-10FF58E09AD1}"/>
                </a:ext>
              </a:extLst>
            </p:cNvPr>
            <p:cNvSpPr/>
            <p:nvPr/>
          </p:nvSpPr>
          <p:spPr>
            <a:xfrm>
              <a:off x="1141029" y="90866"/>
              <a:ext cx="6633195" cy="42349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3600"/>
                </a:lnSpc>
              </a:pPr>
              <a:r>
                <a:rPr lang="da-DK"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A) </a:t>
              </a: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Pathogen</a:t>
              </a:r>
              <a:r>
                <a:rPr lang="da-DK" sz="24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ic</a:t>
              </a:r>
              <a:r>
                <a:rPr sz="24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variants, assay control</a:t>
              </a:r>
            </a:p>
          </p:txBody>
        </p:sp>
      </p:grpSp>
      <p:grpSp>
        <p:nvGrpSpPr>
          <p:cNvPr id="809" name="Gruppe 808">
            <a:extLst>
              <a:ext uri="{FF2B5EF4-FFF2-40B4-BE49-F238E27FC236}">
                <a16:creationId xmlns:a16="http://schemas.microsoft.com/office/drawing/2014/main" id="{A1DB8D1A-F0B9-EB82-4055-D621C0DFF135}"/>
              </a:ext>
            </a:extLst>
          </p:cNvPr>
          <p:cNvGrpSpPr/>
          <p:nvPr/>
        </p:nvGrpSpPr>
        <p:grpSpPr>
          <a:xfrm>
            <a:off x="6335039" y="3840652"/>
            <a:ext cx="5200739" cy="2588047"/>
            <a:chOff x="637591" y="661427"/>
            <a:chExt cx="6115286" cy="5494836"/>
          </a:xfrm>
        </p:grpSpPr>
        <p:sp>
          <p:nvSpPr>
            <p:cNvPr id="810" name="rc5">
              <a:extLst>
                <a:ext uri="{FF2B5EF4-FFF2-40B4-BE49-F238E27FC236}">
                  <a16:creationId xmlns:a16="http://schemas.microsoft.com/office/drawing/2014/main" id="{512D33EA-F357-39C3-A86C-245D979BB399}"/>
                </a:ext>
              </a:extLst>
            </p:cNvPr>
            <p:cNvSpPr/>
            <p:nvPr/>
          </p:nvSpPr>
          <p:spPr>
            <a:xfrm>
              <a:off x="1232114" y="803067"/>
              <a:ext cx="5290116" cy="496420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1" name="rc6">
              <a:extLst>
                <a:ext uri="{FF2B5EF4-FFF2-40B4-BE49-F238E27FC236}">
                  <a16:creationId xmlns:a16="http://schemas.microsoft.com/office/drawing/2014/main" id="{D7E7EE48-AD45-8AE9-6519-67E9C82E350D}"/>
                </a:ext>
              </a:extLst>
            </p:cNvPr>
            <p:cNvSpPr/>
            <p:nvPr/>
          </p:nvSpPr>
          <p:spPr>
            <a:xfrm>
              <a:off x="1480088" y="2962818"/>
              <a:ext cx="495948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2" name="rc7">
              <a:extLst>
                <a:ext uri="{FF2B5EF4-FFF2-40B4-BE49-F238E27FC236}">
                  <a16:creationId xmlns:a16="http://schemas.microsoft.com/office/drawing/2014/main" id="{B7A74D61-2E6B-F90E-915E-234CF2156463}"/>
                </a:ext>
              </a:extLst>
            </p:cNvPr>
            <p:cNvSpPr/>
            <p:nvPr/>
          </p:nvSpPr>
          <p:spPr>
            <a:xfrm>
              <a:off x="1976036" y="4960770"/>
              <a:ext cx="495948" cy="580855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3" name="rc8">
              <a:extLst>
                <a:ext uri="{FF2B5EF4-FFF2-40B4-BE49-F238E27FC236}">
                  <a16:creationId xmlns:a16="http://schemas.microsoft.com/office/drawing/2014/main" id="{2E40B172-E93F-10C2-1139-C2B6B386BE45}"/>
                </a:ext>
              </a:extLst>
            </p:cNvPr>
            <p:cNvSpPr/>
            <p:nvPr/>
          </p:nvSpPr>
          <p:spPr>
            <a:xfrm>
              <a:off x="2471985" y="4990903"/>
              <a:ext cx="495948" cy="550722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4" name="rc9">
              <a:extLst>
                <a:ext uri="{FF2B5EF4-FFF2-40B4-BE49-F238E27FC236}">
                  <a16:creationId xmlns:a16="http://schemas.microsoft.com/office/drawing/2014/main" id="{7904156D-493A-4DAC-02CD-073D56FC9757}"/>
                </a:ext>
              </a:extLst>
            </p:cNvPr>
            <p:cNvSpPr/>
            <p:nvPr/>
          </p:nvSpPr>
          <p:spPr>
            <a:xfrm>
              <a:off x="3133249" y="2962818"/>
              <a:ext cx="495948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5" name="rc10">
              <a:extLst>
                <a:ext uri="{FF2B5EF4-FFF2-40B4-BE49-F238E27FC236}">
                  <a16:creationId xmlns:a16="http://schemas.microsoft.com/office/drawing/2014/main" id="{6EE1D428-7420-FAB7-C405-3F78C8FF17DA}"/>
                </a:ext>
              </a:extLst>
            </p:cNvPr>
            <p:cNvSpPr/>
            <p:nvPr/>
          </p:nvSpPr>
          <p:spPr>
            <a:xfrm>
              <a:off x="3629198" y="5110438"/>
              <a:ext cx="495948" cy="431188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6" name="rc11">
              <a:extLst>
                <a:ext uri="{FF2B5EF4-FFF2-40B4-BE49-F238E27FC236}">
                  <a16:creationId xmlns:a16="http://schemas.microsoft.com/office/drawing/2014/main" id="{B7AB858E-55AD-186F-E7E2-05D79AE51040}"/>
                </a:ext>
              </a:extLst>
            </p:cNvPr>
            <p:cNvSpPr/>
            <p:nvPr/>
          </p:nvSpPr>
          <p:spPr>
            <a:xfrm>
              <a:off x="4125146" y="5067901"/>
              <a:ext cx="495948" cy="473725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7" name="rc12">
              <a:extLst>
                <a:ext uri="{FF2B5EF4-FFF2-40B4-BE49-F238E27FC236}">
                  <a16:creationId xmlns:a16="http://schemas.microsoft.com/office/drawing/2014/main" id="{ED067615-072E-2832-D77C-895984186A36}"/>
                </a:ext>
              </a:extLst>
            </p:cNvPr>
            <p:cNvSpPr/>
            <p:nvPr/>
          </p:nvSpPr>
          <p:spPr>
            <a:xfrm>
              <a:off x="4786411" y="2962818"/>
              <a:ext cx="495948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8" name="rc13">
              <a:extLst>
                <a:ext uri="{FF2B5EF4-FFF2-40B4-BE49-F238E27FC236}">
                  <a16:creationId xmlns:a16="http://schemas.microsoft.com/office/drawing/2014/main" id="{EFD2CC4A-AEFD-081D-CEBB-D527029B019A}"/>
                </a:ext>
              </a:extLst>
            </p:cNvPr>
            <p:cNvSpPr/>
            <p:nvPr/>
          </p:nvSpPr>
          <p:spPr>
            <a:xfrm>
              <a:off x="5282359" y="4720474"/>
              <a:ext cx="495948" cy="821152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19" name="rc14">
              <a:extLst>
                <a:ext uri="{FF2B5EF4-FFF2-40B4-BE49-F238E27FC236}">
                  <a16:creationId xmlns:a16="http://schemas.microsoft.com/office/drawing/2014/main" id="{D450D963-CFBA-3F72-7B1C-2F93F972F1B3}"/>
                </a:ext>
              </a:extLst>
            </p:cNvPr>
            <p:cNvSpPr/>
            <p:nvPr/>
          </p:nvSpPr>
          <p:spPr>
            <a:xfrm>
              <a:off x="5778307" y="4768000"/>
              <a:ext cx="495948" cy="77362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0" name="pg15">
              <a:extLst>
                <a:ext uri="{FF2B5EF4-FFF2-40B4-BE49-F238E27FC236}">
                  <a16:creationId xmlns:a16="http://schemas.microsoft.com/office/drawing/2014/main" id="{6C598078-FFAB-B0E1-7A44-7ABF7C2D6F88}"/>
                </a:ext>
              </a:extLst>
            </p:cNvPr>
            <p:cNvSpPr/>
            <p:nvPr/>
          </p:nvSpPr>
          <p:spPr>
            <a:xfrm>
              <a:off x="3838795" y="509463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1" name="pg16">
              <a:extLst>
                <a:ext uri="{FF2B5EF4-FFF2-40B4-BE49-F238E27FC236}">
                  <a16:creationId xmlns:a16="http://schemas.microsoft.com/office/drawing/2014/main" id="{309B9EC2-1ECA-0B51-E5FD-F2EC9C23D126}"/>
                </a:ext>
              </a:extLst>
            </p:cNvPr>
            <p:cNvSpPr/>
            <p:nvPr/>
          </p:nvSpPr>
          <p:spPr>
            <a:xfrm>
              <a:off x="4334744" y="495434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2" name="pg17">
              <a:extLst>
                <a:ext uri="{FF2B5EF4-FFF2-40B4-BE49-F238E27FC236}">
                  <a16:creationId xmlns:a16="http://schemas.microsoft.com/office/drawing/2014/main" id="{DC36C988-E6F5-D494-76C8-8051C7762A93}"/>
                </a:ext>
              </a:extLst>
            </p:cNvPr>
            <p:cNvSpPr/>
            <p:nvPr/>
          </p:nvSpPr>
          <p:spPr>
            <a:xfrm>
              <a:off x="3838795" y="500433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3" name="pg18">
              <a:extLst>
                <a:ext uri="{FF2B5EF4-FFF2-40B4-BE49-F238E27FC236}">
                  <a16:creationId xmlns:a16="http://schemas.microsoft.com/office/drawing/2014/main" id="{764C928B-F797-A78E-9DEA-1D9D33F5A6F2}"/>
                </a:ext>
              </a:extLst>
            </p:cNvPr>
            <p:cNvSpPr/>
            <p:nvPr/>
          </p:nvSpPr>
          <p:spPr>
            <a:xfrm>
              <a:off x="4334744" y="495556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4" name="pg19">
              <a:extLst>
                <a:ext uri="{FF2B5EF4-FFF2-40B4-BE49-F238E27FC236}">
                  <a16:creationId xmlns:a16="http://schemas.microsoft.com/office/drawing/2014/main" id="{7CBE9951-03C8-3284-4879-0754D8598B95}"/>
                </a:ext>
              </a:extLst>
            </p:cNvPr>
            <p:cNvSpPr/>
            <p:nvPr/>
          </p:nvSpPr>
          <p:spPr>
            <a:xfrm>
              <a:off x="3838795" y="511722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5" name="pg20">
              <a:extLst>
                <a:ext uri="{FF2B5EF4-FFF2-40B4-BE49-F238E27FC236}">
                  <a16:creationId xmlns:a16="http://schemas.microsoft.com/office/drawing/2014/main" id="{53B92EC4-A918-09B8-2E23-2E15E0B985F4}"/>
                </a:ext>
              </a:extLst>
            </p:cNvPr>
            <p:cNvSpPr/>
            <p:nvPr/>
          </p:nvSpPr>
          <p:spPr>
            <a:xfrm>
              <a:off x="4334744" y="517865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6" name="pg21">
              <a:extLst>
                <a:ext uri="{FF2B5EF4-FFF2-40B4-BE49-F238E27FC236}">
                  <a16:creationId xmlns:a16="http://schemas.microsoft.com/office/drawing/2014/main" id="{DE6E957A-3134-F618-61F4-732F391624FC}"/>
                </a:ext>
              </a:extLst>
            </p:cNvPr>
            <p:cNvSpPr/>
            <p:nvPr/>
          </p:nvSpPr>
          <p:spPr>
            <a:xfrm>
              <a:off x="334284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7" name="pg22">
              <a:extLst>
                <a:ext uri="{FF2B5EF4-FFF2-40B4-BE49-F238E27FC236}">
                  <a16:creationId xmlns:a16="http://schemas.microsoft.com/office/drawing/2014/main" id="{782F52A7-C330-21DD-EED8-E911D9780C60}"/>
                </a:ext>
              </a:extLst>
            </p:cNvPr>
            <p:cNvSpPr/>
            <p:nvPr/>
          </p:nvSpPr>
          <p:spPr>
            <a:xfrm>
              <a:off x="334284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8" name="pg23">
              <a:extLst>
                <a:ext uri="{FF2B5EF4-FFF2-40B4-BE49-F238E27FC236}">
                  <a16:creationId xmlns:a16="http://schemas.microsoft.com/office/drawing/2014/main" id="{FF9B78B8-979A-A75C-3745-27D91EEEDDB6}"/>
                </a:ext>
              </a:extLst>
            </p:cNvPr>
            <p:cNvSpPr/>
            <p:nvPr/>
          </p:nvSpPr>
          <p:spPr>
            <a:xfrm>
              <a:off x="334284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29" name="pg24">
              <a:extLst>
                <a:ext uri="{FF2B5EF4-FFF2-40B4-BE49-F238E27FC236}">
                  <a16:creationId xmlns:a16="http://schemas.microsoft.com/office/drawing/2014/main" id="{82EFF1DC-3ABE-9676-84D5-118E825E5549}"/>
                </a:ext>
              </a:extLst>
            </p:cNvPr>
            <p:cNvSpPr/>
            <p:nvPr/>
          </p:nvSpPr>
          <p:spPr>
            <a:xfrm>
              <a:off x="5491957" y="4594594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0" name="pg25">
              <a:extLst>
                <a:ext uri="{FF2B5EF4-FFF2-40B4-BE49-F238E27FC236}">
                  <a16:creationId xmlns:a16="http://schemas.microsoft.com/office/drawing/2014/main" id="{E671ABFD-EFEE-2604-28AF-B471D81336E6}"/>
                </a:ext>
              </a:extLst>
            </p:cNvPr>
            <p:cNvSpPr/>
            <p:nvPr/>
          </p:nvSpPr>
          <p:spPr>
            <a:xfrm>
              <a:off x="5987905" y="467010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1" name="pg26">
              <a:extLst>
                <a:ext uri="{FF2B5EF4-FFF2-40B4-BE49-F238E27FC236}">
                  <a16:creationId xmlns:a16="http://schemas.microsoft.com/office/drawing/2014/main" id="{8699876C-B37B-BB78-A18A-C322BE239CDA}"/>
                </a:ext>
              </a:extLst>
            </p:cNvPr>
            <p:cNvSpPr/>
            <p:nvPr/>
          </p:nvSpPr>
          <p:spPr>
            <a:xfrm>
              <a:off x="5491957" y="472765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2" name="pg27">
              <a:extLst>
                <a:ext uri="{FF2B5EF4-FFF2-40B4-BE49-F238E27FC236}">
                  <a16:creationId xmlns:a16="http://schemas.microsoft.com/office/drawing/2014/main" id="{F4B9CA1E-8B28-6464-4FD8-41EC47E47779}"/>
                </a:ext>
              </a:extLst>
            </p:cNvPr>
            <p:cNvSpPr/>
            <p:nvPr/>
          </p:nvSpPr>
          <p:spPr>
            <a:xfrm>
              <a:off x="5987905" y="488497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3" name="pg28">
              <a:extLst>
                <a:ext uri="{FF2B5EF4-FFF2-40B4-BE49-F238E27FC236}">
                  <a16:creationId xmlns:a16="http://schemas.microsoft.com/office/drawing/2014/main" id="{8D3861EB-38EA-2EB1-CC50-8565E2116CDC}"/>
                </a:ext>
              </a:extLst>
            </p:cNvPr>
            <p:cNvSpPr/>
            <p:nvPr/>
          </p:nvSpPr>
          <p:spPr>
            <a:xfrm>
              <a:off x="5491957" y="47240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4" name="pg29">
              <a:extLst>
                <a:ext uri="{FF2B5EF4-FFF2-40B4-BE49-F238E27FC236}">
                  <a16:creationId xmlns:a16="http://schemas.microsoft.com/office/drawing/2014/main" id="{9508362E-EC40-BB60-2ACD-5D868004242B}"/>
                </a:ext>
              </a:extLst>
            </p:cNvPr>
            <p:cNvSpPr/>
            <p:nvPr/>
          </p:nvSpPr>
          <p:spPr>
            <a:xfrm>
              <a:off x="5987905" y="463378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5" name="pg30">
              <a:extLst>
                <a:ext uri="{FF2B5EF4-FFF2-40B4-BE49-F238E27FC236}">
                  <a16:creationId xmlns:a16="http://schemas.microsoft.com/office/drawing/2014/main" id="{45288C88-D57E-EDCA-4F37-941D7E092F57}"/>
                </a:ext>
              </a:extLst>
            </p:cNvPr>
            <p:cNvSpPr/>
            <p:nvPr/>
          </p:nvSpPr>
          <p:spPr>
            <a:xfrm>
              <a:off x="4996008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6" name="pg31">
              <a:extLst>
                <a:ext uri="{FF2B5EF4-FFF2-40B4-BE49-F238E27FC236}">
                  <a16:creationId xmlns:a16="http://schemas.microsoft.com/office/drawing/2014/main" id="{476BC3AC-6DE2-BCAB-B277-5D00F7CA372C}"/>
                </a:ext>
              </a:extLst>
            </p:cNvPr>
            <p:cNvSpPr/>
            <p:nvPr/>
          </p:nvSpPr>
          <p:spPr>
            <a:xfrm>
              <a:off x="4996008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7" name="pg32">
              <a:extLst>
                <a:ext uri="{FF2B5EF4-FFF2-40B4-BE49-F238E27FC236}">
                  <a16:creationId xmlns:a16="http://schemas.microsoft.com/office/drawing/2014/main" id="{D4943500-A058-5C65-1DE1-8097720281B5}"/>
                </a:ext>
              </a:extLst>
            </p:cNvPr>
            <p:cNvSpPr/>
            <p:nvPr/>
          </p:nvSpPr>
          <p:spPr>
            <a:xfrm>
              <a:off x="4996008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8" name="pg33">
              <a:extLst>
                <a:ext uri="{FF2B5EF4-FFF2-40B4-BE49-F238E27FC236}">
                  <a16:creationId xmlns:a16="http://schemas.microsoft.com/office/drawing/2014/main" id="{B79E3640-D51F-C3FE-AA01-F8B138061094}"/>
                </a:ext>
              </a:extLst>
            </p:cNvPr>
            <p:cNvSpPr/>
            <p:nvPr/>
          </p:nvSpPr>
          <p:spPr>
            <a:xfrm>
              <a:off x="2185634" y="495191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39" name="pg34">
              <a:extLst>
                <a:ext uri="{FF2B5EF4-FFF2-40B4-BE49-F238E27FC236}">
                  <a16:creationId xmlns:a16="http://schemas.microsoft.com/office/drawing/2014/main" id="{040421B1-BD81-77C0-1C3E-4E2C0ACED0C2}"/>
                </a:ext>
              </a:extLst>
            </p:cNvPr>
            <p:cNvSpPr/>
            <p:nvPr/>
          </p:nvSpPr>
          <p:spPr>
            <a:xfrm>
              <a:off x="2185634" y="505201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0" name="pg35">
              <a:extLst>
                <a:ext uri="{FF2B5EF4-FFF2-40B4-BE49-F238E27FC236}">
                  <a16:creationId xmlns:a16="http://schemas.microsoft.com/office/drawing/2014/main" id="{1F4216A2-566F-026F-6608-7259ADA7C1DF}"/>
                </a:ext>
              </a:extLst>
            </p:cNvPr>
            <p:cNvSpPr/>
            <p:nvPr/>
          </p:nvSpPr>
          <p:spPr>
            <a:xfrm>
              <a:off x="2185634" y="476325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1" name="pg36">
              <a:extLst>
                <a:ext uri="{FF2B5EF4-FFF2-40B4-BE49-F238E27FC236}">
                  <a16:creationId xmlns:a16="http://schemas.microsoft.com/office/drawing/2014/main" id="{BC0EA7F4-3EC9-AF6F-9903-DE6BE8DAE256}"/>
                </a:ext>
              </a:extLst>
            </p:cNvPr>
            <p:cNvSpPr/>
            <p:nvPr/>
          </p:nvSpPr>
          <p:spPr>
            <a:xfrm>
              <a:off x="168968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2" name="pg37">
              <a:extLst>
                <a:ext uri="{FF2B5EF4-FFF2-40B4-BE49-F238E27FC236}">
                  <a16:creationId xmlns:a16="http://schemas.microsoft.com/office/drawing/2014/main" id="{49DD4389-3E75-7FAC-42DC-CA78F236F36B}"/>
                </a:ext>
              </a:extLst>
            </p:cNvPr>
            <p:cNvSpPr/>
            <p:nvPr/>
          </p:nvSpPr>
          <p:spPr>
            <a:xfrm>
              <a:off x="168968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3" name="pg38">
              <a:extLst>
                <a:ext uri="{FF2B5EF4-FFF2-40B4-BE49-F238E27FC236}">
                  <a16:creationId xmlns:a16="http://schemas.microsoft.com/office/drawing/2014/main" id="{68C2F4B1-9C65-4571-7FF4-D30128A93201}"/>
                </a:ext>
              </a:extLst>
            </p:cNvPr>
            <p:cNvSpPr/>
            <p:nvPr/>
          </p:nvSpPr>
          <p:spPr>
            <a:xfrm>
              <a:off x="168968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4" name="pg39">
              <a:extLst>
                <a:ext uri="{FF2B5EF4-FFF2-40B4-BE49-F238E27FC236}">
                  <a16:creationId xmlns:a16="http://schemas.microsoft.com/office/drawing/2014/main" id="{54D92E06-320B-7B23-DDA6-84B4A5BF8830}"/>
                </a:ext>
              </a:extLst>
            </p:cNvPr>
            <p:cNvSpPr/>
            <p:nvPr/>
          </p:nvSpPr>
          <p:spPr>
            <a:xfrm>
              <a:off x="2681582" y="484038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5" name="pg40">
              <a:extLst>
                <a:ext uri="{FF2B5EF4-FFF2-40B4-BE49-F238E27FC236}">
                  <a16:creationId xmlns:a16="http://schemas.microsoft.com/office/drawing/2014/main" id="{80C8E487-6244-E38C-33D0-C2B2085F9B4C}"/>
                </a:ext>
              </a:extLst>
            </p:cNvPr>
            <p:cNvSpPr/>
            <p:nvPr/>
          </p:nvSpPr>
          <p:spPr>
            <a:xfrm>
              <a:off x="2681582" y="491559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6" name="pg41">
              <a:extLst>
                <a:ext uri="{FF2B5EF4-FFF2-40B4-BE49-F238E27FC236}">
                  <a16:creationId xmlns:a16="http://schemas.microsoft.com/office/drawing/2014/main" id="{772724CE-582D-63A6-3019-706A784D9AD8}"/>
                </a:ext>
              </a:extLst>
            </p:cNvPr>
            <p:cNvSpPr/>
            <p:nvPr/>
          </p:nvSpPr>
          <p:spPr>
            <a:xfrm>
              <a:off x="2681582" y="5101601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7" name="pl42">
              <a:extLst>
                <a:ext uri="{FF2B5EF4-FFF2-40B4-BE49-F238E27FC236}">
                  <a16:creationId xmlns:a16="http://schemas.microsoft.com/office/drawing/2014/main" id="{81A60FBD-D3E3-66D8-61EB-5AE72B06769A}"/>
                </a:ext>
              </a:extLst>
            </p:cNvPr>
            <p:cNvSpPr/>
            <p:nvPr/>
          </p:nvSpPr>
          <p:spPr>
            <a:xfrm>
              <a:off x="1645404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8" name="pl43">
              <a:extLst>
                <a:ext uri="{FF2B5EF4-FFF2-40B4-BE49-F238E27FC236}">
                  <a16:creationId xmlns:a16="http://schemas.microsoft.com/office/drawing/2014/main" id="{0B67A737-4A35-7B74-E327-709ED57E8D97}"/>
                </a:ext>
              </a:extLst>
            </p:cNvPr>
            <p:cNvSpPr/>
            <p:nvPr/>
          </p:nvSpPr>
          <p:spPr>
            <a:xfrm>
              <a:off x="1728062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49" name="pl44">
              <a:extLst>
                <a:ext uri="{FF2B5EF4-FFF2-40B4-BE49-F238E27FC236}">
                  <a16:creationId xmlns:a16="http://schemas.microsoft.com/office/drawing/2014/main" id="{26D693EA-3E3C-763A-AC26-B1D91FF63233}"/>
                </a:ext>
              </a:extLst>
            </p:cNvPr>
            <p:cNvSpPr/>
            <p:nvPr/>
          </p:nvSpPr>
          <p:spPr>
            <a:xfrm>
              <a:off x="1645404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0" name="pl45">
              <a:extLst>
                <a:ext uri="{FF2B5EF4-FFF2-40B4-BE49-F238E27FC236}">
                  <a16:creationId xmlns:a16="http://schemas.microsoft.com/office/drawing/2014/main" id="{FDFAF422-009C-A544-020F-94367F0D162D}"/>
                </a:ext>
              </a:extLst>
            </p:cNvPr>
            <p:cNvSpPr/>
            <p:nvPr/>
          </p:nvSpPr>
          <p:spPr>
            <a:xfrm>
              <a:off x="2141352" y="4814144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1" name="pl46">
              <a:extLst>
                <a:ext uri="{FF2B5EF4-FFF2-40B4-BE49-F238E27FC236}">
                  <a16:creationId xmlns:a16="http://schemas.microsoft.com/office/drawing/2014/main" id="{8F68215B-7CD2-746C-B3F9-96D2AE5B9801}"/>
                </a:ext>
              </a:extLst>
            </p:cNvPr>
            <p:cNvSpPr/>
            <p:nvPr/>
          </p:nvSpPr>
          <p:spPr>
            <a:xfrm>
              <a:off x="2224011" y="4814144"/>
              <a:ext cx="0" cy="293253"/>
            </a:xfrm>
            <a:custGeom>
              <a:avLst/>
              <a:gdLst/>
              <a:ahLst/>
              <a:cxnLst/>
              <a:rect l="0" t="0" r="0" b="0"/>
              <a:pathLst>
                <a:path h="293253">
                  <a:moveTo>
                    <a:pt x="0" y="0"/>
                  </a:moveTo>
                  <a:lnTo>
                    <a:pt x="0" y="29325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2" name="pl47">
              <a:extLst>
                <a:ext uri="{FF2B5EF4-FFF2-40B4-BE49-F238E27FC236}">
                  <a16:creationId xmlns:a16="http://schemas.microsoft.com/office/drawing/2014/main" id="{ABE31E36-A3D1-7D1E-88A4-A0E527DC058C}"/>
                </a:ext>
              </a:extLst>
            </p:cNvPr>
            <p:cNvSpPr/>
            <p:nvPr/>
          </p:nvSpPr>
          <p:spPr>
            <a:xfrm>
              <a:off x="2141352" y="5107397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3" name="pl48">
              <a:extLst>
                <a:ext uri="{FF2B5EF4-FFF2-40B4-BE49-F238E27FC236}">
                  <a16:creationId xmlns:a16="http://schemas.microsoft.com/office/drawing/2014/main" id="{47563CD5-B369-B10C-5ECB-A677005019E7}"/>
                </a:ext>
              </a:extLst>
            </p:cNvPr>
            <p:cNvSpPr/>
            <p:nvPr/>
          </p:nvSpPr>
          <p:spPr>
            <a:xfrm>
              <a:off x="2637301" y="4856437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4" name="pl49">
              <a:extLst>
                <a:ext uri="{FF2B5EF4-FFF2-40B4-BE49-F238E27FC236}">
                  <a16:creationId xmlns:a16="http://schemas.microsoft.com/office/drawing/2014/main" id="{055317CF-101D-681D-803D-F62ADFF0A338}"/>
                </a:ext>
              </a:extLst>
            </p:cNvPr>
            <p:cNvSpPr/>
            <p:nvPr/>
          </p:nvSpPr>
          <p:spPr>
            <a:xfrm>
              <a:off x="2719959" y="4856437"/>
              <a:ext cx="0" cy="268933"/>
            </a:xfrm>
            <a:custGeom>
              <a:avLst/>
              <a:gdLst/>
              <a:ahLst/>
              <a:cxnLst/>
              <a:rect l="0" t="0" r="0" b="0"/>
              <a:pathLst>
                <a:path h="268933">
                  <a:moveTo>
                    <a:pt x="0" y="0"/>
                  </a:moveTo>
                  <a:lnTo>
                    <a:pt x="0" y="2689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5" name="pl50">
              <a:extLst>
                <a:ext uri="{FF2B5EF4-FFF2-40B4-BE49-F238E27FC236}">
                  <a16:creationId xmlns:a16="http://schemas.microsoft.com/office/drawing/2014/main" id="{76790BD5-ECB0-DCEF-F867-89C0F58C316D}"/>
                </a:ext>
              </a:extLst>
            </p:cNvPr>
            <p:cNvSpPr/>
            <p:nvPr/>
          </p:nvSpPr>
          <p:spPr>
            <a:xfrm>
              <a:off x="2637301" y="5125370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6" name="pl51">
              <a:extLst>
                <a:ext uri="{FF2B5EF4-FFF2-40B4-BE49-F238E27FC236}">
                  <a16:creationId xmlns:a16="http://schemas.microsoft.com/office/drawing/2014/main" id="{190544BD-724F-F6AB-8D8C-D1BF378F40FE}"/>
                </a:ext>
              </a:extLst>
            </p:cNvPr>
            <p:cNvSpPr/>
            <p:nvPr/>
          </p:nvSpPr>
          <p:spPr>
            <a:xfrm>
              <a:off x="3298565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7" name="pl52">
              <a:extLst>
                <a:ext uri="{FF2B5EF4-FFF2-40B4-BE49-F238E27FC236}">
                  <a16:creationId xmlns:a16="http://schemas.microsoft.com/office/drawing/2014/main" id="{9F2389C9-D9D3-055D-685F-4B38155B2750}"/>
                </a:ext>
              </a:extLst>
            </p:cNvPr>
            <p:cNvSpPr/>
            <p:nvPr/>
          </p:nvSpPr>
          <p:spPr>
            <a:xfrm>
              <a:off x="3381223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8" name="pl53">
              <a:extLst>
                <a:ext uri="{FF2B5EF4-FFF2-40B4-BE49-F238E27FC236}">
                  <a16:creationId xmlns:a16="http://schemas.microsoft.com/office/drawing/2014/main" id="{CFFC0A89-DB95-D456-EA93-8AFAC668DBEC}"/>
                </a:ext>
              </a:extLst>
            </p:cNvPr>
            <p:cNvSpPr/>
            <p:nvPr/>
          </p:nvSpPr>
          <p:spPr>
            <a:xfrm>
              <a:off x="3298565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59" name="pl54">
              <a:extLst>
                <a:ext uri="{FF2B5EF4-FFF2-40B4-BE49-F238E27FC236}">
                  <a16:creationId xmlns:a16="http://schemas.microsoft.com/office/drawing/2014/main" id="{DD98484D-DE61-816B-959D-97687E349697}"/>
                </a:ext>
              </a:extLst>
            </p:cNvPr>
            <p:cNvSpPr/>
            <p:nvPr/>
          </p:nvSpPr>
          <p:spPr>
            <a:xfrm>
              <a:off x="3794514" y="5050706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0" name="pl55">
              <a:extLst>
                <a:ext uri="{FF2B5EF4-FFF2-40B4-BE49-F238E27FC236}">
                  <a16:creationId xmlns:a16="http://schemas.microsoft.com/office/drawing/2014/main" id="{6B8BB59A-722A-97BC-A173-4F0BFF1C54DB}"/>
                </a:ext>
              </a:extLst>
            </p:cNvPr>
            <p:cNvSpPr/>
            <p:nvPr/>
          </p:nvSpPr>
          <p:spPr>
            <a:xfrm>
              <a:off x="3877172" y="5050706"/>
              <a:ext cx="0" cy="119462"/>
            </a:xfrm>
            <a:custGeom>
              <a:avLst/>
              <a:gdLst/>
              <a:ahLst/>
              <a:cxnLst/>
              <a:rect l="0" t="0" r="0" b="0"/>
              <a:pathLst>
                <a:path h="119462">
                  <a:moveTo>
                    <a:pt x="0" y="0"/>
                  </a:moveTo>
                  <a:lnTo>
                    <a:pt x="0" y="11946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1" name="pl56">
              <a:extLst>
                <a:ext uri="{FF2B5EF4-FFF2-40B4-BE49-F238E27FC236}">
                  <a16:creationId xmlns:a16="http://schemas.microsoft.com/office/drawing/2014/main" id="{9F288635-6E77-5BE2-B3F5-2383CDB2DF85}"/>
                </a:ext>
              </a:extLst>
            </p:cNvPr>
            <p:cNvSpPr/>
            <p:nvPr/>
          </p:nvSpPr>
          <p:spPr>
            <a:xfrm>
              <a:off x="3794514" y="5170169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2" name="pl57">
              <a:extLst>
                <a:ext uri="{FF2B5EF4-FFF2-40B4-BE49-F238E27FC236}">
                  <a16:creationId xmlns:a16="http://schemas.microsoft.com/office/drawing/2014/main" id="{C2DA94E7-8CE8-270B-B49A-FA847878C78F}"/>
                </a:ext>
              </a:extLst>
            </p:cNvPr>
            <p:cNvSpPr/>
            <p:nvPr/>
          </p:nvSpPr>
          <p:spPr>
            <a:xfrm>
              <a:off x="4290462" y="493874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3" name="pl58">
              <a:extLst>
                <a:ext uri="{FF2B5EF4-FFF2-40B4-BE49-F238E27FC236}">
                  <a16:creationId xmlns:a16="http://schemas.microsoft.com/office/drawing/2014/main" id="{53852767-DD42-BCE4-E4B1-DFB3F0962FF1}"/>
                </a:ext>
              </a:extLst>
            </p:cNvPr>
            <p:cNvSpPr/>
            <p:nvPr/>
          </p:nvSpPr>
          <p:spPr>
            <a:xfrm>
              <a:off x="4373120" y="4938748"/>
              <a:ext cx="0" cy="258305"/>
            </a:xfrm>
            <a:custGeom>
              <a:avLst/>
              <a:gdLst/>
              <a:ahLst/>
              <a:cxnLst/>
              <a:rect l="0" t="0" r="0" b="0"/>
              <a:pathLst>
                <a:path h="258305">
                  <a:moveTo>
                    <a:pt x="0" y="0"/>
                  </a:moveTo>
                  <a:lnTo>
                    <a:pt x="0" y="25830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4" name="pl59">
              <a:extLst>
                <a:ext uri="{FF2B5EF4-FFF2-40B4-BE49-F238E27FC236}">
                  <a16:creationId xmlns:a16="http://schemas.microsoft.com/office/drawing/2014/main" id="{EC209412-B7D1-804E-D44D-123FC4661D91}"/>
                </a:ext>
              </a:extLst>
            </p:cNvPr>
            <p:cNvSpPr/>
            <p:nvPr/>
          </p:nvSpPr>
          <p:spPr>
            <a:xfrm>
              <a:off x="4290462" y="5197053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5" name="pl60">
              <a:extLst>
                <a:ext uri="{FF2B5EF4-FFF2-40B4-BE49-F238E27FC236}">
                  <a16:creationId xmlns:a16="http://schemas.microsoft.com/office/drawing/2014/main" id="{04E77B5C-FF9D-9E37-1FAE-47F52BF82F71}"/>
                </a:ext>
              </a:extLst>
            </p:cNvPr>
            <p:cNvSpPr/>
            <p:nvPr/>
          </p:nvSpPr>
          <p:spPr>
            <a:xfrm>
              <a:off x="4951727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6" name="pl61">
              <a:extLst>
                <a:ext uri="{FF2B5EF4-FFF2-40B4-BE49-F238E27FC236}">
                  <a16:creationId xmlns:a16="http://schemas.microsoft.com/office/drawing/2014/main" id="{D65F0C47-F501-7F6D-219F-4A5D48A2BF70}"/>
                </a:ext>
              </a:extLst>
            </p:cNvPr>
            <p:cNvSpPr/>
            <p:nvPr/>
          </p:nvSpPr>
          <p:spPr>
            <a:xfrm>
              <a:off x="5034385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7" name="pl62">
              <a:extLst>
                <a:ext uri="{FF2B5EF4-FFF2-40B4-BE49-F238E27FC236}">
                  <a16:creationId xmlns:a16="http://schemas.microsoft.com/office/drawing/2014/main" id="{CE0013AC-7FD8-975E-AF2D-B0028EB31302}"/>
                </a:ext>
              </a:extLst>
            </p:cNvPr>
            <p:cNvSpPr/>
            <p:nvPr/>
          </p:nvSpPr>
          <p:spPr>
            <a:xfrm>
              <a:off x="4951727" y="296281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8" name="pl63">
              <a:extLst>
                <a:ext uri="{FF2B5EF4-FFF2-40B4-BE49-F238E27FC236}">
                  <a16:creationId xmlns:a16="http://schemas.microsoft.com/office/drawing/2014/main" id="{A3C243D3-CCAD-646B-B040-CF24B04DED2D}"/>
                </a:ext>
              </a:extLst>
            </p:cNvPr>
            <p:cNvSpPr/>
            <p:nvPr/>
          </p:nvSpPr>
          <p:spPr>
            <a:xfrm>
              <a:off x="5447675" y="4644672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69" name="pl64">
              <a:extLst>
                <a:ext uri="{FF2B5EF4-FFF2-40B4-BE49-F238E27FC236}">
                  <a16:creationId xmlns:a16="http://schemas.microsoft.com/office/drawing/2014/main" id="{BEBAB621-B519-2221-7B3A-ABAFB509669B}"/>
                </a:ext>
              </a:extLst>
            </p:cNvPr>
            <p:cNvSpPr/>
            <p:nvPr/>
          </p:nvSpPr>
          <p:spPr>
            <a:xfrm>
              <a:off x="5530333" y="4644672"/>
              <a:ext cx="0" cy="151603"/>
            </a:xfrm>
            <a:custGeom>
              <a:avLst/>
              <a:gdLst/>
              <a:ahLst/>
              <a:cxnLst/>
              <a:rect l="0" t="0" r="0" b="0"/>
              <a:pathLst>
                <a:path h="151603">
                  <a:moveTo>
                    <a:pt x="0" y="0"/>
                  </a:moveTo>
                  <a:lnTo>
                    <a:pt x="0" y="15160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70" name="pl65">
              <a:extLst>
                <a:ext uri="{FF2B5EF4-FFF2-40B4-BE49-F238E27FC236}">
                  <a16:creationId xmlns:a16="http://schemas.microsoft.com/office/drawing/2014/main" id="{BBFF8221-BFA7-8C83-4D19-00CF2DD630E7}"/>
                </a:ext>
              </a:extLst>
            </p:cNvPr>
            <p:cNvSpPr/>
            <p:nvPr/>
          </p:nvSpPr>
          <p:spPr>
            <a:xfrm>
              <a:off x="5447675" y="4796275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71" name="pl66">
              <a:extLst>
                <a:ext uri="{FF2B5EF4-FFF2-40B4-BE49-F238E27FC236}">
                  <a16:creationId xmlns:a16="http://schemas.microsoft.com/office/drawing/2014/main" id="{136FEBAC-559A-AA29-117C-05B83FA10BEB}"/>
                </a:ext>
              </a:extLst>
            </p:cNvPr>
            <p:cNvSpPr/>
            <p:nvPr/>
          </p:nvSpPr>
          <p:spPr>
            <a:xfrm>
              <a:off x="5943623" y="4632238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72" name="pl67">
              <a:extLst>
                <a:ext uri="{FF2B5EF4-FFF2-40B4-BE49-F238E27FC236}">
                  <a16:creationId xmlns:a16="http://schemas.microsoft.com/office/drawing/2014/main" id="{8D37244B-4AA0-2E0D-FC63-5C09544ED701}"/>
                </a:ext>
              </a:extLst>
            </p:cNvPr>
            <p:cNvSpPr/>
            <p:nvPr/>
          </p:nvSpPr>
          <p:spPr>
            <a:xfrm>
              <a:off x="6026282" y="4632238"/>
              <a:ext cx="0" cy="271522"/>
            </a:xfrm>
            <a:custGeom>
              <a:avLst/>
              <a:gdLst/>
              <a:ahLst/>
              <a:cxnLst/>
              <a:rect l="0" t="0" r="0" b="0"/>
              <a:pathLst>
                <a:path h="271522">
                  <a:moveTo>
                    <a:pt x="0" y="0"/>
                  </a:moveTo>
                  <a:lnTo>
                    <a:pt x="0" y="2715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73" name="pl68">
              <a:extLst>
                <a:ext uri="{FF2B5EF4-FFF2-40B4-BE49-F238E27FC236}">
                  <a16:creationId xmlns:a16="http://schemas.microsoft.com/office/drawing/2014/main" id="{88600A13-841B-D4DF-CD05-AB240A37BE07}"/>
                </a:ext>
              </a:extLst>
            </p:cNvPr>
            <p:cNvSpPr/>
            <p:nvPr/>
          </p:nvSpPr>
          <p:spPr>
            <a:xfrm>
              <a:off x="5943623" y="4903761"/>
              <a:ext cx="165316" cy="0"/>
            </a:xfrm>
            <a:custGeom>
              <a:avLst/>
              <a:gdLst/>
              <a:ahLst/>
              <a:cxnLst/>
              <a:rect l="0" t="0" r="0" b="0"/>
              <a:pathLst>
                <a:path w="165316">
                  <a:moveTo>
                    <a:pt x="0" y="0"/>
                  </a:moveTo>
                  <a:lnTo>
                    <a:pt x="16531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74" name="tx69">
              <a:extLst>
                <a:ext uri="{FF2B5EF4-FFF2-40B4-BE49-F238E27FC236}">
                  <a16:creationId xmlns:a16="http://schemas.microsoft.com/office/drawing/2014/main" id="{74300986-9F70-7AB5-9267-E41558F73368}"/>
                </a:ext>
              </a:extLst>
            </p:cNvPr>
            <p:cNvSpPr/>
            <p:nvPr/>
          </p:nvSpPr>
          <p:spPr>
            <a:xfrm>
              <a:off x="3852073" y="31568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875" name="tx70">
              <a:extLst>
                <a:ext uri="{FF2B5EF4-FFF2-40B4-BE49-F238E27FC236}">
                  <a16:creationId xmlns:a16="http://schemas.microsoft.com/office/drawing/2014/main" id="{17A17937-07BB-6FEF-94F2-87C9222E334B}"/>
                </a:ext>
              </a:extLst>
            </p:cNvPr>
            <p:cNvSpPr/>
            <p:nvPr/>
          </p:nvSpPr>
          <p:spPr>
            <a:xfrm>
              <a:off x="3771705" y="3101765"/>
              <a:ext cx="210934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*</a:t>
              </a:r>
            </a:p>
          </p:txBody>
        </p:sp>
        <p:sp>
          <p:nvSpPr>
            <p:cNvPr id="877" name="tx72">
              <a:extLst>
                <a:ext uri="{FF2B5EF4-FFF2-40B4-BE49-F238E27FC236}">
                  <a16:creationId xmlns:a16="http://schemas.microsoft.com/office/drawing/2014/main" id="{ECA8562D-B745-83B2-2A39-808FD9F31F10}"/>
                </a:ext>
              </a:extLst>
            </p:cNvPr>
            <p:cNvSpPr/>
            <p:nvPr/>
          </p:nvSpPr>
          <p:spPr>
            <a:xfrm>
              <a:off x="5505234" y="31568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879" name="tx74">
              <a:extLst>
                <a:ext uri="{FF2B5EF4-FFF2-40B4-BE49-F238E27FC236}">
                  <a16:creationId xmlns:a16="http://schemas.microsoft.com/office/drawing/2014/main" id="{D0A525CE-B8EC-15DE-BC96-945E5B9FE2A9}"/>
                </a:ext>
              </a:extLst>
            </p:cNvPr>
            <p:cNvSpPr/>
            <p:nvPr/>
          </p:nvSpPr>
          <p:spPr>
            <a:xfrm>
              <a:off x="5460022" y="31017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880" name="tx75">
              <a:extLst>
                <a:ext uri="{FF2B5EF4-FFF2-40B4-BE49-F238E27FC236}">
                  <a16:creationId xmlns:a16="http://schemas.microsoft.com/office/drawing/2014/main" id="{276A44CF-A066-1A0E-07C8-0702BDED4742}"/>
                </a:ext>
              </a:extLst>
            </p:cNvPr>
            <p:cNvSpPr/>
            <p:nvPr/>
          </p:nvSpPr>
          <p:spPr>
            <a:xfrm>
              <a:off x="2198912" y="3156814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881" name="tx76">
              <a:extLst>
                <a:ext uri="{FF2B5EF4-FFF2-40B4-BE49-F238E27FC236}">
                  <a16:creationId xmlns:a16="http://schemas.microsoft.com/office/drawing/2014/main" id="{4C91CF23-A95A-CD6A-2638-700F492C792C}"/>
                </a:ext>
              </a:extLst>
            </p:cNvPr>
            <p:cNvSpPr/>
            <p:nvPr/>
          </p:nvSpPr>
          <p:spPr>
            <a:xfrm>
              <a:off x="2153699" y="31017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882" name="tx77">
              <a:extLst>
                <a:ext uri="{FF2B5EF4-FFF2-40B4-BE49-F238E27FC236}">
                  <a16:creationId xmlns:a16="http://schemas.microsoft.com/office/drawing/2014/main" id="{9753C01E-4743-6F58-FCFA-DB8D83D73E39}"/>
                </a:ext>
              </a:extLst>
            </p:cNvPr>
            <p:cNvSpPr/>
            <p:nvPr/>
          </p:nvSpPr>
          <p:spPr>
            <a:xfrm>
              <a:off x="2153699" y="3101765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883" name="pl78">
              <a:extLst>
                <a:ext uri="{FF2B5EF4-FFF2-40B4-BE49-F238E27FC236}">
                  <a16:creationId xmlns:a16="http://schemas.microsoft.com/office/drawing/2014/main" id="{3CF5B428-0F73-6A0C-12CA-7BAE50FB904E}"/>
                </a:ext>
              </a:extLst>
            </p:cNvPr>
            <p:cNvSpPr/>
            <p:nvPr/>
          </p:nvSpPr>
          <p:spPr>
            <a:xfrm>
              <a:off x="1232114" y="2962818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  <a:lnTo>
                    <a:pt x="5290116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84" name="pl79">
              <a:extLst>
                <a:ext uri="{FF2B5EF4-FFF2-40B4-BE49-F238E27FC236}">
                  <a16:creationId xmlns:a16="http://schemas.microsoft.com/office/drawing/2014/main" id="{71211045-9318-8E95-8BBA-D5D2A921A604}"/>
                </a:ext>
              </a:extLst>
            </p:cNvPr>
            <p:cNvSpPr/>
            <p:nvPr/>
          </p:nvSpPr>
          <p:spPr>
            <a:xfrm>
              <a:off x="1232114" y="803067"/>
              <a:ext cx="0" cy="4964205"/>
            </a:xfrm>
            <a:custGeom>
              <a:avLst/>
              <a:gdLst/>
              <a:ahLst/>
              <a:cxnLst/>
              <a:rect l="0" t="0" r="0" b="0"/>
              <a:pathLst>
                <a:path h="4964205">
                  <a:moveTo>
                    <a:pt x="0" y="4964205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85" name="tx80">
              <a:extLst>
                <a:ext uri="{FF2B5EF4-FFF2-40B4-BE49-F238E27FC236}">
                  <a16:creationId xmlns:a16="http://schemas.microsoft.com/office/drawing/2014/main" id="{2832338B-8990-0383-69BB-9F976B762414}"/>
                </a:ext>
              </a:extLst>
            </p:cNvPr>
            <p:cNvSpPr/>
            <p:nvPr/>
          </p:nvSpPr>
          <p:spPr>
            <a:xfrm>
              <a:off x="637591" y="5427922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0</a:t>
              </a:r>
            </a:p>
          </p:txBody>
        </p:sp>
        <p:sp>
          <p:nvSpPr>
            <p:cNvPr id="886" name="tx81">
              <a:extLst>
                <a:ext uri="{FF2B5EF4-FFF2-40B4-BE49-F238E27FC236}">
                  <a16:creationId xmlns:a16="http://schemas.microsoft.com/office/drawing/2014/main" id="{79B0159C-5FCE-50D4-851D-6A12A56DA256}"/>
                </a:ext>
              </a:extLst>
            </p:cNvPr>
            <p:cNvSpPr/>
            <p:nvPr/>
          </p:nvSpPr>
          <p:spPr>
            <a:xfrm>
              <a:off x="637591" y="4138518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5</a:t>
              </a:r>
            </a:p>
          </p:txBody>
        </p:sp>
        <p:sp>
          <p:nvSpPr>
            <p:cNvPr id="887" name="tx82">
              <a:extLst>
                <a:ext uri="{FF2B5EF4-FFF2-40B4-BE49-F238E27FC236}">
                  <a16:creationId xmlns:a16="http://schemas.microsoft.com/office/drawing/2014/main" id="{78540002-CB31-394E-3CFA-FC1131E3B131}"/>
                </a:ext>
              </a:extLst>
            </p:cNvPr>
            <p:cNvSpPr/>
            <p:nvPr/>
          </p:nvSpPr>
          <p:spPr>
            <a:xfrm>
              <a:off x="637591" y="2849114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0</a:t>
              </a:r>
            </a:p>
          </p:txBody>
        </p:sp>
        <p:sp>
          <p:nvSpPr>
            <p:cNvPr id="888" name="tx83">
              <a:extLst>
                <a:ext uri="{FF2B5EF4-FFF2-40B4-BE49-F238E27FC236}">
                  <a16:creationId xmlns:a16="http://schemas.microsoft.com/office/drawing/2014/main" id="{22146EAD-0BD8-72C0-364E-5D7091D5BBE4}"/>
                </a:ext>
              </a:extLst>
            </p:cNvPr>
            <p:cNvSpPr/>
            <p:nvPr/>
          </p:nvSpPr>
          <p:spPr>
            <a:xfrm>
              <a:off x="637591" y="1559710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5</a:t>
              </a:r>
            </a:p>
          </p:txBody>
        </p:sp>
        <p:sp>
          <p:nvSpPr>
            <p:cNvPr id="889" name="pl84">
              <a:extLst>
                <a:ext uri="{FF2B5EF4-FFF2-40B4-BE49-F238E27FC236}">
                  <a16:creationId xmlns:a16="http://schemas.microsoft.com/office/drawing/2014/main" id="{EB17BBC0-6782-952D-EAA9-BB3A4BA152AF}"/>
                </a:ext>
              </a:extLst>
            </p:cNvPr>
            <p:cNvSpPr/>
            <p:nvPr/>
          </p:nvSpPr>
          <p:spPr>
            <a:xfrm>
              <a:off x="1137220" y="5541626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0" name="pl85">
              <a:extLst>
                <a:ext uri="{FF2B5EF4-FFF2-40B4-BE49-F238E27FC236}">
                  <a16:creationId xmlns:a16="http://schemas.microsoft.com/office/drawing/2014/main" id="{537C2FA8-4813-F771-3142-C85BC51C0A15}"/>
                </a:ext>
              </a:extLst>
            </p:cNvPr>
            <p:cNvSpPr/>
            <p:nvPr/>
          </p:nvSpPr>
          <p:spPr>
            <a:xfrm>
              <a:off x="1137220" y="4252222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1" name="pl86">
              <a:extLst>
                <a:ext uri="{FF2B5EF4-FFF2-40B4-BE49-F238E27FC236}">
                  <a16:creationId xmlns:a16="http://schemas.microsoft.com/office/drawing/2014/main" id="{EE71088F-6FEC-62D0-637E-2825382E7FFD}"/>
                </a:ext>
              </a:extLst>
            </p:cNvPr>
            <p:cNvSpPr/>
            <p:nvPr/>
          </p:nvSpPr>
          <p:spPr>
            <a:xfrm>
              <a:off x="1137220" y="2962818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2" name="pl87">
              <a:extLst>
                <a:ext uri="{FF2B5EF4-FFF2-40B4-BE49-F238E27FC236}">
                  <a16:creationId xmlns:a16="http://schemas.microsoft.com/office/drawing/2014/main" id="{A834E494-BCDF-C296-1314-C59845D1F335}"/>
                </a:ext>
              </a:extLst>
            </p:cNvPr>
            <p:cNvSpPr/>
            <p:nvPr/>
          </p:nvSpPr>
          <p:spPr>
            <a:xfrm>
              <a:off x="1137220" y="1673414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3" name="pl88">
              <a:extLst>
                <a:ext uri="{FF2B5EF4-FFF2-40B4-BE49-F238E27FC236}">
                  <a16:creationId xmlns:a16="http://schemas.microsoft.com/office/drawing/2014/main" id="{1605AD0C-A99B-5757-6ECF-5460D50E17B2}"/>
                </a:ext>
              </a:extLst>
            </p:cNvPr>
            <p:cNvSpPr/>
            <p:nvPr/>
          </p:nvSpPr>
          <p:spPr>
            <a:xfrm>
              <a:off x="1232114" y="5767272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4" name="pl89">
              <a:extLst>
                <a:ext uri="{FF2B5EF4-FFF2-40B4-BE49-F238E27FC236}">
                  <a16:creationId xmlns:a16="http://schemas.microsoft.com/office/drawing/2014/main" id="{744159DF-EC37-4ECC-33F8-75ECF3BEC0FD}"/>
                </a:ext>
              </a:extLst>
            </p:cNvPr>
            <p:cNvSpPr/>
            <p:nvPr/>
          </p:nvSpPr>
          <p:spPr>
            <a:xfrm>
              <a:off x="2224011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5" name="pl90">
              <a:extLst>
                <a:ext uri="{FF2B5EF4-FFF2-40B4-BE49-F238E27FC236}">
                  <a16:creationId xmlns:a16="http://schemas.microsoft.com/office/drawing/2014/main" id="{B81135CC-199B-F133-7746-7A9293390307}"/>
                </a:ext>
              </a:extLst>
            </p:cNvPr>
            <p:cNvSpPr/>
            <p:nvPr/>
          </p:nvSpPr>
          <p:spPr>
            <a:xfrm>
              <a:off x="3877172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6" name="pl91">
              <a:extLst>
                <a:ext uri="{FF2B5EF4-FFF2-40B4-BE49-F238E27FC236}">
                  <a16:creationId xmlns:a16="http://schemas.microsoft.com/office/drawing/2014/main" id="{23DADE81-7D2B-8BF8-D246-7A5F9B4BD3EA}"/>
                </a:ext>
              </a:extLst>
            </p:cNvPr>
            <p:cNvSpPr/>
            <p:nvPr/>
          </p:nvSpPr>
          <p:spPr>
            <a:xfrm>
              <a:off x="5530333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897" name="tx92">
              <a:extLst>
                <a:ext uri="{FF2B5EF4-FFF2-40B4-BE49-F238E27FC236}">
                  <a16:creationId xmlns:a16="http://schemas.microsoft.com/office/drawing/2014/main" id="{44BC1ED7-442E-20BA-6DDD-94DE0A56AAF1}"/>
                </a:ext>
              </a:extLst>
            </p:cNvPr>
            <p:cNvSpPr/>
            <p:nvPr/>
          </p:nvSpPr>
          <p:spPr>
            <a:xfrm>
              <a:off x="1741138" y="5930491"/>
              <a:ext cx="965745" cy="2257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G313R</a:t>
              </a:r>
            </a:p>
          </p:txBody>
        </p:sp>
        <p:sp>
          <p:nvSpPr>
            <p:cNvPr id="898" name="tx93">
              <a:extLst>
                <a:ext uri="{FF2B5EF4-FFF2-40B4-BE49-F238E27FC236}">
                  <a16:creationId xmlns:a16="http://schemas.microsoft.com/office/drawing/2014/main" id="{C8B17B38-720C-8FE1-F786-D7BA8C595E92}"/>
                </a:ext>
              </a:extLst>
            </p:cNvPr>
            <p:cNvSpPr/>
            <p:nvPr/>
          </p:nvSpPr>
          <p:spPr>
            <a:xfrm>
              <a:off x="3402782" y="5930640"/>
              <a:ext cx="948779" cy="2256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R400C</a:t>
              </a:r>
            </a:p>
          </p:txBody>
        </p:sp>
        <p:sp>
          <p:nvSpPr>
            <p:cNvPr id="899" name="tx94">
              <a:extLst>
                <a:ext uri="{FF2B5EF4-FFF2-40B4-BE49-F238E27FC236}">
                  <a16:creationId xmlns:a16="http://schemas.microsoft.com/office/drawing/2014/main" id="{7712632E-FFBB-FFFF-B56B-C73671692724}"/>
                </a:ext>
              </a:extLst>
            </p:cNvPr>
            <p:cNvSpPr/>
            <p:nvPr/>
          </p:nvSpPr>
          <p:spPr>
            <a:xfrm>
              <a:off x="5022159" y="5933468"/>
              <a:ext cx="1016347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R479W</a:t>
              </a:r>
            </a:p>
          </p:txBody>
        </p:sp>
        <p:sp>
          <p:nvSpPr>
            <p:cNvPr id="900" name="tx104">
              <a:extLst>
                <a:ext uri="{FF2B5EF4-FFF2-40B4-BE49-F238E27FC236}">
                  <a16:creationId xmlns:a16="http://schemas.microsoft.com/office/drawing/2014/main" id="{188940DE-AEA1-CB63-3E99-AFD87CEF5D10}"/>
                </a:ext>
              </a:extLst>
            </p:cNvPr>
            <p:cNvSpPr/>
            <p:nvPr/>
          </p:nvSpPr>
          <p:spPr>
            <a:xfrm>
              <a:off x="1137220" y="661427"/>
              <a:ext cx="5615657" cy="42906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3600"/>
                </a:lnSpc>
              </a:pPr>
              <a:r>
                <a:rPr lang="da-DK"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C) </a:t>
              </a: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VUS variants, assay control</a:t>
              </a:r>
            </a:p>
          </p:txBody>
        </p:sp>
      </p:grpSp>
      <p:grpSp>
        <p:nvGrpSpPr>
          <p:cNvPr id="901" name="Gruppe 900">
            <a:extLst>
              <a:ext uri="{FF2B5EF4-FFF2-40B4-BE49-F238E27FC236}">
                <a16:creationId xmlns:a16="http://schemas.microsoft.com/office/drawing/2014/main" id="{B1E2D1CE-867B-463D-45D0-EA5DD66C4F17}"/>
              </a:ext>
            </a:extLst>
          </p:cNvPr>
          <p:cNvGrpSpPr/>
          <p:nvPr/>
        </p:nvGrpSpPr>
        <p:grpSpPr>
          <a:xfrm>
            <a:off x="1243921" y="3853048"/>
            <a:ext cx="4908637" cy="2455563"/>
            <a:chOff x="637591" y="789313"/>
            <a:chExt cx="6438244" cy="5366950"/>
          </a:xfrm>
        </p:grpSpPr>
        <p:sp>
          <p:nvSpPr>
            <p:cNvPr id="902" name="rc5">
              <a:extLst>
                <a:ext uri="{FF2B5EF4-FFF2-40B4-BE49-F238E27FC236}">
                  <a16:creationId xmlns:a16="http://schemas.microsoft.com/office/drawing/2014/main" id="{E12E5FAF-A967-3CAD-4A80-3EE6822FE72C}"/>
                </a:ext>
              </a:extLst>
            </p:cNvPr>
            <p:cNvSpPr/>
            <p:nvPr/>
          </p:nvSpPr>
          <p:spPr>
            <a:xfrm>
              <a:off x="1232114" y="803067"/>
              <a:ext cx="5290116" cy="4964205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3" name="rc6">
              <a:extLst>
                <a:ext uri="{FF2B5EF4-FFF2-40B4-BE49-F238E27FC236}">
                  <a16:creationId xmlns:a16="http://schemas.microsoft.com/office/drawing/2014/main" id="{9BCA9959-F9AB-23A1-F3A7-218DDC9DE245}"/>
                </a:ext>
              </a:extLst>
            </p:cNvPr>
            <p:cNvSpPr/>
            <p:nvPr/>
          </p:nvSpPr>
          <p:spPr>
            <a:xfrm>
              <a:off x="1421046" y="2962818"/>
              <a:ext cx="377865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4" name="rc7">
              <a:extLst>
                <a:ext uri="{FF2B5EF4-FFF2-40B4-BE49-F238E27FC236}">
                  <a16:creationId xmlns:a16="http://schemas.microsoft.com/office/drawing/2014/main" id="{ED4878EE-04E0-B503-AC3B-292851F790F7}"/>
                </a:ext>
              </a:extLst>
            </p:cNvPr>
            <p:cNvSpPr/>
            <p:nvPr/>
          </p:nvSpPr>
          <p:spPr>
            <a:xfrm>
              <a:off x="1798912" y="4545009"/>
              <a:ext cx="377865" cy="996616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5" name="rc8">
              <a:extLst>
                <a:ext uri="{FF2B5EF4-FFF2-40B4-BE49-F238E27FC236}">
                  <a16:creationId xmlns:a16="http://schemas.microsoft.com/office/drawing/2014/main" id="{F2F421FC-1C6E-35A6-3EDC-F96046F37961}"/>
                </a:ext>
              </a:extLst>
            </p:cNvPr>
            <p:cNvSpPr/>
            <p:nvPr/>
          </p:nvSpPr>
          <p:spPr>
            <a:xfrm>
              <a:off x="2176777" y="4741070"/>
              <a:ext cx="377865" cy="800556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6" name="rc9">
              <a:extLst>
                <a:ext uri="{FF2B5EF4-FFF2-40B4-BE49-F238E27FC236}">
                  <a16:creationId xmlns:a16="http://schemas.microsoft.com/office/drawing/2014/main" id="{7EA70144-53D1-7243-FC81-32F1C872F85F}"/>
                </a:ext>
              </a:extLst>
            </p:cNvPr>
            <p:cNvSpPr/>
            <p:nvPr/>
          </p:nvSpPr>
          <p:spPr>
            <a:xfrm>
              <a:off x="2680598" y="2962818"/>
              <a:ext cx="377865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7" name="rc10">
              <a:extLst>
                <a:ext uri="{FF2B5EF4-FFF2-40B4-BE49-F238E27FC236}">
                  <a16:creationId xmlns:a16="http://schemas.microsoft.com/office/drawing/2014/main" id="{0959A694-FB49-84BD-7810-9BD225048132}"/>
                </a:ext>
              </a:extLst>
            </p:cNvPr>
            <p:cNvSpPr/>
            <p:nvPr/>
          </p:nvSpPr>
          <p:spPr>
            <a:xfrm>
              <a:off x="3058463" y="3539418"/>
              <a:ext cx="377865" cy="2002208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8" name="rc11">
              <a:extLst>
                <a:ext uri="{FF2B5EF4-FFF2-40B4-BE49-F238E27FC236}">
                  <a16:creationId xmlns:a16="http://schemas.microsoft.com/office/drawing/2014/main" id="{561CB5E3-77CF-23DB-5AA6-AF9735F9AA37}"/>
                </a:ext>
              </a:extLst>
            </p:cNvPr>
            <p:cNvSpPr/>
            <p:nvPr/>
          </p:nvSpPr>
          <p:spPr>
            <a:xfrm>
              <a:off x="3436329" y="3452157"/>
              <a:ext cx="377865" cy="2089469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09" name="rc12">
              <a:extLst>
                <a:ext uri="{FF2B5EF4-FFF2-40B4-BE49-F238E27FC236}">
                  <a16:creationId xmlns:a16="http://schemas.microsoft.com/office/drawing/2014/main" id="{58FE53DA-1E58-F49E-4FF6-C659E6B329A9}"/>
                </a:ext>
              </a:extLst>
            </p:cNvPr>
            <p:cNvSpPr/>
            <p:nvPr/>
          </p:nvSpPr>
          <p:spPr>
            <a:xfrm>
              <a:off x="3940149" y="2962818"/>
              <a:ext cx="377865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0" name="rc13">
              <a:extLst>
                <a:ext uri="{FF2B5EF4-FFF2-40B4-BE49-F238E27FC236}">
                  <a16:creationId xmlns:a16="http://schemas.microsoft.com/office/drawing/2014/main" id="{9751DB92-0776-CA10-E164-3F86D7661AD0}"/>
                </a:ext>
              </a:extLst>
            </p:cNvPr>
            <p:cNvSpPr/>
            <p:nvPr/>
          </p:nvSpPr>
          <p:spPr>
            <a:xfrm>
              <a:off x="4318015" y="3241049"/>
              <a:ext cx="377865" cy="2300577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1" name="rc14">
              <a:extLst>
                <a:ext uri="{FF2B5EF4-FFF2-40B4-BE49-F238E27FC236}">
                  <a16:creationId xmlns:a16="http://schemas.microsoft.com/office/drawing/2014/main" id="{D484AB33-7B8A-C7F3-5BCE-912EDC3FD296}"/>
                </a:ext>
              </a:extLst>
            </p:cNvPr>
            <p:cNvSpPr/>
            <p:nvPr/>
          </p:nvSpPr>
          <p:spPr>
            <a:xfrm>
              <a:off x="4695880" y="3671401"/>
              <a:ext cx="377865" cy="1870225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2" name="rc15">
              <a:extLst>
                <a:ext uri="{FF2B5EF4-FFF2-40B4-BE49-F238E27FC236}">
                  <a16:creationId xmlns:a16="http://schemas.microsoft.com/office/drawing/2014/main" id="{82DD0A19-32D5-75C7-D0B5-65C26BFE3E75}"/>
                </a:ext>
              </a:extLst>
            </p:cNvPr>
            <p:cNvSpPr/>
            <p:nvPr/>
          </p:nvSpPr>
          <p:spPr>
            <a:xfrm>
              <a:off x="5199701" y="2962818"/>
              <a:ext cx="377865" cy="2578808"/>
            </a:xfrm>
            <a:prstGeom prst="rect">
              <a:avLst/>
            </a:prstGeom>
            <a:solidFill>
              <a:srgbClr val="00468B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3" name="rc16">
              <a:extLst>
                <a:ext uri="{FF2B5EF4-FFF2-40B4-BE49-F238E27FC236}">
                  <a16:creationId xmlns:a16="http://schemas.microsoft.com/office/drawing/2014/main" id="{7FC29FA3-E87C-3308-8870-1DEC0ECFDF41}"/>
                </a:ext>
              </a:extLst>
            </p:cNvPr>
            <p:cNvSpPr/>
            <p:nvPr/>
          </p:nvSpPr>
          <p:spPr>
            <a:xfrm>
              <a:off x="5577566" y="5210511"/>
              <a:ext cx="377865" cy="331115"/>
            </a:xfrm>
            <a:prstGeom prst="rect">
              <a:avLst/>
            </a:prstGeom>
            <a:solidFill>
              <a:srgbClr val="ED0000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4" name="rc17">
              <a:extLst>
                <a:ext uri="{FF2B5EF4-FFF2-40B4-BE49-F238E27FC236}">
                  <a16:creationId xmlns:a16="http://schemas.microsoft.com/office/drawing/2014/main" id="{035FAA26-4028-4912-9C9D-813EAEE17EFE}"/>
                </a:ext>
              </a:extLst>
            </p:cNvPr>
            <p:cNvSpPr/>
            <p:nvPr/>
          </p:nvSpPr>
          <p:spPr>
            <a:xfrm>
              <a:off x="5955432" y="5240311"/>
              <a:ext cx="377865" cy="301314"/>
            </a:xfrm>
            <a:prstGeom prst="rect">
              <a:avLst/>
            </a:prstGeom>
            <a:solidFill>
              <a:srgbClr val="D3D3D3">
                <a:alpha val="100000"/>
              </a:srgbClr>
            </a:solidFill>
            <a:ln w="13550" cap="flat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5" name="pg18">
              <a:extLst>
                <a:ext uri="{FF2B5EF4-FFF2-40B4-BE49-F238E27FC236}">
                  <a16:creationId xmlns:a16="http://schemas.microsoft.com/office/drawing/2014/main" id="{EAB7E48A-55AC-F442-AE31-AED13244F4F4}"/>
                </a:ext>
              </a:extLst>
            </p:cNvPr>
            <p:cNvSpPr/>
            <p:nvPr/>
          </p:nvSpPr>
          <p:spPr>
            <a:xfrm>
              <a:off x="1949468" y="446841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6" name="pg19">
              <a:extLst>
                <a:ext uri="{FF2B5EF4-FFF2-40B4-BE49-F238E27FC236}">
                  <a16:creationId xmlns:a16="http://schemas.microsoft.com/office/drawing/2014/main" id="{9652C6F8-6D15-46FF-697A-52BE056E804A}"/>
                </a:ext>
              </a:extLst>
            </p:cNvPr>
            <p:cNvSpPr/>
            <p:nvPr/>
          </p:nvSpPr>
          <p:spPr>
            <a:xfrm>
              <a:off x="2327334" y="471178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7" name="pg20">
              <a:extLst>
                <a:ext uri="{FF2B5EF4-FFF2-40B4-BE49-F238E27FC236}">
                  <a16:creationId xmlns:a16="http://schemas.microsoft.com/office/drawing/2014/main" id="{87DD4A3F-8365-EB4D-9AC0-175F3D467DDE}"/>
                </a:ext>
              </a:extLst>
            </p:cNvPr>
            <p:cNvSpPr/>
            <p:nvPr/>
          </p:nvSpPr>
          <p:spPr>
            <a:xfrm>
              <a:off x="1949468" y="441873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8" name="pg21">
              <a:extLst>
                <a:ext uri="{FF2B5EF4-FFF2-40B4-BE49-F238E27FC236}">
                  <a16:creationId xmlns:a16="http://schemas.microsoft.com/office/drawing/2014/main" id="{3C9EC897-7226-8634-1A0A-14A70219A024}"/>
                </a:ext>
              </a:extLst>
            </p:cNvPr>
            <p:cNvSpPr/>
            <p:nvPr/>
          </p:nvSpPr>
          <p:spPr>
            <a:xfrm>
              <a:off x="2327334" y="460239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19" name="pg22">
              <a:extLst>
                <a:ext uri="{FF2B5EF4-FFF2-40B4-BE49-F238E27FC236}">
                  <a16:creationId xmlns:a16="http://schemas.microsoft.com/office/drawing/2014/main" id="{859F4B59-04B2-3016-4D30-F7CBDBE6AE8A}"/>
                </a:ext>
              </a:extLst>
            </p:cNvPr>
            <p:cNvSpPr/>
            <p:nvPr/>
          </p:nvSpPr>
          <p:spPr>
            <a:xfrm>
              <a:off x="1949468" y="463274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0" name="pg23">
              <a:extLst>
                <a:ext uri="{FF2B5EF4-FFF2-40B4-BE49-F238E27FC236}">
                  <a16:creationId xmlns:a16="http://schemas.microsoft.com/office/drawing/2014/main" id="{E20C9DD2-F57A-9A02-71C2-01F56DFDB0AC}"/>
                </a:ext>
              </a:extLst>
            </p:cNvPr>
            <p:cNvSpPr/>
            <p:nvPr/>
          </p:nvSpPr>
          <p:spPr>
            <a:xfrm>
              <a:off x="2327334" y="479390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1" name="pg24">
              <a:extLst>
                <a:ext uri="{FF2B5EF4-FFF2-40B4-BE49-F238E27FC236}">
                  <a16:creationId xmlns:a16="http://schemas.microsoft.com/office/drawing/2014/main" id="{5E780734-8493-9BBF-A3B4-19B42052D3F5}"/>
                </a:ext>
              </a:extLst>
            </p:cNvPr>
            <p:cNvSpPr/>
            <p:nvPr/>
          </p:nvSpPr>
          <p:spPr>
            <a:xfrm>
              <a:off x="1571603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2" name="pg25">
              <a:extLst>
                <a:ext uri="{FF2B5EF4-FFF2-40B4-BE49-F238E27FC236}">
                  <a16:creationId xmlns:a16="http://schemas.microsoft.com/office/drawing/2014/main" id="{6690DE75-5752-E743-5A72-D758CCD9AF34}"/>
                </a:ext>
              </a:extLst>
            </p:cNvPr>
            <p:cNvSpPr/>
            <p:nvPr/>
          </p:nvSpPr>
          <p:spPr>
            <a:xfrm>
              <a:off x="1571603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3" name="pg26">
              <a:extLst>
                <a:ext uri="{FF2B5EF4-FFF2-40B4-BE49-F238E27FC236}">
                  <a16:creationId xmlns:a16="http://schemas.microsoft.com/office/drawing/2014/main" id="{46F5F5E7-DDEB-D054-8CF4-CBA7D7E0089C}"/>
                </a:ext>
              </a:extLst>
            </p:cNvPr>
            <p:cNvSpPr/>
            <p:nvPr/>
          </p:nvSpPr>
          <p:spPr>
            <a:xfrm>
              <a:off x="1571603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4" name="pg27">
              <a:extLst>
                <a:ext uri="{FF2B5EF4-FFF2-40B4-BE49-F238E27FC236}">
                  <a16:creationId xmlns:a16="http://schemas.microsoft.com/office/drawing/2014/main" id="{7C155D5E-6B6C-F850-AE64-F20F7C22481F}"/>
                </a:ext>
              </a:extLst>
            </p:cNvPr>
            <p:cNvSpPr/>
            <p:nvPr/>
          </p:nvSpPr>
          <p:spPr>
            <a:xfrm>
              <a:off x="3209020" y="407509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5" name="pg28">
              <a:extLst>
                <a:ext uri="{FF2B5EF4-FFF2-40B4-BE49-F238E27FC236}">
                  <a16:creationId xmlns:a16="http://schemas.microsoft.com/office/drawing/2014/main" id="{8FB74AB2-57C5-919F-2210-952466826C5D}"/>
                </a:ext>
              </a:extLst>
            </p:cNvPr>
            <p:cNvSpPr/>
            <p:nvPr/>
          </p:nvSpPr>
          <p:spPr>
            <a:xfrm>
              <a:off x="2831154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6" name="pg29">
              <a:extLst>
                <a:ext uri="{FF2B5EF4-FFF2-40B4-BE49-F238E27FC236}">
                  <a16:creationId xmlns:a16="http://schemas.microsoft.com/office/drawing/2014/main" id="{F0FB54FC-9130-94B9-5FFA-808E1A102AB6}"/>
                </a:ext>
              </a:extLst>
            </p:cNvPr>
            <p:cNvSpPr/>
            <p:nvPr/>
          </p:nvSpPr>
          <p:spPr>
            <a:xfrm>
              <a:off x="3209020" y="331887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7" name="pg30">
              <a:extLst>
                <a:ext uri="{FF2B5EF4-FFF2-40B4-BE49-F238E27FC236}">
                  <a16:creationId xmlns:a16="http://schemas.microsoft.com/office/drawing/2014/main" id="{F54556C8-EA80-EDCA-CC29-FC269D3A2F98}"/>
                </a:ext>
              </a:extLst>
            </p:cNvPr>
            <p:cNvSpPr/>
            <p:nvPr/>
          </p:nvSpPr>
          <p:spPr>
            <a:xfrm>
              <a:off x="2831154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8" name="pg31">
              <a:extLst>
                <a:ext uri="{FF2B5EF4-FFF2-40B4-BE49-F238E27FC236}">
                  <a16:creationId xmlns:a16="http://schemas.microsoft.com/office/drawing/2014/main" id="{BADEE4CE-5BA0-8D42-7649-1665BB05DA17}"/>
                </a:ext>
              </a:extLst>
            </p:cNvPr>
            <p:cNvSpPr/>
            <p:nvPr/>
          </p:nvSpPr>
          <p:spPr>
            <a:xfrm>
              <a:off x="3209020" y="310915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29" name="pg32">
              <a:extLst>
                <a:ext uri="{FF2B5EF4-FFF2-40B4-BE49-F238E27FC236}">
                  <a16:creationId xmlns:a16="http://schemas.microsoft.com/office/drawing/2014/main" id="{BBE5C58E-8702-E8CB-7698-5A3B444DC2EF}"/>
                </a:ext>
              </a:extLst>
            </p:cNvPr>
            <p:cNvSpPr/>
            <p:nvPr/>
          </p:nvSpPr>
          <p:spPr>
            <a:xfrm>
              <a:off x="2831154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0" name="pg33">
              <a:extLst>
                <a:ext uri="{FF2B5EF4-FFF2-40B4-BE49-F238E27FC236}">
                  <a16:creationId xmlns:a16="http://schemas.microsoft.com/office/drawing/2014/main" id="{57424FC6-92B5-01FE-0F71-3C51940D6DDB}"/>
                </a:ext>
              </a:extLst>
            </p:cNvPr>
            <p:cNvSpPr/>
            <p:nvPr/>
          </p:nvSpPr>
          <p:spPr>
            <a:xfrm>
              <a:off x="3586885" y="387980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1" name="pg34">
              <a:extLst>
                <a:ext uri="{FF2B5EF4-FFF2-40B4-BE49-F238E27FC236}">
                  <a16:creationId xmlns:a16="http://schemas.microsoft.com/office/drawing/2014/main" id="{5CFE7110-D58E-8466-4D72-AB8AF317F942}"/>
                </a:ext>
              </a:extLst>
            </p:cNvPr>
            <p:cNvSpPr/>
            <p:nvPr/>
          </p:nvSpPr>
          <p:spPr>
            <a:xfrm>
              <a:off x="3586885" y="303180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2" name="pg35">
              <a:extLst>
                <a:ext uri="{FF2B5EF4-FFF2-40B4-BE49-F238E27FC236}">
                  <a16:creationId xmlns:a16="http://schemas.microsoft.com/office/drawing/2014/main" id="{FA39F8CB-EC9D-A0E3-D3CF-C291D62E15A7}"/>
                </a:ext>
              </a:extLst>
            </p:cNvPr>
            <p:cNvSpPr/>
            <p:nvPr/>
          </p:nvSpPr>
          <p:spPr>
            <a:xfrm>
              <a:off x="3586885" y="332972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3" name="pg36">
              <a:extLst>
                <a:ext uri="{FF2B5EF4-FFF2-40B4-BE49-F238E27FC236}">
                  <a16:creationId xmlns:a16="http://schemas.microsoft.com/office/drawing/2014/main" id="{25D823E4-C6FE-11E9-AA55-F07167A862BA}"/>
                </a:ext>
              </a:extLst>
            </p:cNvPr>
            <p:cNvSpPr/>
            <p:nvPr/>
          </p:nvSpPr>
          <p:spPr>
            <a:xfrm>
              <a:off x="4468571" y="391111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4" name="pg37">
              <a:extLst>
                <a:ext uri="{FF2B5EF4-FFF2-40B4-BE49-F238E27FC236}">
                  <a16:creationId xmlns:a16="http://schemas.microsoft.com/office/drawing/2014/main" id="{9ADA8E87-4B45-8DFF-F10C-293D7D34377B}"/>
                </a:ext>
              </a:extLst>
            </p:cNvPr>
            <p:cNvSpPr/>
            <p:nvPr/>
          </p:nvSpPr>
          <p:spPr>
            <a:xfrm>
              <a:off x="4846436" y="3537108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5" name="pg38">
              <a:extLst>
                <a:ext uri="{FF2B5EF4-FFF2-40B4-BE49-F238E27FC236}">
                  <a16:creationId xmlns:a16="http://schemas.microsoft.com/office/drawing/2014/main" id="{0BAC7084-2587-8358-B485-42B4A5E1F3B2}"/>
                </a:ext>
              </a:extLst>
            </p:cNvPr>
            <p:cNvSpPr/>
            <p:nvPr/>
          </p:nvSpPr>
          <p:spPr>
            <a:xfrm>
              <a:off x="4468571" y="1963509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6" name="pg39">
              <a:extLst>
                <a:ext uri="{FF2B5EF4-FFF2-40B4-BE49-F238E27FC236}">
                  <a16:creationId xmlns:a16="http://schemas.microsoft.com/office/drawing/2014/main" id="{F4FBD28D-B4B7-C87B-E4A2-5DF3ACE2CDE6}"/>
                </a:ext>
              </a:extLst>
            </p:cNvPr>
            <p:cNvSpPr/>
            <p:nvPr/>
          </p:nvSpPr>
          <p:spPr>
            <a:xfrm>
              <a:off x="4846436" y="3482140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7" name="pg40">
              <a:extLst>
                <a:ext uri="{FF2B5EF4-FFF2-40B4-BE49-F238E27FC236}">
                  <a16:creationId xmlns:a16="http://schemas.microsoft.com/office/drawing/2014/main" id="{F2692AAC-B06B-8C5D-A166-05F39A63B935}"/>
                </a:ext>
              </a:extLst>
            </p:cNvPr>
            <p:cNvSpPr/>
            <p:nvPr/>
          </p:nvSpPr>
          <p:spPr>
            <a:xfrm>
              <a:off x="4468571" y="373339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8" name="pg41">
              <a:extLst>
                <a:ext uri="{FF2B5EF4-FFF2-40B4-BE49-F238E27FC236}">
                  <a16:creationId xmlns:a16="http://schemas.microsoft.com/office/drawing/2014/main" id="{A9FF2167-2E61-82F5-7C21-A5A6A0D29872}"/>
                </a:ext>
              </a:extLst>
            </p:cNvPr>
            <p:cNvSpPr/>
            <p:nvPr/>
          </p:nvSpPr>
          <p:spPr>
            <a:xfrm>
              <a:off x="4846436" y="3879825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39" name="pg42">
              <a:extLst>
                <a:ext uri="{FF2B5EF4-FFF2-40B4-BE49-F238E27FC236}">
                  <a16:creationId xmlns:a16="http://schemas.microsoft.com/office/drawing/2014/main" id="{5234EF8D-6407-9CE4-DC86-9280162BE596}"/>
                </a:ext>
              </a:extLst>
            </p:cNvPr>
            <p:cNvSpPr/>
            <p:nvPr/>
          </p:nvSpPr>
          <p:spPr>
            <a:xfrm>
              <a:off x="409070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0" name="pg43">
              <a:extLst>
                <a:ext uri="{FF2B5EF4-FFF2-40B4-BE49-F238E27FC236}">
                  <a16:creationId xmlns:a16="http://schemas.microsoft.com/office/drawing/2014/main" id="{700CE309-70C7-52FF-DF69-50FA0437BB11}"/>
                </a:ext>
              </a:extLst>
            </p:cNvPr>
            <p:cNvSpPr/>
            <p:nvPr/>
          </p:nvSpPr>
          <p:spPr>
            <a:xfrm>
              <a:off x="409070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1" name="pg44">
              <a:extLst>
                <a:ext uri="{FF2B5EF4-FFF2-40B4-BE49-F238E27FC236}">
                  <a16:creationId xmlns:a16="http://schemas.microsoft.com/office/drawing/2014/main" id="{BAB598B8-5919-A641-82C8-83A3CE709A01}"/>
                </a:ext>
              </a:extLst>
            </p:cNvPr>
            <p:cNvSpPr/>
            <p:nvPr/>
          </p:nvSpPr>
          <p:spPr>
            <a:xfrm>
              <a:off x="4090706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2" name="pg45">
              <a:extLst>
                <a:ext uri="{FF2B5EF4-FFF2-40B4-BE49-F238E27FC236}">
                  <a16:creationId xmlns:a16="http://schemas.microsoft.com/office/drawing/2014/main" id="{38CC8D01-40D1-4F4B-5392-B6A753F11142}"/>
                </a:ext>
              </a:extLst>
            </p:cNvPr>
            <p:cNvSpPr/>
            <p:nvPr/>
          </p:nvSpPr>
          <p:spPr>
            <a:xfrm>
              <a:off x="6105988" y="520679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3" name="pg46">
              <a:extLst>
                <a:ext uri="{FF2B5EF4-FFF2-40B4-BE49-F238E27FC236}">
                  <a16:creationId xmlns:a16="http://schemas.microsoft.com/office/drawing/2014/main" id="{4168268B-F817-0011-ACC9-76C7AA145FE5}"/>
                </a:ext>
              </a:extLst>
            </p:cNvPr>
            <p:cNvSpPr/>
            <p:nvPr/>
          </p:nvSpPr>
          <p:spPr>
            <a:xfrm>
              <a:off x="5728122" y="5141771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4" name="pg47">
              <a:extLst>
                <a:ext uri="{FF2B5EF4-FFF2-40B4-BE49-F238E27FC236}">
                  <a16:creationId xmlns:a16="http://schemas.microsoft.com/office/drawing/2014/main" id="{ECDC311A-9FC0-5365-75C0-6F2E6A67DAFF}"/>
                </a:ext>
              </a:extLst>
            </p:cNvPr>
            <p:cNvSpPr/>
            <p:nvPr/>
          </p:nvSpPr>
          <p:spPr>
            <a:xfrm>
              <a:off x="6105988" y="5135866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5" name="pg48">
              <a:extLst>
                <a:ext uri="{FF2B5EF4-FFF2-40B4-BE49-F238E27FC236}">
                  <a16:creationId xmlns:a16="http://schemas.microsoft.com/office/drawing/2014/main" id="{FA4E3654-0C50-94D0-5F8B-BE3A0BD81C40}"/>
                </a:ext>
              </a:extLst>
            </p:cNvPr>
            <p:cNvSpPr/>
            <p:nvPr/>
          </p:nvSpPr>
          <p:spPr>
            <a:xfrm>
              <a:off x="5728122" y="5202497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6" name="pg49">
              <a:extLst>
                <a:ext uri="{FF2B5EF4-FFF2-40B4-BE49-F238E27FC236}">
                  <a16:creationId xmlns:a16="http://schemas.microsoft.com/office/drawing/2014/main" id="{D53C19F1-3B5A-CF7D-179F-500A57496A2B}"/>
                </a:ext>
              </a:extLst>
            </p:cNvPr>
            <p:cNvSpPr/>
            <p:nvPr/>
          </p:nvSpPr>
          <p:spPr>
            <a:xfrm>
              <a:off x="6105988" y="5263143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7" name="pg50">
              <a:extLst>
                <a:ext uri="{FF2B5EF4-FFF2-40B4-BE49-F238E27FC236}">
                  <a16:creationId xmlns:a16="http://schemas.microsoft.com/office/drawing/2014/main" id="{E0D5C372-1C65-2268-CD41-E5FC1DB1973A}"/>
                </a:ext>
              </a:extLst>
            </p:cNvPr>
            <p:cNvSpPr/>
            <p:nvPr/>
          </p:nvSpPr>
          <p:spPr>
            <a:xfrm>
              <a:off x="535025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8" name="pg51">
              <a:extLst>
                <a:ext uri="{FF2B5EF4-FFF2-40B4-BE49-F238E27FC236}">
                  <a16:creationId xmlns:a16="http://schemas.microsoft.com/office/drawing/2014/main" id="{7E90DDE8-D7A3-69DA-1A91-733F0EF89DE9}"/>
                </a:ext>
              </a:extLst>
            </p:cNvPr>
            <p:cNvSpPr/>
            <p:nvPr/>
          </p:nvSpPr>
          <p:spPr>
            <a:xfrm>
              <a:off x="535025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49" name="pg52">
              <a:extLst>
                <a:ext uri="{FF2B5EF4-FFF2-40B4-BE49-F238E27FC236}">
                  <a16:creationId xmlns:a16="http://schemas.microsoft.com/office/drawing/2014/main" id="{24DA443B-7463-51AA-70B9-C5EDF87C2CE4}"/>
                </a:ext>
              </a:extLst>
            </p:cNvPr>
            <p:cNvSpPr/>
            <p:nvPr/>
          </p:nvSpPr>
          <p:spPr>
            <a:xfrm>
              <a:off x="5350257" y="2924442"/>
              <a:ext cx="76753" cy="76753"/>
            </a:xfrm>
            <a:custGeom>
              <a:avLst/>
              <a:gdLst/>
              <a:ahLst/>
              <a:cxnLst/>
              <a:rect l="0" t="0" r="0" b="0"/>
              <a:pathLst>
                <a:path w="76753" h="76753">
                  <a:moveTo>
                    <a:pt x="0" y="76753"/>
                  </a:moveTo>
                  <a:lnTo>
                    <a:pt x="76753" y="76753"/>
                  </a:lnTo>
                  <a:lnTo>
                    <a:pt x="76753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0" name="pl53">
              <a:extLst>
                <a:ext uri="{FF2B5EF4-FFF2-40B4-BE49-F238E27FC236}">
                  <a16:creationId xmlns:a16="http://schemas.microsoft.com/office/drawing/2014/main" id="{F3AE1445-FF18-722F-1BD2-B450FF828513}"/>
                </a:ext>
              </a:extLst>
            </p:cNvPr>
            <p:cNvSpPr/>
            <p:nvPr/>
          </p:nvSpPr>
          <p:spPr>
            <a:xfrm>
              <a:off x="1547002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1" name="pl54">
              <a:extLst>
                <a:ext uri="{FF2B5EF4-FFF2-40B4-BE49-F238E27FC236}">
                  <a16:creationId xmlns:a16="http://schemas.microsoft.com/office/drawing/2014/main" id="{8DA279B7-5F5A-772F-8948-6D8809DD4A75}"/>
                </a:ext>
              </a:extLst>
            </p:cNvPr>
            <p:cNvSpPr/>
            <p:nvPr/>
          </p:nvSpPr>
          <p:spPr>
            <a:xfrm>
              <a:off x="1609979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2" name="pl55">
              <a:extLst>
                <a:ext uri="{FF2B5EF4-FFF2-40B4-BE49-F238E27FC236}">
                  <a16:creationId xmlns:a16="http://schemas.microsoft.com/office/drawing/2014/main" id="{83A55A0F-46F5-E411-6E97-9837CD823AD3}"/>
                </a:ext>
              </a:extLst>
            </p:cNvPr>
            <p:cNvSpPr/>
            <p:nvPr/>
          </p:nvSpPr>
          <p:spPr>
            <a:xfrm>
              <a:off x="1547002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3" name="pl56">
              <a:extLst>
                <a:ext uri="{FF2B5EF4-FFF2-40B4-BE49-F238E27FC236}">
                  <a16:creationId xmlns:a16="http://schemas.microsoft.com/office/drawing/2014/main" id="{F8C04900-998C-E1EF-DC2C-893277D8263E}"/>
                </a:ext>
              </a:extLst>
            </p:cNvPr>
            <p:cNvSpPr/>
            <p:nvPr/>
          </p:nvSpPr>
          <p:spPr>
            <a:xfrm>
              <a:off x="1924867" y="4433001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4" name="pl57">
              <a:extLst>
                <a:ext uri="{FF2B5EF4-FFF2-40B4-BE49-F238E27FC236}">
                  <a16:creationId xmlns:a16="http://schemas.microsoft.com/office/drawing/2014/main" id="{63B54825-F3D7-5B4B-0FA1-2E2F113B9475}"/>
                </a:ext>
              </a:extLst>
            </p:cNvPr>
            <p:cNvSpPr/>
            <p:nvPr/>
          </p:nvSpPr>
          <p:spPr>
            <a:xfrm>
              <a:off x="1987845" y="4433001"/>
              <a:ext cx="0" cy="224016"/>
            </a:xfrm>
            <a:custGeom>
              <a:avLst/>
              <a:gdLst/>
              <a:ahLst/>
              <a:cxnLst/>
              <a:rect l="0" t="0" r="0" b="0"/>
              <a:pathLst>
                <a:path h="224016">
                  <a:moveTo>
                    <a:pt x="0" y="0"/>
                  </a:moveTo>
                  <a:lnTo>
                    <a:pt x="0" y="22401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5" name="pl58">
              <a:extLst>
                <a:ext uri="{FF2B5EF4-FFF2-40B4-BE49-F238E27FC236}">
                  <a16:creationId xmlns:a16="http://schemas.microsoft.com/office/drawing/2014/main" id="{5556A2EC-3FF0-6132-74B2-B31EF9E8B6D4}"/>
                </a:ext>
              </a:extLst>
            </p:cNvPr>
            <p:cNvSpPr/>
            <p:nvPr/>
          </p:nvSpPr>
          <p:spPr>
            <a:xfrm>
              <a:off x="1924867" y="46570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6" name="pl59">
              <a:extLst>
                <a:ext uri="{FF2B5EF4-FFF2-40B4-BE49-F238E27FC236}">
                  <a16:creationId xmlns:a16="http://schemas.microsoft.com/office/drawing/2014/main" id="{7F0AE2CD-3FDB-5923-9452-926453AE925C}"/>
                </a:ext>
              </a:extLst>
            </p:cNvPr>
            <p:cNvSpPr/>
            <p:nvPr/>
          </p:nvSpPr>
          <p:spPr>
            <a:xfrm>
              <a:off x="2302733" y="4644989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7" name="pl60">
              <a:extLst>
                <a:ext uri="{FF2B5EF4-FFF2-40B4-BE49-F238E27FC236}">
                  <a16:creationId xmlns:a16="http://schemas.microsoft.com/office/drawing/2014/main" id="{60265557-6ED0-7B3E-8977-481C11FA2EBF}"/>
                </a:ext>
              </a:extLst>
            </p:cNvPr>
            <p:cNvSpPr/>
            <p:nvPr/>
          </p:nvSpPr>
          <p:spPr>
            <a:xfrm>
              <a:off x="2365710" y="4644989"/>
              <a:ext cx="0" cy="192162"/>
            </a:xfrm>
            <a:custGeom>
              <a:avLst/>
              <a:gdLst/>
              <a:ahLst/>
              <a:cxnLst/>
              <a:rect l="0" t="0" r="0" b="0"/>
              <a:pathLst>
                <a:path h="192162">
                  <a:moveTo>
                    <a:pt x="0" y="0"/>
                  </a:moveTo>
                  <a:lnTo>
                    <a:pt x="0" y="19216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8" name="pl61">
              <a:extLst>
                <a:ext uri="{FF2B5EF4-FFF2-40B4-BE49-F238E27FC236}">
                  <a16:creationId xmlns:a16="http://schemas.microsoft.com/office/drawing/2014/main" id="{28975DA9-3D39-1066-90F5-C2F00674795B}"/>
                </a:ext>
              </a:extLst>
            </p:cNvPr>
            <p:cNvSpPr/>
            <p:nvPr/>
          </p:nvSpPr>
          <p:spPr>
            <a:xfrm>
              <a:off x="2302733" y="4837151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59" name="pl62">
              <a:extLst>
                <a:ext uri="{FF2B5EF4-FFF2-40B4-BE49-F238E27FC236}">
                  <a16:creationId xmlns:a16="http://schemas.microsoft.com/office/drawing/2014/main" id="{98F2520B-8A6F-C101-0268-B9E56AFD3907}"/>
                </a:ext>
              </a:extLst>
            </p:cNvPr>
            <p:cNvSpPr/>
            <p:nvPr/>
          </p:nvSpPr>
          <p:spPr>
            <a:xfrm>
              <a:off x="2806553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0" name="pl63">
              <a:extLst>
                <a:ext uri="{FF2B5EF4-FFF2-40B4-BE49-F238E27FC236}">
                  <a16:creationId xmlns:a16="http://schemas.microsoft.com/office/drawing/2014/main" id="{7161B705-552A-7DB1-086D-23AA950BD988}"/>
                </a:ext>
              </a:extLst>
            </p:cNvPr>
            <p:cNvSpPr/>
            <p:nvPr/>
          </p:nvSpPr>
          <p:spPr>
            <a:xfrm>
              <a:off x="2869531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1" name="pl64">
              <a:extLst>
                <a:ext uri="{FF2B5EF4-FFF2-40B4-BE49-F238E27FC236}">
                  <a16:creationId xmlns:a16="http://schemas.microsoft.com/office/drawing/2014/main" id="{ECC6A0D8-2DCA-2F9C-A3E2-C23AFA3ACBFC}"/>
                </a:ext>
              </a:extLst>
            </p:cNvPr>
            <p:cNvSpPr/>
            <p:nvPr/>
          </p:nvSpPr>
          <p:spPr>
            <a:xfrm>
              <a:off x="2806553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2" name="pl65">
              <a:extLst>
                <a:ext uri="{FF2B5EF4-FFF2-40B4-BE49-F238E27FC236}">
                  <a16:creationId xmlns:a16="http://schemas.microsoft.com/office/drawing/2014/main" id="{D3871A0A-BFAC-E313-9477-DD29B4D4CAE8}"/>
                </a:ext>
              </a:extLst>
            </p:cNvPr>
            <p:cNvSpPr/>
            <p:nvPr/>
          </p:nvSpPr>
          <p:spPr>
            <a:xfrm>
              <a:off x="3184419" y="3031335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3" name="pl66">
              <a:extLst>
                <a:ext uri="{FF2B5EF4-FFF2-40B4-BE49-F238E27FC236}">
                  <a16:creationId xmlns:a16="http://schemas.microsoft.com/office/drawing/2014/main" id="{B051F84D-B2D4-0F2E-6D4E-E540ECA60BF8}"/>
                </a:ext>
              </a:extLst>
            </p:cNvPr>
            <p:cNvSpPr/>
            <p:nvPr/>
          </p:nvSpPr>
          <p:spPr>
            <a:xfrm>
              <a:off x="3247396" y="3031335"/>
              <a:ext cx="0" cy="1016165"/>
            </a:xfrm>
            <a:custGeom>
              <a:avLst/>
              <a:gdLst/>
              <a:ahLst/>
              <a:cxnLst/>
              <a:rect l="0" t="0" r="0" b="0"/>
              <a:pathLst>
                <a:path h="1016165">
                  <a:moveTo>
                    <a:pt x="0" y="0"/>
                  </a:moveTo>
                  <a:lnTo>
                    <a:pt x="0" y="10161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4" name="pl67">
              <a:extLst>
                <a:ext uri="{FF2B5EF4-FFF2-40B4-BE49-F238E27FC236}">
                  <a16:creationId xmlns:a16="http://schemas.microsoft.com/office/drawing/2014/main" id="{A1BD7EDE-4025-2381-F6A9-F3B37860C9DF}"/>
                </a:ext>
              </a:extLst>
            </p:cNvPr>
            <p:cNvSpPr/>
            <p:nvPr/>
          </p:nvSpPr>
          <p:spPr>
            <a:xfrm>
              <a:off x="3184419" y="4047500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5" name="pl68">
              <a:extLst>
                <a:ext uri="{FF2B5EF4-FFF2-40B4-BE49-F238E27FC236}">
                  <a16:creationId xmlns:a16="http://schemas.microsoft.com/office/drawing/2014/main" id="{F711FFE1-3293-3CDB-69A5-ED6A2E6ADF7E}"/>
                </a:ext>
              </a:extLst>
            </p:cNvPr>
            <p:cNvSpPr/>
            <p:nvPr/>
          </p:nvSpPr>
          <p:spPr>
            <a:xfrm>
              <a:off x="3562284" y="3021954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6" name="pl69">
              <a:extLst>
                <a:ext uri="{FF2B5EF4-FFF2-40B4-BE49-F238E27FC236}">
                  <a16:creationId xmlns:a16="http://schemas.microsoft.com/office/drawing/2014/main" id="{9320842A-7E4B-7B6F-1290-CB3EEF7E9A5C}"/>
                </a:ext>
              </a:extLst>
            </p:cNvPr>
            <p:cNvSpPr/>
            <p:nvPr/>
          </p:nvSpPr>
          <p:spPr>
            <a:xfrm>
              <a:off x="3625262" y="3021954"/>
              <a:ext cx="0" cy="860404"/>
            </a:xfrm>
            <a:custGeom>
              <a:avLst/>
              <a:gdLst/>
              <a:ahLst/>
              <a:cxnLst/>
              <a:rect l="0" t="0" r="0" b="0"/>
              <a:pathLst>
                <a:path h="860404">
                  <a:moveTo>
                    <a:pt x="0" y="0"/>
                  </a:moveTo>
                  <a:lnTo>
                    <a:pt x="0" y="86040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7" name="pl70">
              <a:extLst>
                <a:ext uri="{FF2B5EF4-FFF2-40B4-BE49-F238E27FC236}">
                  <a16:creationId xmlns:a16="http://schemas.microsoft.com/office/drawing/2014/main" id="{AF8D9463-7BB8-DAF6-F5FB-4C17C62A4D54}"/>
                </a:ext>
              </a:extLst>
            </p:cNvPr>
            <p:cNvSpPr/>
            <p:nvPr/>
          </p:nvSpPr>
          <p:spPr>
            <a:xfrm>
              <a:off x="3562284" y="3882359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8" name="pl71">
              <a:extLst>
                <a:ext uri="{FF2B5EF4-FFF2-40B4-BE49-F238E27FC236}">
                  <a16:creationId xmlns:a16="http://schemas.microsoft.com/office/drawing/2014/main" id="{EF1C5ED4-D06E-2E11-A4D9-486997076FC6}"/>
                </a:ext>
              </a:extLst>
            </p:cNvPr>
            <p:cNvSpPr/>
            <p:nvPr/>
          </p:nvSpPr>
          <p:spPr>
            <a:xfrm>
              <a:off x="4066105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69" name="pl72">
              <a:extLst>
                <a:ext uri="{FF2B5EF4-FFF2-40B4-BE49-F238E27FC236}">
                  <a16:creationId xmlns:a16="http://schemas.microsoft.com/office/drawing/2014/main" id="{26DFDC4F-8345-D1D3-7394-114845AAC972}"/>
                </a:ext>
              </a:extLst>
            </p:cNvPr>
            <p:cNvSpPr/>
            <p:nvPr/>
          </p:nvSpPr>
          <p:spPr>
            <a:xfrm>
              <a:off x="4129082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0" name="pl73">
              <a:extLst>
                <a:ext uri="{FF2B5EF4-FFF2-40B4-BE49-F238E27FC236}">
                  <a16:creationId xmlns:a16="http://schemas.microsoft.com/office/drawing/2014/main" id="{9E49B0B9-C62E-0194-B0C9-9A7EFFC9B464}"/>
                </a:ext>
              </a:extLst>
            </p:cNvPr>
            <p:cNvSpPr/>
            <p:nvPr/>
          </p:nvSpPr>
          <p:spPr>
            <a:xfrm>
              <a:off x="4066105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1" name="pl74">
              <a:extLst>
                <a:ext uri="{FF2B5EF4-FFF2-40B4-BE49-F238E27FC236}">
                  <a16:creationId xmlns:a16="http://schemas.microsoft.com/office/drawing/2014/main" id="{58CECD09-4439-C153-0459-B51F17C57273}"/>
                </a:ext>
              </a:extLst>
            </p:cNvPr>
            <p:cNvSpPr/>
            <p:nvPr/>
          </p:nvSpPr>
          <p:spPr>
            <a:xfrm>
              <a:off x="4443970" y="2164229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2" name="pl75">
              <a:extLst>
                <a:ext uri="{FF2B5EF4-FFF2-40B4-BE49-F238E27FC236}">
                  <a16:creationId xmlns:a16="http://schemas.microsoft.com/office/drawing/2014/main" id="{542FDE27-C2FC-88BD-7BA1-0413373A4204}"/>
                </a:ext>
              </a:extLst>
            </p:cNvPr>
            <p:cNvSpPr/>
            <p:nvPr/>
          </p:nvSpPr>
          <p:spPr>
            <a:xfrm>
              <a:off x="4506948" y="2164229"/>
              <a:ext cx="0" cy="2153639"/>
            </a:xfrm>
            <a:custGeom>
              <a:avLst/>
              <a:gdLst/>
              <a:ahLst/>
              <a:cxnLst/>
              <a:rect l="0" t="0" r="0" b="0"/>
              <a:pathLst>
                <a:path h="2153639">
                  <a:moveTo>
                    <a:pt x="0" y="0"/>
                  </a:moveTo>
                  <a:lnTo>
                    <a:pt x="0" y="215363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3" name="pl76">
              <a:extLst>
                <a:ext uri="{FF2B5EF4-FFF2-40B4-BE49-F238E27FC236}">
                  <a16:creationId xmlns:a16="http://schemas.microsoft.com/office/drawing/2014/main" id="{615A9B1C-7FC0-D419-D028-6993E3AA8503}"/>
                </a:ext>
              </a:extLst>
            </p:cNvPr>
            <p:cNvSpPr/>
            <p:nvPr/>
          </p:nvSpPr>
          <p:spPr>
            <a:xfrm>
              <a:off x="4443970" y="4317869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4" name="pl77">
              <a:extLst>
                <a:ext uri="{FF2B5EF4-FFF2-40B4-BE49-F238E27FC236}">
                  <a16:creationId xmlns:a16="http://schemas.microsoft.com/office/drawing/2014/main" id="{D432451B-424F-A03D-FC51-8A085F336A3A}"/>
                </a:ext>
              </a:extLst>
            </p:cNvPr>
            <p:cNvSpPr/>
            <p:nvPr/>
          </p:nvSpPr>
          <p:spPr>
            <a:xfrm>
              <a:off x="4821835" y="3455905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5" name="pl78">
              <a:extLst>
                <a:ext uri="{FF2B5EF4-FFF2-40B4-BE49-F238E27FC236}">
                  <a16:creationId xmlns:a16="http://schemas.microsoft.com/office/drawing/2014/main" id="{5D129B80-D608-856D-C91E-4376D324B5FA}"/>
                </a:ext>
              </a:extLst>
            </p:cNvPr>
            <p:cNvSpPr/>
            <p:nvPr/>
          </p:nvSpPr>
          <p:spPr>
            <a:xfrm>
              <a:off x="4884813" y="3455905"/>
              <a:ext cx="0" cy="430990"/>
            </a:xfrm>
            <a:custGeom>
              <a:avLst/>
              <a:gdLst/>
              <a:ahLst/>
              <a:cxnLst/>
              <a:rect l="0" t="0" r="0" b="0"/>
              <a:pathLst>
                <a:path h="430990">
                  <a:moveTo>
                    <a:pt x="0" y="0"/>
                  </a:moveTo>
                  <a:lnTo>
                    <a:pt x="0" y="4309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6" name="pl79">
              <a:extLst>
                <a:ext uri="{FF2B5EF4-FFF2-40B4-BE49-F238E27FC236}">
                  <a16:creationId xmlns:a16="http://schemas.microsoft.com/office/drawing/2014/main" id="{BA5109EC-5F75-FAE9-28B2-2A814F56B1A6}"/>
                </a:ext>
              </a:extLst>
            </p:cNvPr>
            <p:cNvSpPr/>
            <p:nvPr/>
          </p:nvSpPr>
          <p:spPr>
            <a:xfrm>
              <a:off x="4821835" y="3886896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7" name="pl80">
              <a:extLst>
                <a:ext uri="{FF2B5EF4-FFF2-40B4-BE49-F238E27FC236}">
                  <a16:creationId xmlns:a16="http://schemas.microsoft.com/office/drawing/2014/main" id="{C7AD178A-0AC5-E974-2695-D0DB2AD9D75E}"/>
                </a:ext>
              </a:extLst>
            </p:cNvPr>
            <p:cNvSpPr/>
            <p:nvPr/>
          </p:nvSpPr>
          <p:spPr>
            <a:xfrm>
              <a:off x="5325656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8" name="pl81">
              <a:extLst>
                <a:ext uri="{FF2B5EF4-FFF2-40B4-BE49-F238E27FC236}">
                  <a16:creationId xmlns:a16="http://schemas.microsoft.com/office/drawing/2014/main" id="{FB4363F0-FE03-EB79-8B76-C217B16B03D6}"/>
                </a:ext>
              </a:extLst>
            </p:cNvPr>
            <p:cNvSpPr/>
            <p:nvPr/>
          </p:nvSpPr>
          <p:spPr>
            <a:xfrm>
              <a:off x="5388634" y="2962818"/>
              <a:ext cx="0" cy="0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79" name="pl82">
              <a:extLst>
                <a:ext uri="{FF2B5EF4-FFF2-40B4-BE49-F238E27FC236}">
                  <a16:creationId xmlns:a16="http://schemas.microsoft.com/office/drawing/2014/main" id="{B4241D99-7A4B-9211-DB38-017C4575A58E}"/>
                </a:ext>
              </a:extLst>
            </p:cNvPr>
            <p:cNvSpPr/>
            <p:nvPr/>
          </p:nvSpPr>
          <p:spPr>
            <a:xfrm>
              <a:off x="5325656" y="2962818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0" name="pl83">
              <a:extLst>
                <a:ext uri="{FF2B5EF4-FFF2-40B4-BE49-F238E27FC236}">
                  <a16:creationId xmlns:a16="http://schemas.microsoft.com/office/drawing/2014/main" id="{ACA3C31E-754F-6B5D-1147-F3CB86222AC4}"/>
                </a:ext>
              </a:extLst>
            </p:cNvPr>
            <p:cNvSpPr/>
            <p:nvPr/>
          </p:nvSpPr>
          <p:spPr>
            <a:xfrm>
              <a:off x="5703521" y="5167571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1" name="pl84">
              <a:extLst>
                <a:ext uri="{FF2B5EF4-FFF2-40B4-BE49-F238E27FC236}">
                  <a16:creationId xmlns:a16="http://schemas.microsoft.com/office/drawing/2014/main" id="{7C7D1658-A087-0F85-F538-8E28DD0F092F}"/>
                </a:ext>
              </a:extLst>
            </p:cNvPr>
            <p:cNvSpPr/>
            <p:nvPr/>
          </p:nvSpPr>
          <p:spPr>
            <a:xfrm>
              <a:off x="5766499" y="5167571"/>
              <a:ext cx="0" cy="85878"/>
            </a:xfrm>
            <a:custGeom>
              <a:avLst/>
              <a:gdLst/>
              <a:ahLst/>
              <a:cxnLst/>
              <a:rect l="0" t="0" r="0" b="0"/>
              <a:pathLst>
                <a:path h="85878">
                  <a:moveTo>
                    <a:pt x="0" y="0"/>
                  </a:moveTo>
                  <a:lnTo>
                    <a:pt x="0" y="8587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2" name="pl85">
              <a:extLst>
                <a:ext uri="{FF2B5EF4-FFF2-40B4-BE49-F238E27FC236}">
                  <a16:creationId xmlns:a16="http://schemas.microsoft.com/office/drawing/2014/main" id="{7D09C544-4AEE-4B7A-B1CD-1FA42F84F2CC}"/>
                </a:ext>
              </a:extLst>
            </p:cNvPr>
            <p:cNvSpPr/>
            <p:nvPr/>
          </p:nvSpPr>
          <p:spPr>
            <a:xfrm>
              <a:off x="5703521" y="5253450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3" name="pl86">
              <a:extLst>
                <a:ext uri="{FF2B5EF4-FFF2-40B4-BE49-F238E27FC236}">
                  <a16:creationId xmlns:a16="http://schemas.microsoft.com/office/drawing/2014/main" id="{B8899A61-A76B-A5C0-DBCA-E9B07EAF827C}"/>
                </a:ext>
              </a:extLst>
            </p:cNvPr>
            <p:cNvSpPr/>
            <p:nvPr/>
          </p:nvSpPr>
          <p:spPr>
            <a:xfrm>
              <a:off x="6081387" y="5176534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4" name="pl87">
              <a:extLst>
                <a:ext uri="{FF2B5EF4-FFF2-40B4-BE49-F238E27FC236}">
                  <a16:creationId xmlns:a16="http://schemas.microsoft.com/office/drawing/2014/main" id="{14C59FE1-AF69-34A8-CB6E-9D4F5525C04C}"/>
                </a:ext>
              </a:extLst>
            </p:cNvPr>
            <p:cNvSpPr/>
            <p:nvPr/>
          </p:nvSpPr>
          <p:spPr>
            <a:xfrm>
              <a:off x="6144364" y="5176534"/>
              <a:ext cx="0" cy="127554"/>
            </a:xfrm>
            <a:custGeom>
              <a:avLst/>
              <a:gdLst/>
              <a:ahLst/>
              <a:cxnLst/>
              <a:rect l="0" t="0" r="0" b="0"/>
              <a:pathLst>
                <a:path h="127554">
                  <a:moveTo>
                    <a:pt x="0" y="0"/>
                  </a:moveTo>
                  <a:lnTo>
                    <a:pt x="0" y="12755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5" name="pl88">
              <a:extLst>
                <a:ext uri="{FF2B5EF4-FFF2-40B4-BE49-F238E27FC236}">
                  <a16:creationId xmlns:a16="http://schemas.microsoft.com/office/drawing/2014/main" id="{195B46E5-E1BE-61EF-6FCC-EF2BA62DD8E3}"/>
                </a:ext>
              </a:extLst>
            </p:cNvPr>
            <p:cNvSpPr/>
            <p:nvPr/>
          </p:nvSpPr>
          <p:spPr>
            <a:xfrm>
              <a:off x="6081387" y="5304089"/>
              <a:ext cx="125955" cy="0"/>
            </a:xfrm>
            <a:custGeom>
              <a:avLst/>
              <a:gdLst/>
              <a:ahLst/>
              <a:cxnLst/>
              <a:rect l="0" t="0" r="0" b="0"/>
              <a:pathLst>
                <a:path w="125955">
                  <a:moveTo>
                    <a:pt x="0" y="0"/>
                  </a:moveTo>
                  <a:lnTo>
                    <a:pt x="125955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86" name="tx89">
              <a:extLst>
                <a:ext uri="{FF2B5EF4-FFF2-40B4-BE49-F238E27FC236}">
                  <a16:creationId xmlns:a16="http://schemas.microsoft.com/office/drawing/2014/main" id="{F40C4B69-F725-AA81-7AE2-FEBAFB59769B}"/>
                </a:ext>
              </a:extLst>
            </p:cNvPr>
            <p:cNvSpPr/>
            <p:nvPr/>
          </p:nvSpPr>
          <p:spPr>
            <a:xfrm>
              <a:off x="1962746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87" name="tx90">
              <a:extLst>
                <a:ext uri="{FF2B5EF4-FFF2-40B4-BE49-F238E27FC236}">
                  <a16:creationId xmlns:a16="http://schemas.microsoft.com/office/drawing/2014/main" id="{43E1D1EB-982D-736D-B2B4-17CFE2DA910C}"/>
                </a:ext>
              </a:extLst>
            </p:cNvPr>
            <p:cNvSpPr/>
            <p:nvPr/>
          </p:nvSpPr>
          <p:spPr>
            <a:xfrm>
              <a:off x="1917533" y="2140832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988" name="tx91">
              <a:extLst>
                <a:ext uri="{FF2B5EF4-FFF2-40B4-BE49-F238E27FC236}">
                  <a16:creationId xmlns:a16="http://schemas.microsoft.com/office/drawing/2014/main" id="{871584F2-CCB6-A409-CAD7-9E41B603ED1F}"/>
                </a:ext>
              </a:extLst>
            </p:cNvPr>
            <p:cNvSpPr/>
            <p:nvPr/>
          </p:nvSpPr>
          <p:spPr>
            <a:xfrm>
              <a:off x="1882377" y="2140832"/>
              <a:ext cx="210934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989" name="tx92">
              <a:extLst>
                <a:ext uri="{FF2B5EF4-FFF2-40B4-BE49-F238E27FC236}">
                  <a16:creationId xmlns:a16="http://schemas.microsoft.com/office/drawing/2014/main" id="{A1416F32-84C9-2D63-6E89-53E7EF051434}"/>
                </a:ext>
              </a:extLst>
            </p:cNvPr>
            <p:cNvSpPr/>
            <p:nvPr/>
          </p:nvSpPr>
          <p:spPr>
            <a:xfrm>
              <a:off x="3222297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0" name="tx93">
              <a:extLst>
                <a:ext uri="{FF2B5EF4-FFF2-40B4-BE49-F238E27FC236}">
                  <a16:creationId xmlns:a16="http://schemas.microsoft.com/office/drawing/2014/main" id="{0B428F84-14CE-E88E-140A-E26D7482A732}"/>
                </a:ext>
              </a:extLst>
            </p:cNvPr>
            <p:cNvSpPr/>
            <p:nvPr/>
          </p:nvSpPr>
          <p:spPr>
            <a:xfrm>
              <a:off x="3222297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1" name="tx94">
              <a:extLst>
                <a:ext uri="{FF2B5EF4-FFF2-40B4-BE49-F238E27FC236}">
                  <a16:creationId xmlns:a16="http://schemas.microsoft.com/office/drawing/2014/main" id="{58830785-53A9-4BA1-5A55-1623DD904A52}"/>
                </a:ext>
              </a:extLst>
            </p:cNvPr>
            <p:cNvSpPr/>
            <p:nvPr/>
          </p:nvSpPr>
          <p:spPr>
            <a:xfrm>
              <a:off x="3222297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2" name="tx95">
              <a:extLst>
                <a:ext uri="{FF2B5EF4-FFF2-40B4-BE49-F238E27FC236}">
                  <a16:creationId xmlns:a16="http://schemas.microsoft.com/office/drawing/2014/main" id="{45D39D28-6A99-98E2-C54E-7AFB84977FA5}"/>
                </a:ext>
              </a:extLst>
            </p:cNvPr>
            <p:cNvSpPr/>
            <p:nvPr/>
          </p:nvSpPr>
          <p:spPr>
            <a:xfrm>
              <a:off x="4481849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3" name="tx96">
              <a:extLst>
                <a:ext uri="{FF2B5EF4-FFF2-40B4-BE49-F238E27FC236}">
                  <a16:creationId xmlns:a16="http://schemas.microsoft.com/office/drawing/2014/main" id="{76CB4348-94A1-5B38-6BA9-23BECA5E7121}"/>
                </a:ext>
              </a:extLst>
            </p:cNvPr>
            <p:cNvSpPr/>
            <p:nvPr/>
          </p:nvSpPr>
          <p:spPr>
            <a:xfrm>
              <a:off x="4481849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4" name="tx97">
              <a:extLst>
                <a:ext uri="{FF2B5EF4-FFF2-40B4-BE49-F238E27FC236}">
                  <a16:creationId xmlns:a16="http://schemas.microsoft.com/office/drawing/2014/main" id="{E4F3C2A2-25FF-B594-1895-45D00EB0DD41}"/>
                </a:ext>
              </a:extLst>
            </p:cNvPr>
            <p:cNvSpPr/>
            <p:nvPr/>
          </p:nvSpPr>
          <p:spPr>
            <a:xfrm>
              <a:off x="4610999" y="2113309"/>
              <a:ext cx="70310" cy="5504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lang="da-DK" sz="1422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</a:t>
              </a:r>
              <a:endParaRPr sz="1422" dirty="0">
                <a:solidFill>
                  <a:srgbClr val="000000">
                    <a:alpha val="100000"/>
                  </a:srgbClr>
                </a:solidFill>
                <a:latin typeface="SF Pro Semibold"/>
                <a:cs typeface="Arial"/>
              </a:endParaRPr>
            </a:p>
          </p:txBody>
        </p:sp>
        <p:sp>
          <p:nvSpPr>
            <p:cNvPr id="995" name="tx98">
              <a:extLst>
                <a:ext uri="{FF2B5EF4-FFF2-40B4-BE49-F238E27FC236}">
                  <a16:creationId xmlns:a16="http://schemas.microsoft.com/office/drawing/2014/main" id="{AB56096A-1A65-BBCC-0B25-026912A0D0B1}"/>
                </a:ext>
              </a:extLst>
            </p:cNvPr>
            <p:cNvSpPr/>
            <p:nvPr/>
          </p:nvSpPr>
          <p:spPr>
            <a:xfrm>
              <a:off x="5741400" y="2195882"/>
              <a:ext cx="50197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 </a:t>
              </a:r>
            </a:p>
          </p:txBody>
        </p:sp>
        <p:sp>
          <p:nvSpPr>
            <p:cNvPr id="996" name="tx99">
              <a:extLst>
                <a:ext uri="{FF2B5EF4-FFF2-40B4-BE49-F238E27FC236}">
                  <a16:creationId xmlns:a16="http://schemas.microsoft.com/office/drawing/2014/main" id="{EEED7E06-FF5D-7B49-34C4-1E04EE4D35F4}"/>
                </a:ext>
              </a:extLst>
            </p:cNvPr>
            <p:cNvSpPr/>
            <p:nvPr/>
          </p:nvSpPr>
          <p:spPr>
            <a:xfrm>
              <a:off x="5696188" y="2140832"/>
              <a:ext cx="140623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997" name="tx100">
              <a:extLst>
                <a:ext uri="{FF2B5EF4-FFF2-40B4-BE49-F238E27FC236}">
                  <a16:creationId xmlns:a16="http://schemas.microsoft.com/office/drawing/2014/main" id="{652466EB-1714-134D-CE71-F8BEEF636AC1}"/>
                </a:ext>
              </a:extLst>
            </p:cNvPr>
            <p:cNvSpPr/>
            <p:nvPr/>
          </p:nvSpPr>
          <p:spPr>
            <a:xfrm>
              <a:off x="5661032" y="2140832"/>
              <a:ext cx="210934" cy="550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422"/>
                </a:lnSpc>
              </a:pPr>
              <a:r>
                <a:rPr sz="1422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**</a:t>
              </a:r>
            </a:p>
          </p:txBody>
        </p:sp>
        <p:sp>
          <p:nvSpPr>
            <p:cNvPr id="998" name="pl101">
              <a:extLst>
                <a:ext uri="{FF2B5EF4-FFF2-40B4-BE49-F238E27FC236}">
                  <a16:creationId xmlns:a16="http://schemas.microsoft.com/office/drawing/2014/main" id="{78054524-2B77-1D0F-85FF-0BD3B7E08652}"/>
                </a:ext>
              </a:extLst>
            </p:cNvPr>
            <p:cNvSpPr/>
            <p:nvPr/>
          </p:nvSpPr>
          <p:spPr>
            <a:xfrm>
              <a:off x="1232114" y="2962818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  <a:lnTo>
                    <a:pt x="5290116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ash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999" name="pl102">
              <a:extLst>
                <a:ext uri="{FF2B5EF4-FFF2-40B4-BE49-F238E27FC236}">
                  <a16:creationId xmlns:a16="http://schemas.microsoft.com/office/drawing/2014/main" id="{7B09B687-2A74-785E-AF3C-5CDE805F6F3D}"/>
                </a:ext>
              </a:extLst>
            </p:cNvPr>
            <p:cNvSpPr/>
            <p:nvPr/>
          </p:nvSpPr>
          <p:spPr>
            <a:xfrm>
              <a:off x="1232114" y="803067"/>
              <a:ext cx="0" cy="4964205"/>
            </a:xfrm>
            <a:custGeom>
              <a:avLst/>
              <a:gdLst/>
              <a:ahLst/>
              <a:cxnLst/>
              <a:rect l="0" t="0" r="0" b="0"/>
              <a:pathLst>
                <a:path h="4964205">
                  <a:moveTo>
                    <a:pt x="0" y="4964205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1000" name="tx103">
              <a:extLst>
                <a:ext uri="{FF2B5EF4-FFF2-40B4-BE49-F238E27FC236}">
                  <a16:creationId xmlns:a16="http://schemas.microsoft.com/office/drawing/2014/main" id="{C438191D-88F7-1D64-037D-480519AEF1F6}"/>
                </a:ext>
              </a:extLst>
            </p:cNvPr>
            <p:cNvSpPr/>
            <p:nvPr/>
          </p:nvSpPr>
          <p:spPr>
            <a:xfrm>
              <a:off x="637591" y="5427922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0</a:t>
              </a:r>
            </a:p>
          </p:txBody>
        </p:sp>
        <p:sp>
          <p:nvSpPr>
            <p:cNvPr id="1001" name="tx104">
              <a:extLst>
                <a:ext uri="{FF2B5EF4-FFF2-40B4-BE49-F238E27FC236}">
                  <a16:creationId xmlns:a16="http://schemas.microsoft.com/office/drawing/2014/main" id="{8D8C71CF-7CFC-4E71-AE0A-DA787F26A7A3}"/>
                </a:ext>
              </a:extLst>
            </p:cNvPr>
            <p:cNvSpPr/>
            <p:nvPr/>
          </p:nvSpPr>
          <p:spPr>
            <a:xfrm>
              <a:off x="637591" y="4138518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0.5</a:t>
              </a:r>
            </a:p>
          </p:txBody>
        </p:sp>
        <p:sp>
          <p:nvSpPr>
            <p:cNvPr id="1002" name="tx105">
              <a:extLst>
                <a:ext uri="{FF2B5EF4-FFF2-40B4-BE49-F238E27FC236}">
                  <a16:creationId xmlns:a16="http://schemas.microsoft.com/office/drawing/2014/main" id="{870BD392-91E9-9136-AA76-162C906A7275}"/>
                </a:ext>
              </a:extLst>
            </p:cNvPr>
            <p:cNvSpPr/>
            <p:nvPr/>
          </p:nvSpPr>
          <p:spPr>
            <a:xfrm>
              <a:off x="637591" y="2849114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0</a:t>
              </a:r>
            </a:p>
          </p:txBody>
        </p:sp>
        <p:sp>
          <p:nvSpPr>
            <p:cNvPr id="1003" name="tx106">
              <a:extLst>
                <a:ext uri="{FF2B5EF4-FFF2-40B4-BE49-F238E27FC236}">
                  <a16:creationId xmlns:a16="http://schemas.microsoft.com/office/drawing/2014/main" id="{891C3F5B-DA02-4D3E-D7D7-384827A6A5DA}"/>
                </a:ext>
              </a:extLst>
            </p:cNvPr>
            <p:cNvSpPr/>
            <p:nvPr/>
          </p:nvSpPr>
          <p:spPr>
            <a:xfrm>
              <a:off x="637591" y="1559710"/>
              <a:ext cx="423713" cy="222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 dirty="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1.5</a:t>
              </a:r>
            </a:p>
          </p:txBody>
        </p:sp>
        <p:sp>
          <p:nvSpPr>
            <p:cNvPr id="1004" name="pl107">
              <a:extLst>
                <a:ext uri="{FF2B5EF4-FFF2-40B4-BE49-F238E27FC236}">
                  <a16:creationId xmlns:a16="http://schemas.microsoft.com/office/drawing/2014/main" id="{32E5270F-05A8-1ED3-ABC7-DBD20E1F24BC}"/>
                </a:ext>
              </a:extLst>
            </p:cNvPr>
            <p:cNvSpPr/>
            <p:nvPr/>
          </p:nvSpPr>
          <p:spPr>
            <a:xfrm>
              <a:off x="1137220" y="5541626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1005" name="pl108">
              <a:extLst>
                <a:ext uri="{FF2B5EF4-FFF2-40B4-BE49-F238E27FC236}">
                  <a16:creationId xmlns:a16="http://schemas.microsoft.com/office/drawing/2014/main" id="{21FFC091-DE1B-98CA-6BA3-64FA2DCFDCCB}"/>
                </a:ext>
              </a:extLst>
            </p:cNvPr>
            <p:cNvSpPr/>
            <p:nvPr/>
          </p:nvSpPr>
          <p:spPr>
            <a:xfrm>
              <a:off x="1137220" y="4252222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1006" name="pl109">
              <a:extLst>
                <a:ext uri="{FF2B5EF4-FFF2-40B4-BE49-F238E27FC236}">
                  <a16:creationId xmlns:a16="http://schemas.microsoft.com/office/drawing/2014/main" id="{FFD30528-1065-2B1E-DBF8-EEEA630A0F5A}"/>
                </a:ext>
              </a:extLst>
            </p:cNvPr>
            <p:cNvSpPr/>
            <p:nvPr/>
          </p:nvSpPr>
          <p:spPr>
            <a:xfrm>
              <a:off x="1137220" y="2962818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1007" name="pl110">
              <a:extLst>
                <a:ext uri="{FF2B5EF4-FFF2-40B4-BE49-F238E27FC236}">
                  <a16:creationId xmlns:a16="http://schemas.microsoft.com/office/drawing/2014/main" id="{5BC8AB96-1BBF-BAB2-8233-8EBA3B14C231}"/>
                </a:ext>
              </a:extLst>
            </p:cNvPr>
            <p:cNvSpPr/>
            <p:nvPr/>
          </p:nvSpPr>
          <p:spPr>
            <a:xfrm>
              <a:off x="1137220" y="1673414"/>
              <a:ext cx="94894" cy="0"/>
            </a:xfrm>
            <a:custGeom>
              <a:avLst/>
              <a:gdLst/>
              <a:ahLst/>
              <a:cxnLst/>
              <a:rect l="0" t="0" r="0" b="0"/>
              <a:pathLst>
                <a:path w="94894">
                  <a:moveTo>
                    <a:pt x="0" y="0"/>
                  </a:moveTo>
                  <a:lnTo>
                    <a:pt x="94894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>
                <a:latin typeface="SF Pro Semibold"/>
              </a:endParaRPr>
            </a:p>
          </p:txBody>
        </p:sp>
        <p:sp>
          <p:nvSpPr>
            <p:cNvPr id="1008" name="pl111">
              <a:extLst>
                <a:ext uri="{FF2B5EF4-FFF2-40B4-BE49-F238E27FC236}">
                  <a16:creationId xmlns:a16="http://schemas.microsoft.com/office/drawing/2014/main" id="{F62D4FE7-A5CF-2643-C6C7-9B2AF5E21936}"/>
                </a:ext>
              </a:extLst>
            </p:cNvPr>
            <p:cNvSpPr/>
            <p:nvPr/>
          </p:nvSpPr>
          <p:spPr>
            <a:xfrm>
              <a:off x="1232114" y="5767272"/>
              <a:ext cx="5290116" cy="0"/>
            </a:xfrm>
            <a:custGeom>
              <a:avLst/>
              <a:gdLst/>
              <a:ahLst/>
              <a:cxnLst/>
              <a:rect l="0" t="0" r="0" b="0"/>
              <a:pathLst>
                <a:path w="5290116">
                  <a:moveTo>
                    <a:pt x="0" y="0"/>
                  </a:moveTo>
                  <a:lnTo>
                    <a:pt x="5290116" y="0"/>
                  </a:lnTo>
                </a:path>
              </a:pathLst>
            </a:custGeom>
            <a:ln w="36956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1009" name="pl112">
              <a:extLst>
                <a:ext uri="{FF2B5EF4-FFF2-40B4-BE49-F238E27FC236}">
                  <a16:creationId xmlns:a16="http://schemas.microsoft.com/office/drawing/2014/main" id="{D0E08357-AE5A-1C51-C0DB-FE8D7D635DBE}"/>
                </a:ext>
              </a:extLst>
            </p:cNvPr>
            <p:cNvSpPr/>
            <p:nvPr/>
          </p:nvSpPr>
          <p:spPr>
            <a:xfrm>
              <a:off x="1987845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1010" name="pl113">
              <a:extLst>
                <a:ext uri="{FF2B5EF4-FFF2-40B4-BE49-F238E27FC236}">
                  <a16:creationId xmlns:a16="http://schemas.microsoft.com/office/drawing/2014/main" id="{2200D68E-EC99-EF64-A5E8-6339537BCE71}"/>
                </a:ext>
              </a:extLst>
            </p:cNvPr>
            <p:cNvSpPr/>
            <p:nvPr/>
          </p:nvSpPr>
          <p:spPr>
            <a:xfrm>
              <a:off x="3247396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1011" name="pl114">
              <a:extLst>
                <a:ext uri="{FF2B5EF4-FFF2-40B4-BE49-F238E27FC236}">
                  <a16:creationId xmlns:a16="http://schemas.microsoft.com/office/drawing/2014/main" id="{C59066AC-036C-F888-0BAD-37A74330FC8E}"/>
                </a:ext>
              </a:extLst>
            </p:cNvPr>
            <p:cNvSpPr/>
            <p:nvPr/>
          </p:nvSpPr>
          <p:spPr>
            <a:xfrm>
              <a:off x="4506948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1012" name="pl115">
              <a:extLst>
                <a:ext uri="{FF2B5EF4-FFF2-40B4-BE49-F238E27FC236}">
                  <a16:creationId xmlns:a16="http://schemas.microsoft.com/office/drawing/2014/main" id="{F283F686-6499-BE38-86FC-681FBF72067F}"/>
                </a:ext>
              </a:extLst>
            </p:cNvPr>
            <p:cNvSpPr/>
            <p:nvPr/>
          </p:nvSpPr>
          <p:spPr>
            <a:xfrm>
              <a:off x="5766499" y="5767272"/>
              <a:ext cx="0" cy="94894"/>
            </a:xfrm>
            <a:custGeom>
              <a:avLst/>
              <a:gdLst/>
              <a:ahLst/>
              <a:cxnLst/>
              <a:rect l="0" t="0" r="0" b="0"/>
              <a:pathLst>
                <a:path h="94894">
                  <a:moveTo>
                    <a:pt x="0" y="94894"/>
                  </a:moveTo>
                  <a:lnTo>
                    <a:pt x="0" y="0"/>
                  </a:lnTo>
                </a:path>
              </a:pathLst>
            </a:custGeom>
            <a:ln w="36956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200">
                <a:latin typeface="SF Pro Semibold"/>
              </a:endParaRPr>
            </a:p>
          </p:txBody>
        </p:sp>
        <p:sp>
          <p:nvSpPr>
            <p:cNvPr id="1013" name="tx116">
              <a:extLst>
                <a:ext uri="{FF2B5EF4-FFF2-40B4-BE49-F238E27FC236}">
                  <a16:creationId xmlns:a16="http://schemas.microsoft.com/office/drawing/2014/main" id="{8E736964-CF98-F63C-BC31-E39FF5642B57}"/>
                </a:ext>
              </a:extLst>
            </p:cNvPr>
            <p:cNvSpPr/>
            <p:nvPr/>
          </p:nvSpPr>
          <p:spPr>
            <a:xfrm>
              <a:off x="1699788" y="5933319"/>
              <a:ext cx="576113" cy="22294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E3K</a:t>
              </a:r>
            </a:p>
          </p:txBody>
        </p:sp>
        <p:sp>
          <p:nvSpPr>
            <p:cNvPr id="1014" name="tx117">
              <a:extLst>
                <a:ext uri="{FF2B5EF4-FFF2-40B4-BE49-F238E27FC236}">
                  <a16:creationId xmlns:a16="http://schemas.microsoft.com/office/drawing/2014/main" id="{DD1E245D-87F1-31AA-22EB-E863DEF85004}"/>
                </a:ext>
              </a:extLst>
            </p:cNvPr>
            <p:cNvSpPr/>
            <p:nvPr/>
          </p:nvSpPr>
          <p:spPr>
            <a:xfrm>
              <a:off x="2866173" y="5933319"/>
              <a:ext cx="762446" cy="22294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P35R</a:t>
              </a:r>
            </a:p>
          </p:txBody>
        </p:sp>
        <p:sp>
          <p:nvSpPr>
            <p:cNvPr id="1015" name="tx118">
              <a:extLst>
                <a:ext uri="{FF2B5EF4-FFF2-40B4-BE49-F238E27FC236}">
                  <a16:creationId xmlns:a16="http://schemas.microsoft.com/office/drawing/2014/main" id="{C290A499-E4CE-A6E5-E5CD-BA301C0D375D}"/>
                </a:ext>
              </a:extLst>
            </p:cNvPr>
            <p:cNvSpPr/>
            <p:nvPr/>
          </p:nvSpPr>
          <p:spPr>
            <a:xfrm>
              <a:off x="4032558" y="5930640"/>
              <a:ext cx="948779" cy="2256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R282C</a:t>
              </a:r>
            </a:p>
          </p:txBody>
        </p:sp>
        <p:sp>
          <p:nvSpPr>
            <p:cNvPr id="1016" name="tx119">
              <a:extLst>
                <a:ext uri="{FF2B5EF4-FFF2-40B4-BE49-F238E27FC236}">
                  <a16:creationId xmlns:a16="http://schemas.microsoft.com/office/drawing/2014/main" id="{C8054B6F-883F-4A93-11DD-DA000E62C1D2}"/>
                </a:ext>
              </a:extLst>
            </p:cNvPr>
            <p:cNvSpPr/>
            <p:nvPr/>
          </p:nvSpPr>
          <p:spPr>
            <a:xfrm>
              <a:off x="5308927" y="5930491"/>
              <a:ext cx="915144" cy="2257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2400"/>
                </a:lnSpc>
              </a:pPr>
              <a:r>
                <a:rPr sz="1600" dirty="0">
                  <a:solidFill>
                    <a:srgbClr val="4D4D4D">
                      <a:alpha val="100000"/>
                    </a:srgbClr>
                  </a:solidFill>
                  <a:latin typeface="SF Pro Semibold"/>
                  <a:cs typeface="Arial"/>
                </a:rPr>
                <a:t>S493S</a:t>
              </a:r>
            </a:p>
          </p:txBody>
        </p:sp>
        <p:sp>
          <p:nvSpPr>
            <p:cNvPr id="1017" name="tx129">
              <a:extLst>
                <a:ext uri="{FF2B5EF4-FFF2-40B4-BE49-F238E27FC236}">
                  <a16:creationId xmlns:a16="http://schemas.microsoft.com/office/drawing/2014/main" id="{04B1743F-D8F3-91E9-2846-98AF5B949FB5}"/>
                </a:ext>
              </a:extLst>
            </p:cNvPr>
            <p:cNvSpPr/>
            <p:nvPr/>
          </p:nvSpPr>
          <p:spPr>
            <a:xfrm>
              <a:off x="976636" y="789313"/>
              <a:ext cx="6099199" cy="42349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3600"/>
                </a:lnSpc>
              </a:pPr>
              <a:r>
                <a:rPr lang="da-DK"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B) </a:t>
              </a:r>
              <a:r>
                <a:rPr sz="2400" dirty="0">
                  <a:solidFill>
                    <a:srgbClr val="000000">
                      <a:alpha val="100000"/>
                    </a:srgbClr>
                  </a:solidFill>
                  <a:latin typeface="SF Pro Semibold"/>
                  <a:cs typeface="Arial"/>
                </a:rPr>
                <a:t>Benign variants, assay control</a:t>
              </a:r>
            </a:p>
          </p:txBody>
        </p:sp>
      </p:grpSp>
      <p:sp>
        <p:nvSpPr>
          <p:cNvPr id="3" name="tx222">
            <a:extLst>
              <a:ext uri="{FF2B5EF4-FFF2-40B4-BE49-F238E27FC236}">
                <a16:creationId xmlns:a16="http://schemas.microsoft.com/office/drawing/2014/main" id="{91DD5A39-636A-F4A4-D6C7-8151170BBDE9}"/>
              </a:ext>
            </a:extLst>
          </p:cNvPr>
          <p:cNvSpPr/>
          <p:nvPr/>
        </p:nvSpPr>
        <p:spPr>
          <a:xfrm rot="16200000">
            <a:off x="-1631526" y="2904789"/>
            <a:ext cx="4333450" cy="1278751"/>
          </a:xfrm>
          <a:prstGeom prst="rect">
            <a:avLst/>
          </a:prstGeom>
          <a:noFill/>
        </p:spPr>
        <p:txBody>
          <a:bodyPr wrap="none" lIns="0" tIns="0" rIns="0" bIns="0" anchor="ctr" anchorCtr="1"/>
          <a:lstStyle/>
          <a:p>
            <a:pPr marL="0" marR="0" indent="0" algn="l">
              <a:spcBef>
                <a:spcPts val="0"/>
              </a:spcBef>
              <a:spcAft>
                <a:spcPts val="0"/>
              </a:spcAft>
            </a:pPr>
            <a:r>
              <a:rPr sz="2800" dirty="0">
                <a:solidFill>
                  <a:srgbClr val="000000">
                    <a:alpha val="100000"/>
                  </a:srgbClr>
                </a:solidFill>
                <a:latin typeface="SF Pro Semibold"/>
                <a:cs typeface="Arial"/>
              </a:rPr>
              <a:t>Normalized</a:t>
            </a:r>
            <a:r>
              <a:rPr lang="da-DK" sz="2800" dirty="0">
                <a:solidFill>
                  <a:srgbClr val="000000">
                    <a:alpha val="100000"/>
                  </a:srgbClr>
                </a:solidFill>
                <a:latin typeface="SF Pro Semibold"/>
                <a:cs typeface="Arial"/>
              </a:rPr>
              <a:t> Frameshift InDels </a:t>
            </a:r>
            <a:r>
              <a:rPr sz="2800" dirty="0">
                <a:solidFill>
                  <a:srgbClr val="000000">
                    <a:alpha val="100000"/>
                  </a:srgbClr>
                </a:solidFill>
                <a:latin typeface="SF Pro Semibold"/>
                <a:cs typeface="Arial"/>
              </a:rPr>
              <a:t>/</a:t>
            </a:r>
            <a:r>
              <a:rPr lang="da-DK" sz="2800" dirty="0">
                <a:solidFill>
                  <a:srgbClr val="000000">
                    <a:alpha val="100000"/>
                  </a:srgbClr>
                </a:solidFill>
                <a:latin typeface="SF Pro Semibold"/>
                <a:cs typeface="Arial"/>
              </a:rPr>
              <a:t>WT’</a:t>
            </a:r>
            <a:endParaRPr sz="2800" dirty="0">
              <a:solidFill>
                <a:srgbClr val="000000">
                  <a:alpha val="100000"/>
                </a:srgbClr>
              </a:solidFill>
              <a:latin typeface="SF Pro Semibold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63922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33</TotalTime>
  <Words>102</Words>
  <Application>Microsoft Office PowerPoint</Application>
  <PresentationFormat>Widescreen</PresentationFormat>
  <Paragraphs>78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F Pro Semibold</vt:lpstr>
      <vt:lpstr>Office-tema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Nikolaj Juul Nitschke</dc:creator>
  <cp:lastModifiedBy>Nikolaj Juul Nitschke</cp:lastModifiedBy>
  <cp:revision>22</cp:revision>
  <dcterms:created xsi:type="dcterms:W3CDTF">2024-03-18T13:14:37Z</dcterms:created>
  <dcterms:modified xsi:type="dcterms:W3CDTF">2025-08-25T09:52:16Z</dcterms:modified>
</cp:coreProperties>
</file>